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3"/>
  </p:notesMasterIdLst>
  <p:sldIdLst>
    <p:sldId id="315" r:id="rId2"/>
    <p:sldId id="316" r:id="rId3"/>
    <p:sldId id="324" r:id="rId4"/>
    <p:sldId id="327" r:id="rId5"/>
    <p:sldId id="302" r:id="rId6"/>
    <p:sldId id="318" r:id="rId7"/>
    <p:sldId id="319" r:id="rId8"/>
    <p:sldId id="313" r:id="rId9"/>
    <p:sldId id="297" r:id="rId10"/>
    <p:sldId id="312" r:id="rId11"/>
    <p:sldId id="320" r:id="rId12"/>
  </p:sldIdLst>
  <p:sldSz cx="13895388" cy="8783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45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CD5C5C"/>
    <a:srgbClr val="C0C0C0"/>
    <a:srgbClr val="FF4300"/>
    <a:srgbClr val="FFC24F"/>
    <a:srgbClr val="6E2D9F"/>
    <a:srgbClr val="006400"/>
    <a:srgbClr val="FFFF00"/>
    <a:srgbClr val="C2E105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1F6D7A-DBD0-4E9C-B3BA-DF0BF870C42F}" v="6" dt="2021-04-22T11:56:59.8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7957" autoAdjust="0"/>
  </p:normalViewPr>
  <p:slideViewPr>
    <p:cSldViewPr snapToGrid="0" showGuides="1">
      <p:cViewPr varScale="1">
        <p:scale>
          <a:sx n="79" d="100"/>
          <a:sy n="79" d="100"/>
        </p:scale>
        <p:origin x="1410" y="90"/>
      </p:cViewPr>
      <p:guideLst>
        <p:guide orient="horz" pos="1927"/>
        <p:guide pos="45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ang hui" userId="7090c9456b8cb81b" providerId="LiveId" clId="{EB1F6D7A-DBD0-4E9C-B3BA-DF0BF870C42F}"/>
    <pc:docChg chg="undo custSel modSld">
      <pc:chgData name="zhang hui" userId="7090c9456b8cb81b" providerId="LiveId" clId="{EB1F6D7A-DBD0-4E9C-B3BA-DF0BF870C42F}" dt="2021-04-22T11:57:17.043" v="202" actId="6549"/>
      <pc:docMkLst>
        <pc:docMk/>
      </pc:docMkLst>
      <pc:sldChg chg="addSp delSp modSp mod">
        <pc:chgData name="zhang hui" userId="7090c9456b8cb81b" providerId="LiveId" clId="{EB1F6D7A-DBD0-4E9C-B3BA-DF0BF870C42F}" dt="2021-04-22T11:57:17.043" v="202" actId="6549"/>
        <pc:sldMkLst>
          <pc:docMk/>
          <pc:sldMk cId="2592613582" sldId="302"/>
        </pc:sldMkLst>
        <pc:spChg chg="del">
          <ac:chgData name="zhang hui" userId="7090c9456b8cb81b" providerId="LiveId" clId="{EB1F6D7A-DBD0-4E9C-B3BA-DF0BF870C42F}" dt="2021-04-22T11:54:49.234" v="3" actId="478"/>
          <ac:spMkLst>
            <pc:docMk/>
            <pc:sldMk cId="2592613582" sldId="302"/>
            <ac:spMk id="4" creationId="{60BC06D0-727B-477D-8A8E-7DD29F6A61AF}"/>
          </ac:spMkLst>
        </pc:spChg>
        <pc:spChg chg="mod">
          <ac:chgData name="zhang hui" userId="7090c9456b8cb81b" providerId="LiveId" clId="{EB1F6D7A-DBD0-4E9C-B3BA-DF0BF870C42F}" dt="2021-04-22T11:56:25.305" v="151" actId="1035"/>
          <ac:spMkLst>
            <pc:docMk/>
            <pc:sldMk cId="2592613582" sldId="302"/>
            <ac:spMk id="5" creationId="{7A53B1E5-6C3F-407E-ADDB-82CA4B201BCD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8" creationId="{821AEB1F-913F-4D75-AE82-60967330B12F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9" creationId="{2609574A-39E1-4F63-ACB4-2733466DABCF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0" creationId="{EB45E979-E20E-4DA6-B437-43359A2FA7EA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1" creationId="{E82C47D8-EBE1-4C4D-BD9E-226A3A2E02D9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2" creationId="{9B9667E1-406E-4321-B9FB-5F00DC099C3D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3" creationId="{7F4949B7-58B7-4828-91AD-9CCDEA0D4B3D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4" creationId="{6DFA696E-7DAC-42E3-9B08-057C5BE04A31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5" creationId="{CB57EA0D-B7AD-40E8-BB88-FC97FC920B6A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6" creationId="{6422EDA3-BB86-4162-8533-EA85763017C8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27" creationId="{E38D9886-8C4D-4445-81D6-5A5661BA11B7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30" creationId="{EFE6269F-73CB-42B9-B5DB-270C8ADF53BD}"/>
          </ac:spMkLst>
        </pc:spChg>
        <pc:spChg chg="del">
          <ac:chgData name="zhang hui" userId="7090c9456b8cb81b" providerId="LiveId" clId="{EB1F6D7A-DBD0-4E9C-B3BA-DF0BF870C42F}" dt="2021-04-22T10:04:57.334" v="0" actId="21"/>
          <ac:spMkLst>
            <pc:docMk/>
            <pc:sldMk cId="2592613582" sldId="302"/>
            <ac:spMk id="54" creationId="{F31D5DDD-555E-4119-BDF3-E3841ADB6BB0}"/>
          </ac:spMkLst>
        </pc:spChg>
        <pc:spChg chg="del">
          <ac:chgData name="zhang hui" userId="7090c9456b8cb81b" providerId="LiveId" clId="{EB1F6D7A-DBD0-4E9C-B3BA-DF0BF870C42F}" dt="2021-04-22T11:54:42.079" v="2" actId="478"/>
          <ac:spMkLst>
            <pc:docMk/>
            <pc:sldMk cId="2592613582" sldId="302"/>
            <ac:spMk id="55" creationId="{31C8D841-7016-4A24-B417-6995D0EEFAC9}"/>
          </ac:spMkLst>
        </pc:spChg>
        <pc:spChg chg="mod">
          <ac:chgData name="zhang hui" userId="7090c9456b8cb81b" providerId="LiveId" clId="{EB1F6D7A-DBD0-4E9C-B3BA-DF0BF870C42F}" dt="2021-04-22T11:57:17.043" v="202" actId="6549"/>
          <ac:spMkLst>
            <pc:docMk/>
            <pc:sldMk cId="2592613582" sldId="302"/>
            <ac:spMk id="81" creationId="{1DFD81D9-0A68-41A1-B55D-DB9D48F65573}"/>
          </ac:spMkLst>
        </pc:spChg>
        <pc:spChg chg="del">
          <ac:chgData name="zhang hui" userId="7090c9456b8cb81b" providerId="LiveId" clId="{EB1F6D7A-DBD0-4E9C-B3BA-DF0BF870C42F}" dt="2021-04-22T11:56:39.926" v="167" actId="478"/>
          <ac:spMkLst>
            <pc:docMk/>
            <pc:sldMk cId="2592613582" sldId="302"/>
            <ac:spMk id="89" creationId="{6F9DE0A6-3A9C-45B4-9CEA-510C92FE9B8E}"/>
          </ac:spMkLst>
        </pc:spChg>
        <pc:spChg chg="del mod">
          <ac:chgData name="zhang hui" userId="7090c9456b8cb81b" providerId="LiveId" clId="{EB1F6D7A-DBD0-4E9C-B3BA-DF0BF870C42F}" dt="2021-04-22T11:55:52.891" v="135" actId="478"/>
          <ac:spMkLst>
            <pc:docMk/>
            <pc:sldMk cId="2592613582" sldId="302"/>
            <ac:spMk id="90" creationId="{281205A2-9914-4A23-BA1F-FA8C7B3A6170}"/>
          </ac:spMkLst>
        </pc:spChg>
        <pc:spChg chg="add mod">
          <ac:chgData name="zhang hui" userId="7090c9456b8cb81b" providerId="LiveId" clId="{EB1F6D7A-DBD0-4E9C-B3BA-DF0BF870C42F}" dt="2021-04-22T11:56:25.305" v="151" actId="1035"/>
          <ac:spMkLst>
            <pc:docMk/>
            <pc:sldMk cId="2592613582" sldId="302"/>
            <ac:spMk id="91" creationId="{51E697D2-E217-4547-9938-366F635C4657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95" creationId="{3AB244C9-E808-406D-BAE7-A94D4E8B8671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96" creationId="{4DAB25F3-72B3-40AC-8190-9991B687270E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97" creationId="{2D214DB9-18EA-4DE0-8845-529854ED9B0F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98" creationId="{E2E5E1F9-0C16-4D91-87D1-022DE4850DAD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99" creationId="{AF6D4869-3647-4339-A17D-116369FDAC73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0" creationId="{837A38FC-29DB-41E2-B4B0-055EC722ACBD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1" creationId="{524F9A88-7916-4592-817B-82D212A57B46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2" creationId="{402CE2B4-8B9A-4E18-B961-027236808F87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3" creationId="{8AD6E0B9-512B-4110-BE7C-A2166B781AD7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4" creationId="{2857AC52-7BB8-432A-9C2B-BC406DE4BDAC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07" creationId="{B0031FA6-971E-4731-B873-C523A07CFB2F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1" creationId="{11CF06A7-6F87-431C-81FE-A8B5E2EDA63F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2" creationId="{1C386595-C74F-45CA-9967-A36FA4E35B69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3" creationId="{07F7DAC8-C0F0-446D-B6FF-06801D2C8B51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4" creationId="{EF3F9733-F4CD-4428-B79C-073DA82F1F77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5" creationId="{DBAA551A-9599-435D-8AD3-F985EB252126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6" creationId="{0A5FC626-547D-4E92-AF90-C21F5330DE18}"/>
          </ac:spMkLst>
        </pc:spChg>
        <pc:spChg chg="mod topLvl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7" creationId="{0B21C1B4-4B33-4453-BA68-C79832C706A0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8" creationId="{35397D77-63AD-4926-8202-BEA1E240A05C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19" creationId="{7B3C0B63-7CBC-4040-BBA0-806FA252EFA3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20" creationId="{CF9605DF-1752-4687-8713-FE79B38EA4DC}"/>
          </ac:spMkLst>
        </pc:spChg>
        <pc:spChg chg="mod">
          <ac:chgData name="zhang hui" userId="7090c9456b8cb81b" providerId="LiveId" clId="{EB1F6D7A-DBD0-4E9C-B3BA-DF0BF870C42F}" dt="2021-04-22T11:56:11.496" v="142" actId="165"/>
          <ac:spMkLst>
            <pc:docMk/>
            <pc:sldMk cId="2592613582" sldId="302"/>
            <ac:spMk id="123" creationId="{D4D3530D-211E-43BC-979C-FED5EDCA835F}"/>
          </ac:spMkLst>
        </pc:spChg>
        <pc:spChg chg="add mod">
          <ac:chgData name="zhang hui" userId="7090c9456b8cb81b" providerId="LiveId" clId="{EB1F6D7A-DBD0-4E9C-B3BA-DF0BF870C42F}" dt="2021-04-22T11:56:30.772" v="166" actId="1037"/>
          <ac:spMkLst>
            <pc:docMk/>
            <pc:sldMk cId="2592613582" sldId="302"/>
            <ac:spMk id="124" creationId="{7F31D952-B3B2-49F4-A011-8AB58422F71B}"/>
          </ac:spMkLst>
        </pc:spChg>
        <pc:grpChg chg="mod topLvl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17" creationId="{EFB0F145-674D-4232-9411-83B5182805BB}"/>
          </ac:grpSpMkLst>
        </pc:grpChg>
        <pc:grpChg chg="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28" creationId="{876EDC17-0E4D-491C-A768-3ADBACF50CB4}"/>
          </ac:grpSpMkLst>
        </pc:grpChg>
        <pc:grpChg chg="del">
          <ac:chgData name="zhang hui" userId="7090c9456b8cb81b" providerId="LiveId" clId="{EB1F6D7A-DBD0-4E9C-B3BA-DF0BF870C42F}" dt="2021-04-22T11:54:39.252" v="1" actId="478"/>
          <ac:grpSpMkLst>
            <pc:docMk/>
            <pc:sldMk cId="2592613582" sldId="302"/>
            <ac:grpSpMk id="34" creationId="{6F02A979-0EA2-4660-A4AD-8C6288BAA800}"/>
          </ac:grpSpMkLst>
        </pc:grpChg>
        <pc:grpChg chg="del">
          <ac:chgData name="zhang hui" userId="7090c9456b8cb81b" providerId="LiveId" clId="{EB1F6D7A-DBD0-4E9C-B3BA-DF0BF870C42F}" dt="2021-04-22T11:54:49.234" v="3" actId="478"/>
          <ac:grpSpMkLst>
            <pc:docMk/>
            <pc:sldMk cId="2592613582" sldId="302"/>
            <ac:grpSpMk id="86" creationId="{EBE58A11-3B51-453A-9FA7-F7B7EA6A4146}"/>
          </ac:grpSpMkLst>
        </pc:grpChg>
        <pc:grpChg chg="del 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87" creationId="{D946DAB5-73D0-4DB9-A1EF-7F96E2AC2E37}"/>
          </ac:grpSpMkLst>
        </pc:grpChg>
        <pc:grpChg chg="del">
          <ac:chgData name="zhang hui" userId="7090c9456b8cb81b" providerId="LiveId" clId="{EB1F6D7A-DBD0-4E9C-B3BA-DF0BF870C42F}" dt="2021-04-22T10:04:57.334" v="0" actId="21"/>
          <ac:grpSpMkLst>
            <pc:docMk/>
            <pc:sldMk cId="2592613582" sldId="302"/>
            <ac:grpSpMk id="88" creationId="{D725788F-C356-415A-91B0-467F19CFFF1F}"/>
          </ac:grpSpMkLst>
        </pc:grpChg>
        <pc:grpChg chg="add del 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92" creationId="{89916AF6-C1AD-400D-8A34-7CEB64257F93}"/>
          </ac:grpSpMkLst>
        </pc:grpChg>
        <pc:grpChg chg="mod topLvl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94" creationId="{F5555769-8BE3-4498-BFF2-06C639498C51}"/>
          </ac:grpSpMkLst>
        </pc:grpChg>
        <pc:grpChg chg="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105" creationId="{C114F81A-DBB2-4D93-B582-CF550851D24D}"/>
          </ac:grpSpMkLst>
        </pc:grpChg>
        <pc:grpChg chg="add del 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108" creationId="{16AA2F1B-A352-4AC5-9905-6F1ED3CF364E}"/>
          </ac:grpSpMkLst>
        </pc:grpChg>
        <pc:grpChg chg="mod topLvl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110" creationId="{FD2B0CBB-DA58-4FB8-80DA-481C9A51A648}"/>
          </ac:grpSpMkLst>
        </pc:grpChg>
        <pc:grpChg chg="mod">
          <ac:chgData name="zhang hui" userId="7090c9456b8cb81b" providerId="LiveId" clId="{EB1F6D7A-DBD0-4E9C-B3BA-DF0BF870C42F}" dt="2021-04-22T11:56:11.496" v="142" actId="165"/>
          <ac:grpSpMkLst>
            <pc:docMk/>
            <pc:sldMk cId="2592613582" sldId="302"/>
            <ac:grpSpMk id="121" creationId="{2440A6FF-D484-4F9B-B4A5-475BB1EE1EED}"/>
          </ac:grpSpMkLst>
        </pc:grpChg>
        <pc:graphicFrameChg chg="mod topLvl">
          <ac:chgData name="zhang hui" userId="7090c9456b8cb81b" providerId="LiveId" clId="{EB1F6D7A-DBD0-4E9C-B3BA-DF0BF870C42F}" dt="2021-04-22T11:56:11.496" v="142" actId="165"/>
          <ac:graphicFrameMkLst>
            <pc:docMk/>
            <pc:sldMk cId="2592613582" sldId="302"/>
            <ac:graphicFrameMk id="3" creationId="{415F7CD9-9750-4C5F-B4DE-6F55032EEB00}"/>
          </ac:graphicFrameMkLst>
        </pc:graphicFrameChg>
        <pc:graphicFrameChg chg="mod topLvl">
          <ac:chgData name="zhang hui" userId="7090c9456b8cb81b" providerId="LiveId" clId="{EB1F6D7A-DBD0-4E9C-B3BA-DF0BF870C42F}" dt="2021-04-22T11:56:11.496" v="142" actId="165"/>
          <ac:graphicFrameMkLst>
            <pc:docMk/>
            <pc:sldMk cId="2592613582" sldId="302"/>
            <ac:graphicFrameMk id="93" creationId="{D5E9DB4F-150E-4658-A1D7-C95F1AEFC9F9}"/>
          </ac:graphicFrameMkLst>
        </pc:graphicFrameChg>
        <pc:graphicFrameChg chg="mod topLvl">
          <ac:chgData name="zhang hui" userId="7090c9456b8cb81b" providerId="LiveId" clId="{EB1F6D7A-DBD0-4E9C-B3BA-DF0BF870C42F}" dt="2021-04-22T11:56:11.496" v="142" actId="165"/>
          <ac:graphicFrameMkLst>
            <pc:docMk/>
            <pc:sldMk cId="2592613582" sldId="302"/>
            <ac:graphicFrameMk id="109" creationId="{0B299B12-0DE2-4B22-BEDE-C8FD97742C50}"/>
          </ac:graphicFrameMkLst>
        </pc:graphicFrameChg>
        <pc:cxnChg chg="mod">
          <ac:chgData name="zhang hui" userId="7090c9456b8cb81b" providerId="LiveId" clId="{EB1F6D7A-DBD0-4E9C-B3BA-DF0BF870C42F}" dt="2021-04-22T11:56:11.496" v="142" actId="165"/>
          <ac:cxnSpMkLst>
            <pc:docMk/>
            <pc:sldMk cId="2592613582" sldId="302"/>
            <ac:cxnSpMk id="29" creationId="{5723785D-1685-48F2-8179-5A74DD3B62A8}"/>
          </ac:cxnSpMkLst>
        </pc:cxnChg>
        <pc:cxnChg chg="mod">
          <ac:chgData name="zhang hui" userId="7090c9456b8cb81b" providerId="LiveId" clId="{EB1F6D7A-DBD0-4E9C-B3BA-DF0BF870C42F}" dt="2021-04-22T11:56:11.496" v="142" actId="165"/>
          <ac:cxnSpMkLst>
            <pc:docMk/>
            <pc:sldMk cId="2592613582" sldId="302"/>
            <ac:cxnSpMk id="106" creationId="{BAD2E6CC-D3B1-4A3D-8DA3-C97A9671B1EA}"/>
          </ac:cxnSpMkLst>
        </pc:cxnChg>
        <pc:cxnChg chg="mod">
          <ac:chgData name="zhang hui" userId="7090c9456b8cb81b" providerId="LiveId" clId="{EB1F6D7A-DBD0-4E9C-B3BA-DF0BF870C42F}" dt="2021-04-22T11:56:11.496" v="142" actId="165"/>
          <ac:cxnSpMkLst>
            <pc:docMk/>
            <pc:sldMk cId="2592613582" sldId="302"/>
            <ac:cxnSpMk id="122" creationId="{E9C0CD36-810D-4AF4-9D0E-1C8DAE8E8012}"/>
          </ac:cxnSpMkLst>
        </pc:cxnChg>
      </pc:sldChg>
    </pc:docChg>
  </pc:docChgLst>
  <pc:docChgLst>
    <pc:chgData name="zhang hui" userId="7090c9456b8cb81b" providerId="LiveId" clId="{C7F17EC0-8BA4-4DB1-A5CC-F03E68D8F369}"/>
    <pc:docChg chg="undo redo custSel addSld delSld modSld sldOrd">
      <pc:chgData name="zhang hui" userId="7090c9456b8cb81b" providerId="LiveId" clId="{C7F17EC0-8BA4-4DB1-A5CC-F03E68D8F369}" dt="2020-06-29T03:34:35.473" v="4204" actId="1038"/>
      <pc:docMkLst>
        <pc:docMk/>
      </pc:docMkLst>
      <pc:sldChg chg="modSp mod">
        <pc:chgData name="zhang hui" userId="7090c9456b8cb81b" providerId="LiveId" clId="{C7F17EC0-8BA4-4DB1-A5CC-F03E68D8F369}" dt="2020-06-18T15:41:26.635" v="29" actId="1037"/>
        <pc:sldMkLst>
          <pc:docMk/>
          <pc:sldMk cId="2592613582" sldId="302"/>
        </pc:sldMkLst>
        <pc:spChg chg="mod">
          <ac:chgData name="zhang hui" userId="7090c9456b8cb81b" providerId="LiveId" clId="{C7F17EC0-8BA4-4DB1-A5CC-F03E68D8F369}" dt="2020-06-18T15:41:17.090" v="12" actId="1037"/>
          <ac:spMkLst>
            <pc:docMk/>
            <pc:sldMk cId="2592613582" sldId="302"/>
            <ac:spMk id="4" creationId="{60BC06D0-727B-477D-8A8E-7DD29F6A61AF}"/>
          </ac:spMkLst>
        </pc:spChg>
        <pc:spChg chg="mod">
          <ac:chgData name="zhang hui" userId="7090c9456b8cb81b" providerId="LiveId" clId="{C7F17EC0-8BA4-4DB1-A5CC-F03E68D8F369}" dt="2020-06-18T15:41:26.635" v="29" actId="1037"/>
          <ac:spMkLst>
            <pc:docMk/>
            <pc:sldMk cId="2592613582" sldId="302"/>
            <ac:spMk id="5" creationId="{7A53B1E5-6C3F-407E-ADDB-82CA4B201BCD}"/>
          </ac:spMkLst>
        </pc:spChg>
      </pc:sldChg>
      <pc:sldChg chg="addSp modSp mod">
        <pc:chgData name="zhang hui" userId="7090c9456b8cb81b" providerId="LiveId" clId="{C7F17EC0-8BA4-4DB1-A5CC-F03E68D8F369}" dt="2020-06-29T03:34:35.473" v="4204" actId="1038"/>
        <pc:sldMkLst>
          <pc:docMk/>
          <pc:sldMk cId="1064264200" sldId="312"/>
        </pc:sldMkLst>
        <pc:spChg chg="mod">
          <ac:chgData name="zhang hui" userId="7090c9456b8cb81b" providerId="LiveId" clId="{C7F17EC0-8BA4-4DB1-A5CC-F03E68D8F369}" dt="2020-06-29T03:34:25.936" v="4198" actId="554"/>
          <ac:spMkLst>
            <pc:docMk/>
            <pc:sldMk cId="1064264200" sldId="312"/>
            <ac:spMk id="10" creationId="{8855E072-1598-4CE9-8769-5E9A29079637}"/>
          </ac:spMkLst>
        </pc:spChg>
        <pc:spChg chg="mod">
          <ac:chgData name="zhang hui" userId="7090c9456b8cb81b" providerId="LiveId" clId="{C7F17EC0-8BA4-4DB1-A5CC-F03E68D8F369}" dt="2020-06-29T03:34:25.936" v="4198" actId="554"/>
          <ac:spMkLst>
            <pc:docMk/>
            <pc:sldMk cId="1064264200" sldId="312"/>
            <ac:spMk id="11" creationId="{CE0A2329-B490-4E93-97E9-52A14C4DE2E1}"/>
          </ac:spMkLst>
        </pc:spChg>
        <pc:spChg chg="mod">
          <ac:chgData name="zhang hui" userId="7090c9456b8cb81b" providerId="LiveId" clId="{C7F17EC0-8BA4-4DB1-A5CC-F03E68D8F369}" dt="2020-06-29T03:34:25.936" v="4198" actId="554"/>
          <ac:spMkLst>
            <pc:docMk/>
            <pc:sldMk cId="1064264200" sldId="312"/>
            <ac:spMk id="12" creationId="{0CA72C4A-F7EF-4491-82AC-1088112B29B9}"/>
          </ac:spMkLst>
        </pc:spChg>
        <pc:spChg chg="mod">
          <ac:chgData name="zhang hui" userId="7090c9456b8cb81b" providerId="LiveId" clId="{C7F17EC0-8BA4-4DB1-A5CC-F03E68D8F369}" dt="2020-06-29T03:34:25.936" v="4198" actId="554"/>
          <ac:spMkLst>
            <pc:docMk/>
            <pc:sldMk cId="1064264200" sldId="312"/>
            <ac:spMk id="13" creationId="{5983E7F8-CEA4-4D45-A9D0-3D23F4009610}"/>
          </ac:spMkLst>
        </pc:spChg>
        <pc:spChg chg="mod">
          <ac:chgData name="zhang hui" userId="7090c9456b8cb81b" providerId="LiveId" clId="{C7F17EC0-8BA4-4DB1-A5CC-F03E68D8F369}" dt="2020-06-29T03:33:21.025" v="4182" actId="554"/>
          <ac:spMkLst>
            <pc:docMk/>
            <pc:sldMk cId="1064264200" sldId="312"/>
            <ac:spMk id="14" creationId="{6F348835-0AC3-4100-8E0B-4A5AD09194B6}"/>
          </ac:spMkLst>
        </pc:spChg>
        <pc:spChg chg="mod">
          <ac:chgData name="zhang hui" userId="7090c9456b8cb81b" providerId="LiveId" clId="{C7F17EC0-8BA4-4DB1-A5CC-F03E68D8F369}" dt="2020-06-29T03:33:21.025" v="4182" actId="554"/>
          <ac:spMkLst>
            <pc:docMk/>
            <pc:sldMk cId="1064264200" sldId="312"/>
            <ac:spMk id="15" creationId="{518A5720-0BCF-48FD-828A-776D09E5E3B9}"/>
          </ac:spMkLst>
        </pc:spChg>
        <pc:spChg chg="mod">
          <ac:chgData name="zhang hui" userId="7090c9456b8cb81b" providerId="LiveId" clId="{C7F17EC0-8BA4-4DB1-A5CC-F03E68D8F369}" dt="2020-06-29T03:33:21.025" v="4182" actId="554"/>
          <ac:spMkLst>
            <pc:docMk/>
            <pc:sldMk cId="1064264200" sldId="312"/>
            <ac:spMk id="16" creationId="{5C8A7A58-E674-42CD-84BE-39C050361A34}"/>
          </ac:spMkLst>
        </pc:spChg>
        <pc:spChg chg="mod">
          <ac:chgData name="zhang hui" userId="7090c9456b8cb81b" providerId="LiveId" clId="{C7F17EC0-8BA4-4DB1-A5CC-F03E68D8F369}" dt="2020-06-29T03:33:21.025" v="4182" actId="554"/>
          <ac:spMkLst>
            <pc:docMk/>
            <pc:sldMk cId="1064264200" sldId="312"/>
            <ac:spMk id="17" creationId="{2A3A6054-04C5-4C99-8C8E-02D7CD509B00}"/>
          </ac:spMkLst>
        </pc:spChg>
        <pc:spChg chg="add mod">
          <ac:chgData name="zhang hui" userId="7090c9456b8cb81b" providerId="LiveId" clId="{C7F17EC0-8BA4-4DB1-A5CC-F03E68D8F369}" dt="2020-06-29T03:33:21.025" v="4182" actId="554"/>
          <ac:spMkLst>
            <pc:docMk/>
            <pc:sldMk cId="1064264200" sldId="312"/>
            <ac:spMk id="82" creationId="{EC4D0D1F-9987-473B-B5A9-754235579ADC}"/>
          </ac:spMkLst>
        </pc:spChg>
        <pc:spChg chg="add mod">
          <ac:chgData name="zhang hui" userId="7090c9456b8cb81b" providerId="LiveId" clId="{C7F17EC0-8BA4-4DB1-A5CC-F03E68D8F369}" dt="2020-06-29T03:34:35.473" v="4204" actId="1038"/>
          <ac:spMkLst>
            <pc:docMk/>
            <pc:sldMk cId="1064264200" sldId="312"/>
            <ac:spMk id="83" creationId="{FFE5E1B2-CDE4-4903-B5C8-9ACAC190FB09}"/>
          </ac:spMkLst>
        </pc:spChg>
        <pc:graphicFrameChg chg="mod">
          <ac:chgData name="zhang hui" userId="7090c9456b8cb81b" providerId="LiveId" clId="{C7F17EC0-8BA4-4DB1-A5CC-F03E68D8F369}" dt="2020-06-29T03:32:34.897" v="4065"/>
          <ac:graphicFrameMkLst>
            <pc:docMk/>
            <pc:sldMk cId="1064264200" sldId="312"/>
            <ac:graphicFrameMk id="2" creationId="{028E551F-D3A3-4DD8-B99C-77C52511E99E}"/>
          </ac:graphicFrameMkLst>
        </pc:graphicFrameChg>
      </pc:sldChg>
      <pc:sldChg chg="modSp">
        <pc:chgData name="zhang hui" userId="7090c9456b8cb81b" providerId="LiveId" clId="{C7F17EC0-8BA4-4DB1-A5CC-F03E68D8F369}" dt="2020-06-20T06:54:04.408" v="4039"/>
        <pc:sldMkLst>
          <pc:docMk/>
          <pc:sldMk cId="1365617920" sldId="313"/>
        </pc:sldMkLst>
        <pc:graphicFrameChg chg="mod">
          <ac:chgData name="zhang hui" userId="7090c9456b8cb81b" providerId="LiveId" clId="{C7F17EC0-8BA4-4DB1-A5CC-F03E68D8F369}" dt="2020-06-20T06:53:29.057" v="4037"/>
          <ac:graphicFrameMkLst>
            <pc:docMk/>
            <pc:sldMk cId="1365617920" sldId="313"/>
            <ac:graphicFrameMk id="3" creationId="{A49A4CFB-948C-4B3C-9180-BE018043A6D7}"/>
          </ac:graphicFrameMkLst>
        </pc:graphicFrameChg>
        <pc:graphicFrameChg chg="mod">
          <ac:chgData name="zhang hui" userId="7090c9456b8cb81b" providerId="LiveId" clId="{C7F17EC0-8BA4-4DB1-A5CC-F03E68D8F369}" dt="2020-06-20T06:54:04.408" v="4039"/>
          <ac:graphicFrameMkLst>
            <pc:docMk/>
            <pc:sldMk cId="1365617920" sldId="313"/>
            <ac:graphicFrameMk id="5" creationId="{B1FE244D-3D29-4C25-839D-9AAD38E5735A}"/>
          </ac:graphicFrameMkLst>
        </pc:graphicFrameChg>
      </pc:sldChg>
      <pc:sldChg chg="modSp">
        <pc:chgData name="zhang hui" userId="7090c9456b8cb81b" providerId="LiveId" clId="{C7F17EC0-8BA4-4DB1-A5CC-F03E68D8F369}" dt="2020-06-20T11:32:37.316" v="4058"/>
        <pc:sldMkLst>
          <pc:docMk/>
          <pc:sldMk cId="4035117534" sldId="315"/>
        </pc:sldMkLst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86" creationId="{D54C51C1-07DC-4C25-B6A2-B997771A9C6C}"/>
          </ac:spMkLst>
        </pc:spChg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87" creationId="{653DB647-82F1-40CF-9F2F-B9A9599C076E}"/>
          </ac:spMkLst>
        </pc:spChg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88" creationId="{CA168E52-8A84-44C0-AA6F-07AD8D5630F9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90" creationId="{3B9ADC07-1877-40D1-B719-7B7E3DDAD1B3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91" creationId="{5870A4F0-E494-4333-8A0A-8A968BCB2C2F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92" creationId="{C61A45C3-18C0-4C7B-A297-EAFB6AB79B06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94" creationId="{7FBCD153-7F8E-4975-843C-378D10BA2D74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95" creationId="{26ECD337-FF1F-4F28-BC0B-39C900611D0D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96" creationId="{F90ADF11-1F36-48D4-946B-4D4BB53E5A16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98" creationId="{4BF25686-CA4D-42BE-874D-2D4C74B3A3DD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99" creationId="{6CE17F03-5086-4E99-B932-ADF61351CCF8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100" creationId="{EE3A3D3A-2A99-4CF3-8371-6FE51DFDAA06}"/>
          </ac:spMkLst>
        </pc:spChg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101" creationId="{B30252C3-27C6-497C-B0F2-697E54B6D69F}"/>
          </ac:spMkLst>
        </pc:spChg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102" creationId="{592FFEFF-4226-44AF-BC10-D4084C37032C}"/>
          </ac:spMkLst>
        </pc:spChg>
        <pc:spChg chg="mod">
          <ac:chgData name="zhang hui" userId="7090c9456b8cb81b" providerId="LiveId" clId="{C7F17EC0-8BA4-4DB1-A5CC-F03E68D8F369}" dt="2020-06-20T11:32:37.316" v="4058"/>
          <ac:spMkLst>
            <pc:docMk/>
            <pc:sldMk cId="4035117534" sldId="315"/>
            <ac:spMk id="103" creationId="{839FF1DF-6DC6-4D19-AF5C-0818F22B6083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105" creationId="{27C4ECB4-208A-492B-B9E7-DD78196DFDBC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106" creationId="{97872512-3D1C-4116-9C51-ADEE02CAACA0}"/>
          </ac:spMkLst>
        </pc:spChg>
        <pc:spChg chg="mod">
          <ac:chgData name="zhang hui" userId="7090c9456b8cb81b" providerId="LiveId" clId="{C7F17EC0-8BA4-4DB1-A5CC-F03E68D8F369}" dt="2020-06-20T11:29:28.441" v="4045"/>
          <ac:spMkLst>
            <pc:docMk/>
            <pc:sldMk cId="4035117534" sldId="315"/>
            <ac:spMk id="107" creationId="{75267916-18AC-42E1-B64A-692B3AFF7AFB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109" creationId="{F86D2BC5-BCBE-4B68-A29A-851F6CD6E681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110" creationId="{9A77D785-744E-45AB-88C9-02DA4A89A56C}"/>
          </ac:spMkLst>
        </pc:spChg>
        <pc:spChg chg="mod">
          <ac:chgData name="zhang hui" userId="7090c9456b8cb81b" providerId="LiveId" clId="{C7F17EC0-8BA4-4DB1-A5CC-F03E68D8F369}" dt="2020-06-20T11:31:13.421" v="4054"/>
          <ac:spMkLst>
            <pc:docMk/>
            <pc:sldMk cId="4035117534" sldId="315"/>
            <ac:spMk id="111" creationId="{8E921E5E-AC1B-45FE-B75E-639C862E5E70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113" creationId="{49B1B3D0-EC01-4D3A-AB4B-6A95CCA86BC2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114" creationId="{61A1F72D-38A5-4462-B873-E2FF2BF6E12C}"/>
          </ac:spMkLst>
        </pc:spChg>
        <pc:spChg chg="mod">
          <ac:chgData name="zhang hui" userId="7090c9456b8cb81b" providerId="LiveId" clId="{C7F17EC0-8BA4-4DB1-A5CC-F03E68D8F369}" dt="2020-06-20T11:31:46.398" v="4056"/>
          <ac:spMkLst>
            <pc:docMk/>
            <pc:sldMk cId="4035117534" sldId="315"/>
            <ac:spMk id="115" creationId="{32E6CE21-164D-4E97-96B7-B4F0C8343781}"/>
          </ac:spMkLst>
        </pc:spChg>
        <pc:grpChg chg="mod">
          <ac:chgData name="zhang hui" userId="7090c9456b8cb81b" providerId="LiveId" clId="{C7F17EC0-8BA4-4DB1-A5CC-F03E68D8F369}" dt="2020-06-20T11:32:37.316" v="4058"/>
          <ac:grpSpMkLst>
            <pc:docMk/>
            <pc:sldMk cId="4035117534" sldId="315"/>
            <ac:grpSpMk id="3" creationId="{E4EFCC43-D347-4A13-B25B-C76CC1E06D6A}"/>
          </ac:grpSpMkLst>
        </pc:grpChg>
        <pc:grpChg chg="mod">
          <ac:chgData name="zhang hui" userId="7090c9456b8cb81b" providerId="LiveId" clId="{C7F17EC0-8BA4-4DB1-A5CC-F03E68D8F369}" dt="2020-06-20T11:32:37.316" v="4058"/>
          <ac:grpSpMkLst>
            <pc:docMk/>
            <pc:sldMk cId="4035117534" sldId="315"/>
            <ac:grpSpMk id="4" creationId="{ECF805FB-671D-49A8-803B-2E2D38E67568}"/>
          </ac:grpSpMkLst>
        </pc:grpChg>
        <pc:grpChg chg="mod">
          <ac:chgData name="zhang hui" userId="7090c9456b8cb81b" providerId="LiveId" clId="{C7F17EC0-8BA4-4DB1-A5CC-F03E68D8F369}" dt="2020-06-20T11:32:37.316" v="4058"/>
          <ac:grpSpMkLst>
            <pc:docMk/>
            <pc:sldMk cId="4035117534" sldId="315"/>
            <ac:grpSpMk id="5" creationId="{FCEFBDEE-7658-4519-9ADA-ABA3FCAA9921}"/>
          </ac:grpSpMkLst>
        </pc:grpChg>
        <pc:grpChg chg="mod">
          <ac:chgData name="zhang hui" userId="7090c9456b8cb81b" providerId="LiveId" clId="{C7F17EC0-8BA4-4DB1-A5CC-F03E68D8F369}" dt="2020-06-20T11:29:28.441" v="4045"/>
          <ac:grpSpMkLst>
            <pc:docMk/>
            <pc:sldMk cId="4035117534" sldId="315"/>
            <ac:grpSpMk id="6" creationId="{C4C12A93-ABD7-44C3-8511-91C79CB221A1}"/>
          </ac:grpSpMkLst>
        </pc:grpChg>
        <pc:grpChg chg="mod">
          <ac:chgData name="zhang hui" userId="7090c9456b8cb81b" providerId="LiveId" clId="{C7F17EC0-8BA4-4DB1-A5CC-F03E68D8F369}" dt="2020-06-20T11:31:13.421" v="4054"/>
          <ac:grpSpMkLst>
            <pc:docMk/>
            <pc:sldMk cId="4035117534" sldId="315"/>
            <ac:grpSpMk id="7" creationId="{5C98FA99-DCD9-4E5B-AA29-115FF45D00DF}"/>
          </ac:grpSpMkLst>
        </pc:grpChg>
        <pc:grpChg chg="mod">
          <ac:chgData name="zhang hui" userId="7090c9456b8cb81b" providerId="LiveId" clId="{C7F17EC0-8BA4-4DB1-A5CC-F03E68D8F369}" dt="2020-06-20T11:31:46.398" v="4056"/>
          <ac:grpSpMkLst>
            <pc:docMk/>
            <pc:sldMk cId="4035117534" sldId="315"/>
            <ac:grpSpMk id="8" creationId="{B31E5200-C932-4C92-9248-2AC51467F6A5}"/>
          </ac:grpSpMkLst>
        </pc:grpChg>
        <pc:grpChg chg="mod">
          <ac:chgData name="zhang hui" userId="7090c9456b8cb81b" providerId="LiveId" clId="{C7F17EC0-8BA4-4DB1-A5CC-F03E68D8F369}" dt="2020-06-20T11:29:28.441" v="4045"/>
          <ac:grpSpMkLst>
            <pc:docMk/>
            <pc:sldMk cId="4035117534" sldId="315"/>
            <ac:grpSpMk id="89" creationId="{ADF34A42-0784-44BB-854F-2E7A33325C4E}"/>
          </ac:grpSpMkLst>
        </pc:grpChg>
        <pc:grpChg chg="mod">
          <ac:chgData name="zhang hui" userId="7090c9456b8cb81b" providerId="LiveId" clId="{C7F17EC0-8BA4-4DB1-A5CC-F03E68D8F369}" dt="2020-06-20T11:31:13.421" v="4054"/>
          <ac:grpSpMkLst>
            <pc:docMk/>
            <pc:sldMk cId="4035117534" sldId="315"/>
            <ac:grpSpMk id="93" creationId="{C1461BDB-01C6-485D-A7A5-A0808A91D061}"/>
          </ac:grpSpMkLst>
        </pc:grpChg>
        <pc:grpChg chg="mod">
          <ac:chgData name="zhang hui" userId="7090c9456b8cb81b" providerId="LiveId" clId="{C7F17EC0-8BA4-4DB1-A5CC-F03E68D8F369}" dt="2020-06-20T11:31:46.398" v="4056"/>
          <ac:grpSpMkLst>
            <pc:docMk/>
            <pc:sldMk cId="4035117534" sldId="315"/>
            <ac:grpSpMk id="97" creationId="{03953CF1-A3FC-42FC-B81D-92E5750BEF80}"/>
          </ac:grpSpMkLst>
        </pc:grpChg>
        <pc:grpChg chg="mod">
          <ac:chgData name="zhang hui" userId="7090c9456b8cb81b" providerId="LiveId" clId="{C7F17EC0-8BA4-4DB1-A5CC-F03E68D8F369}" dt="2020-06-20T11:29:28.441" v="4045"/>
          <ac:grpSpMkLst>
            <pc:docMk/>
            <pc:sldMk cId="4035117534" sldId="315"/>
            <ac:grpSpMk id="104" creationId="{E3622A87-55CF-4B36-85FD-369F3C6A7960}"/>
          </ac:grpSpMkLst>
        </pc:grpChg>
        <pc:grpChg chg="mod">
          <ac:chgData name="zhang hui" userId="7090c9456b8cb81b" providerId="LiveId" clId="{C7F17EC0-8BA4-4DB1-A5CC-F03E68D8F369}" dt="2020-06-20T11:31:13.421" v="4054"/>
          <ac:grpSpMkLst>
            <pc:docMk/>
            <pc:sldMk cId="4035117534" sldId="315"/>
            <ac:grpSpMk id="108" creationId="{95A611D3-E0E6-448D-A908-C9856E32A692}"/>
          </ac:grpSpMkLst>
        </pc:grpChg>
        <pc:grpChg chg="mod">
          <ac:chgData name="zhang hui" userId="7090c9456b8cb81b" providerId="LiveId" clId="{C7F17EC0-8BA4-4DB1-A5CC-F03E68D8F369}" dt="2020-06-20T11:31:46.398" v="4056"/>
          <ac:grpSpMkLst>
            <pc:docMk/>
            <pc:sldMk cId="4035117534" sldId="315"/>
            <ac:grpSpMk id="112" creationId="{CF15774B-8559-4BCB-A319-17BAAB516CAA}"/>
          </ac:grpSpMkLst>
        </pc:grpChg>
        <pc:graphicFrameChg chg="mod">
          <ac:chgData name="zhang hui" userId="7090c9456b8cb81b" providerId="LiveId" clId="{C7F17EC0-8BA4-4DB1-A5CC-F03E68D8F369}" dt="2020-06-20T11:32:37.316" v="4058"/>
          <ac:graphicFrameMkLst>
            <pc:docMk/>
            <pc:sldMk cId="4035117534" sldId="315"/>
            <ac:graphicFrameMk id="43" creationId="{1F86F398-F87F-4396-895C-582D0807BE32}"/>
          </ac:graphicFrameMkLst>
        </pc:graphicFrameChg>
        <pc:graphicFrameChg chg="mod">
          <ac:chgData name="zhang hui" userId="7090c9456b8cb81b" providerId="LiveId" clId="{C7F17EC0-8BA4-4DB1-A5CC-F03E68D8F369}" dt="2020-06-20T11:30:23.209" v="4050"/>
          <ac:graphicFrameMkLst>
            <pc:docMk/>
            <pc:sldMk cId="4035117534" sldId="315"/>
            <ac:graphicFrameMk id="44" creationId="{35DBAEC1-9656-452C-B46D-F5558144A9EE}"/>
          </ac:graphicFrameMkLst>
        </pc:graphicFrameChg>
        <pc:graphicFrameChg chg="mod">
          <ac:chgData name="zhang hui" userId="7090c9456b8cb81b" providerId="LiveId" clId="{C7F17EC0-8BA4-4DB1-A5CC-F03E68D8F369}" dt="2020-06-20T11:31:13.421" v="4054"/>
          <ac:graphicFrameMkLst>
            <pc:docMk/>
            <pc:sldMk cId="4035117534" sldId="315"/>
            <ac:graphicFrameMk id="47" creationId="{70FCEA17-E40B-4964-BC4C-BEA4FCAAEC1C}"/>
          </ac:graphicFrameMkLst>
        </pc:graphicFrameChg>
        <pc:graphicFrameChg chg="mod">
          <ac:chgData name="zhang hui" userId="7090c9456b8cb81b" providerId="LiveId" clId="{C7F17EC0-8BA4-4DB1-A5CC-F03E68D8F369}" dt="2020-06-20T11:31:46.398" v="4056"/>
          <ac:graphicFrameMkLst>
            <pc:docMk/>
            <pc:sldMk cId="4035117534" sldId="315"/>
            <ac:graphicFrameMk id="48" creationId="{651C32C9-D332-4273-BEDF-8825E519B519}"/>
          </ac:graphicFrameMkLst>
        </pc:graphicFrameChg>
      </pc:sldChg>
      <pc:sldChg chg="del">
        <pc:chgData name="zhang hui" userId="7090c9456b8cb81b" providerId="LiveId" clId="{C7F17EC0-8BA4-4DB1-A5CC-F03E68D8F369}" dt="2020-06-20T05:57:09.680" v="1935" actId="47"/>
        <pc:sldMkLst>
          <pc:docMk/>
          <pc:sldMk cId="2231517387" sldId="317"/>
        </pc:sldMkLst>
      </pc:sldChg>
      <pc:sldChg chg="modSp">
        <pc:chgData name="zhang hui" userId="7090c9456b8cb81b" providerId="LiveId" clId="{C7F17EC0-8BA4-4DB1-A5CC-F03E68D8F369}" dt="2020-06-29T03:28:33.089" v="4062"/>
        <pc:sldMkLst>
          <pc:docMk/>
          <pc:sldMk cId="3984070681" sldId="319"/>
        </pc:sldMkLst>
        <pc:graphicFrameChg chg="mod">
          <ac:chgData name="zhang hui" userId="7090c9456b8cb81b" providerId="LiveId" clId="{C7F17EC0-8BA4-4DB1-A5CC-F03E68D8F369}" dt="2020-06-29T03:28:33.089" v="4062"/>
          <ac:graphicFrameMkLst>
            <pc:docMk/>
            <pc:sldMk cId="3984070681" sldId="319"/>
            <ac:graphicFrameMk id="2" creationId="{ECAF0B23-33C6-4B07-8559-93C9BDF5A2DF}"/>
          </ac:graphicFrameMkLst>
        </pc:graphicFrameChg>
      </pc:sldChg>
      <pc:sldChg chg="del ord">
        <pc:chgData name="zhang hui" userId="7090c9456b8cb81b" providerId="LiveId" clId="{C7F17EC0-8BA4-4DB1-A5CC-F03E68D8F369}" dt="2020-06-20T06:49:21.819" v="4017" actId="47"/>
        <pc:sldMkLst>
          <pc:docMk/>
          <pc:sldMk cId="1461529931" sldId="321"/>
        </pc:sldMkLst>
      </pc:sldChg>
      <pc:sldChg chg="addSp delSp modSp mod">
        <pc:chgData name="zhang hui" userId="7090c9456b8cb81b" providerId="LiveId" clId="{C7F17EC0-8BA4-4DB1-A5CC-F03E68D8F369}" dt="2020-06-20T05:54:16.549" v="1918" actId="1035"/>
        <pc:sldMkLst>
          <pc:docMk/>
          <pc:sldMk cId="3638699392" sldId="324"/>
        </pc:sldMkLst>
        <pc:spChg chg="mod">
          <ac:chgData name="zhang hui" userId="7090c9456b8cb81b" providerId="LiveId" clId="{C7F17EC0-8BA4-4DB1-A5CC-F03E68D8F369}" dt="2020-06-20T05:43:47.007" v="1629" actId="1076"/>
          <ac:spMkLst>
            <pc:docMk/>
            <pc:sldMk cId="3638699392" sldId="324"/>
            <ac:spMk id="2" creationId="{F9F659F8-7912-42D6-BCF3-6EA1EFB9B8D9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4" creationId="{4900291D-F217-43FD-B286-8126D9852374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" creationId="{9E6ADF14-CFC6-4302-A704-2BAE8BF6BDF1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" creationId="{3C2E763E-FB19-48A5-92C0-6812AB2440A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7" creationId="{1C01237B-4794-4059-BE08-2F09D014EF61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8" creationId="{D09D51D1-1755-435F-BEE2-3F163D100006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9" creationId="{2ADF9423-D8A7-4B70-B30A-3C73DDC2D2CF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0" creationId="{39187D34-7CE5-4560-B620-DA0A6F2C42A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1" creationId="{B2AE81BF-6532-44FD-BE71-CE46C2E4F8C7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12" creationId="{801025C7-659E-4467-84F0-AAD6E86D727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8" creationId="{9EABCAB6-FE46-4776-B5F8-25DFBCBCD14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9" creationId="{60A3E181-428C-48E0-A0D5-2A1879958CB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" creationId="{DE09725E-AC92-40E7-8D15-D6B36CAF69E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1" creationId="{3AF75B3B-FF90-43B3-8E3E-58935F62C763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2" creationId="{64F17E40-D769-493C-A225-5EDEE3C41D6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3" creationId="{426FA677-44A7-4D9E-B782-58151474ACB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" creationId="{1E0BEE68-2448-47FF-9BA7-A2D4B0CFEE0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5" creationId="{A5AAC7E9-D750-4782-A264-3D94BE0047E0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7" creationId="{B22BB598-29D3-4BFB-B500-9968D3D9E85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8" creationId="{5F5D79F2-5FAB-43B0-A8DA-A23C9AA8134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9" creationId="{8ECD8A69-AE2D-4D66-9047-0B82B3FF5E2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30" creationId="{446F45E7-4D53-4C88-8FFA-C70C08348F5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35" creationId="{69EA84AF-7D47-4B5B-B0B1-B9D1CFA92B91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39" creationId="{0C9B4740-26C1-47AE-975E-5CB4D721E03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40" creationId="{75BF59F8-0E90-4B18-BEA1-668070E955F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41" creationId="{38EF02AE-0776-411F-82DA-F0F841ED64F1}"/>
          </ac:spMkLst>
        </pc:spChg>
        <pc:spChg chg="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2" creationId="{9D035EAE-2C49-4A25-B3A0-3F73F09C28CC}"/>
          </ac:spMkLst>
        </pc:spChg>
        <pc:spChg chg="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3" creationId="{AF20D546-3058-4895-91E6-1E04DAB181BC}"/>
          </ac:spMkLst>
        </pc:spChg>
        <pc:spChg chg="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4" creationId="{97080916-9E3E-4C35-985C-A610AA3CCC29}"/>
          </ac:spMkLst>
        </pc:spChg>
        <pc:spChg chg="add 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5" creationId="{68E4AEF9-94CF-4CD1-85C9-C7B9F5A13529}"/>
          </ac:spMkLst>
        </pc:spChg>
        <pc:spChg chg="add 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6" creationId="{C48AE653-6933-4916-BC2E-A79C604936C0}"/>
          </ac:spMkLst>
        </pc:spChg>
        <pc:spChg chg="add del mod">
          <ac:chgData name="zhang hui" userId="7090c9456b8cb81b" providerId="LiveId" clId="{C7F17EC0-8BA4-4DB1-A5CC-F03E68D8F369}" dt="2020-06-20T05:43:32.479" v="1626" actId="478"/>
          <ac:spMkLst>
            <pc:docMk/>
            <pc:sldMk cId="3638699392" sldId="324"/>
            <ac:spMk id="47" creationId="{9643E5DD-4267-45FD-B15B-775750F079B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49" creationId="{C13A9BB4-A6AF-49A3-B83A-A796A7716F3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0" creationId="{844F9B03-397B-4F23-8895-794B2A24297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1" creationId="{8A0AC62B-8A44-49FC-8969-DF3D70988F4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2" creationId="{FF24ECCE-44A3-4196-BE3C-F203FAC7A27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4" creationId="{14DAE79E-B57A-47C3-9E80-392F6B6B38D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5" creationId="{3A1940AF-860D-457F-B40D-3ADEB1DFFDC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6" creationId="{50A072DC-60C8-4675-B993-AC865975016C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57" creationId="{9A710CCC-856D-4134-B0AB-09B76A5D0F6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8" creationId="{27378D77-1C07-476B-940D-3E2859ABDA7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59" creationId="{0F6D5153-1D43-40BE-AFD4-5C0E946A330B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0" creationId="{9D62C36B-8123-427D-846B-24CFDEF554B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1" creationId="{D950F2C6-5C8F-4C74-92A5-388560C71809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2" creationId="{4D5DAC3D-185C-471A-BE18-ACD4937A39E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3" creationId="{FDC29F0A-E479-4D22-A84F-38F1D2C02714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64" creationId="{54AB620E-454B-48B7-BD27-33A81EC60ACF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74" creationId="{AE58F1DA-4647-4EF9-B8DF-AE4755A9F138}"/>
          </ac:spMkLst>
        </pc:spChg>
        <pc:spChg chg="add del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113" creationId="{F0126EBF-B1D9-4077-8C52-6271E565C11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14" creationId="{DE4DE78B-AD62-4AFF-9F50-D361E728494B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15" creationId="{478E105F-05F0-4E24-A87D-092FA0086C94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16" creationId="{E20CCC44-CC82-4B5B-81A8-5435CBDF9B3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19" creationId="{F8527CCF-3FDC-4FDF-B4D0-41FD4AC3778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0" creationId="{B1B0A048-A56C-4979-8DBB-A00C7F60E13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1" creationId="{72A792BD-D32D-44DA-B44C-6B165E42B274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24" creationId="{4952997E-FA68-4F10-B963-F8F8F7DCD6A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5" creationId="{FE00DB91-7B76-42FB-A892-470814BEEF3A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6" creationId="{E9FA394B-D960-4D60-8715-13F2AD4BE423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127" creationId="{4CEE4A0A-0DAA-4E73-8508-6D5C4ED0BB8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8" creationId="{24ABFBC6-5F9B-4968-BC06-2A2A501A130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29" creationId="{17239443-8189-46D3-A2A7-B954D6D6198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0" creationId="{BEDB7AF7-E658-43A2-998B-1E58FE814FA1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1" creationId="{50E28BF3-7A7B-4FDC-9E9E-210B5818653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2" creationId="{5DDC654E-43D0-4AA8-9293-F45476F1D2B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3" creationId="{36C69FE5-6C4C-4676-B6E0-F1D9D2099D0F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5" creationId="{2B47C82B-6961-46ED-B8D3-476519E432D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6" creationId="{B7A09CF5-3A24-43DB-99E6-E0394A3AC95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7" creationId="{593AAA15-011C-463D-9FA1-491F4E4635D4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8" creationId="{542ED6E7-32B6-486C-8B6D-0896ACCA0BD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39" creationId="{985E93BD-0B16-41FD-ACBE-7C8A06F6DC1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0" creationId="{798F65D6-F6E8-4E21-A269-9213946E1FD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1" creationId="{272E328E-556E-431A-BA71-1DA119459BEB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2" creationId="{7D37804F-A3E2-4EA5-B579-43583EA9EC3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3" creationId="{B2AE6002-D453-45E9-BF65-BDDDB6392049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144" creationId="{5A5D5747-76DE-4011-AC2C-EB0C2EAF4A45}"/>
          </ac:spMkLst>
        </pc:spChg>
        <pc:spChg chg="mod topLvl">
          <ac:chgData name="zhang hui" userId="7090c9456b8cb81b" providerId="LiveId" clId="{C7F17EC0-8BA4-4DB1-A5CC-F03E68D8F369}" dt="2020-06-20T05:54:09.301" v="1912" actId="1035"/>
          <ac:spMkLst>
            <pc:docMk/>
            <pc:sldMk cId="3638699392" sldId="324"/>
            <ac:spMk id="145" creationId="{D2BB7028-23BA-4A48-BBDC-CE3748A962A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6" creationId="{13ECCEB0-827C-43E2-A290-EC756BB0877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47" creationId="{7BDE182E-582F-4A00-AD8B-C5656BE04AC1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8" creationId="{8A828AEB-CCBD-48E2-B31F-F667B5DEFC6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49" creationId="{EE35C927-060B-4445-A4E0-21977221071A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50" creationId="{D909FD86-B0B4-4D9C-900E-D4F244178DA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1" creationId="{E17AB36A-3070-48B7-BC73-1963A6C29A7B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2" creationId="{19B4FE6A-CC83-4B0E-ACA1-C656061B062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3" creationId="{02A56EB2-0362-44E1-A94C-766C8C47A12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4" creationId="{5E93BCE3-C921-4770-AED1-BF3BCCDF708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55" creationId="{E2AECB52-134F-420B-B932-C30E20CB716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6" creationId="{D85DFF24-FCD6-410C-994F-55520B4CC00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7" creationId="{AC69828E-BDFA-43FE-A79E-7ACEA0C3217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8" creationId="{7D3A46FE-0964-4C3E-885B-0688E591C5B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59" creationId="{DA679184-D13F-4A57-8717-CCB4C3A1E63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60" creationId="{89D573D1-8EC5-4ECF-90F3-D83E9F6F287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61" creationId="{E1A0162B-04C7-42D7-8371-16CAC2B0EE5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62" creationId="{92F45C4A-33D0-472B-8143-C658682206AB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63" creationId="{3C9FDFC0-6928-434A-86D0-389148E0066A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1" creationId="{ADBD22EA-0159-4BC9-BDED-AB51AA15B84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2" creationId="{2955941A-094A-4720-AEA9-1E54D1C8A7E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3" creationId="{E6D62E16-29D7-42F7-84DB-2DBFE6D4715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4" creationId="{32BA7F46-CE29-4DFF-BD9B-0EB3A6CE4B2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5" creationId="{61B3237D-FA05-4FB8-8012-89453ACF6B3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6" creationId="{07282008-52B3-4E5A-8F85-AD3A81B042FD}"/>
          </ac:spMkLst>
        </pc:spChg>
        <pc:spChg chg="del mod">
          <ac:chgData name="zhang hui" userId="7090c9456b8cb81b" providerId="LiveId" clId="{C7F17EC0-8BA4-4DB1-A5CC-F03E68D8F369}" dt="2020-06-20T05:13:19.372" v="447" actId="478"/>
          <ac:spMkLst>
            <pc:docMk/>
            <pc:sldMk cId="3638699392" sldId="324"/>
            <ac:spMk id="177" creationId="{3594BB44-75B9-486D-9CD3-2473CD62A6D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8" creationId="{0A59919D-2E8F-4AD7-AD61-6F4EFF8E14E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79" creationId="{54B6C4AF-B68F-4E63-8A81-4679DB46C74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0" creationId="{58C999AF-C62F-4EF2-B8D9-9E12E7DFB6CD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1" creationId="{0608FE65-EDE6-4828-9FBC-40CA2117627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2" creationId="{0CD1F52C-2C99-4600-AF1E-E0557CFD6AB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3" creationId="{01262261-7252-4EEA-B45C-C566C401597F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4" creationId="{24C99CAE-4C36-4E1C-A1EC-B82B469EB74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5" creationId="{63A8FC40-519D-4AB4-A241-226947FC3C6A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7" creationId="{99FFCBDC-3487-4C45-A188-5C28B6C972E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8" creationId="{A4D3C8C4-C544-42D2-B397-44AA3CD3E7C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89" creationId="{7139A97C-82A9-4742-B3FE-AD27C8D7EFD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0" creationId="{A60DDC82-2E00-4350-9F6A-DB60381F9F71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1" creationId="{A479D848-3030-4A20-84D2-27619C1045D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2" creationId="{D75CDE43-CEBC-46EA-842A-84C1A84CA15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3" creationId="{5A77B359-CF9E-416A-AA05-74B80A7C951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4" creationId="{E4212E7C-FD75-490E-8064-5E9F409DE92D}"/>
          </ac:spMkLst>
        </pc:spChg>
        <pc:spChg chg="add del 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196" creationId="{2F3A0104-099F-4F9C-A5D6-864FA99A5033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97" creationId="{9DEC4FB8-7779-4E27-B27E-9C6B18AC9C5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98" creationId="{93CAEB62-C434-486B-8544-17134CC3857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199" creationId="{043DA878-1B59-41EB-8A4F-7DEBFF055A50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00" creationId="{0E637E2B-9269-4019-8B6B-828658F0D126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1" creationId="{F15A511B-4F84-41A5-B507-C1D01E750EF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2" creationId="{A69E9275-7638-40E9-A354-EF08DA1F46E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3" creationId="{182082F9-DF62-4970-B26A-664FDA54586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04" creationId="{E99330C1-5902-4173-9AB3-ACC57B071AF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5" creationId="{21ACF541-BDBD-4A6F-A685-5314AAF1BEB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6" creationId="{8F46CA49-2108-467F-90B0-F5ECD309874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7" creationId="{47117B2C-FEA4-4A46-BD4A-E9E479CF323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8" creationId="{8A1FCBF8-EBCA-4986-9580-585D6614420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09" creationId="{F54DB6A9-9E79-4886-B0D8-D19F9700E07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10" creationId="{4E9000D2-616A-48A7-93B5-8894290BA457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11" creationId="{B5601EA7-AA94-44BE-8483-C383B8C12B8B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2" creationId="{F93F1962-B927-4626-99A4-157ADE614F6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3" creationId="{81132986-3C91-48FE-B9C9-9A0FDB376519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14" creationId="{6BEB23B6-1A6C-4C47-8514-4ED4B321DEF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15" creationId="{15A747CE-38C8-4635-AC78-B85C7E21A12A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6" creationId="{4C9F8657-6FEA-418E-A7CA-8FC06A640D0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7" creationId="{E7618AF3-68A3-47FE-A6F6-4D44144E564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8" creationId="{6FC1E160-9041-4660-88A0-59C772D9FB5C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19" creationId="{A498C5A6-3552-41C8-AC04-7D0417B450ED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0" creationId="{51BC41D6-F9AB-4658-8E2D-FC413FC2912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1" creationId="{3846F88F-8060-4506-8304-4F000FA704BA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2" creationId="{54BDCC1C-A825-46B2-9DCA-FAA37CC4A52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3" creationId="{FD01ADAE-65AB-44BE-8363-91E4B6F6D876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5" creationId="{3119AB20-FAB4-4ACB-BCA2-D37DFBD8FA9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6" creationId="{A8988B0F-A273-491A-9F82-23B992F8E13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7" creationId="{FFC1082C-7588-43D0-BDD9-79636D4B12F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8" creationId="{8D204BF5-0802-4AC0-870F-23756DD908F9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29" creationId="{B3875A2B-7CCF-4870-B9E8-3CDF4E7A870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0" creationId="{824B831B-A802-4AB5-B055-DBC836AB64E2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1" creationId="{3E89A4BC-A4C0-4A66-9AC7-31FBD39FF135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2" creationId="{01431A97-480E-4A6D-98B5-12814717BB94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3" creationId="{4AED47F6-0518-4605-9BCB-AB8DE88F4A6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4" creationId="{DA22687C-0B33-4592-B63F-F5B690998008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5" creationId="{3064C382-2DAF-4DAA-96D0-99AD03DE3DC3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6" creationId="{52CF738C-B514-4225-9BCC-1638BE6F4337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7" creationId="{5FF09CAD-853A-4632-9D24-68F15322A5C4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8" creationId="{01A0E49C-86A1-4EF2-B059-6653B0AEFFDE}"/>
          </ac:spMkLst>
        </pc:spChg>
        <pc:spChg chg="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39" creationId="{08BA8AFE-F653-4581-8056-0CBBCFFC826C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41" creationId="{364387D3-BAB6-4989-A622-BAF1435F138C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42" creationId="{8D33EA74-3557-474E-BF5A-927861287823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43" creationId="{57184C56-DE4E-4B81-8752-569BDCC5AF1D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44" creationId="{6A119887-7D57-4635-B171-A2BB7B573D0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5" creationId="{A3092A5A-9F73-4C30-8E92-9632AEC0332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6" creationId="{F744F014-3598-4162-8E03-AC0D86104A6C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7" creationId="{7F070809-89A9-4AB4-B07F-379C2E076EAF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8" creationId="{4F065928-647B-4227-81EA-D2F30CD0C04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49" creationId="{B0DFABCD-B014-4D4B-8628-404BC87A83C6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50" creationId="{03DB5FCF-BC49-4EB9-B7FB-F72BED5EE31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51" creationId="{60F8C56A-73E9-431C-A661-4990C1AA79EF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52" creationId="{F2DBDAF9-45A6-43EF-B6DB-24BA426C56D3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53" creationId="{80501259-3E14-4467-B101-AE396A48C68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54" creationId="{082F8A64-6B19-409C-911C-91784013B908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55" creationId="{00400CCE-7609-45A3-A722-DB03FC2807D6}"/>
          </ac:spMkLst>
        </pc:spChg>
        <pc:spChg chg="del mod topLvl">
          <ac:chgData name="zhang hui" userId="7090c9456b8cb81b" providerId="LiveId" clId="{C7F17EC0-8BA4-4DB1-A5CC-F03E68D8F369}" dt="2020-06-20T05:22:18.574" v="1049" actId="478"/>
          <ac:spMkLst>
            <pc:docMk/>
            <pc:sldMk cId="3638699392" sldId="324"/>
            <ac:spMk id="256" creationId="{CF614745-4C25-4CCA-8FE8-2548C4FC586A}"/>
          </ac:spMkLst>
        </pc:spChg>
        <pc:spChg chg="del mod topLvl">
          <ac:chgData name="zhang hui" userId="7090c9456b8cb81b" providerId="LiveId" clId="{C7F17EC0-8BA4-4DB1-A5CC-F03E68D8F369}" dt="2020-06-20T05:22:14.325" v="1048" actId="478"/>
          <ac:spMkLst>
            <pc:docMk/>
            <pc:sldMk cId="3638699392" sldId="324"/>
            <ac:spMk id="258" creationId="{447D299D-CA8C-4DD8-BECE-31A35C217C1E}"/>
          </ac:spMkLst>
        </pc:spChg>
        <pc:spChg chg="del mod topLvl">
          <ac:chgData name="zhang hui" userId="7090c9456b8cb81b" providerId="LiveId" clId="{C7F17EC0-8BA4-4DB1-A5CC-F03E68D8F369}" dt="2020-06-20T05:22:14.325" v="1048" actId="478"/>
          <ac:spMkLst>
            <pc:docMk/>
            <pc:sldMk cId="3638699392" sldId="324"/>
            <ac:spMk id="259" creationId="{AB4592A6-5893-4ECC-B52D-15BA0B39DD02}"/>
          </ac:spMkLst>
        </pc:spChg>
        <pc:spChg chg="del mod topLvl">
          <ac:chgData name="zhang hui" userId="7090c9456b8cb81b" providerId="LiveId" clId="{C7F17EC0-8BA4-4DB1-A5CC-F03E68D8F369}" dt="2020-06-20T05:22:14.325" v="1048" actId="478"/>
          <ac:spMkLst>
            <pc:docMk/>
            <pc:sldMk cId="3638699392" sldId="324"/>
            <ac:spMk id="260" creationId="{81C73FC2-D222-47F1-BD1D-37134AEE661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1" creationId="{3EDA9213-7E6C-42F6-BE49-77ED9E5DBBB4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2" creationId="{FE600461-99F6-48C5-B175-867BFD98B551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3" creationId="{AAA774B5-A1EF-4E8A-A956-3B9A5462265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4" creationId="{2AE4E6D8-FFAD-44B9-8A2C-A1FBCC35337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5" creationId="{5B5CBB99-7AF0-4F7B-8A71-568656F78B7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6" creationId="{B53DB36B-AB37-4020-8713-CE36287A35B3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7" creationId="{D10859C6-2EE4-4B5A-9483-A9D338CE97FE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8" creationId="{967EDEB0-72EA-4C9B-A48A-3104F5FF655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69" creationId="{00A35AE1-66A1-485F-B71A-5C8AF01E39B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70" creationId="{E029735C-6E23-43F2-A8E4-CFC202B568EC}"/>
          </ac:spMkLst>
        </pc:spChg>
        <pc:spChg chg="del mod topLvl">
          <ac:chgData name="zhang hui" userId="7090c9456b8cb81b" providerId="LiveId" clId="{C7F17EC0-8BA4-4DB1-A5CC-F03E68D8F369}" dt="2020-06-20T05:22:14.325" v="1048" actId="478"/>
          <ac:spMkLst>
            <pc:docMk/>
            <pc:sldMk cId="3638699392" sldId="324"/>
            <ac:spMk id="271" creationId="{C7C5FB27-8606-4B09-B759-8DE8B8CFA678}"/>
          </ac:spMkLst>
        </pc:spChg>
        <pc:spChg chg="del mod topLvl">
          <ac:chgData name="zhang hui" userId="7090c9456b8cb81b" providerId="LiveId" clId="{C7F17EC0-8BA4-4DB1-A5CC-F03E68D8F369}" dt="2020-06-20T05:22:14.325" v="1048" actId="478"/>
          <ac:spMkLst>
            <pc:docMk/>
            <pc:sldMk cId="3638699392" sldId="324"/>
            <ac:spMk id="272" creationId="{89038B6C-835C-4A09-BAF8-682495F5D86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73" creationId="{13AAE8D8-82C4-43F4-962B-B5485A7E209F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74" creationId="{D522435F-9E04-489E-B6BC-4AC7FF61F20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75" creationId="{16942CCA-C5CB-4976-9A95-4B942BC5700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76" creationId="{05369460-A3CD-4FA7-B0B9-991C1CD03980}"/>
          </ac:spMkLst>
        </pc:spChg>
        <pc:spChg chg="del mod topLvl">
          <ac:chgData name="zhang hui" userId="7090c9456b8cb81b" providerId="LiveId" clId="{C7F17EC0-8BA4-4DB1-A5CC-F03E68D8F369}" dt="2020-06-20T05:22:10.810" v="1047" actId="478"/>
          <ac:spMkLst>
            <pc:docMk/>
            <pc:sldMk cId="3638699392" sldId="324"/>
            <ac:spMk id="279" creationId="{0F905498-BD7B-44CF-AB08-E2969AAFD5B0}"/>
          </ac:spMkLst>
        </pc:spChg>
        <pc:spChg chg="del mod topLvl">
          <ac:chgData name="zhang hui" userId="7090c9456b8cb81b" providerId="LiveId" clId="{C7F17EC0-8BA4-4DB1-A5CC-F03E68D8F369}" dt="2020-06-20T05:22:10.810" v="1047" actId="478"/>
          <ac:spMkLst>
            <pc:docMk/>
            <pc:sldMk cId="3638699392" sldId="324"/>
            <ac:spMk id="280" creationId="{E207571C-2D0B-4635-A19D-9AFBB0A5B2F9}"/>
          </ac:spMkLst>
        </pc:spChg>
        <pc:spChg chg="del mod topLvl">
          <ac:chgData name="zhang hui" userId="7090c9456b8cb81b" providerId="LiveId" clId="{C7F17EC0-8BA4-4DB1-A5CC-F03E68D8F369}" dt="2020-06-20T05:22:10.810" v="1047" actId="478"/>
          <ac:spMkLst>
            <pc:docMk/>
            <pc:sldMk cId="3638699392" sldId="324"/>
            <ac:spMk id="281" creationId="{C902F094-DEDC-452D-8ABD-2ADA97A291F1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2" creationId="{96AD8C9D-BDAB-44FC-894A-EE6E48F8EF0F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3" creationId="{A116A7B0-0584-4CE1-9E87-71BFA00A53C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4" creationId="{A18DDA42-FD9E-405D-A2FE-0041352A275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5" creationId="{1FCB6960-0318-4863-AB10-70EC83EBB7B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6" creationId="{A097EF94-E3FE-402F-974F-75DC04A93FE4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287" creationId="{E0759C9D-6934-414D-8571-7FD8EB48134C}"/>
          </ac:spMkLst>
        </pc:spChg>
        <pc:spChg chg="del mod topLvl">
          <ac:chgData name="zhang hui" userId="7090c9456b8cb81b" providerId="LiveId" clId="{C7F17EC0-8BA4-4DB1-A5CC-F03E68D8F369}" dt="2020-06-20T05:22:10.810" v="1047" actId="478"/>
          <ac:spMkLst>
            <pc:docMk/>
            <pc:sldMk cId="3638699392" sldId="324"/>
            <ac:spMk id="288" creationId="{68D1CC1E-B167-480F-839C-45C030B51A95}"/>
          </ac:spMkLst>
        </pc:spChg>
        <pc:spChg chg="del mod topLvl">
          <ac:chgData name="zhang hui" userId="7090c9456b8cb81b" providerId="LiveId" clId="{C7F17EC0-8BA4-4DB1-A5CC-F03E68D8F369}" dt="2020-06-20T05:22:10.810" v="1047" actId="478"/>
          <ac:spMkLst>
            <pc:docMk/>
            <pc:sldMk cId="3638699392" sldId="324"/>
            <ac:spMk id="289" creationId="{A46F875C-ACA8-4F44-9D81-7FE52E621E5C}"/>
          </ac:spMkLst>
        </pc:spChg>
        <pc:spChg chg="add 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90" creationId="{1B629542-BAE2-42FD-9BEB-FB3DFB09C19C}"/>
          </ac:spMkLst>
        </pc:spChg>
        <pc:spChg chg="add mod topLvl">
          <ac:chgData name="zhang hui" userId="7090c9456b8cb81b" providerId="LiveId" clId="{C7F17EC0-8BA4-4DB1-A5CC-F03E68D8F369}" dt="2020-06-20T05:38:59.092" v="1615" actId="164"/>
          <ac:spMkLst>
            <pc:docMk/>
            <pc:sldMk cId="3638699392" sldId="324"/>
            <ac:spMk id="291" creationId="{64B349AB-449D-4AD3-9247-77A959A50426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296" creationId="{536F0502-597A-431B-948F-B434297512C4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297" creationId="{6B4594D0-5BC4-4407-A930-AE626DCBF2E4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298" creationId="{592BA919-1AAB-4A49-9B1C-365272665080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299" creationId="{2FA60793-EAF8-40B9-98B6-F33C30248ECD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0" creationId="{1543E908-2616-4983-B21F-CC861BA3F20A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1" creationId="{C5A89DD7-5185-457B-AE67-BF81223B601F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2" creationId="{C84CC176-DFDB-47FF-86C0-AED7635579EA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3" creationId="{F3DEC42D-20F7-41B3-9BCE-4DCD1E61734A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4" creationId="{A23A5ED6-0AFC-4231-8E51-1188E73FC5E0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5" creationId="{6C6B1CD0-A288-4D54-94BA-C599E2235E19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6" creationId="{87DD63CF-ECF2-4AAB-AA08-4E00321AC3DB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7" creationId="{2801CC08-735D-46F2-9AA5-629C69B4B2EC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8" creationId="{138F65F5-01F6-42A6-9EA2-383C8ECE4CE2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09" creationId="{84F50195-4C37-4A4F-977E-74C13157B965}"/>
          </ac:spMkLst>
        </pc:spChg>
        <pc:spChg chg="mod">
          <ac:chgData name="zhang hui" userId="7090c9456b8cb81b" providerId="LiveId" clId="{C7F17EC0-8BA4-4DB1-A5CC-F03E68D8F369}" dt="2020-06-20T05:24:50.851" v="1074" actId="165"/>
          <ac:spMkLst>
            <pc:docMk/>
            <pc:sldMk cId="3638699392" sldId="324"/>
            <ac:spMk id="310" creationId="{ABEA8466-34FF-44F7-82E3-108F93F9DA54}"/>
          </ac:spMkLst>
        </pc:spChg>
        <pc:spChg chg="add del mod">
          <ac:chgData name="zhang hui" userId="7090c9456b8cb81b" providerId="LiveId" clId="{C7F17EC0-8BA4-4DB1-A5CC-F03E68D8F369}" dt="2020-06-20T05:24:50.366" v="1073"/>
          <ac:spMkLst>
            <pc:docMk/>
            <pc:sldMk cId="3638699392" sldId="324"/>
            <ac:spMk id="311" creationId="{D7950F4E-B03B-4B87-AF23-B936709172C2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16" creationId="{24AD8B63-6CAA-4242-AF87-31C879D94661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17" creationId="{1AC04FDA-8249-495B-9BB1-19A88C5B8620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18" creationId="{1DBA1D0E-A261-47C1-AC20-AC2202D56ADB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19" creationId="{61DB8E32-67C3-4A8D-84DB-148CB8B617C6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0" creationId="{CB821DC3-459F-4DDC-B9CD-4BC09089C7BB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1" creationId="{322F6684-AE02-4ECA-BD73-6438D87D31D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2" creationId="{664CB18E-E287-471E-A277-29FC5241C4DB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3" creationId="{C51D297A-7FED-4AD6-A22F-43A2B7E46B4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4" creationId="{26531851-277C-4315-864B-FFD314E1316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5" creationId="{2F387DB2-58B4-45A6-95C6-EFE2878DC1CA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6" creationId="{9147406C-C7C9-477A-87E7-D438AEC33875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7" creationId="{FD5BDAD5-AEC0-403E-B32E-A3FD96C17BAB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8" creationId="{3B1DB415-4BBE-4270-BD2A-30970825F9E6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29" creationId="{60CC7D34-C471-4D10-B133-91E6D9C133C8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30" creationId="{58B54919-115B-42D6-BD5D-10A6998B118D}"/>
          </ac:spMkLst>
        </pc:spChg>
        <pc:spChg chg="mod topLvl">
          <ac:chgData name="zhang hui" userId="7090c9456b8cb81b" providerId="LiveId" clId="{C7F17EC0-8BA4-4DB1-A5CC-F03E68D8F369}" dt="2020-06-20T05:53:53.960" v="1904" actId="165"/>
          <ac:spMkLst>
            <pc:docMk/>
            <pc:sldMk cId="3638699392" sldId="324"/>
            <ac:spMk id="331" creationId="{37C4E74D-8601-457C-932C-D279EA2A68F4}"/>
          </ac:spMkLst>
        </pc:spChg>
        <pc:spChg chg="add mod">
          <ac:chgData name="zhang hui" userId="7090c9456b8cb81b" providerId="LiveId" clId="{C7F17EC0-8BA4-4DB1-A5CC-F03E68D8F369}" dt="2020-06-20T05:45:22.469" v="1680" actId="1076"/>
          <ac:spMkLst>
            <pc:docMk/>
            <pc:sldMk cId="3638699392" sldId="324"/>
            <ac:spMk id="332" creationId="{9729539B-6005-46C1-8D67-9A8CD3A4867F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3" creationId="{994F2042-3C46-48E4-B28C-9A1560853F4A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4" creationId="{9A92DB3D-98C8-4905-9450-B93208F33BC0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5" creationId="{8084BB98-5127-4796-BB11-23F9FF5B4D0A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6" creationId="{288CDEB0-BF5B-49E5-9E2A-1D8E4E936F89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7" creationId="{7B50FB1C-4426-436D-8C44-FD3436677A10}"/>
          </ac:spMkLst>
        </pc:spChg>
        <pc:spChg chg="add mod">
          <ac:chgData name="zhang hui" userId="7090c9456b8cb81b" providerId="LiveId" clId="{C7F17EC0-8BA4-4DB1-A5CC-F03E68D8F369}" dt="2020-06-20T05:53:48.149" v="1903" actId="164"/>
          <ac:spMkLst>
            <pc:docMk/>
            <pc:sldMk cId="3638699392" sldId="324"/>
            <ac:spMk id="338" creationId="{451680BE-AFB5-4A8F-AF3B-809A7A0ED8EE}"/>
          </ac:spMkLst>
        </pc:spChg>
        <pc:spChg chg="add mod">
          <ac:chgData name="zhang hui" userId="7090c9456b8cb81b" providerId="LiveId" clId="{C7F17EC0-8BA4-4DB1-A5CC-F03E68D8F369}" dt="2020-06-20T05:54:16.549" v="1918" actId="1035"/>
          <ac:spMkLst>
            <pc:docMk/>
            <pc:sldMk cId="3638699392" sldId="324"/>
            <ac:spMk id="339" creationId="{9C2E7013-DDB8-480B-820E-C5EA0A2B0CBE}"/>
          </ac:spMkLst>
        </pc:spChg>
        <pc:spChg chg="add mod">
          <ac:chgData name="zhang hui" userId="7090c9456b8cb81b" providerId="LiveId" clId="{C7F17EC0-8BA4-4DB1-A5CC-F03E68D8F369}" dt="2020-06-20T05:53:13.111" v="1888" actId="553"/>
          <ac:spMkLst>
            <pc:docMk/>
            <pc:sldMk cId="3638699392" sldId="324"/>
            <ac:spMk id="340" creationId="{C32A596B-1D39-4DB8-A9C3-58EA658BEF2D}"/>
          </ac:spMkLst>
        </pc:s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13" creationId="{D61F4362-2463-4AF0-996F-4CC6B0972177}"/>
          </ac:grpSpMkLst>
        </pc:gr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14" creationId="{2C35C3DA-4CF3-4C91-9FE4-6B51F9A1BF7A}"/>
          </ac:grpSpMkLst>
        </pc:grpChg>
        <pc:grpChg chg="del mod topLvl">
          <ac:chgData name="zhang hui" userId="7090c9456b8cb81b" providerId="LiveId" clId="{C7F17EC0-8BA4-4DB1-A5CC-F03E68D8F369}" dt="2020-06-20T05:27:06.069" v="1103" actId="165"/>
          <ac:grpSpMkLst>
            <pc:docMk/>
            <pc:sldMk cId="3638699392" sldId="324"/>
            <ac:grpSpMk id="15" creationId="{B80A69C7-B8B2-43CF-B53C-6AD7D0164713}"/>
          </ac:grpSpMkLst>
        </pc:gr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16" creationId="{9F7AD944-6590-4C91-9663-E2B53BB8E1F5}"/>
          </ac:grpSpMkLst>
        </pc:gr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17" creationId="{0783093A-12ED-49AB-AFB6-F7D8F175D863}"/>
          </ac:grpSpMkLst>
        </pc:gr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31" creationId="{F72DEE0B-CE1D-41E2-A612-76F6B1B25F0D}"/>
          </ac:grpSpMkLst>
        </pc:grpChg>
        <pc:grpChg chg="del mod topLvl">
          <ac:chgData name="zhang hui" userId="7090c9456b8cb81b" providerId="LiveId" clId="{C7F17EC0-8BA4-4DB1-A5CC-F03E68D8F369}" dt="2020-06-20T05:26:42.683" v="1101" actId="165"/>
          <ac:grpSpMkLst>
            <pc:docMk/>
            <pc:sldMk cId="3638699392" sldId="324"/>
            <ac:grpSpMk id="32" creationId="{DA6D194B-0262-4162-B85F-0F126E8EF339}"/>
          </ac:grpSpMkLst>
        </pc:grpChg>
        <pc:grpChg chg="add del mod">
          <ac:chgData name="zhang hui" userId="7090c9456b8cb81b" providerId="LiveId" clId="{C7F17EC0-8BA4-4DB1-A5CC-F03E68D8F369}" dt="2020-06-20T05:26:08.270" v="1097" actId="165"/>
          <ac:grpSpMkLst>
            <pc:docMk/>
            <pc:sldMk cId="3638699392" sldId="324"/>
            <ac:grpSpMk id="33" creationId="{19F8BFC8-2715-4A07-B007-A9DB40710CFC}"/>
          </ac:grpSpMkLst>
        </pc:grpChg>
        <pc:grpChg chg="add del mod topLvl">
          <ac:chgData name="zhang hui" userId="7090c9456b8cb81b" providerId="LiveId" clId="{C7F17EC0-8BA4-4DB1-A5CC-F03E68D8F369}" dt="2020-06-20T05:23:22.418" v="1056" actId="165"/>
          <ac:grpSpMkLst>
            <pc:docMk/>
            <pc:sldMk cId="3638699392" sldId="324"/>
            <ac:grpSpMk id="34" creationId="{50750774-A6F4-434D-A555-C11F91084DA2}"/>
          </ac:grpSpMkLst>
        </pc:grpChg>
        <pc:grpChg chg="add 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36" creationId="{62214489-D996-47CC-BE17-86905981904E}"/>
          </ac:grpSpMkLst>
        </pc:grpChg>
        <pc:grpChg chg="add 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37" creationId="{18A37241-CCEA-4BFE-B8A9-204B395921A1}"/>
          </ac:grpSpMkLst>
        </pc:grpChg>
        <pc:grpChg chg="add del mod">
          <ac:chgData name="zhang hui" userId="7090c9456b8cb81b" providerId="LiveId" clId="{C7F17EC0-8BA4-4DB1-A5CC-F03E68D8F369}" dt="2020-06-20T05:23:11.686" v="1055" actId="165"/>
          <ac:grpSpMkLst>
            <pc:docMk/>
            <pc:sldMk cId="3638699392" sldId="324"/>
            <ac:grpSpMk id="38" creationId="{5B390DA2-A0E2-41F1-8A04-FC271126BABA}"/>
          </ac:grpSpMkLst>
        </pc:grpChg>
        <pc:grpChg chg="add 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53" creationId="{02D2B411-E85D-4D4F-B73F-B836A9776687}"/>
          </ac:grpSpMkLst>
        </pc:grpChg>
        <pc:grpChg chg="add del mod">
          <ac:chgData name="zhang hui" userId="7090c9456b8cb81b" providerId="LiveId" clId="{C7F17EC0-8BA4-4DB1-A5CC-F03E68D8F369}" dt="2020-06-20T05:35:45.888" v="1465" actId="165"/>
          <ac:grpSpMkLst>
            <pc:docMk/>
            <pc:sldMk cId="3638699392" sldId="324"/>
            <ac:grpSpMk id="65" creationId="{E50524CD-65FE-4D3F-AB33-9732A1E2F6AD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66" creationId="{8EEE9CAB-BD55-43CF-9ED6-D85B8ACC72F2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67" creationId="{1F55B711-A8B1-498B-87AF-EEFC7A859464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68" creationId="{036DD0A9-BBAB-48FE-A157-398328117F95}"/>
          </ac:grpSpMkLst>
        </pc:grpChg>
        <pc:grpChg chg="add del mod">
          <ac:chgData name="zhang hui" userId="7090c9456b8cb81b" providerId="LiveId" clId="{C7F17EC0-8BA4-4DB1-A5CC-F03E68D8F369}" dt="2020-06-20T05:35:45.888" v="1465" actId="165"/>
          <ac:grpSpMkLst>
            <pc:docMk/>
            <pc:sldMk cId="3638699392" sldId="324"/>
            <ac:grpSpMk id="69" creationId="{16A041E1-43BB-4F7C-98E4-D73387CF8105}"/>
          </ac:grpSpMkLst>
        </pc:grpChg>
        <pc:grpChg chg="add mod">
          <ac:chgData name="zhang hui" userId="7090c9456b8cb81b" providerId="LiveId" clId="{C7F17EC0-8BA4-4DB1-A5CC-F03E68D8F369}" dt="2020-06-20T05:35:29.720" v="1460" actId="164"/>
          <ac:grpSpMkLst>
            <pc:docMk/>
            <pc:sldMk cId="3638699392" sldId="324"/>
            <ac:grpSpMk id="70" creationId="{C017C1BE-2C40-4C96-A9CD-6D3640563418}"/>
          </ac:grpSpMkLst>
        </pc:grpChg>
        <pc:grpChg chg="add mod">
          <ac:chgData name="zhang hui" userId="7090c9456b8cb81b" providerId="LiveId" clId="{C7F17EC0-8BA4-4DB1-A5CC-F03E68D8F369}" dt="2020-06-20T05:35:29.392" v="1459" actId="164"/>
          <ac:grpSpMkLst>
            <pc:docMk/>
            <pc:sldMk cId="3638699392" sldId="324"/>
            <ac:grpSpMk id="71" creationId="{738D7527-CAD3-44A7-8FE0-BF2C57F1BF5B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72" creationId="{B654E344-A205-4FCB-8309-F0F03817B327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73" creationId="{3B784BFF-998A-4940-8EB0-1A3894C41C76}"/>
          </ac:grpSpMkLst>
        </pc:grpChg>
        <pc:grpChg chg="add del mod">
          <ac:chgData name="zhang hui" userId="7090c9456b8cb81b" providerId="LiveId" clId="{C7F17EC0-8BA4-4DB1-A5CC-F03E68D8F369}" dt="2020-06-20T05:38:24.538" v="1546" actId="165"/>
          <ac:grpSpMkLst>
            <pc:docMk/>
            <pc:sldMk cId="3638699392" sldId="324"/>
            <ac:grpSpMk id="75" creationId="{8ECAB3AB-050D-4C65-8630-1E2C9C052EB6}"/>
          </ac:grpSpMkLst>
        </pc:grpChg>
        <pc:grpChg chg="add mod">
          <ac:chgData name="zhang hui" userId="7090c9456b8cb81b" providerId="LiveId" clId="{C7F17EC0-8BA4-4DB1-A5CC-F03E68D8F369}" dt="2020-06-20T05:52:31.605" v="1864" actId="1038"/>
          <ac:grpSpMkLst>
            <pc:docMk/>
            <pc:sldMk cId="3638699392" sldId="324"/>
            <ac:grpSpMk id="76" creationId="{8D3A759E-7681-474F-B440-AAC241BEA55E}"/>
          </ac:grpSpMkLst>
        </pc:grpChg>
        <pc:grpChg chg="add del mod">
          <ac:chgData name="zhang hui" userId="7090c9456b8cb81b" providerId="LiveId" clId="{C7F17EC0-8BA4-4DB1-A5CC-F03E68D8F369}" dt="2020-06-20T05:53:53.960" v="1904" actId="165"/>
          <ac:grpSpMkLst>
            <pc:docMk/>
            <pc:sldMk cId="3638699392" sldId="324"/>
            <ac:grpSpMk id="77" creationId="{636A2E70-B085-47F9-8042-B5B662E2C4A7}"/>
          </ac:grpSpMkLst>
        </pc:grpChg>
        <pc:grpChg chg="add mod">
          <ac:chgData name="zhang hui" userId="7090c9456b8cb81b" providerId="LiveId" clId="{C7F17EC0-8BA4-4DB1-A5CC-F03E68D8F369}" dt="2020-06-20T05:54:09.301" v="1912" actId="1035"/>
          <ac:grpSpMkLst>
            <pc:docMk/>
            <pc:sldMk cId="3638699392" sldId="324"/>
            <ac:grpSpMk id="78" creationId="{35E02598-6EE5-4975-BD66-B4430C194237}"/>
          </ac:grpSpMkLst>
        </pc:grpChg>
        <pc:grpChg chg="add del mod">
          <ac:chgData name="zhang hui" userId="7090c9456b8cb81b" providerId="LiveId" clId="{C7F17EC0-8BA4-4DB1-A5CC-F03E68D8F369}" dt="2020-06-20T05:10:13.728" v="81" actId="165"/>
          <ac:grpSpMkLst>
            <pc:docMk/>
            <pc:sldMk cId="3638699392" sldId="324"/>
            <ac:grpSpMk id="123" creationId="{3335C24C-0EA3-4543-8678-A94CB23A9FCA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4" creationId="{78BB8968-2CA5-4AD8-B4B5-3A66245AAC0C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5" creationId="{B3D4D3ED-7B24-43D7-8BCD-A1FEA454C999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6" creationId="{18026A01-49A5-41AB-9D6A-DFAFB3FA3AB5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7" creationId="{D39A750C-FDC3-4CD4-91BC-D9B3F22E1686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8" creationId="{2FD80258-9FE4-4E3B-983B-B65046900413}"/>
          </ac:grpSpMkLst>
        </pc:grpChg>
        <pc:grpChg chg="del mod topLvl">
          <ac:chgData name="zhang hui" userId="7090c9456b8cb81b" providerId="LiveId" clId="{C7F17EC0-8BA4-4DB1-A5CC-F03E68D8F369}" dt="2020-06-20T05:19:55.996" v="938" actId="165"/>
          <ac:grpSpMkLst>
            <pc:docMk/>
            <pc:sldMk cId="3638699392" sldId="324"/>
            <ac:grpSpMk id="169" creationId="{F30CFCE2-2BED-43B2-9825-128D57026E39}"/>
          </ac:grpSpMkLst>
        </pc:grpChg>
        <pc:grpChg chg="del mod topLvl">
          <ac:chgData name="zhang hui" userId="7090c9456b8cb81b" providerId="LiveId" clId="{C7F17EC0-8BA4-4DB1-A5CC-F03E68D8F369}" dt="2020-06-20T05:22:06.374" v="1046" actId="165"/>
          <ac:grpSpMkLst>
            <pc:docMk/>
            <pc:sldMk cId="3638699392" sldId="324"/>
            <ac:grpSpMk id="277" creationId="{95379C18-298A-4DED-A937-DCEA67529E5D}"/>
          </ac:grpSpMkLst>
        </pc:grpChg>
        <pc:grpChg chg="add del mod">
          <ac:chgData name="zhang hui" userId="7090c9456b8cb81b" providerId="LiveId" clId="{C7F17EC0-8BA4-4DB1-A5CC-F03E68D8F369}" dt="2020-06-20T05:24:52.100" v="1075" actId="478"/>
          <ac:grpSpMkLst>
            <pc:docMk/>
            <pc:sldMk cId="3638699392" sldId="324"/>
            <ac:grpSpMk id="292" creationId="{9280733E-D107-4803-8F8C-BA5503C49003}"/>
          </ac:grpSpMkLst>
        </pc:grpChg>
        <pc:grpChg chg="mod topLvl">
          <ac:chgData name="zhang hui" userId="7090c9456b8cb81b" providerId="LiveId" clId="{C7F17EC0-8BA4-4DB1-A5CC-F03E68D8F369}" dt="2020-06-20T05:24:50.851" v="1074" actId="165"/>
          <ac:grpSpMkLst>
            <pc:docMk/>
            <pc:sldMk cId="3638699392" sldId="324"/>
            <ac:grpSpMk id="293" creationId="{80C5F164-76CA-4642-871E-DEFA054D1413}"/>
          </ac:grpSpMkLst>
        </pc:grpChg>
        <pc:grpChg chg="mod topLvl">
          <ac:chgData name="zhang hui" userId="7090c9456b8cb81b" providerId="LiveId" clId="{C7F17EC0-8BA4-4DB1-A5CC-F03E68D8F369}" dt="2020-06-20T05:24:50.851" v="1074" actId="165"/>
          <ac:grpSpMkLst>
            <pc:docMk/>
            <pc:sldMk cId="3638699392" sldId="324"/>
            <ac:grpSpMk id="294" creationId="{C0DFC300-1E7A-4C3C-AC0C-DB802568F284}"/>
          </ac:grpSpMkLst>
        </pc:grpChg>
        <pc:grpChg chg="mod topLvl">
          <ac:chgData name="zhang hui" userId="7090c9456b8cb81b" providerId="LiveId" clId="{C7F17EC0-8BA4-4DB1-A5CC-F03E68D8F369}" dt="2020-06-20T05:24:50.851" v="1074" actId="165"/>
          <ac:grpSpMkLst>
            <pc:docMk/>
            <pc:sldMk cId="3638699392" sldId="324"/>
            <ac:grpSpMk id="295" creationId="{C0DB252C-80D2-4BDC-8B6B-777440945F13}"/>
          </ac:grpSpMkLst>
        </pc:grpChg>
        <pc:grpChg chg="add del mod">
          <ac:chgData name="zhang hui" userId="7090c9456b8cb81b" providerId="LiveId" clId="{C7F17EC0-8BA4-4DB1-A5CC-F03E68D8F369}" dt="2020-06-20T05:35:45.888" v="1465" actId="165"/>
          <ac:grpSpMkLst>
            <pc:docMk/>
            <pc:sldMk cId="3638699392" sldId="324"/>
            <ac:grpSpMk id="312" creationId="{1B238B35-EBD4-4114-9985-D060B652F034}"/>
          </ac:grpSpMkLst>
        </pc:grpChg>
        <pc:grpChg chg="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313" creationId="{0456D5F2-237B-4B7B-AF48-35F2F88E7B21}"/>
          </ac:grpSpMkLst>
        </pc:grpChg>
        <pc:grpChg chg="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314" creationId="{5697D84E-D4B8-4E20-AAC3-320F2280F182}"/>
          </ac:grpSpMkLst>
        </pc:grpChg>
        <pc:grpChg chg="del mod topLvl">
          <ac:chgData name="zhang hui" userId="7090c9456b8cb81b" providerId="LiveId" clId="{C7F17EC0-8BA4-4DB1-A5CC-F03E68D8F369}" dt="2020-06-20T05:35:52.793" v="1466" actId="165"/>
          <ac:grpSpMkLst>
            <pc:docMk/>
            <pc:sldMk cId="3638699392" sldId="324"/>
            <ac:grpSpMk id="315" creationId="{D886FF78-A0CB-4FB9-9964-581B8FBCA6B1}"/>
          </ac:grpSpMkLst>
        </pc:grp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3" creationId="{AED05AAA-4043-48C9-A3CE-636CF81CCDA2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26" creationId="{8A781608-9265-461B-B5D1-0B9C81627C8B}"/>
          </ac:graphicFrameMkLst>
        </pc:graphicFrame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48" creationId="{F8A202D5-E664-40E7-958D-40383F50A9E2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117" creationId="{D8CA78C3-D147-4170-B082-45B8B57D76F9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134" creationId="{2666294E-E524-404E-AC45-BAD330729B37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170" creationId="{C17BAEE5-91FD-4674-8C1B-2118FCDD0B23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186" creationId="{C1FC6736-E311-4859-9A38-65EAC4DF0E00}"/>
          </ac:graphicFrameMkLst>
        </pc:graphicFrame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195" creationId="{C8C8E197-1F26-4396-BEA9-EF77B54015C1}"/>
          </ac:graphicFrameMkLst>
        </pc:graphicFrameChg>
        <pc:graphicFrameChg chg="mod topLvl">
          <ac:chgData name="zhang hui" userId="7090c9456b8cb81b" providerId="LiveId" clId="{C7F17EC0-8BA4-4DB1-A5CC-F03E68D8F369}" dt="2020-06-20T05:38:59.092" v="1615" actId="164"/>
          <ac:graphicFrameMkLst>
            <pc:docMk/>
            <pc:sldMk cId="3638699392" sldId="324"/>
            <ac:graphicFrameMk id="224" creationId="{EBF9BF84-E6B8-464A-9885-4857BBFB261D}"/>
          </ac:graphicFrameMkLst>
        </pc:graphicFrame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240" creationId="{79EB2B05-8E67-4E63-B320-0F327654307E}"/>
          </ac:graphicFrameMkLst>
        </pc:graphicFrame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257" creationId="{0E16BF54-A5EC-4AB2-ACFD-8A0CA633AEED}"/>
          </ac:graphicFrameMkLst>
        </pc:graphicFrameChg>
        <pc:graphicFrameChg chg="mod topLvl">
          <ac:chgData name="zhang hui" userId="7090c9456b8cb81b" providerId="LiveId" clId="{C7F17EC0-8BA4-4DB1-A5CC-F03E68D8F369}" dt="2020-06-20T05:53:53.960" v="1904" actId="165"/>
          <ac:graphicFrameMkLst>
            <pc:docMk/>
            <pc:sldMk cId="3638699392" sldId="324"/>
            <ac:graphicFrameMk id="278" creationId="{4DD80E40-45D4-4A98-87CB-9342C4750C69}"/>
          </ac:graphicFrameMkLst>
        </pc:graphicFrameChg>
      </pc:sldChg>
      <pc:sldChg chg="modSp del">
        <pc:chgData name="zhang hui" userId="7090c9456b8cb81b" providerId="LiveId" clId="{C7F17EC0-8BA4-4DB1-A5CC-F03E68D8F369}" dt="2020-06-20T05:57:05.806" v="1934" actId="47"/>
        <pc:sldMkLst>
          <pc:docMk/>
          <pc:sldMk cId="2230019978" sldId="325"/>
        </pc:sldMkLst>
        <pc:graphicFrameChg chg="mod">
          <ac:chgData name="zhang hui" userId="7090c9456b8cb81b" providerId="LiveId" clId="{C7F17EC0-8BA4-4DB1-A5CC-F03E68D8F369}" dt="2020-06-20T05:03:34.464" v="50"/>
          <ac:graphicFrameMkLst>
            <pc:docMk/>
            <pc:sldMk cId="2230019978" sldId="325"/>
            <ac:graphicFrameMk id="3" creationId="{AED05AAA-4043-48C9-A3CE-636CF81CCDA2}"/>
          </ac:graphicFrameMkLst>
        </pc:graphicFrameChg>
      </pc:sldChg>
      <pc:sldChg chg="del">
        <pc:chgData name="zhang hui" userId="7090c9456b8cb81b" providerId="LiveId" clId="{C7F17EC0-8BA4-4DB1-A5CC-F03E68D8F369}" dt="2020-06-20T06:49:22.835" v="4018" actId="47"/>
        <pc:sldMkLst>
          <pc:docMk/>
          <pc:sldMk cId="2558558483" sldId="326"/>
        </pc:sldMkLst>
      </pc:sldChg>
      <pc:sldChg chg="addSp delSp modSp add mod">
        <pc:chgData name="zhang hui" userId="7090c9456b8cb81b" providerId="LiveId" clId="{C7F17EC0-8BA4-4DB1-A5CC-F03E68D8F369}" dt="2020-06-20T06:50:01.137" v="4035" actId="1038"/>
        <pc:sldMkLst>
          <pc:docMk/>
          <pc:sldMk cId="3488352191" sldId="327"/>
        </pc:sldMkLst>
        <pc:spChg chg="mod">
          <ac:chgData name="zhang hui" userId="7090c9456b8cb81b" providerId="LiveId" clId="{C7F17EC0-8BA4-4DB1-A5CC-F03E68D8F369}" dt="2020-06-20T06:02:19.964" v="1943" actId="20577"/>
          <ac:spMkLst>
            <pc:docMk/>
            <pc:sldMk cId="3488352191" sldId="327"/>
            <ac:spMk id="4" creationId="{4900291D-F217-43FD-B286-8126D9852374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5" creationId="{9E6ADF14-CFC6-4302-A704-2BAE8BF6BDF1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6" creationId="{3C2E763E-FB19-48A5-92C0-6812AB2440A8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7" creationId="{1C01237B-4794-4059-BE08-2F09D014EF61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8" creationId="{D09D51D1-1755-435F-BEE2-3F163D100006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9" creationId="{2ADF9423-D8A7-4B70-B30A-3C73DDC2D2CF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0" creationId="{39187D34-7CE5-4560-B620-DA0A6F2C42AC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1" creationId="{B2AE81BF-6532-44FD-BE71-CE46C2E4F8C7}"/>
          </ac:spMkLst>
        </pc:spChg>
        <pc:spChg chg="mod">
          <ac:chgData name="zhang hui" userId="7090c9456b8cb81b" providerId="LiveId" clId="{C7F17EC0-8BA4-4DB1-A5CC-F03E68D8F369}" dt="2020-06-20T06:29:30.795" v="3272" actId="20577"/>
          <ac:spMkLst>
            <pc:docMk/>
            <pc:sldMk cId="3488352191" sldId="327"/>
            <ac:spMk id="12" creationId="{801025C7-659E-4467-84F0-AAD6E86D727D}"/>
          </ac:spMkLst>
        </pc:spChg>
        <pc:spChg chg="mod">
          <ac:chgData name="zhang hui" userId="7090c9456b8cb81b" providerId="LiveId" clId="{C7F17EC0-8BA4-4DB1-A5CC-F03E68D8F369}" dt="2020-06-20T06:12:32.660" v="2003" actId="20577"/>
          <ac:spMkLst>
            <pc:docMk/>
            <pc:sldMk cId="3488352191" sldId="327"/>
            <ac:spMk id="19" creationId="{60A3E181-428C-48E0-A0D5-2A1879958CBE}"/>
          </ac:spMkLst>
        </pc:spChg>
        <pc:spChg chg="mod">
          <ac:chgData name="zhang hui" userId="7090c9456b8cb81b" providerId="LiveId" clId="{C7F17EC0-8BA4-4DB1-A5CC-F03E68D8F369}" dt="2020-06-20T06:12:36.909" v="2006" actId="20577"/>
          <ac:spMkLst>
            <pc:docMk/>
            <pc:sldMk cId="3488352191" sldId="327"/>
            <ac:spMk id="20" creationId="{DE09725E-AC92-40E7-8D15-D6B36CAF69E8}"/>
          </ac:spMkLst>
        </pc:spChg>
        <pc:spChg chg="mod">
          <ac:chgData name="zhang hui" userId="7090c9456b8cb81b" providerId="LiveId" clId="{C7F17EC0-8BA4-4DB1-A5CC-F03E68D8F369}" dt="2020-06-20T06:12:41.658" v="2011" actId="20577"/>
          <ac:spMkLst>
            <pc:docMk/>
            <pc:sldMk cId="3488352191" sldId="327"/>
            <ac:spMk id="21" creationId="{3AF75B3B-FF90-43B3-8E3E-58935F62C763}"/>
          </ac:spMkLst>
        </pc:spChg>
        <pc:spChg chg="mod topLvl">
          <ac:chgData name="zhang hui" userId="7090c9456b8cb81b" providerId="LiveId" clId="{C7F17EC0-8BA4-4DB1-A5CC-F03E68D8F369}" dt="2020-06-20T06:30:19.128" v="3309" actId="20577"/>
          <ac:spMkLst>
            <pc:docMk/>
            <pc:sldMk cId="3488352191" sldId="327"/>
            <ac:spMk id="25" creationId="{A5AAC7E9-D750-4782-A264-3D94BE0047E0}"/>
          </ac:spMkLst>
        </pc:spChg>
        <pc:spChg chg="del mod topLvl">
          <ac:chgData name="zhang hui" userId="7090c9456b8cb81b" providerId="LiveId" clId="{C7F17EC0-8BA4-4DB1-A5CC-F03E68D8F369}" dt="2020-06-20T06:36:20.474" v="3540" actId="478"/>
          <ac:spMkLst>
            <pc:docMk/>
            <pc:sldMk cId="3488352191" sldId="327"/>
            <ac:spMk id="27" creationId="{B22BB598-29D3-4BFB-B500-9968D3D9E853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8" creationId="{5F5D79F2-5FAB-43B0-A8DA-A23C9AA81349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9" creationId="{8ECD8A69-AE2D-4D66-9047-0B82B3FF5E2C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30" creationId="{446F45E7-4D53-4C88-8FFA-C70C08348F5E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5" creationId="{69EA84AF-7D47-4B5B-B0B1-B9D1CFA92B91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9" creationId="{0C9B4740-26C1-47AE-975E-5CB4D721E038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40" creationId="{75BF59F8-0E90-4B18-BEA1-668070E955F7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41" creationId="{38EF02AE-0776-411F-82DA-F0F841ED64F1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49" creationId="{C13A9BB4-A6AF-49A3-B83A-A796A7716F3C}"/>
          </ac:spMkLst>
        </pc:spChg>
        <pc:spChg chg="add del">
          <ac:chgData name="zhang hui" userId="7090c9456b8cb81b" providerId="LiveId" clId="{C7F17EC0-8BA4-4DB1-A5CC-F03E68D8F369}" dt="2020-06-20T06:36:08.696" v="3538" actId="478"/>
          <ac:spMkLst>
            <pc:docMk/>
            <pc:sldMk cId="3488352191" sldId="327"/>
            <ac:spMk id="50" creationId="{844F9B03-397B-4F23-8895-794B2A24297E}"/>
          </ac:spMkLst>
        </pc:spChg>
        <pc:spChg chg="add del">
          <ac:chgData name="zhang hui" userId="7090c9456b8cb81b" providerId="LiveId" clId="{C7F17EC0-8BA4-4DB1-A5CC-F03E68D8F369}" dt="2020-06-20T06:36:08.696" v="3538" actId="478"/>
          <ac:spMkLst>
            <pc:docMk/>
            <pc:sldMk cId="3488352191" sldId="327"/>
            <ac:spMk id="51" creationId="{8A0AC62B-8A44-49FC-8969-DF3D70988F47}"/>
          </ac:spMkLst>
        </pc:spChg>
        <pc:spChg chg="add del">
          <ac:chgData name="zhang hui" userId="7090c9456b8cb81b" providerId="LiveId" clId="{C7F17EC0-8BA4-4DB1-A5CC-F03E68D8F369}" dt="2020-06-20T06:36:08.696" v="3538" actId="478"/>
          <ac:spMkLst>
            <pc:docMk/>
            <pc:sldMk cId="3488352191" sldId="327"/>
            <ac:spMk id="52" creationId="{FF24ECCE-44A3-4196-BE3C-F203FAC7A270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54" creationId="{14DAE79E-B57A-47C3-9E80-392F6B6B38DD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55" creationId="{3A1940AF-860D-457F-B40D-3ADEB1DFFDC7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56" creationId="{50A072DC-60C8-4675-B993-AC865975016C}"/>
          </ac:spMkLst>
        </pc:spChg>
        <pc:spChg chg="mod">
          <ac:chgData name="zhang hui" userId="7090c9456b8cb81b" providerId="LiveId" clId="{C7F17EC0-8BA4-4DB1-A5CC-F03E68D8F369}" dt="2020-06-20T06:29:36.888" v="3278" actId="20577"/>
          <ac:spMkLst>
            <pc:docMk/>
            <pc:sldMk cId="3488352191" sldId="327"/>
            <ac:spMk id="57" creationId="{9A710CCC-856D-4134-B0AB-09B76A5D0F6D}"/>
          </ac:spMkLst>
        </pc:spChg>
        <pc:spChg chg="mod">
          <ac:chgData name="zhang hui" userId="7090c9456b8cb81b" providerId="LiveId" clId="{C7F17EC0-8BA4-4DB1-A5CC-F03E68D8F369}" dt="2020-06-20T06:12:44.532" v="2015" actId="20577"/>
          <ac:spMkLst>
            <pc:docMk/>
            <pc:sldMk cId="3488352191" sldId="327"/>
            <ac:spMk id="59" creationId="{0F6D5153-1D43-40BE-AFD4-5C0E946A330B}"/>
          </ac:spMkLst>
        </pc:spChg>
        <pc:spChg chg="mod">
          <ac:chgData name="zhang hui" userId="7090c9456b8cb81b" providerId="LiveId" clId="{C7F17EC0-8BA4-4DB1-A5CC-F03E68D8F369}" dt="2020-06-20T06:12:48.359" v="2018" actId="20577"/>
          <ac:spMkLst>
            <pc:docMk/>
            <pc:sldMk cId="3488352191" sldId="327"/>
            <ac:spMk id="60" creationId="{9D62C36B-8123-427D-846B-24CFDEF554B2}"/>
          </ac:spMkLst>
        </pc:spChg>
        <pc:spChg chg="mod">
          <ac:chgData name="zhang hui" userId="7090c9456b8cb81b" providerId="LiveId" clId="{C7F17EC0-8BA4-4DB1-A5CC-F03E68D8F369}" dt="2020-06-20T06:12:51.796" v="2021" actId="20577"/>
          <ac:spMkLst>
            <pc:docMk/>
            <pc:sldMk cId="3488352191" sldId="327"/>
            <ac:spMk id="61" creationId="{D950F2C6-5C8F-4C74-92A5-388560C71809}"/>
          </ac:spMkLst>
        </pc:spChg>
        <pc:spChg chg="mod">
          <ac:chgData name="zhang hui" userId="7090c9456b8cb81b" providerId="LiveId" clId="{C7F17EC0-8BA4-4DB1-A5CC-F03E68D8F369}" dt="2020-06-20T06:29:23.609" v="3266" actId="20577"/>
          <ac:spMkLst>
            <pc:docMk/>
            <pc:sldMk cId="3488352191" sldId="327"/>
            <ac:spMk id="74" creationId="{AE58F1DA-4647-4EF9-B8DF-AE4755A9F138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13" creationId="{F0126EBF-B1D9-4077-8C52-6271E565C117}"/>
          </ac:spMkLst>
        </pc:spChg>
        <pc:spChg chg="add del">
          <ac:chgData name="zhang hui" userId="7090c9456b8cb81b" providerId="LiveId" clId="{C7F17EC0-8BA4-4DB1-A5CC-F03E68D8F369}" dt="2020-06-20T06:36:08.696" v="3538" actId="478"/>
          <ac:spMkLst>
            <pc:docMk/>
            <pc:sldMk cId="3488352191" sldId="327"/>
            <ac:spMk id="114" creationId="{DE4DE78B-AD62-4AFF-9F50-D361E728494B}"/>
          </ac:spMkLst>
        </pc:spChg>
        <pc:spChg chg="del mod topLvl">
          <ac:chgData name="zhang hui" userId="7090c9456b8cb81b" providerId="LiveId" clId="{C7F17EC0-8BA4-4DB1-A5CC-F03E68D8F369}" dt="2020-06-20T06:36:24.176" v="3541" actId="478"/>
          <ac:spMkLst>
            <pc:docMk/>
            <pc:sldMk cId="3488352191" sldId="327"/>
            <ac:spMk id="115" creationId="{478E105F-05F0-4E24-A87D-092FA0086C94}"/>
          </ac:spMkLst>
        </pc:spChg>
        <pc:spChg chg="mod topLvl">
          <ac:chgData name="zhang hui" userId="7090c9456b8cb81b" providerId="LiveId" clId="{C7F17EC0-8BA4-4DB1-A5CC-F03E68D8F369}" dt="2020-06-20T06:30:26.580" v="3316" actId="20577"/>
          <ac:spMkLst>
            <pc:docMk/>
            <pc:sldMk cId="3488352191" sldId="327"/>
            <ac:spMk id="116" creationId="{E20CCC44-CC82-4B5B-81A8-5435CBDF9B38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19" creationId="{F8527CCF-3FDC-4FDF-B4D0-41FD4AC3778E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20" creationId="{B1B0A048-A56C-4979-8DBB-A00C7F60E133}"/>
          </ac:spMkLst>
        </pc:spChg>
        <pc:spChg chg="add del 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21" creationId="{72A792BD-D32D-44DA-B44C-6B165E42B274}"/>
          </ac:spMkLst>
        </pc:spChg>
        <pc:spChg chg="mod">
          <ac:chgData name="zhang hui" userId="7090c9456b8cb81b" providerId="LiveId" clId="{C7F17EC0-8BA4-4DB1-A5CC-F03E68D8F369}" dt="2020-06-20T06:47:04.196" v="4016" actId="1038"/>
          <ac:spMkLst>
            <pc:docMk/>
            <pc:sldMk cId="3488352191" sldId="327"/>
            <ac:spMk id="124" creationId="{4952997E-FA68-4F10-B963-F8F8F7DCD6AE}"/>
          </ac:spMkLst>
        </pc:spChg>
        <pc:spChg chg="del mod topLvl">
          <ac:chgData name="zhang hui" userId="7090c9456b8cb81b" providerId="LiveId" clId="{C7F17EC0-8BA4-4DB1-A5CC-F03E68D8F369}" dt="2020-06-20T06:36:24.176" v="3541" actId="478"/>
          <ac:spMkLst>
            <pc:docMk/>
            <pc:sldMk cId="3488352191" sldId="327"/>
            <ac:spMk id="125" creationId="{FE00DB91-7B76-42FB-A892-470814BEEF3A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26" creationId="{E9FA394B-D960-4D60-8715-13F2AD4BE423}"/>
          </ac:spMkLst>
        </pc:spChg>
        <pc:spChg chg="mod">
          <ac:chgData name="zhang hui" userId="7090c9456b8cb81b" providerId="LiveId" clId="{C7F17EC0-8BA4-4DB1-A5CC-F03E68D8F369}" dt="2020-06-20T06:29:43.495" v="3284" actId="20577"/>
          <ac:spMkLst>
            <pc:docMk/>
            <pc:sldMk cId="3488352191" sldId="327"/>
            <ac:spMk id="127" creationId="{4CEE4A0A-0DAA-4E73-8508-6D5C4ED0BB88}"/>
          </ac:spMkLst>
        </pc:spChg>
        <pc:spChg chg="mod topLvl">
          <ac:chgData name="zhang hui" userId="7090c9456b8cb81b" providerId="LiveId" clId="{C7F17EC0-8BA4-4DB1-A5CC-F03E68D8F369}" dt="2020-06-20T06:30:33.938" v="3320" actId="20577"/>
          <ac:spMkLst>
            <pc:docMk/>
            <pc:sldMk cId="3488352191" sldId="327"/>
            <ac:spMk id="128" creationId="{24ABFBC6-5F9B-4968-BC06-2A2A501A1305}"/>
          </ac:spMkLst>
        </pc:spChg>
        <pc:spChg chg="mod topLvl">
          <ac:chgData name="zhang hui" userId="7090c9456b8cb81b" providerId="LiveId" clId="{C7F17EC0-8BA4-4DB1-A5CC-F03E68D8F369}" dt="2020-06-20T06:47:04.196" v="4016" actId="1038"/>
          <ac:spMkLst>
            <pc:docMk/>
            <pc:sldMk cId="3488352191" sldId="327"/>
            <ac:spMk id="129" creationId="{17239443-8189-46D3-A2A7-B954D6D6198E}"/>
          </ac:spMkLst>
        </pc:spChg>
        <pc:spChg chg="del mod topLvl">
          <ac:chgData name="zhang hui" userId="7090c9456b8cb81b" providerId="LiveId" clId="{C7F17EC0-8BA4-4DB1-A5CC-F03E68D8F369}" dt="2020-06-20T06:36:24.176" v="3541" actId="478"/>
          <ac:spMkLst>
            <pc:docMk/>
            <pc:sldMk cId="3488352191" sldId="327"/>
            <ac:spMk id="130" creationId="{BEDB7AF7-E658-43A2-998B-1E58FE814FA1}"/>
          </ac:spMkLst>
        </pc:spChg>
        <pc:spChg chg="del mod topLvl">
          <ac:chgData name="zhang hui" userId="7090c9456b8cb81b" providerId="LiveId" clId="{C7F17EC0-8BA4-4DB1-A5CC-F03E68D8F369}" dt="2020-06-20T06:36:24.176" v="3541" actId="478"/>
          <ac:spMkLst>
            <pc:docMk/>
            <pc:sldMk cId="3488352191" sldId="327"/>
            <ac:spMk id="131" creationId="{50E28BF3-7A7B-4FDC-9E9E-210B5818653E}"/>
          </ac:spMkLst>
        </pc:spChg>
        <pc:spChg chg="del mod topLvl">
          <ac:chgData name="zhang hui" userId="7090c9456b8cb81b" providerId="LiveId" clId="{C7F17EC0-8BA4-4DB1-A5CC-F03E68D8F369}" dt="2020-06-20T06:36:24.176" v="3541" actId="478"/>
          <ac:spMkLst>
            <pc:docMk/>
            <pc:sldMk cId="3488352191" sldId="327"/>
            <ac:spMk id="132" creationId="{5DDC654E-43D0-4AA8-9293-F45476F1D2B7}"/>
          </ac:spMkLst>
        </pc:spChg>
        <pc:spChg chg="mod topLvl">
          <ac:chgData name="zhang hui" userId="7090c9456b8cb81b" providerId="LiveId" clId="{C7F17EC0-8BA4-4DB1-A5CC-F03E68D8F369}" dt="2020-06-20T06:30:12.693" v="3305" actId="20577"/>
          <ac:spMkLst>
            <pc:docMk/>
            <pc:sldMk cId="3488352191" sldId="327"/>
            <ac:spMk id="133" creationId="{36C69FE5-6C4C-4676-B6E0-F1D9D2099D0F}"/>
          </ac:spMkLst>
        </pc:spChg>
        <pc:spChg chg="del mod topLvl">
          <ac:chgData name="zhang hui" userId="7090c9456b8cb81b" providerId="LiveId" clId="{C7F17EC0-8BA4-4DB1-A5CC-F03E68D8F369}" dt="2020-06-20T06:36:16.522" v="3539" actId="478"/>
          <ac:spMkLst>
            <pc:docMk/>
            <pc:sldMk cId="3488352191" sldId="327"/>
            <ac:spMk id="135" creationId="{2B47C82B-6961-46ED-B8D3-476519E432D6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36" creationId="{B7A09CF5-3A24-43DB-99E6-E0394A3AC952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37" creationId="{593AAA15-011C-463D-9FA1-491F4E4635D4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38" creationId="{542ED6E7-32B6-486C-8B6D-0896ACCA0BD8}"/>
          </ac:spMkLst>
        </pc:spChg>
        <pc:spChg chg="del mod topLvl">
          <ac:chgData name="zhang hui" userId="7090c9456b8cb81b" providerId="LiveId" clId="{C7F17EC0-8BA4-4DB1-A5CC-F03E68D8F369}" dt="2020-06-20T06:36:16.522" v="3539" actId="478"/>
          <ac:spMkLst>
            <pc:docMk/>
            <pc:sldMk cId="3488352191" sldId="327"/>
            <ac:spMk id="139" creationId="{985E93BD-0B16-41FD-ACBE-7C8A06F6DC18}"/>
          </ac:spMkLst>
        </pc:spChg>
        <pc:spChg chg="del mod topLvl">
          <ac:chgData name="zhang hui" userId="7090c9456b8cb81b" providerId="LiveId" clId="{C7F17EC0-8BA4-4DB1-A5CC-F03E68D8F369}" dt="2020-06-20T06:36:16.522" v="3539" actId="478"/>
          <ac:spMkLst>
            <pc:docMk/>
            <pc:sldMk cId="3488352191" sldId="327"/>
            <ac:spMk id="140" creationId="{798F65D6-F6E8-4E21-A269-9213946E1FD7}"/>
          </ac:spMkLst>
        </pc:spChg>
        <pc:spChg chg="del mod topLvl">
          <ac:chgData name="zhang hui" userId="7090c9456b8cb81b" providerId="LiveId" clId="{C7F17EC0-8BA4-4DB1-A5CC-F03E68D8F369}" dt="2020-06-20T06:36:16.522" v="3539" actId="478"/>
          <ac:spMkLst>
            <pc:docMk/>
            <pc:sldMk cId="3488352191" sldId="327"/>
            <ac:spMk id="141" creationId="{272E328E-556E-431A-BA71-1DA119459BEB}"/>
          </ac:spMkLst>
        </pc:spChg>
        <pc:spChg chg="del mod topLvl">
          <ac:chgData name="zhang hui" userId="7090c9456b8cb81b" providerId="LiveId" clId="{C7F17EC0-8BA4-4DB1-A5CC-F03E68D8F369}" dt="2020-06-20T06:36:16.522" v="3539" actId="478"/>
          <ac:spMkLst>
            <pc:docMk/>
            <pc:sldMk cId="3488352191" sldId="327"/>
            <ac:spMk id="142" creationId="{7D37804F-A3E2-4EA5-B579-43583EA9EC35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43" creationId="{B2AE6002-D453-45E9-BF65-BDDDB6392049}"/>
          </ac:spMkLst>
        </pc:spChg>
        <pc:spChg chg="mod">
          <ac:chgData name="zhang hui" userId="7090c9456b8cb81b" providerId="LiveId" clId="{C7F17EC0-8BA4-4DB1-A5CC-F03E68D8F369}" dt="2020-06-20T06:29:54.337" v="3294" actId="20577"/>
          <ac:spMkLst>
            <pc:docMk/>
            <pc:sldMk cId="3488352191" sldId="327"/>
            <ac:spMk id="144" creationId="{5A5D5747-76DE-4011-AC2C-EB0C2EAF4A45}"/>
          </ac:spMkLst>
        </pc:spChg>
        <pc:spChg chg="mod">
          <ac:chgData name="zhang hui" userId="7090c9456b8cb81b" providerId="LiveId" clId="{C7F17EC0-8BA4-4DB1-A5CC-F03E68D8F369}" dt="2020-06-20T06:30:02.086" v="3298" actId="20577"/>
          <ac:spMkLst>
            <pc:docMk/>
            <pc:sldMk cId="3488352191" sldId="327"/>
            <ac:spMk id="145" creationId="{D2BB7028-23BA-4A48-BBDC-CE3748A962AC}"/>
          </ac:spMkLst>
        </pc:spChg>
        <pc:spChg chg="mod topLvl">
          <ac:chgData name="zhang hui" userId="7090c9456b8cb81b" providerId="LiveId" clId="{C7F17EC0-8BA4-4DB1-A5CC-F03E68D8F369}" dt="2020-06-20T06:30:41.342" v="3327" actId="20577"/>
          <ac:spMkLst>
            <pc:docMk/>
            <pc:sldMk cId="3488352191" sldId="327"/>
            <ac:spMk id="146" creationId="{13ECCEB0-827C-43E2-A290-EC756BB08770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147" creationId="{7BDE182E-582F-4A00-AD8B-C5656BE04AC1}"/>
          </ac:spMkLst>
        </pc:spChg>
        <pc:spChg chg="mod topLvl">
          <ac:chgData name="zhang hui" userId="7090c9456b8cb81b" providerId="LiveId" clId="{C7F17EC0-8BA4-4DB1-A5CC-F03E68D8F369}" dt="2020-06-20T06:13:30.974" v="2039" actId="20577"/>
          <ac:spMkLst>
            <pc:docMk/>
            <pc:sldMk cId="3488352191" sldId="327"/>
            <ac:spMk id="148" creationId="{8A828AEB-CCBD-48E2-B31F-F667B5DEFC63}"/>
          </ac:spMkLst>
        </pc:spChg>
        <pc:spChg chg="mod topLvl">
          <ac:chgData name="zhang hui" userId="7090c9456b8cb81b" providerId="LiveId" clId="{C7F17EC0-8BA4-4DB1-A5CC-F03E68D8F369}" dt="2020-06-20T06:13:35.051" v="2044" actId="20577"/>
          <ac:spMkLst>
            <pc:docMk/>
            <pc:sldMk cId="3488352191" sldId="327"/>
            <ac:spMk id="149" creationId="{EE35C927-060B-4445-A4E0-21977221071A}"/>
          </ac:spMkLst>
        </pc:spChg>
        <pc:spChg chg="del">
          <ac:chgData name="zhang hui" userId="7090c9456b8cb81b" providerId="LiveId" clId="{C7F17EC0-8BA4-4DB1-A5CC-F03E68D8F369}" dt="2020-06-20T06:35:49.200" v="3533" actId="478"/>
          <ac:spMkLst>
            <pc:docMk/>
            <pc:sldMk cId="3488352191" sldId="327"/>
            <ac:spMk id="150" creationId="{D909FD86-B0B4-4D9C-900E-D4F244178DA6}"/>
          </ac:spMkLst>
        </pc:spChg>
        <pc:spChg chg="del mod topLvl">
          <ac:chgData name="zhang hui" userId="7090c9456b8cb81b" providerId="LiveId" clId="{C7F17EC0-8BA4-4DB1-A5CC-F03E68D8F369}" dt="2020-06-20T06:36:20.474" v="3540" actId="478"/>
          <ac:spMkLst>
            <pc:docMk/>
            <pc:sldMk cId="3488352191" sldId="327"/>
            <ac:spMk id="151" creationId="{E17AB36A-3070-48B7-BC73-1963A6C29A7B}"/>
          </ac:spMkLst>
        </pc:spChg>
        <pc:spChg chg="del mod topLvl">
          <ac:chgData name="zhang hui" userId="7090c9456b8cb81b" providerId="LiveId" clId="{C7F17EC0-8BA4-4DB1-A5CC-F03E68D8F369}" dt="2020-06-20T06:36:20.474" v="3540" actId="478"/>
          <ac:spMkLst>
            <pc:docMk/>
            <pc:sldMk cId="3488352191" sldId="327"/>
            <ac:spMk id="152" creationId="{19B4FE6A-CC83-4B0E-ACA1-C656061B062C}"/>
          </ac:spMkLst>
        </pc:spChg>
        <pc:spChg chg="del mod topLvl">
          <ac:chgData name="zhang hui" userId="7090c9456b8cb81b" providerId="LiveId" clId="{C7F17EC0-8BA4-4DB1-A5CC-F03E68D8F369}" dt="2020-06-20T06:36:20.474" v="3540" actId="478"/>
          <ac:spMkLst>
            <pc:docMk/>
            <pc:sldMk cId="3488352191" sldId="327"/>
            <ac:spMk id="153" creationId="{02A56EB2-0362-44E1-A94C-766C8C47A122}"/>
          </ac:spMkLst>
        </pc:spChg>
        <pc:spChg chg="del mod topLvl">
          <ac:chgData name="zhang hui" userId="7090c9456b8cb81b" providerId="LiveId" clId="{C7F17EC0-8BA4-4DB1-A5CC-F03E68D8F369}" dt="2020-06-20T06:36:20.474" v="3540" actId="478"/>
          <ac:spMkLst>
            <pc:docMk/>
            <pc:sldMk cId="3488352191" sldId="327"/>
            <ac:spMk id="154" creationId="{5E93BCE3-C921-4770-AED1-BF3BCCDF7080}"/>
          </ac:spMkLst>
        </pc:spChg>
        <pc:spChg chg="add del">
          <ac:chgData name="zhang hui" userId="7090c9456b8cb81b" providerId="LiveId" clId="{C7F17EC0-8BA4-4DB1-A5CC-F03E68D8F369}" dt="2020-06-20T06:36:08.696" v="3538" actId="478"/>
          <ac:spMkLst>
            <pc:docMk/>
            <pc:sldMk cId="3488352191" sldId="327"/>
            <ac:spMk id="155" creationId="{E2AECB52-134F-420B-B932-C30E20CB716E}"/>
          </ac:spMkLst>
        </pc:spChg>
        <pc:spChg chg="mod topLvl">
          <ac:chgData name="zhang hui" userId="7090c9456b8cb81b" providerId="LiveId" clId="{C7F17EC0-8BA4-4DB1-A5CC-F03E68D8F369}" dt="2020-06-20T06:13:39.394" v="2049" actId="20577"/>
          <ac:spMkLst>
            <pc:docMk/>
            <pc:sldMk cId="3488352191" sldId="327"/>
            <ac:spMk id="156" creationId="{D85DFF24-FCD6-410C-994F-55520B4CC009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57" creationId="{AC69828E-BDFA-43FE-A79E-7ACEA0C32176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58" creationId="{7D3A46FE-0964-4C3E-885B-0688E591C5B9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159" creationId="{DA679184-D13F-4A57-8717-CCB4C3A1E63E}"/>
          </ac:spMkLst>
        </pc:spChg>
        <pc:spChg chg="mod topLvl">
          <ac:chgData name="zhang hui" userId="7090c9456b8cb81b" providerId="LiveId" clId="{C7F17EC0-8BA4-4DB1-A5CC-F03E68D8F369}" dt="2020-06-20T06:13:19.976" v="2026" actId="20577"/>
          <ac:spMkLst>
            <pc:docMk/>
            <pc:sldMk cId="3488352191" sldId="327"/>
            <ac:spMk id="160" creationId="{89D573D1-8EC5-4ECF-90F3-D83E9F6F2875}"/>
          </ac:spMkLst>
        </pc:spChg>
        <pc:spChg chg="mod topLvl">
          <ac:chgData name="zhang hui" userId="7090c9456b8cb81b" providerId="LiveId" clId="{C7F17EC0-8BA4-4DB1-A5CC-F03E68D8F369}" dt="2020-06-20T06:13:24.163" v="2031" actId="20577"/>
          <ac:spMkLst>
            <pc:docMk/>
            <pc:sldMk cId="3488352191" sldId="327"/>
            <ac:spMk id="161" creationId="{E1A0162B-04C7-42D7-8371-16CAC2B0EE52}"/>
          </ac:spMkLst>
        </pc:spChg>
        <pc:spChg chg="mod topLvl">
          <ac:chgData name="zhang hui" userId="7090c9456b8cb81b" providerId="LiveId" clId="{C7F17EC0-8BA4-4DB1-A5CC-F03E68D8F369}" dt="2020-06-20T06:13:27.771" v="2036" actId="20577"/>
          <ac:spMkLst>
            <pc:docMk/>
            <pc:sldMk cId="3488352191" sldId="327"/>
            <ac:spMk id="162" creationId="{92F45C4A-33D0-472B-8143-C658682206AB}"/>
          </ac:spMkLst>
        </pc:spChg>
        <pc:spChg chg="mod topLvl">
          <ac:chgData name="zhang hui" userId="7090c9456b8cb81b" providerId="LiveId" clId="{C7F17EC0-8BA4-4DB1-A5CC-F03E68D8F369}" dt="2020-06-20T06:31:07.242" v="3339" actId="20577"/>
          <ac:spMkLst>
            <pc:docMk/>
            <pc:sldMk cId="3488352191" sldId="327"/>
            <ac:spMk id="163" creationId="{3C9FDFC0-6928-434A-86D0-389148E0066A}"/>
          </ac:spMkLst>
        </pc:spChg>
        <pc:spChg chg="del mod topLvl">
          <ac:chgData name="zhang hui" userId="7090c9456b8cb81b" providerId="LiveId" clId="{C7F17EC0-8BA4-4DB1-A5CC-F03E68D8F369}" dt="2020-06-20T06:44:51.602" v="3913" actId="478"/>
          <ac:spMkLst>
            <pc:docMk/>
            <pc:sldMk cId="3488352191" sldId="327"/>
            <ac:spMk id="171" creationId="{ADBD22EA-0159-4BC9-BDED-AB51AA15B845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72" creationId="{2955941A-094A-4720-AEA9-1E54D1C8A7E6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73" creationId="{E6D62E16-29D7-42F7-84DB-2DBFE6D47152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74" creationId="{32BA7F46-CE29-4DFF-BD9B-0EB3A6CE4B29}"/>
          </ac:spMkLst>
        </pc:spChg>
        <pc:spChg chg="del mod topLvl">
          <ac:chgData name="zhang hui" userId="7090c9456b8cb81b" providerId="LiveId" clId="{C7F17EC0-8BA4-4DB1-A5CC-F03E68D8F369}" dt="2020-06-20T06:44:51.602" v="3913" actId="478"/>
          <ac:spMkLst>
            <pc:docMk/>
            <pc:sldMk cId="3488352191" sldId="327"/>
            <ac:spMk id="175" creationId="{61B3237D-FA05-4FB8-8012-89453ACF6B35}"/>
          </ac:spMkLst>
        </pc:spChg>
        <pc:spChg chg="del mod topLvl">
          <ac:chgData name="zhang hui" userId="7090c9456b8cb81b" providerId="LiveId" clId="{C7F17EC0-8BA4-4DB1-A5CC-F03E68D8F369}" dt="2020-06-20T06:44:51.602" v="3913" actId="478"/>
          <ac:spMkLst>
            <pc:docMk/>
            <pc:sldMk cId="3488352191" sldId="327"/>
            <ac:spMk id="176" creationId="{07282008-52B3-4E5A-8F85-AD3A81B042FD}"/>
          </ac:spMkLst>
        </pc:spChg>
        <pc:spChg chg="del mod topLvl">
          <ac:chgData name="zhang hui" userId="7090c9456b8cb81b" providerId="LiveId" clId="{C7F17EC0-8BA4-4DB1-A5CC-F03E68D8F369}" dt="2020-06-20T06:44:51.602" v="3913" actId="478"/>
          <ac:spMkLst>
            <pc:docMk/>
            <pc:sldMk cId="3488352191" sldId="327"/>
            <ac:spMk id="178" creationId="{0A59919D-2E8F-4AD7-AD61-6F4EFF8E14E8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79" creationId="{54B6C4AF-B68F-4E63-8A81-4679DB46C74C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0" creationId="{58C999AF-C62F-4EF2-B8D9-9E12E7DFB6CD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1" creationId="{0608FE65-EDE6-4828-9FBC-40CA21176276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2" creationId="{0CD1F52C-2C99-4600-AF1E-E0557CFD6ABC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3" creationId="{01262261-7252-4EEA-B45C-C566C401597F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4" creationId="{24C99CAE-4C36-4E1C-A1EC-B82B469EB742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85" creationId="{63A8FC40-519D-4AB4-A241-226947FC3C6A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87" creationId="{99FFCBDC-3487-4C45-A188-5C28B6C972E8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88" creationId="{A4D3C8C4-C544-42D2-B397-44AA3CD3E7CE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189" creationId="{7139A97C-82A9-4742-B3FE-AD27C8D7EFD3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90" creationId="{A60DDC82-2E00-4350-9F6A-DB60381F9F71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91" creationId="{A479D848-3030-4A20-84D2-27619C1045D3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92" creationId="{D75CDE43-CEBC-46EA-842A-84C1A84CA159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193" creationId="{5A77B359-CF9E-416A-AA05-74B80A7C951C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194" creationId="{E4212E7C-FD75-490E-8064-5E9F409DE92D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196" creationId="{2F3A0104-099F-4F9C-A5D6-864FA99A5033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197" creationId="{9DEC4FB8-7779-4E27-B27E-9C6B18AC9C55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198" creationId="{93CAEB62-C434-486B-8544-17134CC38570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199" creationId="{043DA878-1B59-41EB-8A4F-7DEBFF055A50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200" creationId="{0E637E2B-9269-4019-8B6B-828658F0D126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01" creationId="{F15A511B-4F84-41A5-B507-C1D01E750EFC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02" creationId="{A69E9275-7638-40E9-A354-EF08DA1F46E7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03" creationId="{182082F9-DF62-4970-B26A-664FDA545862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204" creationId="{E99330C1-5902-4173-9AB3-ACC57B071AF0}"/>
          </ac:spMkLst>
        </pc:spChg>
        <pc:spChg chg="mod">
          <ac:chgData name="zhang hui" userId="7090c9456b8cb81b" providerId="LiveId" clId="{C7F17EC0-8BA4-4DB1-A5CC-F03E68D8F369}" dt="2020-06-20T06:11:58.183" v="1980" actId="20577"/>
          <ac:spMkLst>
            <pc:docMk/>
            <pc:sldMk cId="3488352191" sldId="327"/>
            <ac:spMk id="206" creationId="{8F46CA49-2108-467F-90B0-F5ECD3098748}"/>
          </ac:spMkLst>
        </pc:spChg>
        <pc:spChg chg="mod">
          <ac:chgData name="zhang hui" userId="7090c9456b8cb81b" providerId="LiveId" clId="{C7F17EC0-8BA4-4DB1-A5CC-F03E68D8F369}" dt="2020-06-20T06:12:17.366" v="1992" actId="1038"/>
          <ac:spMkLst>
            <pc:docMk/>
            <pc:sldMk cId="3488352191" sldId="327"/>
            <ac:spMk id="207" creationId="{47117B2C-FEA4-4A46-BD4A-E9E479CF3235}"/>
          </ac:spMkLst>
        </pc:spChg>
        <pc:spChg chg="mod">
          <ac:chgData name="zhang hui" userId="7090c9456b8cb81b" providerId="LiveId" clId="{C7F17EC0-8BA4-4DB1-A5CC-F03E68D8F369}" dt="2020-06-20T06:12:27.473" v="1999" actId="20577"/>
          <ac:spMkLst>
            <pc:docMk/>
            <pc:sldMk cId="3488352191" sldId="327"/>
            <ac:spMk id="208" creationId="{8A1FCBF8-EBCA-4986-9580-585D66144205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212" creationId="{F93F1962-B927-4626-99A4-157ADE614F66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13" creationId="{81132986-3C91-48FE-B9C9-9A0FDB37651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14" creationId="{6BEB23B6-1A6C-4C47-8514-4ED4B321DEF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15" creationId="{15A747CE-38C8-4635-AC78-B85C7E21A12A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16" creationId="{4C9F8657-6FEA-418E-A7CA-8FC06A640D0E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17" creationId="{E7618AF3-68A3-47FE-A6F6-4D44144E5643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18" creationId="{6FC1E160-9041-4660-88A0-59C772D9FB5C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19" creationId="{A498C5A6-3552-41C8-AC04-7D0417B450ED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20" creationId="{51BC41D6-F9AB-4658-8E2D-FC413FC29123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21" creationId="{3846F88F-8060-4506-8304-4F000FA704BA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222" creationId="{54BDCC1C-A825-46B2-9DCA-FAA37CC4A526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23" creationId="{FD01ADAE-65AB-44BE-8363-91E4B6F6D876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25" creationId="{3119AB20-FAB4-4ACB-BCA2-D37DFBD8FA93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26" creationId="{A8988B0F-A273-491A-9F82-23B992F8E137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27" creationId="{FFC1082C-7588-43D0-BDD9-79636D4B12F5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28" creationId="{8D204BF5-0802-4AC0-870F-23756DD908F9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29" creationId="{B3875A2B-7CCF-4870-B9E8-3CDF4E7A870E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0" creationId="{824B831B-A802-4AB5-B055-DBC836AB64E2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1" creationId="{3E89A4BC-A4C0-4A66-9AC7-31FBD39FF135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2" creationId="{01431A97-480E-4A6D-98B5-12814717BB94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33" creationId="{4AED47F6-0518-4605-9BCB-AB8DE88F4A63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34" creationId="{DA22687C-0B33-4592-B63F-F5B690998008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35" creationId="{3064C382-2DAF-4DAA-96D0-99AD03DE3DC3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36" creationId="{52CF738C-B514-4225-9BCC-1638BE6F4337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7" creationId="{5FF09CAD-853A-4632-9D24-68F15322A5C4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8" creationId="{01A0E49C-86A1-4EF2-B059-6653B0AEFFDE}"/>
          </ac:spMkLst>
        </pc:spChg>
        <pc:spChg chg="mod topLvl">
          <ac:chgData name="zhang hui" userId="7090c9456b8cb81b" providerId="LiveId" clId="{C7F17EC0-8BA4-4DB1-A5CC-F03E68D8F369}" dt="2020-06-20T06:49:54.343" v="4031" actId="1038"/>
          <ac:spMkLst>
            <pc:docMk/>
            <pc:sldMk cId="3488352191" sldId="327"/>
            <ac:spMk id="239" creationId="{08BA8AFE-F653-4581-8056-0CBBCFFC826C}"/>
          </ac:spMkLst>
        </pc:spChg>
        <pc:spChg chg="add 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41" creationId="{F78A0DC5-3328-47F6-B6A7-B8D52090FEF9}"/>
          </ac:spMkLst>
        </pc:spChg>
        <pc:spChg chg="add 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42" creationId="{64DB7FDD-C143-40DB-9BF2-3E760FB1754A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44" creationId="{80C65325-5F6E-45CB-BDE6-F84D9428C490}"/>
          </ac:spMkLst>
        </pc:spChg>
        <pc:spChg chg="mod topLvl">
          <ac:chgData name="zhang hui" userId="7090c9456b8cb81b" providerId="LiveId" clId="{C7F17EC0-8BA4-4DB1-A5CC-F03E68D8F369}" dt="2020-06-20T06:41:04.328" v="3661" actId="1036"/>
          <ac:spMkLst>
            <pc:docMk/>
            <pc:sldMk cId="3488352191" sldId="327"/>
            <ac:spMk id="245" creationId="{A3092A5A-9F73-4C30-8E92-9632AEC03328}"/>
          </ac:spMkLst>
        </pc:spChg>
        <pc:spChg chg="mod topLvl">
          <ac:chgData name="zhang hui" userId="7090c9456b8cb81b" providerId="LiveId" clId="{C7F17EC0-8BA4-4DB1-A5CC-F03E68D8F369}" dt="2020-06-20T06:41:13.466" v="3691" actId="1036"/>
          <ac:spMkLst>
            <pc:docMk/>
            <pc:sldMk cId="3488352191" sldId="327"/>
            <ac:spMk id="246" creationId="{F744F014-3598-4162-8E03-AC0D86104A6C}"/>
          </ac:spMkLst>
        </pc:spChg>
        <pc:spChg chg="mod topLvl">
          <ac:chgData name="zhang hui" userId="7090c9456b8cb81b" providerId="LiveId" clId="{C7F17EC0-8BA4-4DB1-A5CC-F03E68D8F369}" dt="2020-06-20T06:41:21.870" v="3708" actId="1035"/>
          <ac:spMkLst>
            <pc:docMk/>
            <pc:sldMk cId="3488352191" sldId="327"/>
            <ac:spMk id="247" creationId="{7F070809-89A9-4AB4-B07F-379C2E076EAF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48" creationId="{4F065928-647B-4227-81EA-D2F30CD0C040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49" creationId="{B0DFABCD-B014-4D4B-8628-404BC87A83C6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50" creationId="{03DB5FCF-BC49-4EB9-B7FB-F72BED5EE31D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51" creationId="{60F8C56A-73E9-431C-A661-4990C1AA79EF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52" creationId="{F2DBDAF9-45A6-43EF-B6DB-24BA426C56D3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53" creationId="{80501259-3E14-4467-B101-AE396A48C685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54" creationId="{082F8A64-6B19-409C-911C-91784013B908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55" creationId="{ADC09699-004A-471F-9631-66DB35454656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56" creationId="{35759104-BA02-4111-9619-65747A086EC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58" creationId="{700F2AF4-426A-436C-961B-59B708A40D7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59" creationId="{3FF91B6B-AA3D-4409-B7F9-4A4653E6F531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60" creationId="{F2A8327A-18E8-437F-8BCC-D5D535369D4F}"/>
          </ac:spMkLst>
        </pc:spChg>
        <pc:spChg chg="del">
          <ac:chgData name="zhang hui" userId="7090c9456b8cb81b" providerId="LiveId" clId="{C7F17EC0-8BA4-4DB1-A5CC-F03E68D8F369}" dt="2020-06-20T06:41:52.566" v="3709" actId="478"/>
          <ac:spMkLst>
            <pc:docMk/>
            <pc:sldMk cId="3488352191" sldId="327"/>
            <ac:spMk id="261" creationId="{3EDA9213-7E6C-42F6-BE49-77ED9E5DBBB4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62" creationId="{FE600461-99F6-48C5-B175-867BFD98B551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63" creationId="{AAA774B5-A1EF-4E8A-A956-3B9A54622650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4" creationId="{2AE4E6D8-FFAD-44B9-8A2C-A1FBCC35337E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5" creationId="{5B5CBB99-7AF0-4F7B-8A71-568656F78B72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6" creationId="{B53DB36B-AB37-4020-8713-CE36287A35B3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7" creationId="{D10859C6-2EE4-4B5A-9483-A9D338CE97FE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8" creationId="{967EDEB0-72EA-4C9B-A48A-3104F5FF6552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69" creationId="{00A35AE1-66A1-485F-B71A-5C8AF01E39B8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70" creationId="{E029735C-6E23-43F2-A8E4-CFC202B568E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72" creationId="{F58D5154-4A5A-4E0D-9E73-88155D489B80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73" creationId="{13AAE8D8-82C4-43F4-962B-B5485A7E209F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74" creationId="{D522435F-9E04-489E-B6BC-4AC7FF61F202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75" creationId="{16942CCA-C5CB-4976-9A95-4B942BC57000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76" creationId="{05369460-A3CD-4FA7-B0B9-991C1CD03980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77" creationId="{25172385-6DB2-4218-87D9-AE4D9B88BE1A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79" creationId="{3FDF77D7-2785-498E-8956-945766C76B9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80" creationId="{01E5D70C-2E60-4A3B-AD6E-A3533AB2F058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81" creationId="{3DDC0E8B-0B48-4C3A-BDC6-67329C02910C}"/>
          </ac:spMkLst>
        </pc:spChg>
        <pc:spChg chg="add del 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82" creationId="{96AD8C9D-BDAB-44FC-894A-EE6E48F8EF0F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83" creationId="{A116A7B0-0584-4CE1-9E87-71BFA00A53C5}"/>
          </ac:spMkLst>
        </pc:spChg>
        <pc:spChg chg="mod topLvl">
          <ac:chgData name="zhang hui" userId="7090c9456b8cb81b" providerId="LiveId" clId="{C7F17EC0-8BA4-4DB1-A5CC-F03E68D8F369}" dt="2020-06-20T06:34:03.007" v="3386" actId="165"/>
          <ac:spMkLst>
            <pc:docMk/>
            <pc:sldMk cId="3488352191" sldId="327"/>
            <ac:spMk id="284" creationId="{A18DDA42-FD9E-405D-A2FE-0041352A2752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85" creationId="{1FCB6960-0318-4863-AB10-70EC83EBB7B2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86" creationId="{A097EF94-E3FE-402F-974F-75DC04A93FE4}"/>
          </ac:spMkLst>
        </pc:spChg>
        <pc:spChg chg="mod">
          <ac:chgData name="zhang hui" userId="7090c9456b8cb81b" providerId="LiveId" clId="{C7F17EC0-8BA4-4DB1-A5CC-F03E68D8F369}" dt="2020-06-20T06:50:01.137" v="4035" actId="1038"/>
          <ac:spMkLst>
            <pc:docMk/>
            <pc:sldMk cId="3488352191" sldId="327"/>
            <ac:spMk id="287" creationId="{E0759C9D-6934-414D-8571-7FD8EB48134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88" creationId="{262057A8-A7EC-4F9F-A5F5-5AD6C66A92FD}"/>
          </ac:spMkLst>
        </pc:spChg>
        <pc:spChg chg="del mod topLvl">
          <ac:chgData name="zhang hui" userId="7090c9456b8cb81b" providerId="LiveId" clId="{C7F17EC0-8BA4-4DB1-A5CC-F03E68D8F369}" dt="2020-06-20T06:44:46.994" v="3912" actId="478"/>
          <ac:spMkLst>
            <pc:docMk/>
            <pc:sldMk cId="3488352191" sldId="327"/>
            <ac:spMk id="290" creationId="{1B629542-BAE2-42FD-9BEB-FB3DFB09C19C}"/>
          </ac:spMkLst>
        </pc:spChg>
        <pc:spChg chg="del mod topLvl">
          <ac:chgData name="zhang hui" userId="7090c9456b8cb81b" providerId="LiveId" clId="{C7F17EC0-8BA4-4DB1-A5CC-F03E68D8F369}" dt="2020-06-20T06:44:40.089" v="3911" actId="478"/>
          <ac:spMkLst>
            <pc:docMk/>
            <pc:sldMk cId="3488352191" sldId="327"/>
            <ac:spMk id="291" creationId="{64B349AB-449D-4AD3-9247-77A959A50426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2" creationId="{512A1166-4B4B-4071-8D62-409DF0D12AAF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3" creationId="{9B9F93AA-4626-45AC-8128-1A4117EFCCB0}"/>
          </ac:spMkLst>
        </pc:spChg>
        <pc:spChg chg="del mod">
          <ac:chgData name="zhang hui" userId="7090c9456b8cb81b" providerId="LiveId" clId="{C7F17EC0-8BA4-4DB1-A5CC-F03E68D8F369}" dt="2020-06-20T06:40:25.884" v="3597" actId="478"/>
          <ac:spMkLst>
            <pc:docMk/>
            <pc:sldMk cId="3488352191" sldId="327"/>
            <ac:spMk id="294" creationId="{58034B7F-6AA2-44E5-A168-F9CA8BDAC8EA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5" creationId="{79D9D30D-13F1-470E-820A-648239D74C14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6" creationId="{EAFE3AE4-9E6C-4C17-AE05-57425F15FA5B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7" creationId="{DB4D62AD-B4BB-4C5E-8511-E67411F2B3A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299" creationId="{82DA8D4F-0207-4348-A57E-235495B58FE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0" creationId="{DBD2CE52-8FD1-4FE3-B200-A73CD2455687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1" creationId="{EDC25D2E-4BC4-4CA0-A9E4-1CF73A065037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2" creationId="{4AA64F95-30FE-4CB6-8D4B-49721D821D35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3" creationId="{E1A08582-B6AC-4FC0-B5E6-791E516F19AD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4" creationId="{ED0907FC-D356-46E9-9DCF-3A86792D5822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6" creationId="{4FBBE193-6A7B-4C2F-BFCD-CA295263A1EB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7" creationId="{8CB16B78-3957-4496-9E0A-2CA7032828D0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08" creationId="{66E4B95D-B324-4A66-A4D3-1D2BB84E2399}"/>
          </ac:spMkLst>
        </pc:spChg>
        <pc:spChg chg="del mod">
          <ac:chgData name="zhang hui" userId="7090c9456b8cb81b" providerId="LiveId" clId="{C7F17EC0-8BA4-4DB1-A5CC-F03E68D8F369}" dt="2020-06-20T06:43:11.235" v="3726" actId="478"/>
          <ac:spMkLst>
            <pc:docMk/>
            <pc:sldMk cId="3488352191" sldId="327"/>
            <ac:spMk id="309" creationId="{01060B58-2563-4C9D-AB4C-A1E152BEA64F}"/>
          </ac:spMkLst>
        </pc:spChg>
        <pc:spChg chg="del mod">
          <ac:chgData name="zhang hui" userId="7090c9456b8cb81b" providerId="LiveId" clId="{C7F17EC0-8BA4-4DB1-A5CC-F03E68D8F369}" dt="2020-06-20T06:43:07.408" v="3725" actId="478"/>
          <ac:spMkLst>
            <pc:docMk/>
            <pc:sldMk cId="3488352191" sldId="327"/>
            <ac:spMk id="310" creationId="{EBF6BC6F-7D23-403D-8F31-AEF7619A729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11" creationId="{2556E26A-5463-4623-8ECE-81DBCB142CAE}"/>
          </ac:spMkLst>
        </pc:spChg>
        <pc:spChg chg="del">
          <ac:chgData name="zhang hui" userId="7090c9456b8cb81b" providerId="LiveId" clId="{C7F17EC0-8BA4-4DB1-A5CC-F03E68D8F369}" dt="2020-06-20T06:37:46.532" v="3559" actId="478"/>
          <ac:spMkLst>
            <pc:docMk/>
            <pc:sldMk cId="3488352191" sldId="327"/>
            <ac:spMk id="316" creationId="{24AD8B63-6CAA-4242-AF87-31C879D94661}"/>
          </ac:spMkLst>
        </pc:spChg>
        <pc:spChg chg="del">
          <ac:chgData name="zhang hui" userId="7090c9456b8cb81b" providerId="LiveId" clId="{C7F17EC0-8BA4-4DB1-A5CC-F03E68D8F369}" dt="2020-06-20T06:37:57.061" v="3563" actId="478"/>
          <ac:spMkLst>
            <pc:docMk/>
            <pc:sldMk cId="3488352191" sldId="327"/>
            <ac:spMk id="317" creationId="{1AC04FDA-8249-495B-9BB1-19A88C5B8620}"/>
          </ac:spMkLst>
        </pc:spChg>
        <pc:spChg chg="del">
          <ac:chgData name="zhang hui" userId="7090c9456b8cb81b" providerId="LiveId" clId="{C7F17EC0-8BA4-4DB1-A5CC-F03E68D8F369}" dt="2020-06-20T06:37:46.532" v="3559" actId="478"/>
          <ac:spMkLst>
            <pc:docMk/>
            <pc:sldMk cId="3488352191" sldId="327"/>
            <ac:spMk id="318" creationId="{1DBA1D0E-A261-47C1-AC20-AC2202D56ADB}"/>
          </ac:spMkLst>
        </pc:spChg>
        <pc:spChg chg="del">
          <ac:chgData name="zhang hui" userId="7090c9456b8cb81b" providerId="LiveId" clId="{C7F17EC0-8BA4-4DB1-A5CC-F03E68D8F369}" dt="2020-06-20T06:37:46.532" v="3559" actId="478"/>
          <ac:spMkLst>
            <pc:docMk/>
            <pc:sldMk cId="3488352191" sldId="327"/>
            <ac:spMk id="319" creationId="{61DB8E32-67C3-4A8D-84DB-148CB8B617C6}"/>
          </ac:spMkLst>
        </pc:spChg>
        <pc:spChg chg="del">
          <ac:chgData name="zhang hui" userId="7090c9456b8cb81b" providerId="LiveId" clId="{C7F17EC0-8BA4-4DB1-A5CC-F03E68D8F369}" dt="2020-06-20T06:37:46.532" v="3559" actId="478"/>
          <ac:spMkLst>
            <pc:docMk/>
            <pc:sldMk cId="3488352191" sldId="327"/>
            <ac:spMk id="320" creationId="{CB821DC3-459F-4DDC-B9CD-4BC09089C7BB}"/>
          </ac:spMkLst>
        </pc:spChg>
        <pc:spChg chg="del">
          <ac:chgData name="zhang hui" userId="7090c9456b8cb81b" providerId="LiveId" clId="{C7F17EC0-8BA4-4DB1-A5CC-F03E68D8F369}" dt="2020-06-20T06:37:59.060" v="3564" actId="478"/>
          <ac:spMkLst>
            <pc:docMk/>
            <pc:sldMk cId="3488352191" sldId="327"/>
            <ac:spMk id="321" creationId="{322F6684-AE02-4ECA-BD73-6438D87D31DD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2" creationId="{664CB18E-E287-471E-A277-29FC5241C4DB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3" creationId="{C51D297A-7FED-4AD6-A22F-43A2B7E46B4D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4" creationId="{26531851-277C-4315-864B-FFD314E13168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5" creationId="{2F387DB2-58B4-45A6-95C6-EFE2878DC1CA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6" creationId="{9147406C-C7C9-477A-87E7-D438AEC33875}"/>
          </ac:spMkLst>
        </pc:spChg>
        <pc:spChg chg="del">
          <ac:chgData name="zhang hui" userId="7090c9456b8cb81b" providerId="LiveId" clId="{C7F17EC0-8BA4-4DB1-A5CC-F03E68D8F369}" dt="2020-06-20T06:41:59.330" v="3710" actId="478"/>
          <ac:spMkLst>
            <pc:docMk/>
            <pc:sldMk cId="3488352191" sldId="327"/>
            <ac:spMk id="327" creationId="{FD5BDAD5-AEC0-403E-B32E-A3FD96C17BAB}"/>
          </ac:spMkLst>
        </pc:spChg>
        <pc:spChg chg="del">
          <ac:chgData name="zhang hui" userId="7090c9456b8cb81b" providerId="LiveId" clId="{C7F17EC0-8BA4-4DB1-A5CC-F03E68D8F369}" dt="2020-06-20T06:42:06.829" v="3711" actId="478"/>
          <ac:spMkLst>
            <pc:docMk/>
            <pc:sldMk cId="3488352191" sldId="327"/>
            <ac:spMk id="328" creationId="{3B1DB415-4BBE-4270-BD2A-30970825F9E6}"/>
          </ac:spMkLst>
        </pc:spChg>
        <pc:spChg chg="del">
          <ac:chgData name="zhang hui" userId="7090c9456b8cb81b" providerId="LiveId" clId="{C7F17EC0-8BA4-4DB1-A5CC-F03E68D8F369}" dt="2020-06-20T06:42:06.829" v="3711" actId="478"/>
          <ac:spMkLst>
            <pc:docMk/>
            <pc:sldMk cId="3488352191" sldId="327"/>
            <ac:spMk id="329" creationId="{60CC7D34-C471-4D10-B133-91E6D9C133C8}"/>
          </ac:spMkLst>
        </pc:spChg>
        <pc:spChg chg="del">
          <ac:chgData name="zhang hui" userId="7090c9456b8cb81b" providerId="LiveId" clId="{C7F17EC0-8BA4-4DB1-A5CC-F03E68D8F369}" dt="2020-06-20T06:42:06.829" v="3711" actId="478"/>
          <ac:spMkLst>
            <pc:docMk/>
            <pc:sldMk cId="3488352191" sldId="327"/>
            <ac:spMk id="330" creationId="{58B54919-115B-42D6-BD5D-10A6998B118D}"/>
          </ac:spMkLst>
        </pc:spChg>
        <pc:spChg chg="del">
          <ac:chgData name="zhang hui" userId="7090c9456b8cb81b" providerId="LiveId" clId="{C7F17EC0-8BA4-4DB1-A5CC-F03E68D8F369}" dt="2020-06-20T06:42:06.829" v="3711" actId="478"/>
          <ac:spMkLst>
            <pc:docMk/>
            <pc:sldMk cId="3488352191" sldId="327"/>
            <ac:spMk id="331" creationId="{37C4E74D-8601-457C-932C-D279EA2A68F4}"/>
          </ac:spMkLst>
        </pc:spChg>
        <pc:spChg chg="mod">
          <ac:chgData name="zhang hui" userId="7090c9456b8cb81b" providerId="LiveId" clId="{C7F17EC0-8BA4-4DB1-A5CC-F03E68D8F369}" dt="2020-06-20T05:54:27.015" v="1923" actId="20577"/>
          <ac:spMkLst>
            <pc:docMk/>
            <pc:sldMk cId="3488352191" sldId="327"/>
            <ac:spMk id="332" creationId="{9729539B-6005-46C1-8D67-9A8CD3A4867F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33" creationId="{994F2042-3C46-48E4-B28C-9A1560853F4A}"/>
          </ac:spMkLst>
        </pc:spChg>
        <pc:spChg chg="mod topLvl">
          <ac:chgData name="zhang hui" userId="7090c9456b8cb81b" providerId="LiveId" clId="{C7F17EC0-8BA4-4DB1-A5CC-F03E68D8F369}" dt="2020-06-20T06:35:55.496" v="3535" actId="1076"/>
          <ac:spMkLst>
            <pc:docMk/>
            <pc:sldMk cId="3488352191" sldId="327"/>
            <ac:spMk id="334" creationId="{9A92DB3D-98C8-4905-9450-B93208F33BC0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35" creationId="{8084BB98-5127-4796-BB11-23F9FF5B4D0A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36" creationId="{288CDEB0-BF5B-49E5-9E2A-1D8E4E936F89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37" creationId="{7B50FB1C-4426-436D-8C44-FD3436677A10}"/>
          </ac:spMkLst>
        </pc:spChg>
        <pc:spChg chg="mod topLvl">
          <ac:chgData name="zhang hui" userId="7090c9456b8cb81b" providerId="LiveId" clId="{C7F17EC0-8BA4-4DB1-A5CC-F03E68D8F369}" dt="2020-06-20T06:11:51.825" v="1974" actId="165"/>
          <ac:spMkLst>
            <pc:docMk/>
            <pc:sldMk cId="3488352191" sldId="327"/>
            <ac:spMk id="338" creationId="{451680BE-AFB5-4A8F-AF3B-809A7A0ED8E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4" creationId="{7FDA8545-2A1D-4937-8AC2-837F99335A23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5" creationId="{9B3629BA-B58A-4E50-B4F7-3CCC4F9C5354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6" creationId="{7A61AB28-A484-4966-A82D-388D4A06F85B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7" creationId="{F5E09569-B5EC-4364-9E6B-1BB47456F21B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8" creationId="{54E0DE7A-71FC-427C-B1D4-DE10D10AEDCF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49" creationId="{F55B8301-F9EA-4AC2-8AB4-8662EE11B47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0" creationId="{E1EC8620-2C6A-4891-A552-65E3AF51B942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1" creationId="{425ED516-251B-4A43-8C09-2F1F919D115D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2" creationId="{BA3EF11B-0786-45BF-8D84-28B674511EFE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3" creationId="{3A10831E-AB6B-4D3F-B7FD-F4F5263D49D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4" creationId="{6E4342D9-1A63-485E-8B2D-1C61BBBA806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5" creationId="{EDA5767B-D3B3-4A57-B03C-589B584D9D4F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6" creationId="{A7B5EF70-9180-422D-8A41-E0A764E234A0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7" creationId="{9EE803F1-4780-4720-9BE2-9CE9E7E95A68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8" creationId="{C55ED207-AA80-4882-A813-DC48CF439E55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59" creationId="{C037F999-2C49-4ACC-BE89-0CEEDF54AFE1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0" creationId="{0E4C0BB7-1029-4A4C-A84E-340CBABF9114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1" creationId="{395404D8-EFD2-42E1-B038-F55D498538EB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2" creationId="{70B0979C-ECF7-46E5-B2EE-2E27F0EDBEAF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3" creationId="{11D83C34-BE2A-4D4B-B18B-90374C33ED7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4" creationId="{A14304EE-EBE4-4210-BF0E-5EB84107AFF6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5" creationId="{349A5406-0DCD-4A9E-B03F-ECCDEF22811D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6" creationId="{13770A24-E64E-4633-B63A-C7DE6FA36A62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7" creationId="{589A99DE-8FA3-48B2-B895-A8B1AB45C5B6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8" creationId="{9D7C1E53-69BE-4607-9EAD-AB6D2F819FE5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69" creationId="{F895B95E-7AD5-46B4-9D59-D0345CB5AAB6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0" creationId="{D06F8DC9-1158-4F19-B3B1-05FD8F651C88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1" creationId="{55CBF4FF-B0DE-418E-8738-3F9F99AE06EC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2" creationId="{6473FF9A-E487-4E51-A9AE-C0E3BE0A516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3" creationId="{62647401-59F7-4591-BBBD-82A10105EFB2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4" creationId="{550ADE30-0D82-4D46-AAC4-F023FB6CB639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5" creationId="{A4DE32AC-F0D4-461A-82D9-46DCAC031694}"/>
          </ac:spMkLst>
        </pc:spChg>
        <pc:spChg chg="mod topLvl">
          <ac:chgData name="zhang hui" userId="7090c9456b8cb81b" providerId="LiveId" clId="{C7F17EC0-8BA4-4DB1-A5CC-F03E68D8F369}" dt="2020-06-20T06:45:28.297" v="3999" actId="165"/>
          <ac:spMkLst>
            <pc:docMk/>
            <pc:sldMk cId="3488352191" sldId="327"/>
            <ac:spMk id="376" creationId="{98451141-8E86-4AB6-B953-1D00C20AE49B}"/>
          </ac:spMkLst>
        </pc:s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13" creationId="{E511B122-26CF-4818-A0B4-CD851BDE116C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14" creationId="{94B0F30C-E6B5-4EE8-B57C-51953AB4D51B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15" creationId="{6140BB8C-4B41-46AC-8369-356C8342A550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16" creationId="{165CC495-81FA-458C-B561-C925F1C250E9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17" creationId="{56457438-0650-48CB-BCCE-4E65B8AE5225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1" creationId="{2723ABD0-4A09-44F9-9A35-7693D02DEE33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2" creationId="{D7747A05-6B55-401C-B7EC-AB4F6752F1A3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3" creationId="{A9380EEE-F439-4340-B328-3CFF288DF486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4" creationId="{66A92F16-BA68-4D53-9208-8B14F113099F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6" creationId="{9F75A0CA-7590-4675-8BB8-50881276EA16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7" creationId="{3C786DC7-4178-43ED-8D52-1C33491681B4}"/>
          </ac:grpSpMkLst>
        </pc:grpChg>
        <pc:grpChg chg="add del mod">
          <ac:chgData name="zhang hui" userId="7090c9456b8cb81b" providerId="LiveId" clId="{C7F17EC0-8BA4-4DB1-A5CC-F03E68D8F369}" dt="2020-06-20T06:34:03.007" v="3386" actId="165"/>
          <ac:grpSpMkLst>
            <pc:docMk/>
            <pc:sldMk cId="3488352191" sldId="327"/>
            <ac:grpSpMk id="38" creationId="{EF036E89-B131-406A-9F73-9FC12C781AC3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42" creationId="{767E162F-656B-4C43-9841-0C5994EAF601}"/>
          </ac:grpSpMkLst>
        </pc:grpChg>
        <pc:grpChg chg="add del mod">
          <ac:chgData name="zhang hui" userId="7090c9456b8cb81b" providerId="LiveId" clId="{C7F17EC0-8BA4-4DB1-A5CC-F03E68D8F369}" dt="2020-06-20T06:45:23.610" v="3998" actId="165"/>
          <ac:grpSpMkLst>
            <pc:docMk/>
            <pc:sldMk cId="3488352191" sldId="327"/>
            <ac:grpSpMk id="43" creationId="{A85FBE5F-A571-4FBC-9A84-85CED65D4F58}"/>
          </ac:grpSpMkLst>
        </pc:grpChg>
        <pc:grpChg chg="del mod">
          <ac:chgData name="zhang hui" userId="7090c9456b8cb81b" providerId="LiveId" clId="{C7F17EC0-8BA4-4DB1-A5CC-F03E68D8F369}" dt="2020-06-20T06:11:51.825" v="1974" actId="165"/>
          <ac:grpSpMkLst>
            <pc:docMk/>
            <pc:sldMk cId="3488352191" sldId="327"/>
            <ac:grpSpMk id="76" creationId="{8D3A759E-7681-474F-B440-AAC241BEA55E}"/>
          </ac:grpSpMkLst>
        </pc:grpChg>
        <pc:grpChg chg="del">
          <ac:chgData name="zhang hui" userId="7090c9456b8cb81b" providerId="LiveId" clId="{C7F17EC0-8BA4-4DB1-A5CC-F03E68D8F369}" dt="2020-06-20T06:11:51.825" v="1974" actId="165"/>
          <ac:grpSpMkLst>
            <pc:docMk/>
            <pc:sldMk cId="3488352191" sldId="327"/>
            <ac:grpSpMk id="78" creationId="{35E02598-6EE5-4975-BD66-B4430C194237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243" creationId="{EDA38735-515C-43F7-AABC-F8E131AE6E0D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271" creationId="{E5ECC2EA-A9C9-4FC1-8794-66C8FCCAF84E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289" creationId="{3FE6640C-DF5C-4931-BC49-38523C078D61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298" creationId="{4DB02DC0-9A6F-4876-A487-5878183C29BA}"/>
          </ac:grpSpMkLst>
        </pc:grpChg>
        <pc:grpChg chg="add 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05" creationId="{B1917AB1-3AA4-4BA4-8FD6-4BB6E9CD9EDD}"/>
          </ac:grpSpMkLst>
        </pc:grpChg>
        <pc:grpChg chg="add del mod">
          <ac:chgData name="zhang hui" userId="7090c9456b8cb81b" providerId="LiveId" clId="{C7F17EC0-8BA4-4DB1-A5CC-F03E68D8F369}" dt="2020-06-20T06:45:23.610" v="3998" actId="165"/>
          <ac:grpSpMkLst>
            <pc:docMk/>
            <pc:sldMk cId="3488352191" sldId="327"/>
            <ac:grpSpMk id="312" creationId="{C14BABD6-52CD-411C-8419-877E12BE6CFF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13" creationId="{C5F8EB9B-0B08-4F81-92B6-BFC5608B2AB4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14" creationId="{D8B3E6A5-5E77-4950-BF4A-9B7ABF3E2654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15" creationId="{E7BB4299-0CE3-4DA8-856E-2984CFFD3A93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41" creationId="{24684419-AAC3-4FB8-B073-B205BC61564D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42" creationId="{F44FAD51-03EB-483E-A729-AA23D3A994CC}"/>
          </ac:grpSpMkLst>
        </pc:grpChg>
        <pc:grpChg chg="del mod topLvl">
          <ac:chgData name="zhang hui" userId="7090c9456b8cb81b" providerId="LiveId" clId="{C7F17EC0-8BA4-4DB1-A5CC-F03E68D8F369}" dt="2020-06-20T06:45:28.297" v="3999" actId="165"/>
          <ac:grpSpMkLst>
            <pc:docMk/>
            <pc:sldMk cId="3488352191" sldId="327"/>
            <ac:grpSpMk id="343" creationId="{453BAB76-C99E-4198-9392-832EE9941840}"/>
          </ac:grpSpMkLst>
        </pc:grpChg>
        <pc:graphicFrameChg chg="mod topLvl">
          <ac:chgData name="zhang hui" userId="7090c9456b8cb81b" providerId="LiveId" clId="{C7F17EC0-8BA4-4DB1-A5CC-F03E68D8F369}" dt="2020-06-20T06:46:03.226" v="4004" actId="553"/>
          <ac:graphicFrameMkLst>
            <pc:docMk/>
            <pc:sldMk cId="3488352191" sldId="327"/>
            <ac:graphicFrameMk id="3" creationId="{AED05AAA-4043-48C9-A3CE-636CF81CCDA2}"/>
          </ac:graphicFrameMkLst>
        </pc:graphicFrameChg>
        <pc:graphicFrameChg chg="mod topLvl">
          <ac:chgData name="zhang hui" userId="7090c9456b8cb81b" providerId="LiveId" clId="{C7F17EC0-8BA4-4DB1-A5CC-F03E68D8F369}" dt="2020-06-20T06:46:03.226" v="4004" actId="553"/>
          <ac:graphicFrameMkLst>
            <pc:docMk/>
            <pc:sldMk cId="3488352191" sldId="327"/>
            <ac:graphicFrameMk id="26" creationId="{8A781608-9265-461B-B5D1-0B9C81627C8B}"/>
          </ac:graphicFrameMkLst>
        </pc:graphicFrameChg>
        <pc:graphicFrameChg chg="mod topLvl">
          <ac:chgData name="zhang hui" userId="7090c9456b8cb81b" providerId="LiveId" clId="{C7F17EC0-8BA4-4DB1-A5CC-F03E68D8F369}" dt="2020-06-20T06:45:58.071" v="4003" actId="553"/>
          <ac:graphicFrameMkLst>
            <pc:docMk/>
            <pc:sldMk cId="3488352191" sldId="327"/>
            <ac:graphicFrameMk id="48" creationId="{F8A202D5-E664-40E7-958D-40383F50A9E2}"/>
          </ac:graphicFrameMkLst>
        </pc:graphicFrameChg>
        <pc:graphicFrameChg chg="mod topLvl">
          <ac:chgData name="zhang hui" userId="7090c9456b8cb81b" providerId="LiveId" clId="{C7F17EC0-8BA4-4DB1-A5CC-F03E68D8F369}" dt="2020-06-20T06:45:58.071" v="4003" actId="553"/>
          <ac:graphicFrameMkLst>
            <pc:docMk/>
            <pc:sldMk cId="3488352191" sldId="327"/>
            <ac:graphicFrameMk id="117" creationId="{D8CA78C3-D147-4170-B082-45B8B57D76F9}"/>
          </ac:graphicFrameMkLst>
        </pc:graphicFrameChg>
        <pc:graphicFrameChg chg="mod topLvl">
          <ac:chgData name="zhang hui" userId="7090c9456b8cb81b" providerId="LiveId" clId="{C7F17EC0-8BA4-4DB1-A5CC-F03E68D8F369}" dt="2020-06-20T06:46:08.115" v="4005" actId="553"/>
          <ac:graphicFrameMkLst>
            <pc:docMk/>
            <pc:sldMk cId="3488352191" sldId="327"/>
            <ac:graphicFrameMk id="134" creationId="{2666294E-E524-404E-AC45-BAD330729B37}"/>
          </ac:graphicFrameMkLst>
        </pc:graphicFrameChg>
        <pc:graphicFrameChg chg="mod topLvl">
          <ac:chgData name="zhang hui" userId="7090c9456b8cb81b" providerId="LiveId" clId="{C7F17EC0-8BA4-4DB1-A5CC-F03E68D8F369}" dt="2020-06-20T06:45:35.326" v="4000" actId="553"/>
          <ac:graphicFrameMkLst>
            <pc:docMk/>
            <pc:sldMk cId="3488352191" sldId="327"/>
            <ac:graphicFrameMk id="170" creationId="{C17BAEE5-91FD-4674-8C1B-2118FCDD0B23}"/>
          </ac:graphicFrameMkLst>
        </pc:graphicFrameChg>
        <pc:graphicFrameChg chg="mod topLvl">
          <ac:chgData name="zhang hui" userId="7090c9456b8cb81b" providerId="LiveId" clId="{C7F17EC0-8BA4-4DB1-A5CC-F03E68D8F369}" dt="2020-06-20T06:45:43.840" v="4001" actId="553"/>
          <ac:graphicFrameMkLst>
            <pc:docMk/>
            <pc:sldMk cId="3488352191" sldId="327"/>
            <ac:graphicFrameMk id="186" creationId="{C1FC6736-E311-4859-9A38-65EAC4DF0E00}"/>
          </ac:graphicFrameMkLst>
        </pc:graphicFrameChg>
        <pc:graphicFrameChg chg="mod ord topLvl">
          <ac:chgData name="zhang hui" userId="7090c9456b8cb81b" providerId="LiveId" clId="{C7F17EC0-8BA4-4DB1-A5CC-F03E68D8F369}" dt="2020-06-20T06:46:08.115" v="4005" actId="553"/>
          <ac:graphicFrameMkLst>
            <pc:docMk/>
            <pc:sldMk cId="3488352191" sldId="327"/>
            <ac:graphicFrameMk id="195" creationId="{C8C8E197-1F26-4396-BEA9-EF77B54015C1}"/>
          </ac:graphicFrameMkLst>
        </pc:graphicFrameChg>
        <pc:graphicFrameChg chg="mod topLvl">
          <ac:chgData name="zhang hui" userId="7090c9456b8cb81b" providerId="LiveId" clId="{C7F17EC0-8BA4-4DB1-A5CC-F03E68D8F369}" dt="2020-06-20T06:49:43.877" v="4025" actId="1037"/>
          <ac:graphicFrameMkLst>
            <pc:docMk/>
            <pc:sldMk cId="3488352191" sldId="327"/>
            <ac:graphicFrameMk id="224" creationId="{EBF9BF84-E6B8-464A-9885-4857BBFB261D}"/>
          </ac:graphicFrameMkLst>
        </pc:graphicFrameChg>
        <pc:graphicFrameChg chg="mod topLvl">
          <ac:chgData name="zhang hui" userId="7090c9456b8cb81b" providerId="LiveId" clId="{C7F17EC0-8BA4-4DB1-A5CC-F03E68D8F369}" dt="2020-06-20T06:45:50.869" v="4002" actId="553"/>
          <ac:graphicFrameMkLst>
            <pc:docMk/>
            <pc:sldMk cId="3488352191" sldId="327"/>
            <ac:graphicFrameMk id="240" creationId="{79EB2B05-8E67-4E63-B320-0F327654307E}"/>
          </ac:graphicFrameMkLst>
        </pc:graphicFrameChg>
        <pc:graphicFrameChg chg="mod topLvl">
          <ac:chgData name="zhang hui" userId="7090c9456b8cb81b" providerId="LiveId" clId="{C7F17EC0-8BA4-4DB1-A5CC-F03E68D8F369}" dt="2020-06-20T06:45:43.840" v="4001" actId="553"/>
          <ac:graphicFrameMkLst>
            <pc:docMk/>
            <pc:sldMk cId="3488352191" sldId="327"/>
            <ac:graphicFrameMk id="257" creationId="{0E16BF54-A5EC-4AB2-ACFD-8A0CA633AEED}"/>
          </ac:graphicFrameMkLst>
        </pc:graphicFrameChg>
        <pc:graphicFrameChg chg="mod topLvl">
          <ac:chgData name="zhang hui" userId="7090c9456b8cb81b" providerId="LiveId" clId="{C7F17EC0-8BA4-4DB1-A5CC-F03E68D8F369}" dt="2020-06-20T06:45:35.326" v="4000" actId="553"/>
          <ac:graphicFrameMkLst>
            <pc:docMk/>
            <pc:sldMk cId="3488352191" sldId="327"/>
            <ac:graphicFrameMk id="278" creationId="{4DD80E40-45D4-4A98-87CB-9342C4750C69}"/>
          </ac:graphicFrameMkLst>
        </pc:graphicFrameChg>
      </pc:sldChg>
    </pc:docChg>
  </pc:docChgLst>
  <pc:docChgLst>
    <pc:chgData name="zhang hui" userId="7090c9456b8cb81b" providerId="LiveId" clId="{B8890080-190D-47FD-A1DB-C0B8AD630777}"/>
    <pc:docChg chg="undo custSel delSld modSld">
      <pc:chgData name="zhang hui" userId="7090c9456b8cb81b" providerId="LiveId" clId="{B8890080-190D-47FD-A1DB-C0B8AD630777}" dt="2020-08-04T15:29:25.622" v="1772" actId="47"/>
      <pc:docMkLst>
        <pc:docMk/>
      </pc:docMkLst>
      <pc:sldChg chg="del">
        <pc:chgData name="zhang hui" userId="7090c9456b8cb81b" providerId="LiveId" clId="{B8890080-190D-47FD-A1DB-C0B8AD630777}" dt="2020-08-04T15:29:23.950" v="1770" actId="47"/>
        <pc:sldMkLst>
          <pc:docMk/>
          <pc:sldMk cId="3342779765" sldId="288"/>
        </pc:sldMkLst>
      </pc:sldChg>
      <pc:sldChg chg="del">
        <pc:chgData name="zhang hui" userId="7090c9456b8cb81b" providerId="LiveId" clId="{B8890080-190D-47FD-A1DB-C0B8AD630777}" dt="2020-08-04T15:29:24.799" v="1771" actId="47"/>
        <pc:sldMkLst>
          <pc:docMk/>
          <pc:sldMk cId="1020386032" sldId="289"/>
        </pc:sldMkLst>
      </pc:sldChg>
      <pc:sldChg chg="del">
        <pc:chgData name="zhang hui" userId="7090c9456b8cb81b" providerId="LiveId" clId="{B8890080-190D-47FD-A1DB-C0B8AD630777}" dt="2020-08-04T15:29:23.134" v="1769" actId="47"/>
        <pc:sldMkLst>
          <pc:docMk/>
          <pc:sldMk cId="84434932" sldId="290"/>
        </pc:sldMkLst>
      </pc:sldChg>
      <pc:sldChg chg="del">
        <pc:chgData name="zhang hui" userId="7090c9456b8cb81b" providerId="LiveId" clId="{B8890080-190D-47FD-A1DB-C0B8AD630777}" dt="2020-08-04T15:29:25.622" v="1772" actId="47"/>
        <pc:sldMkLst>
          <pc:docMk/>
          <pc:sldMk cId="581528161" sldId="292"/>
        </pc:sldMkLst>
      </pc:sldChg>
      <pc:sldChg chg="addSp modSp mod">
        <pc:chgData name="zhang hui" userId="7090c9456b8cb81b" providerId="LiveId" clId="{B8890080-190D-47FD-A1DB-C0B8AD630777}" dt="2020-08-04T15:24:03.968" v="1382" actId="1035"/>
        <pc:sldMkLst>
          <pc:docMk/>
          <pc:sldMk cId="2802138345" sldId="297"/>
        </pc:sldMkLst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" creationId="{2FDB31E6-4059-433F-97EA-3C19F80BC1B7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4" creationId="{F3A7D2A3-BE1D-4A77-8967-68616B5B0A62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5" creationId="{49153525-3A62-4CF8-8E41-D93639D73D3A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6" creationId="{909C0F14-4589-4CF4-9AE8-64031C60A702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7" creationId="{F2F9785A-4366-4E01-BA70-8161D48A1AF0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8" creationId="{03D4B726-07CC-49E3-996A-291647A89375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9" creationId="{83CA0030-4EF1-45E0-AC31-A92FE573DCD1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0" creationId="{E53A703E-BF68-44E2-961B-501593599231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1" creationId="{2974A9DE-0036-49E3-B75D-6800D363C6FD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2" creationId="{6BB6407A-DBB9-43B5-9300-77B472D41156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5" creationId="{7FF722DD-B686-44FD-AF13-0D01FDA492CC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6" creationId="{3E3F1D76-ED08-45A7-851D-0680E1478929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17" creationId="{1FA1DD35-34A9-48BC-97CD-AC6F5719596A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2" creationId="{DF61F5B3-661E-430D-81DA-6FAEA9FE4346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3" creationId="{AA160CDD-EF78-4D6B-A702-472153302901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4" creationId="{62E697BE-820F-4CFF-A27C-82C498FD82FE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5" creationId="{53FD67B4-B0E4-4ED5-AD15-577E67FF6C63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6" creationId="{FA6CEABF-13B6-4DC9-A753-7165EEAFFA12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7" creationId="{140BD308-C2BD-4F1E-8256-E6D83CC70458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8" creationId="{E53E03EB-FE0E-46FD-A56C-23D18DB90B2A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29" creationId="{43DDE0DF-617B-40D2-AFD7-FF7A7FCE167A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0" creationId="{F8E5FE40-030E-4E32-9BCE-9DD9281B5D7D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1" creationId="{BEEC2CEC-88B1-4484-976A-3B4A0E3BDABB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2" creationId="{4F52D0BA-0E30-4AD3-BE49-E0E997549594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3" creationId="{4FFB3D3E-649C-4E83-88E6-E8DE88747165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4" creationId="{57BCF4B0-55D8-4112-B020-DF1AD4FD813C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5" creationId="{F61DB005-C10D-402B-9F76-E320B1E672C1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6" creationId="{D75C7210-7D21-46A9-81DF-22B6BE9B8AC6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8" creationId="{53D084BC-0252-49B1-8562-2106FFA722DC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39" creationId="{9C9C0ED8-E985-483C-9CDE-6DE27ACACFD5}"/>
          </ac:spMkLst>
        </pc:spChg>
        <pc:spChg chg="add mod">
          <ac:chgData name="zhang hui" userId="7090c9456b8cb81b" providerId="LiveId" clId="{B8890080-190D-47FD-A1DB-C0B8AD630777}" dt="2020-08-04T15:19:42.897" v="1239" actId="20577"/>
          <ac:spMkLst>
            <pc:docMk/>
            <pc:sldMk cId="2802138345" sldId="297"/>
            <ac:spMk id="43" creationId="{47B570C3-5B81-4CC4-BFBF-0B91D59088D9}"/>
          </ac:spMkLst>
        </pc:spChg>
        <pc:spChg chg="add mod">
          <ac:chgData name="zhang hui" userId="7090c9456b8cb81b" providerId="LiveId" clId="{B8890080-190D-47FD-A1DB-C0B8AD630777}" dt="2020-08-04T15:24:03.968" v="1382" actId="1035"/>
          <ac:spMkLst>
            <pc:docMk/>
            <pc:sldMk cId="2802138345" sldId="297"/>
            <ac:spMk id="44" creationId="{8AE18A2A-ADCB-4C59-8A5D-E9A895D85B7A}"/>
          </ac:spMkLst>
        </pc:spChg>
        <pc:spChg chg="add mod">
          <ac:chgData name="zhang hui" userId="7090c9456b8cb81b" providerId="LiveId" clId="{B8890080-190D-47FD-A1DB-C0B8AD630777}" dt="2020-08-04T15:24:03.968" v="1382" actId="1035"/>
          <ac:spMkLst>
            <pc:docMk/>
            <pc:sldMk cId="2802138345" sldId="297"/>
            <ac:spMk id="45" creationId="{60C884C4-186B-4DCE-80C1-895666C6CE51}"/>
          </ac:spMkLst>
        </pc:spChg>
        <pc:spChg chg="add mod">
          <ac:chgData name="zhang hui" userId="7090c9456b8cb81b" providerId="LiveId" clId="{B8890080-190D-47FD-A1DB-C0B8AD630777}" dt="2020-08-04T15:24:03.968" v="1382" actId="1035"/>
          <ac:spMkLst>
            <pc:docMk/>
            <pc:sldMk cId="2802138345" sldId="297"/>
            <ac:spMk id="46" creationId="{BA6D4199-8EE1-4146-90B5-754ECA0CF8A8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83" creationId="{8FEECFDF-994C-425D-B13D-FD417FF84BFC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94" creationId="{C50F9D06-8833-4B6A-BBE4-5209E3199310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95" creationId="{955C1EF1-A938-4DFC-91CD-D0F544D4938B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96" creationId="{53A62949-FA2F-4BD1-9FC4-B163B8351440}"/>
          </ac:spMkLst>
        </pc:spChg>
        <pc:spChg chg="mod">
          <ac:chgData name="zhang hui" userId="7090c9456b8cb81b" providerId="LiveId" clId="{B8890080-190D-47FD-A1DB-C0B8AD630777}" dt="2020-08-04T15:14:15.049" v="900" actId="1076"/>
          <ac:spMkLst>
            <pc:docMk/>
            <pc:sldMk cId="2802138345" sldId="297"/>
            <ac:spMk id="97" creationId="{E78349D6-975A-4E12-A46A-017F5A6295E3}"/>
          </ac:spMkLst>
        </pc:spChg>
        <pc:grpChg chg="mod">
          <ac:chgData name="zhang hui" userId="7090c9456b8cb81b" providerId="LiveId" clId="{B8890080-190D-47FD-A1DB-C0B8AD630777}" dt="2020-08-04T15:14:15.049" v="900" actId="1076"/>
          <ac:grpSpMkLst>
            <pc:docMk/>
            <pc:sldMk cId="2802138345" sldId="297"/>
            <ac:grpSpMk id="14" creationId="{1307CA45-D8F0-4C3D-ACF2-B9EB2789E368}"/>
          </ac:grpSpMkLst>
        </pc:grpChg>
        <pc:grpChg chg="mod">
          <ac:chgData name="zhang hui" userId="7090c9456b8cb81b" providerId="LiveId" clId="{B8890080-190D-47FD-A1DB-C0B8AD630777}" dt="2020-08-04T15:14:15.049" v="900" actId="1076"/>
          <ac:grpSpMkLst>
            <pc:docMk/>
            <pc:sldMk cId="2802138345" sldId="297"/>
            <ac:grpSpMk id="18" creationId="{795EED5C-19A9-4180-9CFE-4D66CE5EBF3F}"/>
          </ac:grpSpMkLst>
        </pc:grpChg>
        <pc:graphicFrameChg chg="mod">
          <ac:chgData name="zhang hui" userId="7090c9456b8cb81b" providerId="LiveId" clId="{B8890080-190D-47FD-A1DB-C0B8AD630777}" dt="2020-08-04T15:14:15.049" v="900" actId="1076"/>
          <ac:graphicFrameMkLst>
            <pc:docMk/>
            <pc:sldMk cId="2802138345" sldId="297"/>
            <ac:graphicFrameMk id="2" creationId="{70C7D262-2D71-4A5F-ACBD-94F5DEFB11B4}"/>
          </ac:graphicFrameMkLst>
        </pc:graphicFrameChg>
        <pc:graphicFrameChg chg="mod">
          <ac:chgData name="zhang hui" userId="7090c9456b8cb81b" providerId="LiveId" clId="{B8890080-190D-47FD-A1DB-C0B8AD630777}" dt="2020-08-04T15:14:15.049" v="900" actId="1076"/>
          <ac:graphicFrameMkLst>
            <pc:docMk/>
            <pc:sldMk cId="2802138345" sldId="297"/>
            <ac:graphicFrameMk id="21" creationId="{8454891F-A700-4A19-A24F-6C0922AFF300}"/>
          </ac:graphicFrameMkLst>
        </pc:graphicFrameChg>
        <pc:graphicFrameChg chg="mod">
          <ac:chgData name="zhang hui" userId="7090c9456b8cb81b" providerId="LiveId" clId="{B8890080-190D-47FD-A1DB-C0B8AD630777}" dt="2020-08-04T15:14:15.049" v="900" actId="1076"/>
          <ac:graphicFrameMkLst>
            <pc:docMk/>
            <pc:sldMk cId="2802138345" sldId="297"/>
            <ac:graphicFrameMk id="82" creationId="{73B27F39-9118-4910-AAA1-CE8BBFD2390C}"/>
          </ac:graphicFrameMkLst>
        </pc:graphicFrameChg>
      </pc:sldChg>
      <pc:sldChg chg="addSp delSp modSp mod">
        <pc:chgData name="zhang hui" userId="7090c9456b8cb81b" providerId="LiveId" clId="{B8890080-190D-47FD-A1DB-C0B8AD630777}" dt="2020-08-04T15:02:34.436" v="88" actId="20577"/>
        <pc:sldMkLst>
          <pc:docMk/>
          <pc:sldMk cId="2592613582" sldId="302"/>
        </pc:sldMkLst>
        <pc:spChg chg="add del mod">
          <ac:chgData name="zhang hui" userId="7090c9456b8cb81b" providerId="LiveId" clId="{B8890080-190D-47FD-A1DB-C0B8AD630777}" dt="2020-08-04T15:02:34.436" v="88" actId="20577"/>
          <ac:spMkLst>
            <pc:docMk/>
            <pc:sldMk cId="2592613582" sldId="302"/>
            <ac:spMk id="81" creationId="{1DFD81D9-0A68-41A1-B55D-DB9D48F65573}"/>
          </ac:spMkLst>
        </pc:spChg>
        <pc:spChg chg="add del mod">
          <ac:chgData name="zhang hui" userId="7090c9456b8cb81b" providerId="LiveId" clId="{B8890080-190D-47FD-A1DB-C0B8AD630777}" dt="2020-08-04T15:00:43.251" v="5"/>
          <ac:spMkLst>
            <pc:docMk/>
            <pc:sldMk cId="2592613582" sldId="302"/>
            <ac:spMk id="91" creationId="{8E3C62EE-EBD6-4502-9594-6933AC0F3F9B}"/>
          </ac:spMkLst>
        </pc:spChg>
        <pc:spChg chg="add del mod">
          <ac:chgData name="zhang hui" userId="7090c9456b8cb81b" providerId="LiveId" clId="{B8890080-190D-47FD-A1DB-C0B8AD630777}" dt="2020-08-04T15:00:48.158" v="7"/>
          <ac:spMkLst>
            <pc:docMk/>
            <pc:sldMk cId="2592613582" sldId="302"/>
            <ac:spMk id="92" creationId="{7306045E-D56C-4091-AFDA-8BBA3AAF006A}"/>
          </ac:spMkLst>
        </pc:spChg>
        <pc:picChg chg="add del">
          <ac:chgData name="zhang hui" userId="7090c9456b8cb81b" providerId="LiveId" clId="{B8890080-190D-47FD-A1DB-C0B8AD630777}" dt="2020-08-04T15:00:49.560" v="9"/>
          <ac:picMkLst>
            <pc:docMk/>
            <pc:sldMk cId="2592613582" sldId="302"/>
            <ac:picMk id="35" creationId="{D2BF5D4D-F9DF-4820-8516-A5A238988142}"/>
          </ac:picMkLst>
        </pc:picChg>
      </pc:sldChg>
      <pc:sldChg chg="addSp modSp mod">
        <pc:chgData name="zhang hui" userId="7090c9456b8cb81b" providerId="LiveId" clId="{B8890080-190D-47FD-A1DB-C0B8AD630777}" dt="2020-08-04T15:27:22.186" v="1602" actId="1036"/>
        <pc:sldMkLst>
          <pc:docMk/>
          <pc:sldMk cId="1064264200" sldId="312"/>
        </pc:sldMkLst>
        <pc:spChg chg="add mod">
          <ac:chgData name="zhang hui" userId="7090c9456b8cb81b" providerId="LiveId" clId="{B8890080-190D-47FD-A1DB-C0B8AD630777}" dt="2020-08-04T15:27:22.186" v="1602" actId="1036"/>
          <ac:spMkLst>
            <pc:docMk/>
            <pc:sldMk cId="1064264200" sldId="312"/>
            <ac:spMk id="71" creationId="{DCE9DDF9-B729-4F52-80C0-15A0AC9C4755}"/>
          </ac:spMkLst>
        </pc:spChg>
        <pc:spChg chg="add mod">
          <ac:chgData name="zhang hui" userId="7090c9456b8cb81b" providerId="LiveId" clId="{B8890080-190D-47FD-A1DB-C0B8AD630777}" dt="2020-08-04T15:24:12.326" v="1384" actId="1076"/>
          <ac:spMkLst>
            <pc:docMk/>
            <pc:sldMk cId="1064264200" sldId="312"/>
            <ac:spMk id="72" creationId="{0E95158D-7BDC-47B5-9158-3230AF5839CC}"/>
          </ac:spMkLst>
        </pc:spChg>
        <pc:spChg chg="add mod">
          <ac:chgData name="zhang hui" userId="7090c9456b8cb81b" providerId="LiveId" clId="{B8890080-190D-47FD-A1DB-C0B8AD630777}" dt="2020-08-04T15:24:21.761" v="1418" actId="1037"/>
          <ac:spMkLst>
            <pc:docMk/>
            <pc:sldMk cId="1064264200" sldId="312"/>
            <ac:spMk id="73" creationId="{BE1A2F87-020F-490F-A626-626D258E06B8}"/>
          </ac:spMkLst>
        </pc:spChg>
        <pc:spChg chg="add mod">
          <ac:chgData name="zhang hui" userId="7090c9456b8cb81b" providerId="LiveId" clId="{B8890080-190D-47FD-A1DB-C0B8AD630777}" dt="2020-08-04T15:24:25.897" v="1439" actId="1038"/>
          <ac:spMkLst>
            <pc:docMk/>
            <pc:sldMk cId="1064264200" sldId="312"/>
            <ac:spMk id="74" creationId="{AF857D22-D0C6-4994-8028-33D8B4BAF262}"/>
          </ac:spMkLst>
        </pc:spChg>
      </pc:sldChg>
      <pc:sldChg chg="addSp modSp mod">
        <pc:chgData name="zhang hui" userId="7090c9456b8cb81b" providerId="LiveId" clId="{B8890080-190D-47FD-A1DB-C0B8AD630777}" dt="2020-08-04T15:13:57.179" v="895" actId="20577"/>
        <pc:sldMkLst>
          <pc:docMk/>
          <pc:sldMk cId="1365617920" sldId="313"/>
        </pc:sldMkLst>
        <pc:spChg chg="add mod">
          <ac:chgData name="zhang hui" userId="7090c9456b8cb81b" providerId="LiveId" clId="{B8890080-190D-47FD-A1DB-C0B8AD630777}" dt="2020-08-04T15:13:57.179" v="895" actId="20577"/>
          <ac:spMkLst>
            <pc:docMk/>
            <pc:sldMk cId="1365617920" sldId="313"/>
            <ac:spMk id="52" creationId="{9AFBF97A-E4CE-442C-998B-438F753A456D}"/>
          </ac:spMkLst>
        </pc:spChg>
      </pc:sldChg>
      <pc:sldChg chg="addSp modSp mod">
        <pc:chgData name="zhang hui" userId="7090c9456b8cb81b" providerId="LiveId" clId="{B8890080-190D-47FD-A1DB-C0B8AD630777}" dt="2020-08-04T15:23:03.108" v="1355" actId="20577"/>
        <pc:sldMkLst>
          <pc:docMk/>
          <pc:sldMk cId="4035117534" sldId="315"/>
        </pc:sldMkLst>
        <pc:spChg chg="mod">
          <ac:chgData name="zhang hui" userId="7090c9456b8cb81b" providerId="LiveId" clId="{B8890080-190D-47FD-A1DB-C0B8AD630777}" dt="2020-08-04T15:23:03.108" v="1355" actId="20577"/>
          <ac:spMkLst>
            <pc:docMk/>
            <pc:sldMk cId="4035117534" sldId="315"/>
            <ac:spMk id="51" creationId="{30B0BFF0-CA14-4B54-9B6C-E0F4278544F1}"/>
          </ac:spMkLst>
        </pc:spChg>
        <pc:spChg chg="add mod">
          <ac:chgData name="zhang hui" userId="7090c9456b8cb81b" providerId="LiveId" clId="{B8890080-190D-47FD-A1DB-C0B8AD630777}" dt="2020-08-04T15:22:38.051" v="1340" actId="1035"/>
          <ac:spMkLst>
            <pc:docMk/>
            <pc:sldMk cId="4035117534" sldId="315"/>
            <ac:spMk id="52" creationId="{C934FF7E-9418-44F1-BDFD-21DECBFA465E}"/>
          </ac:spMkLst>
        </pc:spChg>
        <pc:spChg chg="add mod">
          <ac:chgData name="zhang hui" userId="7090c9456b8cb81b" providerId="LiveId" clId="{B8890080-190D-47FD-A1DB-C0B8AD630777}" dt="2020-08-04T15:22:42.256" v="1342" actId="20577"/>
          <ac:spMkLst>
            <pc:docMk/>
            <pc:sldMk cId="4035117534" sldId="315"/>
            <ac:spMk id="53" creationId="{20AACDC7-B3B5-4387-9760-E90672160F00}"/>
          </ac:spMkLst>
        </pc:spChg>
      </pc:sldChg>
      <pc:sldChg chg="addSp modSp mod">
        <pc:chgData name="zhang hui" userId="7090c9456b8cb81b" providerId="LiveId" clId="{B8890080-190D-47FD-A1DB-C0B8AD630777}" dt="2020-08-04T15:23:30.646" v="1369" actId="20577"/>
        <pc:sldMkLst>
          <pc:docMk/>
          <pc:sldMk cId="2973589482" sldId="316"/>
        </pc:sldMkLst>
        <pc:spChg chg="mod">
          <ac:chgData name="zhang hui" userId="7090c9456b8cb81b" providerId="LiveId" clId="{B8890080-190D-47FD-A1DB-C0B8AD630777}" dt="2020-08-04T15:23:30.646" v="1369" actId="20577"/>
          <ac:spMkLst>
            <pc:docMk/>
            <pc:sldMk cId="2973589482" sldId="316"/>
            <ac:spMk id="51" creationId="{2371A6A2-1A3E-4D10-A6C9-19B28EF42094}"/>
          </ac:spMkLst>
        </pc:spChg>
        <pc:spChg chg="add mod">
          <ac:chgData name="zhang hui" userId="7090c9456b8cb81b" providerId="LiveId" clId="{B8890080-190D-47FD-A1DB-C0B8AD630777}" dt="2020-08-04T15:23:11.363" v="1356"/>
          <ac:spMkLst>
            <pc:docMk/>
            <pc:sldMk cId="2973589482" sldId="316"/>
            <ac:spMk id="52" creationId="{8915D3C2-6437-4464-8AD8-FD3ED8225623}"/>
          </ac:spMkLst>
        </pc:spChg>
        <pc:spChg chg="add mod">
          <ac:chgData name="zhang hui" userId="7090c9456b8cb81b" providerId="LiveId" clId="{B8890080-190D-47FD-A1DB-C0B8AD630777}" dt="2020-08-04T15:23:11.363" v="1356"/>
          <ac:spMkLst>
            <pc:docMk/>
            <pc:sldMk cId="2973589482" sldId="316"/>
            <ac:spMk id="53" creationId="{5AF2E80F-E574-48A0-AE0C-73C98CA5E37E}"/>
          </ac:spMkLst>
        </pc:spChg>
      </pc:sldChg>
      <pc:sldChg chg="addSp modSp mod">
        <pc:chgData name="zhang hui" userId="7090c9456b8cb81b" providerId="LiveId" clId="{B8890080-190D-47FD-A1DB-C0B8AD630777}" dt="2020-08-04T15:05:08.371" v="331" actId="20577"/>
        <pc:sldMkLst>
          <pc:docMk/>
          <pc:sldMk cId="2411770849" sldId="318"/>
        </pc:sldMkLst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0" creationId="{832C4925-B90D-4601-B42A-7341932A6423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1" creationId="{C0987F41-FFE4-48A2-9AFD-F1010D28268E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2" creationId="{33FD3B3A-BD82-41C8-8077-E6FAA5AE7D41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3" creationId="{9F1A4BDE-82E7-46F3-8C8C-46A7FD976D44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4" creationId="{C65645F9-A8D5-4C59-8876-CBF48680B550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5" creationId="{0A1CF85F-A108-4028-A803-3B3FFA6078EA}"/>
          </ac:spMkLst>
        </pc:spChg>
        <pc:spChg chg="mod">
          <ac:chgData name="zhang hui" userId="7090c9456b8cb81b" providerId="LiveId" clId="{B8890080-190D-47FD-A1DB-C0B8AD630777}" dt="2020-08-04T15:02:44.378" v="89" actId="1076"/>
          <ac:spMkLst>
            <pc:docMk/>
            <pc:sldMk cId="2411770849" sldId="318"/>
            <ac:spMk id="16" creationId="{389534D1-62E1-48AF-82B8-DA6259F1E5FF}"/>
          </ac:spMkLst>
        </pc:spChg>
        <pc:spChg chg="add mod">
          <ac:chgData name="zhang hui" userId="7090c9456b8cb81b" providerId="LiveId" clId="{B8890080-190D-47FD-A1DB-C0B8AD630777}" dt="2020-08-04T15:05:08.371" v="331" actId="20577"/>
          <ac:spMkLst>
            <pc:docMk/>
            <pc:sldMk cId="2411770849" sldId="318"/>
            <ac:spMk id="17" creationId="{542A755A-E663-47F1-BE71-882416967A9E}"/>
          </ac:spMkLst>
        </pc:sp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3" creationId="{62AE9B9E-6C90-4ECA-9BDC-5EC4705DA4AE}"/>
          </ac:picMkLst>
        </pc:pic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4" creationId="{AD72EA08-F53C-4F16-A44F-125B1F64ADE1}"/>
          </ac:picMkLst>
        </pc:pic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5" creationId="{AC54623F-9F51-4754-9280-34E10CC71E99}"/>
          </ac:picMkLst>
        </pc:pic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6" creationId="{18975464-8002-40CF-8E58-F51691158C9D}"/>
          </ac:picMkLst>
        </pc:pic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7" creationId="{25C9FC50-799F-4106-8148-3A78E0BFC610}"/>
          </ac:picMkLst>
        </pc:picChg>
        <pc:picChg chg="mod">
          <ac:chgData name="zhang hui" userId="7090c9456b8cb81b" providerId="LiveId" clId="{B8890080-190D-47FD-A1DB-C0B8AD630777}" dt="2020-08-04T15:02:44.378" v="89" actId="1076"/>
          <ac:picMkLst>
            <pc:docMk/>
            <pc:sldMk cId="2411770849" sldId="318"/>
            <ac:picMk id="8" creationId="{C430B85C-70BA-4807-98C6-75626C7A5D70}"/>
          </ac:picMkLst>
        </pc:picChg>
        <pc:cxnChg chg="mod">
          <ac:chgData name="zhang hui" userId="7090c9456b8cb81b" providerId="LiveId" clId="{B8890080-190D-47FD-A1DB-C0B8AD630777}" dt="2020-08-04T15:02:44.378" v="89" actId="1076"/>
          <ac:cxnSpMkLst>
            <pc:docMk/>
            <pc:sldMk cId="2411770849" sldId="318"/>
            <ac:cxnSpMk id="9" creationId="{116F8F1A-AC11-4DCF-86A1-28997DD391AD}"/>
          </ac:cxnSpMkLst>
        </pc:cxnChg>
      </pc:sldChg>
      <pc:sldChg chg="addSp delSp modSp mod">
        <pc:chgData name="zhang hui" userId="7090c9456b8cb81b" providerId="LiveId" clId="{B8890080-190D-47FD-A1DB-C0B8AD630777}" dt="2020-08-04T15:10:35.893" v="563" actId="20577"/>
        <pc:sldMkLst>
          <pc:docMk/>
          <pc:sldMk cId="3984070681" sldId="319"/>
        </pc:sldMkLst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3" creationId="{BF9A1029-FC3C-4428-8E1F-2A5CE445BA4D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4" creationId="{48879F17-2B2A-4F4F-8DD1-29C62D04EA38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5" creationId="{57BFEB8F-AC3B-45BE-AFB0-1698C6032522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6" creationId="{CA8C8824-7755-4D7B-BD7C-4410EA826F1D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7" creationId="{6F99CBF0-DA68-4D64-AA85-CF3F66538F10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8" creationId="{4F6C47AD-66FD-44D3-9463-A8D6BECACE7B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9" creationId="{EFE2481E-B421-4590-B8F0-FFE661B74EA9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0" creationId="{CF01CA44-13F3-48F6-9675-9483435E61AF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1" creationId="{525AE745-7EC0-4825-BC10-8705045614CC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2" creationId="{AB2705E9-BCF2-40E8-A460-FBEFE6FE2979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3" creationId="{4467061D-17B2-4AC0-8909-CD4C69C6EAE6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4" creationId="{D4CA22E6-D34D-4721-A930-5EC3EFC4008F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5" creationId="{EFF1D76A-1FC1-4AB9-800E-CF171C722F34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6" creationId="{21193397-91AA-4A32-A637-AAEDC37913C0}"/>
          </ac:spMkLst>
        </pc:spChg>
        <pc:spChg chg="mod">
          <ac:chgData name="zhang hui" userId="7090c9456b8cb81b" providerId="LiveId" clId="{B8890080-190D-47FD-A1DB-C0B8AD630777}" dt="2020-08-04T15:05:35.603" v="338" actId="1076"/>
          <ac:spMkLst>
            <pc:docMk/>
            <pc:sldMk cId="3984070681" sldId="319"/>
            <ac:spMk id="17" creationId="{EF601FDE-FB1C-498C-BF22-A770934A20A4}"/>
          </ac:spMkLst>
        </pc:spChg>
        <pc:spChg chg="add mod">
          <ac:chgData name="zhang hui" userId="7090c9456b8cb81b" providerId="LiveId" clId="{B8890080-190D-47FD-A1DB-C0B8AD630777}" dt="2020-08-04T15:10:35.893" v="563" actId="20577"/>
          <ac:spMkLst>
            <pc:docMk/>
            <pc:sldMk cId="3984070681" sldId="319"/>
            <ac:spMk id="19" creationId="{235B5D32-55CC-42F9-8FF8-3BD9CEF16908}"/>
          </ac:spMkLst>
        </pc:spChg>
        <pc:graphicFrameChg chg="add del mod">
          <ac:chgData name="zhang hui" userId="7090c9456b8cb81b" providerId="LiveId" clId="{B8890080-190D-47FD-A1DB-C0B8AD630777}" dt="2020-08-04T15:05:35.603" v="338" actId="1076"/>
          <ac:graphicFrameMkLst>
            <pc:docMk/>
            <pc:sldMk cId="3984070681" sldId="319"/>
            <ac:graphicFrameMk id="2" creationId="{ECAF0B23-33C6-4B07-8559-93C9BDF5A2DF}"/>
          </ac:graphicFrameMkLst>
        </pc:graphicFrameChg>
      </pc:sldChg>
      <pc:sldChg chg="addSp modSp mod">
        <pc:chgData name="zhang hui" userId="7090c9456b8cb81b" providerId="LiveId" clId="{B8890080-190D-47FD-A1DB-C0B8AD630777}" dt="2020-08-04T15:29:10.498" v="1768" actId="20577"/>
        <pc:sldMkLst>
          <pc:docMk/>
          <pc:sldMk cId="349195905" sldId="320"/>
        </pc:sldMkLst>
        <pc:spChg chg="add mod">
          <ac:chgData name="zhang hui" userId="7090c9456b8cb81b" providerId="LiveId" clId="{B8890080-190D-47FD-A1DB-C0B8AD630777}" dt="2020-08-04T15:29:10.498" v="1768" actId="20577"/>
          <ac:spMkLst>
            <pc:docMk/>
            <pc:sldMk cId="349195905" sldId="320"/>
            <ac:spMk id="99" creationId="{3250F840-EC4A-4F55-8E8F-E27A7474DE0E}"/>
          </ac:spMkLst>
        </pc:spChg>
        <pc:grpChg chg="mod">
          <ac:chgData name="zhang hui" userId="7090c9456b8cb81b" providerId="LiveId" clId="{B8890080-190D-47FD-A1DB-C0B8AD630777}" dt="2020-08-04T15:27:13.156" v="1572" actId="1035"/>
          <ac:grpSpMkLst>
            <pc:docMk/>
            <pc:sldMk cId="349195905" sldId="320"/>
            <ac:grpSpMk id="76" creationId="{AAF9656E-D802-45BC-BF3E-D23915DD39DA}"/>
          </ac:grpSpMkLst>
        </pc:grpChg>
        <pc:grpChg chg="mod">
          <ac:chgData name="zhang hui" userId="7090c9456b8cb81b" providerId="LiveId" clId="{B8890080-190D-47FD-A1DB-C0B8AD630777}" dt="2020-08-04T15:27:13.156" v="1572" actId="1035"/>
          <ac:grpSpMkLst>
            <pc:docMk/>
            <pc:sldMk cId="349195905" sldId="320"/>
            <ac:grpSpMk id="77" creationId="{992AB50E-C5FF-4711-80D7-2FD26E7D235B}"/>
          </ac:grpSpMkLst>
        </pc:grpChg>
        <pc:grpChg chg="mod">
          <ac:chgData name="zhang hui" userId="7090c9456b8cb81b" providerId="LiveId" clId="{B8890080-190D-47FD-A1DB-C0B8AD630777}" dt="2020-08-04T15:27:13.156" v="1572" actId="1035"/>
          <ac:grpSpMkLst>
            <pc:docMk/>
            <pc:sldMk cId="349195905" sldId="320"/>
            <ac:grpSpMk id="78" creationId="{7C11C276-BD4B-4AEA-B16C-9C677DE7CC9C}"/>
          </ac:grpSpMkLst>
        </pc:grpChg>
        <pc:grpChg chg="mod">
          <ac:chgData name="zhang hui" userId="7090c9456b8cb81b" providerId="LiveId" clId="{B8890080-190D-47FD-A1DB-C0B8AD630777}" dt="2020-08-04T15:27:13.156" v="1572" actId="1035"/>
          <ac:grpSpMkLst>
            <pc:docMk/>
            <pc:sldMk cId="349195905" sldId="320"/>
            <ac:grpSpMk id="79" creationId="{4FA7D103-6CA2-4574-A70E-8E878D286699}"/>
          </ac:grpSpMkLst>
        </pc:grpChg>
        <pc:grpChg chg="mod">
          <ac:chgData name="zhang hui" userId="7090c9456b8cb81b" providerId="LiveId" clId="{B8890080-190D-47FD-A1DB-C0B8AD630777}" dt="2020-08-04T15:27:13.156" v="1572" actId="1035"/>
          <ac:grpSpMkLst>
            <pc:docMk/>
            <pc:sldMk cId="349195905" sldId="320"/>
            <ac:grpSpMk id="80" creationId="{88F5B028-7826-490C-B558-D1D29D24EE38}"/>
          </ac:grpSpMkLst>
        </pc:grpChg>
        <pc:graphicFrameChg chg="mod">
          <ac:chgData name="zhang hui" userId="7090c9456b8cb81b" providerId="LiveId" clId="{B8890080-190D-47FD-A1DB-C0B8AD630777}" dt="2020-08-04T15:26:54.207" v="1549" actId="1076"/>
          <ac:graphicFrameMkLst>
            <pc:docMk/>
            <pc:sldMk cId="349195905" sldId="320"/>
            <ac:graphicFrameMk id="25" creationId="{0CCF3A1D-3379-44B8-A490-5315E5F3EFA9}"/>
          </ac:graphicFrameMkLst>
        </pc:graphicFrameChg>
        <pc:graphicFrameChg chg="mod">
          <ac:chgData name="zhang hui" userId="7090c9456b8cb81b" providerId="LiveId" clId="{B8890080-190D-47FD-A1DB-C0B8AD630777}" dt="2020-08-04T15:26:58.247" v="1551" actId="1076"/>
          <ac:graphicFrameMkLst>
            <pc:docMk/>
            <pc:sldMk cId="349195905" sldId="320"/>
            <ac:graphicFrameMk id="42" creationId="{7AD81AB7-E46F-45E1-A747-42CD245A0DAD}"/>
          </ac:graphicFrameMkLst>
        </pc:graphicFrameChg>
        <pc:graphicFrameChg chg="mod">
          <ac:chgData name="zhang hui" userId="7090c9456b8cb81b" providerId="LiveId" clId="{B8890080-190D-47FD-A1DB-C0B8AD630777}" dt="2020-08-04T15:27:06.295" v="1553" actId="1076"/>
          <ac:graphicFrameMkLst>
            <pc:docMk/>
            <pc:sldMk cId="349195905" sldId="320"/>
            <ac:graphicFrameMk id="59" creationId="{AD197E73-A943-4A6F-974F-790CCC03D3DF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dministrator\Desktop\ASH-2019\190213GATA3GenotypingZH-2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1D7-44E8-B7A3-2393AD220F1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1D7-44E8-B7A3-2393AD220F1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1D7-44E8-B7A3-2393AD220F17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en-US"/>
                      <a:t>9.4</a:t>
                    </a:r>
                    <a:endParaRPr lang="en-US" alt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D1D7-44E8-B7A3-2393AD220F17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en-US"/>
                      <a:t>6.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D1D7-44E8-B7A3-2393AD220F17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en-US"/>
                      <a:t>7.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D1D7-44E8-B7A3-2393AD220F1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heet5!$AG$9:$AG$11</c:f>
              <c:strCache>
                <c:ptCount val="3"/>
                <c:pt idx="0">
                  <c:v>AA</c:v>
                </c:pt>
                <c:pt idx="1">
                  <c:v>AC</c:v>
                </c:pt>
                <c:pt idx="2">
                  <c:v>CC</c:v>
                </c:pt>
              </c:strCache>
            </c:strRef>
          </c:cat>
          <c:val>
            <c:numRef>
              <c:f>Sheet5!$AL$9:$AL$11</c:f>
              <c:numCache>
                <c:formatCode>General</c:formatCode>
                <c:ptCount val="3"/>
                <c:pt idx="0">
                  <c:v>9.3750000000000266</c:v>
                </c:pt>
                <c:pt idx="1">
                  <c:v>6.8702290076336103</c:v>
                </c:pt>
                <c:pt idx="2">
                  <c:v>7.2727272727272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1D7-44E8-B7A3-2393AD220F1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44941312"/>
        <c:axId val="44942848"/>
      </c:barChart>
      <c:catAx>
        <c:axId val="449413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4942848"/>
        <c:crosses val="autoZero"/>
        <c:auto val="1"/>
        <c:lblAlgn val="ctr"/>
        <c:lblOffset val="100"/>
        <c:noMultiLvlLbl val="0"/>
      </c:catAx>
      <c:valAx>
        <c:axId val="44942848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4941312"/>
        <c:crosses val="autoZero"/>
        <c:crossBetween val="between"/>
        <c:majorUnit val="3"/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BA8EF-7409-4076-A6BA-0AEC53BBEC88}" type="datetimeFigureOut">
              <a:rPr lang="zh-CN" altLang="en-US" smtClean="0"/>
              <a:pPr/>
              <a:t>2021/4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685800"/>
            <a:ext cx="5422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363124-5F09-4A39-AA8D-B409A0BCF58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1pPr>
    <a:lvl2pPr marL="544248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2pPr>
    <a:lvl3pPr marL="1088495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3pPr>
    <a:lvl4pPr marL="1632744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4pPr>
    <a:lvl5pPr marL="2176992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5pPr>
    <a:lvl6pPr marL="2721239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6pPr>
    <a:lvl7pPr marL="3265487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7pPr>
    <a:lvl8pPr marL="3809736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8pPr>
    <a:lvl9pPr marL="4353983" algn="l" defTabSz="1088495" rtl="0" eaLnBrk="1" latinLnBrk="0" hangingPunct="1">
      <a:defRPr sz="142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363124-5F09-4A39-AA8D-B409A0BCF58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59319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363124-5F09-4A39-AA8D-B409A0BCF584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8113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8849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correlation of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GATA3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enotype with MRD level among CCCG-ALL-2015 and GD-ALL-2008 study cohorts.</a:t>
            </a:r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363124-5F09-4A39-AA8D-B409A0BCF584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5703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363124-5F09-4A39-AA8D-B409A0BCF584}" type="slidenum">
              <a:rPr lang="zh-CN" altLang="en-US" smtClean="0"/>
              <a:pPr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9871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363124-5F09-4A39-AA8D-B409A0BCF584}" type="slidenum">
              <a:rPr lang="zh-CN" altLang="en-US" smtClean="0"/>
              <a:pPr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4568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36924" y="1437508"/>
            <a:ext cx="10421541" cy="3058007"/>
          </a:xfrm>
        </p:spPr>
        <p:txBody>
          <a:bodyPr anchor="b"/>
          <a:lstStyle>
            <a:lvl1pPr algn="ctr">
              <a:defRPr sz="68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36924" y="4613444"/>
            <a:ext cx="10421541" cy="2120679"/>
          </a:xfrm>
        </p:spPr>
        <p:txBody>
          <a:bodyPr/>
          <a:lstStyle>
            <a:lvl1pPr marL="0" indent="0" algn="ctr">
              <a:buNone/>
              <a:defRPr sz="2735"/>
            </a:lvl1pPr>
            <a:lvl2pPr marL="521071" indent="0" algn="ctr">
              <a:buNone/>
              <a:defRPr sz="2279"/>
            </a:lvl2pPr>
            <a:lvl3pPr marL="1042142" indent="0" algn="ctr">
              <a:buNone/>
              <a:defRPr sz="2051"/>
            </a:lvl3pPr>
            <a:lvl4pPr marL="1563213" indent="0" algn="ctr">
              <a:buNone/>
              <a:defRPr sz="1824"/>
            </a:lvl4pPr>
            <a:lvl5pPr marL="2084283" indent="0" algn="ctr">
              <a:buNone/>
              <a:defRPr sz="1824"/>
            </a:lvl5pPr>
            <a:lvl6pPr marL="2605354" indent="0" algn="ctr">
              <a:buNone/>
              <a:defRPr sz="1824"/>
            </a:lvl6pPr>
            <a:lvl7pPr marL="3126425" indent="0" algn="ctr">
              <a:buNone/>
              <a:defRPr sz="1824"/>
            </a:lvl7pPr>
            <a:lvl8pPr marL="3647496" indent="0" algn="ctr">
              <a:buNone/>
              <a:defRPr sz="1824"/>
            </a:lvl8pPr>
            <a:lvl9pPr marL="4168567" indent="0" algn="ctr">
              <a:buNone/>
              <a:defRPr sz="182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193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58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43887" y="467647"/>
            <a:ext cx="2996193" cy="744372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55308" y="467647"/>
            <a:ext cx="8814887" cy="744372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62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8071" y="2189811"/>
            <a:ext cx="11984772" cy="3653749"/>
          </a:xfrm>
        </p:spPr>
        <p:txBody>
          <a:bodyPr anchor="b"/>
          <a:lstStyle>
            <a:lvl1pPr>
              <a:defRPr sz="68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8071" y="5878126"/>
            <a:ext cx="11984772" cy="1921420"/>
          </a:xfrm>
        </p:spPr>
        <p:txBody>
          <a:bodyPr/>
          <a:lstStyle>
            <a:lvl1pPr marL="0" indent="0">
              <a:buNone/>
              <a:defRPr sz="2735">
                <a:solidFill>
                  <a:schemeClr val="tx1">
                    <a:tint val="75000"/>
                  </a:schemeClr>
                </a:solidFill>
              </a:defRPr>
            </a:lvl1pPr>
            <a:lvl2pPr marL="521071" indent="0">
              <a:buNone/>
              <a:defRPr sz="2279">
                <a:solidFill>
                  <a:schemeClr val="tx1">
                    <a:tint val="75000"/>
                  </a:schemeClr>
                </a:solidFill>
              </a:defRPr>
            </a:lvl2pPr>
            <a:lvl3pPr marL="1042142" indent="0">
              <a:buNone/>
              <a:defRPr sz="2051">
                <a:solidFill>
                  <a:schemeClr val="tx1">
                    <a:tint val="75000"/>
                  </a:schemeClr>
                </a:solidFill>
              </a:defRPr>
            </a:lvl3pPr>
            <a:lvl4pPr marL="1563213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4pPr>
            <a:lvl5pPr marL="2084283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5pPr>
            <a:lvl6pPr marL="2605354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6pPr>
            <a:lvl7pPr marL="3126425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7pPr>
            <a:lvl8pPr marL="3647496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8pPr>
            <a:lvl9pPr marL="4168567" indent="0">
              <a:buNone/>
              <a:defRPr sz="18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41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55308" y="2338237"/>
            <a:ext cx="5905540" cy="55731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34540" y="2338237"/>
            <a:ext cx="5905540" cy="55731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135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7118" y="467648"/>
            <a:ext cx="11984772" cy="169776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7118" y="2153212"/>
            <a:ext cx="5878400" cy="1055256"/>
          </a:xfrm>
        </p:spPr>
        <p:txBody>
          <a:bodyPr anchor="b"/>
          <a:lstStyle>
            <a:lvl1pPr marL="0" indent="0">
              <a:buNone/>
              <a:defRPr sz="2735" b="1"/>
            </a:lvl1pPr>
            <a:lvl2pPr marL="521071" indent="0">
              <a:buNone/>
              <a:defRPr sz="2279" b="1"/>
            </a:lvl2pPr>
            <a:lvl3pPr marL="1042142" indent="0">
              <a:buNone/>
              <a:defRPr sz="2051" b="1"/>
            </a:lvl3pPr>
            <a:lvl4pPr marL="1563213" indent="0">
              <a:buNone/>
              <a:defRPr sz="1824" b="1"/>
            </a:lvl4pPr>
            <a:lvl5pPr marL="2084283" indent="0">
              <a:buNone/>
              <a:defRPr sz="1824" b="1"/>
            </a:lvl5pPr>
            <a:lvl6pPr marL="2605354" indent="0">
              <a:buNone/>
              <a:defRPr sz="1824" b="1"/>
            </a:lvl6pPr>
            <a:lvl7pPr marL="3126425" indent="0">
              <a:buNone/>
              <a:defRPr sz="1824" b="1"/>
            </a:lvl7pPr>
            <a:lvl8pPr marL="3647496" indent="0">
              <a:buNone/>
              <a:defRPr sz="1824" b="1"/>
            </a:lvl8pPr>
            <a:lvl9pPr marL="4168567" indent="0">
              <a:buNone/>
              <a:defRPr sz="182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57118" y="3208468"/>
            <a:ext cx="5878400" cy="47191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034540" y="2153212"/>
            <a:ext cx="5907350" cy="1055256"/>
          </a:xfrm>
        </p:spPr>
        <p:txBody>
          <a:bodyPr anchor="b"/>
          <a:lstStyle>
            <a:lvl1pPr marL="0" indent="0">
              <a:buNone/>
              <a:defRPr sz="2735" b="1"/>
            </a:lvl1pPr>
            <a:lvl2pPr marL="521071" indent="0">
              <a:buNone/>
              <a:defRPr sz="2279" b="1"/>
            </a:lvl2pPr>
            <a:lvl3pPr marL="1042142" indent="0">
              <a:buNone/>
              <a:defRPr sz="2051" b="1"/>
            </a:lvl3pPr>
            <a:lvl4pPr marL="1563213" indent="0">
              <a:buNone/>
              <a:defRPr sz="1824" b="1"/>
            </a:lvl4pPr>
            <a:lvl5pPr marL="2084283" indent="0">
              <a:buNone/>
              <a:defRPr sz="1824" b="1"/>
            </a:lvl5pPr>
            <a:lvl6pPr marL="2605354" indent="0">
              <a:buNone/>
              <a:defRPr sz="1824" b="1"/>
            </a:lvl6pPr>
            <a:lvl7pPr marL="3126425" indent="0">
              <a:buNone/>
              <a:defRPr sz="1824" b="1"/>
            </a:lvl7pPr>
            <a:lvl8pPr marL="3647496" indent="0">
              <a:buNone/>
              <a:defRPr sz="1824" b="1"/>
            </a:lvl8pPr>
            <a:lvl9pPr marL="4168567" indent="0">
              <a:buNone/>
              <a:defRPr sz="182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034540" y="3208468"/>
            <a:ext cx="5907350" cy="47191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27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18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75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7118" y="585576"/>
            <a:ext cx="4481624" cy="2049516"/>
          </a:xfrm>
        </p:spPr>
        <p:txBody>
          <a:bodyPr anchor="b"/>
          <a:lstStyle>
            <a:lvl1pPr>
              <a:defRPr sz="364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07350" y="1264682"/>
            <a:ext cx="7034540" cy="6242076"/>
          </a:xfrm>
        </p:spPr>
        <p:txBody>
          <a:bodyPr/>
          <a:lstStyle>
            <a:lvl1pPr>
              <a:defRPr sz="3647"/>
            </a:lvl1pPr>
            <a:lvl2pPr>
              <a:defRPr sz="3191"/>
            </a:lvl2pPr>
            <a:lvl3pPr>
              <a:defRPr sz="2735"/>
            </a:lvl3pPr>
            <a:lvl4pPr>
              <a:defRPr sz="2279"/>
            </a:lvl4pPr>
            <a:lvl5pPr>
              <a:defRPr sz="2279"/>
            </a:lvl5pPr>
            <a:lvl6pPr>
              <a:defRPr sz="2279"/>
            </a:lvl6pPr>
            <a:lvl7pPr>
              <a:defRPr sz="2279"/>
            </a:lvl7pPr>
            <a:lvl8pPr>
              <a:defRPr sz="2279"/>
            </a:lvl8pPr>
            <a:lvl9pPr>
              <a:defRPr sz="227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7118" y="2635091"/>
            <a:ext cx="4481624" cy="4881833"/>
          </a:xfrm>
        </p:spPr>
        <p:txBody>
          <a:bodyPr/>
          <a:lstStyle>
            <a:lvl1pPr marL="0" indent="0">
              <a:buNone/>
              <a:defRPr sz="1824"/>
            </a:lvl1pPr>
            <a:lvl2pPr marL="521071" indent="0">
              <a:buNone/>
              <a:defRPr sz="1596"/>
            </a:lvl2pPr>
            <a:lvl3pPr marL="1042142" indent="0">
              <a:buNone/>
              <a:defRPr sz="1368"/>
            </a:lvl3pPr>
            <a:lvl4pPr marL="1563213" indent="0">
              <a:buNone/>
              <a:defRPr sz="1140"/>
            </a:lvl4pPr>
            <a:lvl5pPr marL="2084283" indent="0">
              <a:buNone/>
              <a:defRPr sz="1140"/>
            </a:lvl5pPr>
            <a:lvl6pPr marL="2605354" indent="0">
              <a:buNone/>
              <a:defRPr sz="1140"/>
            </a:lvl6pPr>
            <a:lvl7pPr marL="3126425" indent="0">
              <a:buNone/>
              <a:defRPr sz="1140"/>
            </a:lvl7pPr>
            <a:lvl8pPr marL="3647496" indent="0">
              <a:buNone/>
              <a:defRPr sz="1140"/>
            </a:lvl8pPr>
            <a:lvl9pPr marL="4168567" indent="0">
              <a:buNone/>
              <a:defRPr sz="11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17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7118" y="585576"/>
            <a:ext cx="4481624" cy="2049516"/>
          </a:xfrm>
        </p:spPr>
        <p:txBody>
          <a:bodyPr anchor="b"/>
          <a:lstStyle>
            <a:lvl1pPr>
              <a:defRPr sz="364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907350" y="1264682"/>
            <a:ext cx="7034540" cy="6242076"/>
          </a:xfrm>
        </p:spPr>
        <p:txBody>
          <a:bodyPr anchor="t"/>
          <a:lstStyle>
            <a:lvl1pPr marL="0" indent="0">
              <a:buNone/>
              <a:defRPr sz="3647"/>
            </a:lvl1pPr>
            <a:lvl2pPr marL="521071" indent="0">
              <a:buNone/>
              <a:defRPr sz="3191"/>
            </a:lvl2pPr>
            <a:lvl3pPr marL="1042142" indent="0">
              <a:buNone/>
              <a:defRPr sz="2735"/>
            </a:lvl3pPr>
            <a:lvl4pPr marL="1563213" indent="0">
              <a:buNone/>
              <a:defRPr sz="2279"/>
            </a:lvl4pPr>
            <a:lvl5pPr marL="2084283" indent="0">
              <a:buNone/>
              <a:defRPr sz="2279"/>
            </a:lvl5pPr>
            <a:lvl6pPr marL="2605354" indent="0">
              <a:buNone/>
              <a:defRPr sz="2279"/>
            </a:lvl6pPr>
            <a:lvl7pPr marL="3126425" indent="0">
              <a:buNone/>
              <a:defRPr sz="2279"/>
            </a:lvl7pPr>
            <a:lvl8pPr marL="3647496" indent="0">
              <a:buNone/>
              <a:defRPr sz="2279"/>
            </a:lvl8pPr>
            <a:lvl9pPr marL="4168567" indent="0">
              <a:buNone/>
              <a:defRPr sz="227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57118" y="2635091"/>
            <a:ext cx="4481624" cy="4881833"/>
          </a:xfrm>
        </p:spPr>
        <p:txBody>
          <a:bodyPr/>
          <a:lstStyle>
            <a:lvl1pPr marL="0" indent="0">
              <a:buNone/>
              <a:defRPr sz="1824"/>
            </a:lvl1pPr>
            <a:lvl2pPr marL="521071" indent="0">
              <a:buNone/>
              <a:defRPr sz="1596"/>
            </a:lvl2pPr>
            <a:lvl3pPr marL="1042142" indent="0">
              <a:buNone/>
              <a:defRPr sz="1368"/>
            </a:lvl3pPr>
            <a:lvl4pPr marL="1563213" indent="0">
              <a:buNone/>
              <a:defRPr sz="1140"/>
            </a:lvl4pPr>
            <a:lvl5pPr marL="2084283" indent="0">
              <a:buNone/>
              <a:defRPr sz="1140"/>
            </a:lvl5pPr>
            <a:lvl6pPr marL="2605354" indent="0">
              <a:buNone/>
              <a:defRPr sz="1140"/>
            </a:lvl6pPr>
            <a:lvl7pPr marL="3126425" indent="0">
              <a:buNone/>
              <a:defRPr sz="1140"/>
            </a:lvl7pPr>
            <a:lvl8pPr marL="3647496" indent="0">
              <a:buNone/>
              <a:defRPr sz="1140"/>
            </a:lvl8pPr>
            <a:lvl9pPr marL="4168567" indent="0">
              <a:buNone/>
              <a:defRPr sz="11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92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55308" y="467648"/>
            <a:ext cx="11984772" cy="16977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5308" y="2338237"/>
            <a:ext cx="11984772" cy="55731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55308" y="8141132"/>
            <a:ext cx="3126462" cy="467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8E9F4-06E2-47F5-A8A5-772B91EBE359}" type="datetimeFigureOut">
              <a:rPr lang="en-US" smtClean="0"/>
              <a:pPr/>
              <a:t>4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02848" y="8141132"/>
            <a:ext cx="4689693" cy="467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13618" y="8141132"/>
            <a:ext cx="3126462" cy="467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761C2-DF92-4D61-A07D-7B5D03EA3D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854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42142" rtl="0" eaLnBrk="1" latinLnBrk="0" hangingPunct="1">
        <a:lnSpc>
          <a:spcPct val="90000"/>
        </a:lnSpc>
        <a:spcBef>
          <a:spcPct val="0"/>
        </a:spcBef>
        <a:buNone/>
        <a:defRPr sz="50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0535" indent="-260535" algn="l" defTabSz="1042142" rtl="0" eaLnBrk="1" latinLnBrk="0" hangingPunct="1">
        <a:lnSpc>
          <a:spcPct val="90000"/>
        </a:lnSpc>
        <a:spcBef>
          <a:spcPts val="1140"/>
        </a:spcBef>
        <a:buFont typeface="Arial" panose="020B0604020202020204" pitchFamily="34" charset="0"/>
        <a:buChar char="•"/>
        <a:defRPr sz="3191" kern="1200">
          <a:solidFill>
            <a:schemeClr val="tx1"/>
          </a:solidFill>
          <a:latin typeface="+mn-lt"/>
          <a:ea typeface="+mn-ea"/>
          <a:cs typeface="+mn-cs"/>
        </a:defRPr>
      </a:lvl1pPr>
      <a:lvl2pPr marL="781606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735" kern="1200">
          <a:solidFill>
            <a:schemeClr val="tx1"/>
          </a:solidFill>
          <a:latin typeface="+mn-lt"/>
          <a:ea typeface="+mn-ea"/>
          <a:cs typeface="+mn-cs"/>
        </a:defRPr>
      </a:lvl2pPr>
      <a:lvl3pPr marL="1302677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279" kern="1200">
          <a:solidFill>
            <a:schemeClr val="tx1"/>
          </a:solidFill>
          <a:latin typeface="+mn-lt"/>
          <a:ea typeface="+mn-ea"/>
          <a:cs typeface="+mn-cs"/>
        </a:defRPr>
      </a:lvl3pPr>
      <a:lvl4pPr marL="1823748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4pPr>
      <a:lvl5pPr marL="2344819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5pPr>
      <a:lvl6pPr marL="2865890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6pPr>
      <a:lvl7pPr marL="3386960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7pPr>
      <a:lvl8pPr marL="3908031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8pPr>
      <a:lvl9pPr marL="4429102" indent="-260535" algn="l" defTabSz="1042142" rtl="0" eaLnBrk="1" latinLnBrk="0" hangingPunct="1">
        <a:lnSpc>
          <a:spcPct val="90000"/>
        </a:lnSpc>
        <a:spcBef>
          <a:spcPts val="570"/>
        </a:spcBef>
        <a:buFont typeface="Arial" panose="020B0604020202020204" pitchFamily="34" charset="0"/>
        <a:buChar char="•"/>
        <a:defRPr sz="20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1pPr>
      <a:lvl2pPr marL="521071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2pPr>
      <a:lvl3pPr marL="1042142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3pPr>
      <a:lvl4pPr marL="1563213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4pPr>
      <a:lvl5pPr marL="2084283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5pPr>
      <a:lvl6pPr marL="2605354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6pPr>
      <a:lvl7pPr marL="3126425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7pPr>
      <a:lvl8pPr marL="3647496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8pPr>
      <a:lvl9pPr marL="4168567" algn="l" defTabSz="1042142" rtl="0" eaLnBrk="1" latinLnBrk="0" hangingPunct="1">
        <a:defRPr sz="20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7" Type="http://schemas.openxmlformats.org/officeDocument/2006/relationships/image" Target="../media/image44.emf"/><Relationship Id="rId2" Type="http://schemas.openxmlformats.org/officeDocument/2006/relationships/oleObject" Target="../embeddings/oleObject3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1.bin"/><Relationship Id="rId5" Type="http://schemas.openxmlformats.org/officeDocument/2006/relationships/image" Target="../media/image43.emf"/><Relationship Id="rId4" Type="http://schemas.openxmlformats.org/officeDocument/2006/relationships/oleObject" Target="../embeddings/oleObject40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3" Type="http://schemas.openxmlformats.org/officeDocument/2006/relationships/oleObject" Target="../embeddings/oleObject42.bin"/><Relationship Id="rId7" Type="http://schemas.openxmlformats.org/officeDocument/2006/relationships/oleObject" Target="../embeddings/oleObject44.bin"/><Relationship Id="rId12" Type="http://schemas.openxmlformats.org/officeDocument/2006/relationships/image" Target="../media/image4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emf"/><Relationship Id="rId11" Type="http://schemas.openxmlformats.org/officeDocument/2006/relationships/oleObject" Target="../embeddings/oleObject46.bin"/><Relationship Id="rId5" Type="http://schemas.openxmlformats.org/officeDocument/2006/relationships/oleObject" Target="../embeddings/oleObject43.bin"/><Relationship Id="rId10" Type="http://schemas.openxmlformats.org/officeDocument/2006/relationships/image" Target="../media/image48.emf"/><Relationship Id="rId4" Type="http://schemas.openxmlformats.org/officeDocument/2006/relationships/image" Target="../media/image45.emf"/><Relationship Id="rId9" Type="http://schemas.openxmlformats.org/officeDocument/2006/relationships/oleObject" Target="../embeddings/oleObject45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16.emf"/><Relationship Id="rId26" Type="http://schemas.openxmlformats.org/officeDocument/2006/relationships/image" Target="../media/image20.emf"/><Relationship Id="rId3" Type="http://schemas.openxmlformats.org/officeDocument/2006/relationships/oleObject" Target="../embeddings/oleObject9.bin"/><Relationship Id="rId21" Type="http://schemas.openxmlformats.org/officeDocument/2006/relationships/oleObject" Target="../embeddings/oleObject18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3.emf"/><Relationship Id="rId17" Type="http://schemas.openxmlformats.org/officeDocument/2006/relationships/oleObject" Target="../embeddings/oleObject16.bin"/><Relationship Id="rId25" Type="http://schemas.openxmlformats.org/officeDocument/2006/relationships/oleObject" Target="../embeddings/oleObject20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5.emf"/><Relationship Id="rId20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11" Type="http://schemas.openxmlformats.org/officeDocument/2006/relationships/oleObject" Target="../embeddings/oleObject13.bin"/><Relationship Id="rId24" Type="http://schemas.openxmlformats.org/officeDocument/2006/relationships/image" Target="../media/image19.emf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5.bin"/><Relationship Id="rId23" Type="http://schemas.openxmlformats.org/officeDocument/2006/relationships/oleObject" Target="../embeddings/oleObject19.bin"/><Relationship Id="rId10" Type="http://schemas.openxmlformats.org/officeDocument/2006/relationships/image" Target="../media/image12.emf"/><Relationship Id="rId19" Type="http://schemas.openxmlformats.org/officeDocument/2006/relationships/oleObject" Target="../embeddings/oleObject17.bin"/><Relationship Id="rId4" Type="http://schemas.openxmlformats.org/officeDocument/2006/relationships/image" Target="../media/image9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4.emf"/><Relationship Id="rId22" Type="http://schemas.openxmlformats.org/officeDocument/2006/relationships/image" Target="../media/image1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13" Type="http://schemas.openxmlformats.org/officeDocument/2006/relationships/oleObject" Target="../embeddings/oleObject26.bin"/><Relationship Id="rId18" Type="http://schemas.openxmlformats.org/officeDocument/2006/relationships/image" Target="../media/image28.emf"/><Relationship Id="rId26" Type="http://schemas.openxmlformats.org/officeDocument/2006/relationships/image" Target="../media/image32.emf"/><Relationship Id="rId3" Type="http://schemas.openxmlformats.org/officeDocument/2006/relationships/oleObject" Target="../embeddings/oleObject21.bin"/><Relationship Id="rId21" Type="http://schemas.openxmlformats.org/officeDocument/2006/relationships/oleObject" Target="../embeddings/oleObject30.bin"/><Relationship Id="rId7" Type="http://schemas.openxmlformats.org/officeDocument/2006/relationships/oleObject" Target="../embeddings/oleObject23.bin"/><Relationship Id="rId12" Type="http://schemas.openxmlformats.org/officeDocument/2006/relationships/image" Target="../media/image25.emf"/><Relationship Id="rId17" Type="http://schemas.openxmlformats.org/officeDocument/2006/relationships/oleObject" Target="../embeddings/oleObject28.bin"/><Relationship Id="rId25" Type="http://schemas.openxmlformats.org/officeDocument/2006/relationships/oleObject" Target="../embeddings/oleObject32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7.emf"/><Relationship Id="rId20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11" Type="http://schemas.openxmlformats.org/officeDocument/2006/relationships/oleObject" Target="../embeddings/oleObject25.bin"/><Relationship Id="rId24" Type="http://schemas.openxmlformats.org/officeDocument/2006/relationships/image" Target="../media/image31.emf"/><Relationship Id="rId5" Type="http://schemas.openxmlformats.org/officeDocument/2006/relationships/oleObject" Target="../embeddings/oleObject22.bin"/><Relationship Id="rId15" Type="http://schemas.openxmlformats.org/officeDocument/2006/relationships/oleObject" Target="../embeddings/oleObject27.bin"/><Relationship Id="rId23" Type="http://schemas.openxmlformats.org/officeDocument/2006/relationships/oleObject" Target="../embeddings/oleObject31.bin"/><Relationship Id="rId10" Type="http://schemas.openxmlformats.org/officeDocument/2006/relationships/image" Target="../media/image24.emf"/><Relationship Id="rId19" Type="http://schemas.openxmlformats.org/officeDocument/2006/relationships/oleObject" Target="../embeddings/oleObject29.bin"/><Relationship Id="rId4" Type="http://schemas.openxmlformats.org/officeDocument/2006/relationships/image" Target="../media/image21.emf"/><Relationship Id="rId9" Type="http://schemas.openxmlformats.org/officeDocument/2006/relationships/oleObject" Target="../embeddings/oleObject24.bin"/><Relationship Id="rId14" Type="http://schemas.openxmlformats.org/officeDocument/2006/relationships/image" Target="../media/image26.emf"/><Relationship Id="rId22" Type="http://schemas.openxmlformats.org/officeDocument/2006/relationships/image" Target="../media/image3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oleObject" Target="../embeddings/oleObject33.bin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oleObject" Target="../embeddings/oleObject34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oleObject" Target="../embeddings/oleObject35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emf"/><Relationship Id="rId4" Type="http://schemas.openxmlformats.org/officeDocument/2006/relationships/oleObject" Target="../embeddings/oleObject36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7.bin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38.bin"/><Relationship Id="rId4" Type="http://schemas.openxmlformats.org/officeDocument/2006/relationships/image" Target="../media/image3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32">
            <a:extLst>
              <a:ext uri="{FF2B5EF4-FFF2-40B4-BE49-F238E27FC236}">
                <a16:creationId xmlns:a16="http://schemas.microsoft.com/office/drawing/2014/main" id="{FACCBED3-BCA0-449F-82F9-ACD276F20EFB}"/>
              </a:ext>
            </a:extLst>
          </p:cNvPr>
          <p:cNvSpPr txBox="1"/>
          <p:nvPr/>
        </p:nvSpPr>
        <p:spPr>
          <a:xfrm>
            <a:off x="1177514" y="250089"/>
            <a:ext cx="36086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DF6B087-E142-4CAD-A266-C735A3235BA9}"/>
              </a:ext>
            </a:extLst>
          </p:cNvPr>
          <p:cNvSpPr txBox="1"/>
          <p:nvPr/>
        </p:nvSpPr>
        <p:spPr>
          <a:xfrm>
            <a:off x="1274217" y="1422005"/>
            <a:ext cx="4612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CCG-ALL-2015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9B02203-6959-4DFE-88EA-EF769032860F}"/>
              </a:ext>
            </a:extLst>
          </p:cNvPr>
          <p:cNvSpPr txBox="1"/>
          <p:nvPr/>
        </p:nvSpPr>
        <p:spPr>
          <a:xfrm>
            <a:off x="7776875" y="1422005"/>
            <a:ext cx="4612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D-2008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AL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274FC2D-420D-40CF-9451-BFC71B914C84}"/>
              </a:ext>
            </a:extLst>
          </p:cNvPr>
          <p:cNvSpPr txBox="1"/>
          <p:nvPr/>
        </p:nvSpPr>
        <p:spPr>
          <a:xfrm>
            <a:off x="1377921" y="1921843"/>
            <a:ext cx="907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s382466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59752C0-2F22-478F-AAA7-1B6172EF4D23}"/>
              </a:ext>
            </a:extLst>
          </p:cNvPr>
          <p:cNvSpPr txBox="1"/>
          <p:nvPr/>
        </p:nvSpPr>
        <p:spPr>
          <a:xfrm>
            <a:off x="4134460" y="1921843"/>
            <a:ext cx="907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s378109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2835885-555E-4994-A7B0-1F04356A8BCD}"/>
              </a:ext>
            </a:extLst>
          </p:cNvPr>
          <p:cNvSpPr txBox="1"/>
          <p:nvPr/>
        </p:nvSpPr>
        <p:spPr>
          <a:xfrm>
            <a:off x="7880659" y="1921843"/>
            <a:ext cx="907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s382466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14AA718-79D0-48EB-AA12-ECBC4E6BB830}"/>
              </a:ext>
            </a:extLst>
          </p:cNvPr>
          <p:cNvSpPr txBox="1"/>
          <p:nvPr/>
        </p:nvSpPr>
        <p:spPr>
          <a:xfrm>
            <a:off x="10748043" y="1921843"/>
            <a:ext cx="907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s378109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FCEFBDEE-7658-4519-9ADA-ABA3FCAA9921}"/>
              </a:ext>
            </a:extLst>
          </p:cNvPr>
          <p:cNvGrpSpPr/>
          <p:nvPr/>
        </p:nvGrpSpPr>
        <p:grpSpPr>
          <a:xfrm>
            <a:off x="825335" y="2278728"/>
            <a:ext cx="2788527" cy="2058987"/>
            <a:chOff x="259473" y="3045836"/>
            <a:chExt cx="2788527" cy="2058987"/>
          </a:xfrm>
        </p:grpSpPr>
        <p:graphicFrame>
          <p:nvGraphicFramePr>
            <p:cNvPr id="43" name="对象 42">
              <a:extLst>
                <a:ext uri="{FF2B5EF4-FFF2-40B4-BE49-F238E27FC236}">
                  <a16:creationId xmlns:a16="http://schemas.microsoft.com/office/drawing/2014/main" id="{1F86F398-F87F-4396-895C-582D0807BE3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9693415"/>
                </p:ext>
              </p:extLst>
            </p:nvPr>
          </p:nvGraphicFramePr>
          <p:xfrm>
            <a:off x="259473" y="3045836"/>
            <a:ext cx="2605088" cy="2058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3" imgW="2605582" imgH="2059110" progId="Prism7.Document">
                    <p:embed/>
                  </p:oleObj>
                </mc:Choice>
                <mc:Fallback>
                  <p:oleObj name="Prism 7" r:id="rId3" imgW="2605582" imgH="2059110" progId="Prism7.Document">
                    <p:embed/>
                    <p:pic>
                      <p:nvPicPr>
                        <p:cNvPr id="43" name="对象 42">
                          <a:extLst>
                            <a:ext uri="{FF2B5EF4-FFF2-40B4-BE49-F238E27FC236}">
                              <a16:creationId xmlns:a16="http://schemas.microsoft.com/office/drawing/2014/main" id="{1F86F398-F87F-4396-895C-582D0807BE3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59473" y="3045836"/>
                          <a:ext cx="2605088" cy="20589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E4EFCC43-D347-4A13-B25B-C76CC1E06D6A}"/>
                </a:ext>
              </a:extLst>
            </p:cNvPr>
            <p:cNvGrpSpPr/>
            <p:nvPr/>
          </p:nvGrpSpPr>
          <p:grpSpPr>
            <a:xfrm>
              <a:off x="2569152" y="3125043"/>
              <a:ext cx="478848" cy="637218"/>
              <a:chOff x="2569152" y="3125043"/>
              <a:chExt cx="478848" cy="637218"/>
            </a:xfrm>
          </p:grpSpPr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D54C51C1-07DC-4C25-B6A2-B997771A9C6C}"/>
                  </a:ext>
                </a:extLst>
              </p:cNvPr>
              <p:cNvSpPr txBox="1"/>
              <p:nvPr/>
            </p:nvSpPr>
            <p:spPr>
              <a:xfrm>
                <a:off x="2569152" y="3125043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653DB647-82F1-40CF-9F2F-B9A9599C076E}"/>
                  </a:ext>
                </a:extLst>
              </p:cNvPr>
              <p:cNvSpPr txBox="1"/>
              <p:nvPr/>
            </p:nvSpPr>
            <p:spPr>
              <a:xfrm>
                <a:off x="2569152" y="3302074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C</a:t>
                </a: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CA168E52-8A84-44C0-AA6F-07AD8D5630F9}"/>
                  </a:ext>
                </a:extLst>
              </p:cNvPr>
              <p:cNvSpPr txBox="1"/>
              <p:nvPr/>
            </p:nvSpPr>
            <p:spPr>
              <a:xfrm>
                <a:off x="2569152" y="3485262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</a:p>
            </p:txBody>
          </p: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ECF805FB-671D-49A8-803B-2E2D38E67568}"/>
                </a:ext>
              </a:extLst>
            </p:cNvPr>
            <p:cNvGrpSpPr/>
            <p:nvPr/>
          </p:nvGrpSpPr>
          <p:grpSpPr>
            <a:xfrm>
              <a:off x="431731" y="3344675"/>
              <a:ext cx="1477953" cy="1259979"/>
              <a:chOff x="431731" y="3356914"/>
              <a:chExt cx="1477953" cy="1259979"/>
            </a:xfrm>
          </p:grpSpPr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B30252C3-27C6-497C-B0F2-697E54B6D69F}"/>
                  </a:ext>
                </a:extLst>
              </p:cNvPr>
              <p:cNvSpPr txBox="1"/>
              <p:nvPr/>
            </p:nvSpPr>
            <p:spPr>
              <a:xfrm>
                <a:off x="1199737" y="3356914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.7%</a:t>
                </a: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592FFEFF-4226-44AF-BC10-D4084C37032C}"/>
                  </a:ext>
                </a:extLst>
              </p:cNvPr>
              <p:cNvSpPr txBox="1"/>
              <p:nvPr/>
            </p:nvSpPr>
            <p:spPr>
              <a:xfrm>
                <a:off x="431731" y="3979765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9.3%</a:t>
                </a: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839FF1DF-6DC6-4D19-AF5C-0818F22B6083}"/>
                  </a:ext>
                </a:extLst>
              </p:cNvPr>
              <p:cNvSpPr txBox="1"/>
              <p:nvPr/>
            </p:nvSpPr>
            <p:spPr>
              <a:xfrm>
                <a:off x="1418844" y="433989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%</a:t>
                </a:r>
              </a:p>
            </p:txBody>
          </p:sp>
        </p:grp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C4C12A93-ABD7-44C3-8511-91C79CB221A1}"/>
              </a:ext>
            </a:extLst>
          </p:cNvPr>
          <p:cNvGrpSpPr/>
          <p:nvPr/>
        </p:nvGrpSpPr>
        <p:grpSpPr>
          <a:xfrm>
            <a:off x="3632035" y="2280315"/>
            <a:ext cx="2811010" cy="2058988"/>
            <a:chOff x="3564943" y="3047423"/>
            <a:chExt cx="2811010" cy="2058988"/>
          </a:xfrm>
        </p:grpSpPr>
        <p:graphicFrame>
          <p:nvGraphicFramePr>
            <p:cNvPr id="44" name="对象 43">
              <a:extLst>
                <a:ext uri="{FF2B5EF4-FFF2-40B4-BE49-F238E27FC236}">
                  <a16:creationId xmlns:a16="http://schemas.microsoft.com/office/drawing/2014/main" id="{35DBAEC1-9656-452C-B46D-F5558144A9E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983981"/>
                </p:ext>
              </p:extLst>
            </p:nvPr>
          </p:nvGraphicFramePr>
          <p:xfrm>
            <a:off x="3564943" y="3047423"/>
            <a:ext cx="2614613" cy="2058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5" imgW="2614585" imgH="2059110" progId="Prism7.Document">
                    <p:embed/>
                  </p:oleObj>
                </mc:Choice>
                <mc:Fallback>
                  <p:oleObj name="Prism 7" r:id="rId5" imgW="2614585" imgH="2059110" progId="Prism7.Document">
                    <p:embed/>
                    <p:pic>
                      <p:nvPicPr>
                        <p:cNvPr id="44" name="对象 43">
                          <a:extLst>
                            <a:ext uri="{FF2B5EF4-FFF2-40B4-BE49-F238E27FC236}">
                              <a16:creationId xmlns:a16="http://schemas.microsoft.com/office/drawing/2014/main" id="{35DBAEC1-9656-452C-B46D-F5558144A9E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564943" y="3047423"/>
                          <a:ext cx="2614613" cy="2058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ADF34A42-0784-44BB-854F-2E7A33325C4E}"/>
                </a:ext>
              </a:extLst>
            </p:cNvPr>
            <p:cNvGrpSpPr/>
            <p:nvPr/>
          </p:nvGrpSpPr>
          <p:grpSpPr>
            <a:xfrm>
              <a:off x="5897105" y="3125043"/>
              <a:ext cx="478848" cy="637218"/>
              <a:chOff x="2569152" y="3125043"/>
              <a:chExt cx="478848" cy="637218"/>
            </a:xfrm>
          </p:grpSpPr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3B9ADC07-1877-40D1-B719-7B7E3DDAD1B3}"/>
                  </a:ext>
                </a:extLst>
              </p:cNvPr>
              <p:cNvSpPr txBox="1"/>
              <p:nvPr/>
            </p:nvSpPr>
            <p:spPr>
              <a:xfrm>
                <a:off x="2569152" y="3125043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5870A4F0-E494-4333-8A0A-8A968BCB2C2F}"/>
                  </a:ext>
                </a:extLst>
              </p:cNvPr>
              <p:cNvSpPr txBox="1"/>
              <p:nvPr/>
            </p:nvSpPr>
            <p:spPr>
              <a:xfrm>
                <a:off x="2569152" y="3302074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C</a:t>
                </a: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C61A45C3-18C0-4C7B-A297-EAFB6AB79B06}"/>
                  </a:ext>
                </a:extLst>
              </p:cNvPr>
              <p:cNvSpPr txBox="1"/>
              <p:nvPr/>
            </p:nvSpPr>
            <p:spPr>
              <a:xfrm>
                <a:off x="2569152" y="3485262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T</a:t>
                </a:r>
              </a:p>
            </p:txBody>
          </p:sp>
        </p:grpSp>
        <p:grpSp>
          <p:nvGrpSpPr>
            <p:cNvPr id="104" name="组合 103">
              <a:extLst>
                <a:ext uri="{FF2B5EF4-FFF2-40B4-BE49-F238E27FC236}">
                  <a16:creationId xmlns:a16="http://schemas.microsoft.com/office/drawing/2014/main" id="{E3622A87-55CF-4B36-85FD-369F3C6A7960}"/>
                </a:ext>
              </a:extLst>
            </p:cNvPr>
            <p:cNvGrpSpPr/>
            <p:nvPr/>
          </p:nvGrpSpPr>
          <p:grpSpPr>
            <a:xfrm>
              <a:off x="3737840" y="3344675"/>
              <a:ext cx="1542074" cy="1259979"/>
              <a:chOff x="431731" y="3356914"/>
              <a:chExt cx="1542074" cy="1259979"/>
            </a:xfrm>
          </p:grpSpPr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27C4ECB4-208A-492B-B9E7-DD78196DFDBC}"/>
                  </a:ext>
                </a:extLst>
              </p:cNvPr>
              <p:cNvSpPr txBox="1"/>
              <p:nvPr/>
            </p:nvSpPr>
            <p:spPr>
              <a:xfrm>
                <a:off x="1199737" y="3356914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.7%</a:t>
                </a:r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97872512-3D1C-4116-9C51-ADEE02CAACA0}"/>
                  </a:ext>
                </a:extLst>
              </p:cNvPr>
              <p:cNvSpPr txBox="1"/>
              <p:nvPr/>
            </p:nvSpPr>
            <p:spPr>
              <a:xfrm>
                <a:off x="431731" y="3979765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9.6%</a:t>
                </a: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75267916-18AC-42E1-B64A-692B3AFF7AFB}"/>
                  </a:ext>
                </a:extLst>
              </p:cNvPr>
              <p:cNvSpPr txBox="1"/>
              <p:nvPr/>
            </p:nvSpPr>
            <p:spPr>
              <a:xfrm>
                <a:off x="1354725" y="4339894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9.7%</a:t>
                </a:r>
              </a:p>
            </p:txBody>
          </p:sp>
        </p:grp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5C98FA99-DCD9-4E5B-AA29-115FF45D00DF}"/>
              </a:ext>
            </a:extLst>
          </p:cNvPr>
          <p:cNvGrpSpPr/>
          <p:nvPr/>
        </p:nvGrpSpPr>
        <p:grpSpPr>
          <a:xfrm>
            <a:off x="7310273" y="2283490"/>
            <a:ext cx="2845961" cy="2052638"/>
            <a:chOff x="7118488" y="3050598"/>
            <a:chExt cx="2845961" cy="2052638"/>
          </a:xfrm>
        </p:grpSpPr>
        <p:graphicFrame>
          <p:nvGraphicFramePr>
            <p:cNvPr id="47" name="对象 46">
              <a:extLst>
                <a:ext uri="{FF2B5EF4-FFF2-40B4-BE49-F238E27FC236}">
                  <a16:creationId xmlns:a16="http://schemas.microsoft.com/office/drawing/2014/main" id="{70FCEA17-E40B-4964-BC4C-BEA4FCAAEC1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8917085"/>
                </p:ext>
              </p:extLst>
            </p:nvPr>
          </p:nvGraphicFramePr>
          <p:xfrm>
            <a:off x="7118488" y="3050598"/>
            <a:ext cx="2616200" cy="2052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7" imgW="2616026" imgH="2052989" progId="Prism7.Document">
                    <p:embed/>
                  </p:oleObj>
                </mc:Choice>
                <mc:Fallback>
                  <p:oleObj name="Prism 7" r:id="rId7" imgW="2616026" imgH="2052989" progId="Prism7.Document">
                    <p:embed/>
                    <p:pic>
                      <p:nvPicPr>
                        <p:cNvPr id="47" name="对象 46">
                          <a:extLst>
                            <a:ext uri="{FF2B5EF4-FFF2-40B4-BE49-F238E27FC236}">
                              <a16:creationId xmlns:a16="http://schemas.microsoft.com/office/drawing/2014/main" id="{70FCEA17-E40B-4964-BC4C-BEA4FCAAEC1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118488" y="3050598"/>
                          <a:ext cx="2616200" cy="2052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3" name="组合 92">
              <a:extLst>
                <a:ext uri="{FF2B5EF4-FFF2-40B4-BE49-F238E27FC236}">
                  <a16:creationId xmlns:a16="http://schemas.microsoft.com/office/drawing/2014/main" id="{C1461BDB-01C6-485D-A7A5-A0808A91D061}"/>
                </a:ext>
              </a:extLst>
            </p:cNvPr>
            <p:cNvGrpSpPr/>
            <p:nvPr/>
          </p:nvGrpSpPr>
          <p:grpSpPr>
            <a:xfrm>
              <a:off x="9485601" y="3125043"/>
              <a:ext cx="478848" cy="637218"/>
              <a:chOff x="2569152" y="3125043"/>
              <a:chExt cx="478848" cy="637218"/>
            </a:xfrm>
          </p:grpSpPr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7FBCD153-7F8E-4975-843C-378D10BA2D74}"/>
                  </a:ext>
                </a:extLst>
              </p:cNvPr>
              <p:cNvSpPr txBox="1"/>
              <p:nvPr/>
            </p:nvSpPr>
            <p:spPr>
              <a:xfrm>
                <a:off x="2569152" y="3125043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26ECD337-FF1F-4F28-BC0B-39C900611D0D}"/>
                  </a:ext>
                </a:extLst>
              </p:cNvPr>
              <p:cNvSpPr txBox="1"/>
              <p:nvPr/>
            </p:nvSpPr>
            <p:spPr>
              <a:xfrm>
                <a:off x="2569152" y="3302074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C</a:t>
                </a: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F90ADF11-1F36-48D4-946B-4D4BB53E5A16}"/>
                  </a:ext>
                </a:extLst>
              </p:cNvPr>
              <p:cNvSpPr txBox="1"/>
              <p:nvPr/>
            </p:nvSpPr>
            <p:spPr>
              <a:xfrm>
                <a:off x="2569152" y="3485262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</a:p>
            </p:txBody>
          </p:sp>
        </p:grpSp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95A611D3-E0E6-448D-A908-C9856E32A692}"/>
                </a:ext>
              </a:extLst>
            </p:cNvPr>
            <p:cNvGrpSpPr/>
            <p:nvPr/>
          </p:nvGrpSpPr>
          <p:grpSpPr>
            <a:xfrm>
              <a:off x="7321431" y="3344675"/>
              <a:ext cx="1477956" cy="1259979"/>
              <a:chOff x="495849" y="3356914"/>
              <a:chExt cx="1477956" cy="1259979"/>
            </a:xfrm>
          </p:grpSpPr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F86D2BC5-BCBE-4B68-A29A-851F6CD6E681}"/>
                  </a:ext>
                </a:extLst>
              </p:cNvPr>
              <p:cNvSpPr txBox="1"/>
              <p:nvPr/>
            </p:nvSpPr>
            <p:spPr>
              <a:xfrm>
                <a:off x="1242215" y="3356914"/>
                <a:ext cx="5341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.8%</a:t>
                </a:r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9A77D785-744E-45AB-88C9-02DA4A89A56C}"/>
                  </a:ext>
                </a:extLst>
              </p:cNvPr>
              <p:cNvSpPr txBox="1"/>
              <p:nvPr/>
            </p:nvSpPr>
            <p:spPr>
              <a:xfrm>
                <a:off x="495849" y="3979765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altLang="zh-CN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8E921E5E-AC1B-45FE-B75E-639C862E5E70}"/>
                  </a:ext>
                </a:extLst>
              </p:cNvPr>
              <p:cNvSpPr txBox="1"/>
              <p:nvPr/>
            </p:nvSpPr>
            <p:spPr>
              <a:xfrm>
                <a:off x="1354725" y="4339894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.2%</a:t>
                </a:r>
              </a:p>
            </p:txBody>
          </p:sp>
        </p:grp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B31E5200-C932-4C92-9248-2AC51467F6A5}"/>
              </a:ext>
            </a:extLst>
          </p:cNvPr>
          <p:cNvGrpSpPr/>
          <p:nvPr/>
        </p:nvGrpSpPr>
        <p:grpSpPr>
          <a:xfrm>
            <a:off x="10169360" y="2283490"/>
            <a:ext cx="2836574" cy="2051050"/>
            <a:chOff x="10490200" y="3050598"/>
            <a:chExt cx="2836574" cy="2051050"/>
          </a:xfrm>
        </p:grpSpPr>
        <p:graphicFrame>
          <p:nvGraphicFramePr>
            <p:cNvPr id="48" name="对象 47">
              <a:extLst>
                <a:ext uri="{FF2B5EF4-FFF2-40B4-BE49-F238E27FC236}">
                  <a16:creationId xmlns:a16="http://schemas.microsoft.com/office/drawing/2014/main" id="{651C32C9-D332-4273-BEDF-8825E519B51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5981108"/>
                </p:ext>
              </p:extLst>
            </p:nvPr>
          </p:nvGraphicFramePr>
          <p:xfrm>
            <a:off x="10490200" y="3050598"/>
            <a:ext cx="2605088" cy="2051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9" imgW="2605582" imgH="2051549" progId="Prism7.Document">
                    <p:embed/>
                  </p:oleObj>
                </mc:Choice>
                <mc:Fallback>
                  <p:oleObj name="Prism 7" r:id="rId9" imgW="2605582" imgH="2051549" progId="Prism7.Document">
                    <p:embed/>
                    <p:pic>
                      <p:nvPicPr>
                        <p:cNvPr id="48" name="对象 47">
                          <a:extLst>
                            <a:ext uri="{FF2B5EF4-FFF2-40B4-BE49-F238E27FC236}">
                              <a16:creationId xmlns:a16="http://schemas.microsoft.com/office/drawing/2014/main" id="{651C32C9-D332-4273-BEDF-8825E519B51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0490200" y="3050598"/>
                          <a:ext cx="2605088" cy="2051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7" name="组合 96">
              <a:extLst>
                <a:ext uri="{FF2B5EF4-FFF2-40B4-BE49-F238E27FC236}">
                  <a16:creationId xmlns:a16="http://schemas.microsoft.com/office/drawing/2014/main" id="{03953CF1-A3FC-42FC-B81D-92E5750BEF80}"/>
                </a:ext>
              </a:extLst>
            </p:cNvPr>
            <p:cNvGrpSpPr/>
            <p:nvPr/>
          </p:nvGrpSpPr>
          <p:grpSpPr>
            <a:xfrm>
              <a:off x="12847926" y="3125043"/>
              <a:ext cx="478848" cy="637218"/>
              <a:chOff x="2569152" y="3125043"/>
              <a:chExt cx="478848" cy="637218"/>
            </a:xfrm>
          </p:grpSpPr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4BF25686-CA4D-42BE-874D-2D4C74B3A3DD}"/>
                  </a:ext>
                </a:extLst>
              </p:cNvPr>
              <p:cNvSpPr txBox="1"/>
              <p:nvPr/>
            </p:nvSpPr>
            <p:spPr>
              <a:xfrm>
                <a:off x="2569152" y="3125043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6CE17F03-5086-4E99-B932-ADF61351CCF8}"/>
                  </a:ext>
                </a:extLst>
              </p:cNvPr>
              <p:cNvSpPr txBox="1"/>
              <p:nvPr/>
            </p:nvSpPr>
            <p:spPr>
              <a:xfrm>
                <a:off x="2569152" y="3302074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C</a:t>
                </a: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EE3A3D3A-2A99-4CF3-8371-6FE51DFDAA06}"/>
                  </a:ext>
                </a:extLst>
              </p:cNvPr>
              <p:cNvSpPr txBox="1"/>
              <p:nvPr/>
            </p:nvSpPr>
            <p:spPr>
              <a:xfrm>
                <a:off x="2569152" y="3485262"/>
                <a:ext cx="478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T</a:t>
                </a:r>
              </a:p>
            </p:txBody>
          </p:sp>
        </p:grpSp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CF15774B-8559-4BCB-A319-17BAAB516CAA}"/>
                </a:ext>
              </a:extLst>
            </p:cNvPr>
            <p:cNvGrpSpPr/>
            <p:nvPr/>
          </p:nvGrpSpPr>
          <p:grpSpPr>
            <a:xfrm>
              <a:off x="10606385" y="3344675"/>
              <a:ext cx="1477953" cy="1259979"/>
              <a:chOff x="431731" y="3356914"/>
              <a:chExt cx="1477953" cy="1259979"/>
            </a:xfrm>
          </p:grpSpPr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49B1B3D0-EC01-4D3A-AB4B-6A95CCA86BC2}"/>
                  </a:ext>
                </a:extLst>
              </p:cNvPr>
              <p:cNvSpPr txBox="1"/>
              <p:nvPr/>
            </p:nvSpPr>
            <p:spPr>
              <a:xfrm>
                <a:off x="1242215" y="3356914"/>
                <a:ext cx="5341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.2%</a:t>
                </a:r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61A1F72D-38A5-4462-B873-E2FF2BF6E12C}"/>
                  </a:ext>
                </a:extLst>
              </p:cNvPr>
              <p:cNvSpPr txBox="1"/>
              <p:nvPr/>
            </p:nvSpPr>
            <p:spPr>
              <a:xfrm>
                <a:off x="431731" y="3979765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.8%</a:t>
                </a:r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32E6CE21-164D-4E97-96B7-B4F0C8343781}"/>
                  </a:ext>
                </a:extLst>
              </p:cNvPr>
              <p:cNvSpPr txBox="1"/>
              <p:nvPr/>
            </p:nvSpPr>
            <p:spPr>
              <a:xfrm>
                <a:off x="1418844" y="433989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1%</a:t>
                </a:r>
              </a:p>
            </p:txBody>
          </p:sp>
        </p:grp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30B0BFF0-CA14-4B54-9B6C-E0F4278544F1}"/>
              </a:ext>
            </a:extLst>
          </p:cNvPr>
          <p:cNvSpPr txBox="1"/>
          <p:nvPr/>
        </p:nvSpPr>
        <p:spPr>
          <a:xfrm>
            <a:off x="671206" y="4848457"/>
            <a:ext cx="12334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e frequencies of rs3824662 and rs3791093 genotypes among the CCCG-ALL-2015 (A) and GD-2008-ALL (B) study cohort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934FF7E-9418-44F1-BDFD-21DECBFA465E}"/>
              </a:ext>
            </a:extLst>
          </p:cNvPr>
          <p:cNvSpPr txBox="1"/>
          <p:nvPr/>
        </p:nvSpPr>
        <p:spPr>
          <a:xfrm>
            <a:off x="469147" y="114174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0AACDC7-B3B5-4387-9760-E90672160F00}"/>
              </a:ext>
            </a:extLst>
          </p:cNvPr>
          <p:cNvSpPr txBox="1"/>
          <p:nvPr/>
        </p:nvSpPr>
        <p:spPr>
          <a:xfrm>
            <a:off x="6887354" y="114174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351175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028E551F-D3A3-4DD8-B99C-77C52511E9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0034646"/>
              </p:ext>
            </p:extLst>
          </p:nvPr>
        </p:nvGraphicFramePr>
        <p:xfrm>
          <a:off x="593725" y="1946275"/>
          <a:ext cx="3513138" cy="2513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512764" imgH="2513489" progId="Prism7.Document">
                  <p:embed/>
                </p:oleObj>
              </mc:Choice>
              <mc:Fallback>
                <p:oleObj name="Prism 7" r:id="rId2" imgW="3512764" imgH="2513489" progId="Prism7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028E551F-D3A3-4DD8-B99C-77C52511E9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3725" y="1946275"/>
                        <a:ext cx="3513138" cy="2513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5">
            <a:extLst>
              <a:ext uri="{FF2B5EF4-FFF2-40B4-BE49-F238E27FC236}">
                <a16:creationId xmlns:a16="http://schemas.microsoft.com/office/drawing/2014/main" id="{E510CA18-386A-4260-AA46-FFA66A63687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86330" y="2947602"/>
            <a:ext cx="15376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ene expression</a:t>
            </a:r>
          </a:p>
        </p:txBody>
      </p:sp>
      <p:sp>
        <p:nvSpPr>
          <p:cNvPr id="4" name="TextBox 7">
            <a:extLst>
              <a:ext uri="{FF2B5EF4-FFF2-40B4-BE49-F238E27FC236}">
                <a16:creationId xmlns:a16="http://schemas.microsoft.com/office/drawing/2014/main" id="{35F49F85-9C34-4397-B5B0-83554FBEEE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2958" y="2453793"/>
            <a:ext cx="93682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esistant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F41CBB5-1ACC-481D-BBB9-9F9FFF7266C2}"/>
              </a:ext>
            </a:extLst>
          </p:cNvPr>
          <p:cNvSpPr txBox="1"/>
          <p:nvPr/>
        </p:nvSpPr>
        <p:spPr>
          <a:xfrm>
            <a:off x="657549" y="394131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2ACA8C-A592-4870-82C7-743E7313AAD6}"/>
              </a:ext>
            </a:extLst>
          </p:cNvPr>
          <p:cNvSpPr txBox="1"/>
          <p:nvPr/>
        </p:nvSpPr>
        <p:spPr>
          <a:xfrm>
            <a:off x="657550" y="3311264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4262DDC-9CF1-49D2-8A95-F67673F5D827}"/>
              </a:ext>
            </a:extLst>
          </p:cNvPr>
          <p:cNvSpPr txBox="1"/>
          <p:nvPr/>
        </p:nvSpPr>
        <p:spPr>
          <a:xfrm>
            <a:off x="572591" y="2709028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76B7F4D-CC86-4C5D-B61A-9C93BB2FFB0E}"/>
              </a:ext>
            </a:extLst>
          </p:cNvPr>
          <p:cNvSpPr txBox="1"/>
          <p:nvPr/>
        </p:nvSpPr>
        <p:spPr>
          <a:xfrm>
            <a:off x="572591" y="2089266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7">
            <a:extLst>
              <a:ext uri="{FF2B5EF4-FFF2-40B4-BE49-F238E27FC236}">
                <a16:creationId xmlns:a16="http://schemas.microsoft.com/office/drawing/2014/main" id="{FC583EE7-97F9-4C9C-A89D-5AF6B09A96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2958" y="2204907"/>
            <a:ext cx="8190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ensitive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855E072-1598-4CE9-8769-5E9A29079637}"/>
              </a:ext>
            </a:extLst>
          </p:cNvPr>
          <p:cNvSpPr txBox="1"/>
          <p:nvPr/>
        </p:nvSpPr>
        <p:spPr>
          <a:xfrm>
            <a:off x="1017959" y="2151643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E0A2329-B490-4E93-97E9-52A14C4DE2E1}"/>
              </a:ext>
            </a:extLst>
          </p:cNvPr>
          <p:cNvSpPr txBox="1"/>
          <p:nvPr/>
        </p:nvSpPr>
        <p:spPr>
          <a:xfrm>
            <a:off x="1543180" y="2151643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CA72C4A-F7EF-4491-82AC-1088112B29B9}"/>
              </a:ext>
            </a:extLst>
          </p:cNvPr>
          <p:cNvSpPr txBox="1"/>
          <p:nvPr/>
        </p:nvSpPr>
        <p:spPr>
          <a:xfrm>
            <a:off x="2102078" y="2151643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983E7F8-CEA4-4D45-A9D0-3D23F4009610}"/>
              </a:ext>
            </a:extLst>
          </p:cNvPr>
          <p:cNvSpPr txBox="1"/>
          <p:nvPr/>
        </p:nvSpPr>
        <p:spPr>
          <a:xfrm>
            <a:off x="2592681" y="2151643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348835-0AC3-4100-8E0B-4A5AD09194B6}"/>
              </a:ext>
            </a:extLst>
          </p:cNvPr>
          <p:cNvSpPr txBox="1"/>
          <p:nvPr/>
        </p:nvSpPr>
        <p:spPr>
          <a:xfrm>
            <a:off x="843523" y="4091980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SNS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18A5720-0BCF-48FD-828A-776D09E5E3B9}"/>
              </a:ext>
            </a:extLst>
          </p:cNvPr>
          <p:cNvSpPr txBox="1"/>
          <p:nvPr/>
        </p:nvSpPr>
        <p:spPr>
          <a:xfrm>
            <a:off x="1431962" y="409198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LS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C8A7A58-E674-42CD-84BE-39C050361A34}"/>
              </a:ext>
            </a:extLst>
          </p:cNvPr>
          <p:cNvSpPr txBox="1"/>
          <p:nvPr/>
        </p:nvSpPr>
        <p:spPr>
          <a:xfrm>
            <a:off x="1894135" y="409198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OPRM1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A3A6054-04C5-4C99-8C8E-02D7CD509B00}"/>
              </a:ext>
            </a:extLst>
          </p:cNvPr>
          <p:cNvSpPr txBox="1"/>
          <p:nvPr/>
        </p:nvSpPr>
        <p:spPr>
          <a:xfrm>
            <a:off x="2490610" y="409198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ZBTB1</a:t>
            </a:r>
          </a:p>
        </p:txBody>
      </p:sp>
      <p:graphicFrame>
        <p:nvGraphicFramePr>
          <p:cNvPr id="52" name="对象 51">
            <a:extLst>
              <a:ext uri="{FF2B5EF4-FFF2-40B4-BE49-F238E27FC236}">
                <a16:creationId xmlns:a16="http://schemas.microsoft.com/office/drawing/2014/main" id="{87B74EB7-4251-4331-99CE-90B288AAFF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7823837"/>
              </p:ext>
            </p:extLst>
          </p:nvPr>
        </p:nvGraphicFramePr>
        <p:xfrm>
          <a:off x="5473700" y="1982788"/>
          <a:ext cx="3559175" cy="2422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3558501" imgH="2422037" progId="Prism7.Document">
                  <p:embed/>
                </p:oleObj>
              </mc:Choice>
              <mc:Fallback>
                <p:oleObj name="Prism 7" r:id="rId4" imgW="3558501" imgH="2422037" progId="Prism7.Document">
                  <p:embed/>
                  <p:pic>
                    <p:nvPicPr>
                      <p:cNvPr id="52" name="对象 51">
                        <a:extLst>
                          <a:ext uri="{FF2B5EF4-FFF2-40B4-BE49-F238E27FC236}">
                            <a16:creationId xmlns:a16="http://schemas.microsoft.com/office/drawing/2014/main" id="{87B74EB7-4251-4331-99CE-90B288AAFFC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73700" y="1982788"/>
                        <a:ext cx="3559175" cy="2422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文本框 8">
            <a:extLst>
              <a:ext uri="{FF2B5EF4-FFF2-40B4-BE49-F238E27FC236}">
                <a16:creationId xmlns:a16="http://schemas.microsoft.com/office/drawing/2014/main" id="{E8E33D64-E8E0-4D93-8934-71697CC97365}"/>
              </a:ext>
            </a:extLst>
          </p:cNvPr>
          <p:cNvSpPr txBox="1"/>
          <p:nvPr/>
        </p:nvSpPr>
        <p:spPr>
          <a:xfrm>
            <a:off x="8696629" y="1930078"/>
            <a:ext cx="2844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2000" b="1" dirty="0"/>
          </a:p>
        </p:txBody>
      </p:sp>
      <p:sp>
        <p:nvSpPr>
          <p:cNvPr id="42" name="TextBox 7">
            <a:extLst>
              <a:ext uri="{FF2B5EF4-FFF2-40B4-BE49-F238E27FC236}">
                <a16:creationId xmlns:a16="http://schemas.microsoft.com/office/drawing/2014/main" id="{A3016FC4-7A3F-4212-B036-3CC76589A7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9902" y="2116749"/>
            <a:ext cx="127390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Empty vector</a:t>
            </a:r>
          </a:p>
        </p:txBody>
      </p:sp>
      <p:sp>
        <p:nvSpPr>
          <p:cNvPr id="43" name="TextBox 7">
            <a:extLst>
              <a:ext uri="{FF2B5EF4-FFF2-40B4-BE49-F238E27FC236}">
                <a16:creationId xmlns:a16="http://schemas.microsoft.com/office/drawing/2014/main" id="{F7CF14E8-3896-4824-A340-E7D61F0EED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9902" y="2330109"/>
            <a:ext cx="127390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ATA3</a:t>
            </a:r>
          </a:p>
        </p:txBody>
      </p:sp>
      <p:sp>
        <p:nvSpPr>
          <p:cNvPr id="44" name="TextBox 5">
            <a:extLst>
              <a:ext uri="{FF2B5EF4-FFF2-40B4-BE49-F238E27FC236}">
                <a16:creationId xmlns:a16="http://schemas.microsoft.com/office/drawing/2014/main" id="{FDCF7C41-8BAE-4F91-B459-2D721C739D4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351093" y="2925477"/>
            <a:ext cx="200567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ene expression (A.U)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8A040A1-21DF-4533-89DC-E607ABA73E16}"/>
              </a:ext>
            </a:extLst>
          </p:cNvPr>
          <p:cNvSpPr txBox="1"/>
          <p:nvPr/>
        </p:nvSpPr>
        <p:spPr>
          <a:xfrm>
            <a:off x="5591689" y="388285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C992855-E0B3-4D98-A75E-3B2763B44AE5}"/>
              </a:ext>
            </a:extLst>
          </p:cNvPr>
          <p:cNvSpPr txBox="1"/>
          <p:nvPr/>
        </p:nvSpPr>
        <p:spPr>
          <a:xfrm>
            <a:off x="5591689" y="34386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CB3F4D7-F4CF-40D7-B00A-5B5174A365AA}"/>
              </a:ext>
            </a:extLst>
          </p:cNvPr>
          <p:cNvSpPr txBox="1"/>
          <p:nvPr/>
        </p:nvSpPr>
        <p:spPr>
          <a:xfrm>
            <a:off x="5591689" y="20805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402159F-E8F6-40B4-A174-ECC7E4105F61}"/>
              </a:ext>
            </a:extLst>
          </p:cNvPr>
          <p:cNvSpPr txBox="1"/>
          <p:nvPr/>
        </p:nvSpPr>
        <p:spPr>
          <a:xfrm>
            <a:off x="5248691" y="2984501"/>
            <a:ext cx="61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7">
            <a:extLst>
              <a:ext uri="{FF2B5EF4-FFF2-40B4-BE49-F238E27FC236}">
                <a16:creationId xmlns:a16="http://schemas.microsoft.com/office/drawing/2014/main" id="{9FB67A21-74C2-4917-B9FF-3DD550DD7D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0164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ORPM1</a:t>
            </a:r>
          </a:p>
        </p:txBody>
      </p:sp>
      <p:sp>
        <p:nvSpPr>
          <p:cNvPr id="50" name="TextBox 7">
            <a:extLst>
              <a:ext uri="{FF2B5EF4-FFF2-40B4-BE49-F238E27FC236}">
                <a16:creationId xmlns:a16="http://schemas.microsoft.com/office/drawing/2014/main" id="{E929506E-FC9F-4F59-92A6-9DFFA82622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33726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ASNS</a:t>
            </a:r>
          </a:p>
        </p:txBody>
      </p:sp>
      <p:sp>
        <p:nvSpPr>
          <p:cNvPr id="51" name="TextBox 7">
            <a:extLst>
              <a:ext uri="{FF2B5EF4-FFF2-40B4-BE49-F238E27FC236}">
                <a16:creationId xmlns:a16="http://schemas.microsoft.com/office/drawing/2014/main" id="{D04A17ED-D548-4D40-9A0F-101F985C56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62894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LS</a:t>
            </a:r>
          </a:p>
        </p:txBody>
      </p:sp>
      <p:sp>
        <p:nvSpPr>
          <p:cNvPr id="54" name="TextBox 7">
            <a:extLst>
              <a:ext uri="{FF2B5EF4-FFF2-40B4-BE49-F238E27FC236}">
                <a16:creationId xmlns:a16="http://schemas.microsoft.com/office/drawing/2014/main" id="{BFEF708B-2109-43AB-AFA6-51911B7BB4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21693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BTB1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C38766F-9237-4BC5-B5B7-93055E5C7C56}"/>
              </a:ext>
            </a:extLst>
          </p:cNvPr>
          <p:cNvSpPr txBox="1"/>
          <p:nvPr/>
        </p:nvSpPr>
        <p:spPr>
          <a:xfrm>
            <a:off x="5931725" y="3165112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42EADD0-20B1-4B4A-BBAF-30DDD2BCBDE4}"/>
              </a:ext>
            </a:extLst>
          </p:cNvPr>
          <p:cNvSpPr txBox="1"/>
          <p:nvPr/>
        </p:nvSpPr>
        <p:spPr>
          <a:xfrm>
            <a:off x="6498236" y="3165112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32029DDA-07CD-4507-8F6F-8F5AE946C07B}"/>
              </a:ext>
            </a:extLst>
          </p:cNvPr>
          <p:cNvSpPr txBox="1"/>
          <p:nvPr/>
        </p:nvSpPr>
        <p:spPr>
          <a:xfrm>
            <a:off x="7028761" y="3165112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DC183BA-8079-485B-ADEF-CD948D551416}"/>
              </a:ext>
            </a:extLst>
          </p:cNvPr>
          <p:cNvSpPr txBox="1"/>
          <p:nvPr/>
        </p:nvSpPr>
        <p:spPr>
          <a:xfrm>
            <a:off x="7565623" y="2252911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D0678D53-E9C4-46C6-B23B-04BB1EC1F2CF}"/>
              </a:ext>
            </a:extLst>
          </p:cNvPr>
          <p:cNvSpPr txBox="1"/>
          <p:nvPr/>
        </p:nvSpPr>
        <p:spPr>
          <a:xfrm>
            <a:off x="5802866" y="1807296"/>
            <a:ext cx="1002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m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2" name="对象 61">
            <a:extLst>
              <a:ext uri="{FF2B5EF4-FFF2-40B4-BE49-F238E27FC236}">
                <a16:creationId xmlns:a16="http://schemas.microsoft.com/office/drawing/2014/main" id="{4DF999B5-928F-4F8E-A99F-836A700DE0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8465094"/>
              </p:ext>
            </p:extLst>
          </p:nvPr>
        </p:nvGraphicFramePr>
        <p:xfrm>
          <a:off x="9639300" y="1984375"/>
          <a:ext cx="3559175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558501" imgH="2417356" progId="Prism7.Document">
                  <p:embed/>
                </p:oleObj>
              </mc:Choice>
              <mc:Fallback>
                <p:oleObj name="Prism 7" r:id="rId6" imgW="3558501" imgH="2417356" progId="Prism7.Document">
                  <p:embed/>
                  <p:pic>
                    <p:nvPicPr>
                      <p:cNvPr id="62" name="对象 61">
                        <a:extLst>
                          <a:ext uri="{FF2B5EF4-FFF2-40B4-BE49-F238E27FC236}">
                            <a16:creationId xmlns:a16="http://schemas.microsoft.com/office/drawing/2014/main" id="{4DF999B5-928F-4F8E-A99F-836A700DE0D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639300" y="1984375"/>
                        <a:ext cx="3559175" cy="24177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3" name="文本框 8">
            <a:extLst>
              <a:ext uri="{FF2B5EF4-FFF2-40B4-BE49-F238E27FC236}">
                <a16:creationId xmlns:a16="http://schemas.microsoft.com/office/drawing/2014/main" id="{AE28700B-5A25-49A9-82F8-21E8BA27DFFB}"/>
              </a:ext>
            </a:extLst>
          </p:cNvPr>
          <p:cNvSpPr txBox="1"/>
          <p:nvPr/>
        </p:nvSpPr>
        <p:spPr>
          <a:xfrm>
            <a:off x="12862229" y="1930078"/>
            <a:ext cx="2844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2000" b="1" dirty="0"/>
          </a:p>
        </p:txBody>
      </p:sp>
      <p:sp>
        <p:nvSpPr>
          <p:cNvPr id="64" name="TextBox 7">
            <a:extLst>
              <a:ext uri="{FF2B5EF4-FFF2-40B4-BE49-F238E27FC236}">
                <a16:creationId xmlns:a16="http://schemas.microsoft.com/office/drawing/2014/main" id="{5AC832DC-77FD-46AB-BE44-1AA473092C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15502" y="2116749"/>
            <a:ext cx="127390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Empty vector</a:t>
            </a:r>
          </a:p>
        </p:txBody>
      </p:sp>
      <p:sp>
        <p:nvSpPr>
          <p:cNvPr id="65" name="TextBox 7">
            <a:extLst>
              <a:ext uri="{FF2B5EF4-FFF2-40B4-BE49-F238E27FC236}">
                <a16:creationId xmlns:a16="http://schemas.microsoft.com/office/drawing/2014/main" id="{D0468648-61BB-4730-B9C8-C9982F2EB2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15502" y="2330109"/>
            <a:ext cx="127390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ATA3</a:t>
            </a:r>
          </a:p>
        </p:txBody>
      </p:sp>
      <p:sp>
        <p:nvSpPr>
          <p:cNvPr id="66" name="TextBox 5">
            <a:extLst>
              <a:ext uri="{FF2B5EF4-FFF2-40B4-BE49-F238E27FC236}">
                <a16:creationId xmlns:a16="http://schemas.microsoft.com/office/drawing/2014/main" id="{88E9CF55-9101-461D-B93C-E98B0BD763E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516693" y="2925477"/>
            <a:ext cx="200567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ene expression (A.U)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C1CAF0B-02F3-49A8-BB7A-04DFE221CE8E}"/>
              </a:ext>
            </a:extLst>
          </p:cNvPr>
          <p:cNvSpPr txBox="1"/>
          <p:nvPr/>
        </p:nvSpPr>
        <p:spPr>
          <a:xfrm>
            <a:off x="9754033" y="388285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2A177C8A-D83D-4DD4-9C7A-1A59979CCB59}"/>
              </a:ext>
            </a:extLst>
          </p:cNvPr>
          <p:cNvSpPr txBox="1"/>
          <p:nvPr/>
        </p:nvSpPr>
        <p:spPr>
          <a:xfrm>
            <a:off x="9769273" y="329483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B7EEE67-C2F6-44DB-9732-5EF794D163C9}"/>
              </a:ext>
            </a:extLst>
          </p:cNvPr>
          <p:cNvSpPr txBox="1"/>
          <p:nvPr/>
        </p:nvSpPr>
        <p:spPr>
          <a:xfrm>
            <a:off x="9769273" y="20805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64725AD-9314-4899-98E9-C9D1E6941946}"/>
              </a:ext>
            </a:extLst>
          </p:cNvPr>
          <p:cNvSpPr txBox="1"/>
          <p:nvPr/>
        </p:nvSpPr>
        <p:spPr>
          <a:xfrm>
            <a:off x="9426275" y="2686553"/>
            <a:ext cx="61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AF388E94-F094-488E-A67E-5BBBF81570F7}"/>
              </a:ext>
            </a:extLst>
          </p:cNvPr>
          <p:cNvSpPr txBox="1"/>
          <p:nvPr/>
        </p:nvSpPr>
        <p:spPr>
          <a:xfrm>
            <a:off x="10088856" y="3248242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947FEE6-5D9A-4D37-BD07-66F5E984504B}"/>
              </a:ext>
            </a:extLst>
          </p:cNvPr>
          <p:cNvSpPr txBox="1"/>
          <p:nvPr/>
        </p:nvSpPr>
        <p:spPr>
          <a:xfrm>
            <a:off x="10646902" y="3248242"/>
            <a:ext cx="405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3B9C16D7-CCD4-46B7-9B5A-D3AD0FC1B914}"/>
              </a:ext>
            </a:extLst>
          </p:cNvPr>
          <p:cNvSpPr txBox="1"/>
          <p:nvPr/>
        </p:nvSpPr>
        <p:spPr>
          <a:xfrm>
            <a:off x="11177432" y="3248242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B57B53D-6FE8-4F3D-AE42-78C4D72BAFFD}"/>
              </a:ext>
            </a:extLst>
          </p:cNvPr>
          <p:cNvSpPr txBox="1"/>
          <p:nvPr/>
        </p:nvSpPr>
        <p:spPr>
          <a:xfrm>
            <a:off x="11714290" y="2117445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45B66683-D6AA-4324-B306-106A5FA89298}"/>
              </a:ext>
            </a:extLst>
          </p:cNvPr>
          <p:cNvSpPr txBox="1"/>
          <p:nvPr/>
        </p:nvSpPr>
        <p:spPr>
          <a:xfrm>
            <a:off x="9968466" y="1807296"/>
            <a:ext cx="1002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97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E387EFCF-7A54-4591-8199-AFA6CE84E366}"/>
              </a:ext>
            </a:extLst>
          </p:cNvPr>
          <p:cNvSpPr txBox="1"/>
          <p:nvPr/>
        </p:nvSpPr>
        <p:spPr>
          <a:xfrm>
            <a:off x="461273" y="1005997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9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D08F9BCA-B7F4-4AF9-B4E0-984BC3B54F5E}"/>
              </a:ext>
            </a:extLst>
          </p:cNvPr>
          <p:cNvSpPr txBox="1"/>
          <p:nvPr/>
        </p:nvSpPr>
        <p:spPr>
          <a:xfrm>
            <a:off x="5248691" y="2551276"/>
            <a:ext cx="61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C4D0D1F-9987-473B-B5A9-754235579ADC}"/>
              </a:ext>
            </a:extLst>
          </p:cNvPr>
          <p:cNvSpPr txBox="1"/>
          <p:nvPr/>
        </p:nvSpPr>
        <p:spPr>
          <a:xfrm>
            <a:off x="3082336" y="4091980"/>
            <a:ext cx="585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HAP1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FE5E1B2-CDE4-4903-B5C8-9ACAC190FB09}"/>
              </a:ext>
            </a:extLst>
          </p:cNvPr>
          <p:cNvSpPr txBox="1"/>
          <p:nvPr/>
        </p:nvSpPr>
        <p:spPr>
          <a:xfrm>
            <a:off x="3125180" y="2109308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7">
            <a:extLst>
              <a:ext uri="{FF2B5EF4-FFF2-40B4-BE49-F238E27FC236}">
                <a16:creationId xmlns:a16="http://schemas.microsoft.com/office/drawing/2014/main" id="{85B7E73C-DAC9-4890-BEC5-4396C6F81B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80494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P1</a:t>
            </a:r>
          </a:p>
        </p:txBody>
      </p:sp>
      <p:sp>
        <p:nvSpPr>
          <p:cNvPr id="85" name="TextBox 7">
            <a:extLst>
              <a:ext uri="{FF2B5EF4-FFF2-40B4-BE49-F238E27FC236}">
                <a16:creationId xmlns:a16="http://schemas.microsoft.com/office/drawing/2014/main" id="{E62902F1-5E1B-4472-8D62-6A04DCA127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51961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ORPM1</a:t>
            </a:r>
          </a:p>
        </p:txBody>
      </p:sp>
      <p:sp>
        <p:nvSpPr>
          <p:cNvPr id="86" name="TextBox 7">
            <a:extLst>
              <a:ext uri="{FF2B5EF4-FFF2-40B4-BE49-F238E27FC236}">
                <a16:creationId xmlns:a16="http://schemas.microsoft.com/office/drawing/2014/main" id="{15D4DDCF-6903-4F4F-803A-6E499B7F9C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95523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ASNS</a:t>
            </a:r>
          </a:p>
        </p:txBody>
      </p:sp>
      <p:sp>
        <p:nvSpPr>
          <p:cNvPr id="87" name="TextBox 7">
            <a:extLst>
              <a:ext uri="{FF2B5EF4-FFF2-40B4-BE49-F238E27FC236}">
                <a16:creationId xmlns:a16="http://schemas.microsoft.com/office/drawing/2014/main" id="{C5CA7D12-66C0-430E-A57F-F3FDAA561D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24691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LS</a:t>
            </a:r>
          </a:p>
        </p:txBody>
      </p:sp>
      <p:sp>
        <p:nvSpPr>
          <p:cNvPr id="88" name="TextBox 7">
            <a:extLst>
              <a:ext uri="{FF2B5EF4-FFF2-40B4-BE49-F238E27FC236}">
                <a16:creationId xmlns:a16="http://schemas.microsoft.com/office/drawing/2014/main" id="{22B365F0-6CF5-4FEF-9623-046010218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3490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BTB1</a:t>
            </a:r>
          </a:p>
        </p:txBody>
      </p:sp>
      <p:sp>
        <p:nvSpPr>
          <p:cNvPr id="89" name="TextBox 7">
            <a:extLst>
              <a:ext uri="{FF2B5EF4-FFF2-40B4-BE49-F238E27FC236}">
                <a16:creationId xmlns:a16="http://schemas.microsoft.com/office/drawing/2014/main" id="{AA7F85EB-42B6-4DD1-85C7-7526091C4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42291" y="4104434"/>
            <a:ext cx="7298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HAP1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4B6BBACA-6ECF-49DC-830B-1FCA79485A06}"/>
              </a:ext>
            </a:extLst>
          </p:cNvPr>
          <p:cNvSpPr txBox="1"/>
          <p:nvPr/>
        </p:nvSpPr>
        <p:spPr>
          <a:xfrm>
            <a:off x="8112495" y="3012709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D89F2297-3FC4-4C03-ADEB-906FD49F04F8}"/>
              </a:ext>
            </a:extLst>
          </p:cNvPr>
          <p:cNvSpPr txBox="1"/>
          <p:nvPr/>
        </p:nvSpPr>
        <p:spPr>
          <a:xfrm>
            <a:off x="12295034" y="3248240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DCE9DDF9-B729-4F52-80C0-15A0AC9C4755}"/>
              </a:ext>
            </a:extLst>
          </p:cNvPr>
          <p:cNvSpPr txBox="1"/>
          <p:nvPr/>
        </p:nvSpPr>
        <p:spPr>
          <a:xfrm>
            <a:off x="685336" y="4759886"/>
            <a:ext cx="1233472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9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)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Gene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expression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(ASNS, GLS, OPRM1, ZBTB1, and HAP1)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analysis between L-Asp sensitive and drug resistant primary B-ALL cells.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Gene expression data was retrieved from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SE653-654 datasets. Each box plot shows the distribution of log2 of GATA3 transcription value from the 10th to the 90th percentile. The line inside each box plot represents the median; ****,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&lt; 0.0001, (Unpaired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test).   B-C) )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Gene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expression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(ASNS, GLS, OPRM1, ZBTB1, and HAP1)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in Nalm6 (B) and 697 (C) cells with or without ectopic GATA3 expression, All experiments were performed in triplicate, and repeated in three independent times. Bars represent the mean values; the error bars represent the SD from triplicate.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ns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, no significance; *; **,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&lt; 0.01; ***,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&lt; 0.001, (Student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test)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E95158D-7BDC-47B5-9158-3230AF5839CC}"/>
              </a:ext>
            </a:extLst>
          </p:cNvPr>
          <p:cNvSpPr txBox="1"/>
          <p:nvPr/>
        </p:nvSpPr>
        <p:spPr>
          <a:xfrm>
            <a:off x="216403" y="164673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BE1A2F87-020F-490F-A626-626D258E06B8}"/>
              </a:ext>
            </a:extLst>
          </p:cNvPr>
          <p:cNvSpPr txBox="1"/>
          <p:nvPr/>
        </p:nvSpPr>
        <p:spPr>
          <a:xfrm>
            <a:off x="5031163" y="164673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F857D22-D0C6-4994-8028-33D8B4BAF262}"/>
              </a:ext>
            </a:extLst>
          </p:cNvPr>
          <p:cNvSpPr txBox="1"/>
          <p:nvPr/>
        </p:nvSpPr>
        <p:spPr>
          <a:xfrm>
            <a:off x="9088368" y="164673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642642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5EC746C-47AD-4624-85A3-C48C16B67F20}"/>
              </a:ext>
            </a:extLst>
          </p:cNvPr>
          <p:cNvSpPr txBox="1"/>
          <p:nvPr/>
        </p:nvSpPr>
        <p:spPr>
          <a:xfrm>
            <a:off x="475561" y="1005997"/>
            <a:ext cx="3643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10</a:t>
            </a:r>
          </a:p>
        </p:txBody>
      </p: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AAF9656E-D802-45BC-BF3E-D23915DD39DA}"/>
              </a:ext>
            </a:extLst>
          </p:cNvPr>
          <p:cNvGrpSpPr/>
          <p:nvPr/>
        </p:nvGrpSpPr>
        <p:grpSpPr>
          <a:xfrm>
            <a:off x="552413" y="2003497"/>
            <a:ext cx="2852067" cy="2802118"/>
            <a:chOff x="1486310" y="2451729"/>
            <a:chExt cx="2852067" cy="2802118"/>
          </a:xfrm>
        </p:grpSpPr>
        <p:sp>
          <p:nvSpPr>
            <p:cNvPr id="3" name="TextBox 7">
              <a:extLst>
                <a:ext uri="{FF2B5EF4-FFF2-40B4-BE49-F238E27FC236}">
                  <a16:creationId xmlns:a16="http://schemas.microsoft.com/office/drawing/2014/main" id="{0DFB851B-F913-410A-886A-D99281DABB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1960" y="2451729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ASNS</a:t>
              </a: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5C895B9-F422-4CB4-963C-5B6E2C1493CF}"/>
                </a:ext>
              </a:extLst>
            </p:cNvPr>
            <p:cNvGrpSpPr/>
            <p:nvPr/>
          </p:nvGrpSpPr>
          <p:grpSpPr>
            <a:xfrm>
              <a:off x="1486310" y="2537405"/>
              <a:ext cx="2852067" cy="2716442"/>
              <a:chOff x="330871" y="4740275"/>
              <a:chExt cx="2852067" cy="2716442"/>
            </a:xfrm>
          </p:grpSpPr>
          <p:graphicFrame>
            <p:nvGraphicFramePr>
              <p:cNvPr id="7" name="对象 6">
                <a:extLst>
                  <a:ext uri="{FF2B5EF4-FFF2-40B4-BE49-F238E27FC236}">
                    <a16:creationId xmlns:a16="http://schemas.microsoft.com/office/drawing/2014/main" id="{5CD0A064-93A4-42FB-954F-4682241D9A7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55090668"/>
                  </p:ext>
                </p:extLst>
              </p:nvPr>
            </p:nvGraphicFramePr>
            <p:xfrm>
              <a:off x="544513" y="4740275"/>
              <a:ext cx="2638425" cy="23828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3" imgW="2643756" imgH="2389993" progId="Prism7.Document">
                      <p:embed/>
                    </p:oleObj>
                  </mc:Choice>
                  <mc:Fallback>
                    <p:oleObj name="Prism 7" r:id="rId3" imgW="2643756" imgH="2389993" progId="Prism7.Document">
                      <p:embed/>
                      <p:pic>
                        <p:nvPicPr>
                          <p:cNvPr id="7" name="对象 6">
                            <a:extLst>
                              <a:ext uri="{FF2B5EF4-FFF2-40B4-BE49-F238E27FC236}">
                                <a16:creationId xmlns:a16="http://schemas.microsoft.com/office/drawing/2014/main" id="{5CD0A064-93A4-42FB-954F-4682241D9A7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544513" y="4740275"/>
                            <a:ext cx="2638425" cy="23828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781121FB-3A7F-4EE0-B0DA-BE74A7AE139D}"/>
                  </a:ext>
                </a:extLst>
              </p:cNvPr>
              <p:cNvSpPr txBox="1"/>
              <p:nvPr/>
            </p:nvSpPr>
            <p:spPr>
              <a:xfrm>
                <a:off x="1916876" y="6283546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58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6AC73572-B60A-4B0D-9C5E-08AF0C1B1D73}"/>
                  </a:ext>
                </a:extLst>
              </p:cNvPr>
              <p:cNvGrpSpPr/>
              <p:nvPr/>
            </p:nvGrpSpPr>
            <p:grpSpPr>
              <a:xfrm>
                <a:off x="700609" y="6859918"/>
                <a:ext cx="2307619" cy="596799"/>
                <a:chOff x="700609" y="6859918"/>
                <a:chExt cx="2307619" cy="596799"/>
              </a:xfrm>
            </p:grpSpPr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75BB7DAF-818D-4209-8843-3C781A698A34}"/>
                    </a:ext>
                  </a:extLst>
                </p:cNvPr>
                <p:cNvSpPr txBox="1"/>
                <p:nvPr/>
              </p:nvSpPr>
              <p:spPr>
                <a:xfrm>
                  <a:off x="700609" y="7148940"/>
                  <a:ext cx="230761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g2 of </a:t>
                  </a:r>
                  <a:r>
                    <a:rPr lang="en-US" altLang="zh-CN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TA3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" name="组合 18">
                  <a:extLst>
                    <a:ext uri="{FF2B5EF4-FFF2-40B4-BE49-F238E27FC236}">
                      <a16:creationId xmlns:a16="http://schemas.microsoft.com/office/drawing/2014/main" id="{9853B266-C607-4EED-860A-2DAA5D27AF1B}"/>
                    </a:ext>
                  </a:extLst>
                </p:cNvPr>
                <p:cNvGrpSpPr/>
                <p:nvPr/>
              </p:nvGrpSpPr>
              <p:grpSpPr>
                <a:xfrm>
                  <a:off x="962078" y="6859918"/>
                  <a:ext cx="1784680" cy="276999"/>
                  <a:chOff x="969004" y="6887628"/>
                  <a:chExt cx="1784680" cy="276999"/>
                </a:xfrm>
              </p:grpSpPr>
              <p:sp>
                <p:nvSpPr>
                  <p:cNvPr id="20" name="TextBox 7">
                    <a:extLst>
                      <a:ext uri="{FF2B5EF4-FFF2-40B4-BE49-F238E27FC236}">
                        <a16:creationId xmlns:a16="http://schemas.microsoft.com/office/drawing/2014/main" id="{C149C18A-62D9-4934-9EA5-B99424B9329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00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21" name="TextBox 7">
                    <a:extLst>
                      <a:ext uri="{FF2B5EF4-FFF2-40B4-BE49-F238E27FC236}">
                        <a16:creationId xmlns:a16="http://schemas.microsoft.com/office/drawing/2014/main" id="{31EFF3FC-8830-4716-AEBF-08D1A42371C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2234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22" name="TextBox 7">
                    <a:extLst>
                      <a:ext uri="{FF2B5EF4-FFF2-40B4-BE49-F238E27FC236}">
                        <a16:creationId xmlns:a16="http://schemas.microsoft.com/office/drawing/2014/main" id="{2DE7CC7D-8235-4D3C-8071-1CF904F4B0C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9543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23" name="TextBox 7">
                    <a:extLst>
                      <a:ext uri="{FF2B5EF4-FFF2-40B4-BE49-F238E27FC236}">
                        <a16:creationId xmlns:a16="http://schemas.microsoft.com/office/drawing/2014/main" id="{9639A21E-77DB-47DE-A33A-34761797110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36736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</p:grpSp>
          </p:grp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2D6744F2-10FA-4510-ADEB-4864A00F66EB}"/>
                  </a:ext>
                </a:extLst>
              </p:cNvPr>
              <p:cNvSpPr txBox="1"/>
              <p:nvPr/>
            </p:nvSpPr>
            <p:spPr>
              <a:xfrm rot="16200000">
                <a:off x="-587009" y="5719874"/>
                <a:ext cx="21435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og2 of gene expression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D2144345-1ACC-456D-B0BB-B27138A2891F}"/>
                  </a:ext>
                </a:extLst>
              </p:cNvPr>
              <p:cNvGrpSpPr/>
              <p:nvPr/>
            </p:nvGrpSpPr>
            <p:grpSpPr>
              <a:xfrm>
                <a:off x="501076" y="4841637"/>
                <a:ext cx="416948" cy="2064251"/>
                <a:chOff x="501076" y="4850124"/>
                <a:chExt cx="416948" cy="2064251"/>
              </a:xfrm>
            </p:grpSpPr>
            <p:sp>
              <p:nvSpPr>
                <p:cNvPr id="12" name="TextBox 7">
                  <a:extLst>
                    <a:ext uri="{FF2B5EF4-FFF2-40B4-BE49-F238E27FC236}">
                      <a16:creationId xmlns:a16="http://schemas.microsoft.com/office/drawing/2014/main" id="{DADE3ED7-FB6D-4333-AF51-5E7F5381607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277155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3" name="TextBox 7">
                  <a:extLst>
                    <a:ext uri="{FF2B5EF4-FFF2-40B4-BE49-F238E27FC236}">
                      <a16:creationId xmlns:a16="http://schemas.microsoft.com/office/drawing/2014/main" id="{1D81E806-CA4A-4D69-8645-FD20383D48B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637376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4" name="TextBox 7">
                  <a:extLst>
                    <a:ext uri="{FF2B5EF4-FFF2-40B4-BE49-F238E27FC236}">
                      <a16:creationId xmlns:a16="http://schemas.microsoft.com/office/drawing/2014/main" id="{46A088D1-1F95-4C1C-9558-866F55A6A5C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916937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5" name="TextBox 7">
                  <a:extLst>
                    <a:ext uri="{FF2B5EF4-FFF2-40B4-BE49-F238E27FC236}">
                      <a16:creationId xmlns:a16="http://schemas.microsoft.com/office/drawing/2014/main" id="{34D6AF20-D485-4735-8D9C-40E0566C3E8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570569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16" name="TextBox 7">
                  <a:extLst>
                    <a:ext uri="{FF2B5EF4-FFF2-40B4-BE49-F238E27FC236}">
                      <a16:creationId xmlns:a16="http://schemas.microsoft.com/office/drawing/2014/main" id="{5ACBF6FB-7528-42AB-8196-52BC008DFCA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196492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7" name="TextBox 7">
                  <a:extLst>
                    <a:ext uri="{FF2B5EF4-FFF2-40B4-BE49-F238E27FC236}">
                      <a16:creationId xmlns:a16="http://schemas.microsoft.com/office/drawing/2014/main" id="{C490EBCF-99BA-41AE-99DC-56A9BB47A63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4850124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</p:grp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992AB50E-C5FF-4711-80D7-2FD26E7D235B}"/>
              </a:ext>
            </a:extLst>
          </p:cNvPr>
          <p:cNvGrpSpPr/>
          <p:nvPr/>
        </p:nvGrpSpPr>
        <p:grpSpPr>
          <a:xfrm>
            <a:off x="7915428" y="1994529"/>
            <a:ext cx="2694401" cy="2802118"/>
            <a:chOff x="4288306" y="2451729"/>
            <a:chExt cx="2694401" cy="2802118"/>
          </a:xfrm>
        </p:grpSpPr>
        <p:sp>
          <p:nvSpPr>
            <p:cNvPr id="5" name="TextBox 7">
              <a:extLst>
                <a:ext uri="{FF2B5EF4-FFF2-40B4-BE49-F238E27FC236}">
                  <a16:creationId xmlns:a16="http://schemas.microsoft.com/office/drawing/2014/main" id="{53A82CAC-3FD5-4636-BF2E-3FA225C756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81466" y="2451729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ZBTB1</a:t>
              </a:r>
            </a:p>
          </p:txBody>
        </p: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FD3AF23B-4B3D-441F-8602-E9237A787C70}"/>
                </a:ext>
              </a:extLst>
            </p:cNvPr>
            <p:cNvGrpSpPr/>
            <p:nvPr/>
          </p:nvGrpSpPr>
          <p:grpSpPr>
            <a:xfrm>
              <a:off x="4288306" y="2537405"/>
              <a:ext cx="2694401" cy="2716442"/>
              <a:chOff x="3881024" y="4740275"/>
              <a:chExt cx="2694401" cy="2716442"/>
            </a:xfrm>
          </p:grpSpPr>
          <p:graphicFrame>
            <p:nvGraphicFramePr>
              <p:cNvPr id="25" name="对象 24">
                <a:extLst>
                  <a:ext uri="{FF2B5EF4-FFF2-40B4-BE49-F238E27FC236}">
                    <a16:creationId xmlns:a16="http://schemas.microsoft.com/office/drawing/2014/main" id="{0CCF3A1D-3379-44B8-A490-5315E5F3EFA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19692679"/>
                  </p:ext>
                </p:extLst>
              </p:nvPr>
            </p:nvGraphicFramePr>
            <p:xfrm>
              <a:off x="3937000" y="4740275"/>
              <a:ext cx="2638425" cy="23828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5" imgW="2643756" imgH="2389993" progId="Prism7.Document">
                      <p:embed/>
                    </p:oleObj>
                  </mc:Choice>
                  <mc:Fallback>
                    <p:oleObj name="Prism 7" r:id="rId5" imgW="2643756" imgH="2389993" progId="Prism7.Document">
                      <p:embed/>
                      <p:pic>
                        <p:nvPicPr>
                          <p:cNvPr id="25" name="对象 24">
                            <a:extLst>
                              <a:ext uri="{FF2B5EF4-FFF2-40B4-BE49-F238E27FC236}">
                                <a16:creationId xmlns:a16="http://schemas.microsoft.com/office/drawing/2014/main" id="{0CCF3A1D-3379-44B8-A490-5315E5F3EFA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937000" y="4740275"/>
                            <a:ext cx="2638425" cy="23828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A8E70AF-86C6-436F-97B3-30D960E2BF43}"/>
                  </a:ext>
                </a:extLst>
              </p:cNvPr>
              <p:cNvSpPr txBox="1"/>
              <p:nvPr/>
            </p:nvSpPr>
            <p:spPr>
              <a:xfrm>
                <a:off x="5351819" y="6351890"/>
                <a:ext cx="8258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02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FE25FA73-D55E-48E3-BCEA-A025D2338006}"/>
                  </a:ext>
                </a:extLst>
              </p:cNvPr>
              <p:cNvGrpSpPr/>
              <p:nvPr/>
            </p:nvGrpSpPr>
            <p:grpSpPr>
              <a:xfrm>
                <a:off x="4090747" y="6859918"/>
                <a:ext cx="2307619" cy="596799"/>
                <a:chOff x="700609" y="6859918"/>
                <a:chExt cx="2307619" cy="596799"/>
              </a:xfrm>
            </p:grpSpPr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849B771E-7629-4ADA-A635-7FB8AA7CE50D}"/>
                    </a:ext>
                  </a:extLst>
                </p:cNvPr>
                <p:cNvSpPr txBox="1"/>
                <p:nvPr/>
              </p:nvSpPr>
              <p:spPr>
                <a:xfrm>
                  <a:off x="700609" y="7148940"/>
                  <a:ext cx="230761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g2 of </a:t>
                  </a:r>
                  <a:r>
                    <a:rPr lang="en-US" altLang="zh-CN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TA3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6" name="组合 35">
                  <a:extLst>
                    <a:ext uri="{FF2B5EF4-FFF2-40B4-BE49-F238E27FC236}">
                      <a16:creationId xmlns:a16="http://schemas.microsoft.com/office/drawing/2014/main" id="{0D5AEB3E-2087-4991-9855-95AAF9AF8391}"/>
                    </a:ext>
                  </a:extLst>
                </p:cNvPr>
                <p:cNvGrpSpPr/>
                <p:nvPr/>
              </p:nvGrpSpPr>
              <p:grpSpPr>
                <a:xfrm>
                  <a:off x="962078" y="6859918"/>
                  <a:ext cx="1784680" cy="276999"/>
                  <a:chOff x="969004" y="6887628"/>
                  <a:chExt cx="1784680" cy="276999"/>
                </a:xfrm>
              </p:grpSpPr>
              <p:sp>
                <p:nvSpPr>
                  <p:cNvPr id="37" name="TextBox 7">
                    <a:extLst>
                      <a:ext uri="{FF2B5EF4-FFF2-40B4-BE49-F238E27FC236}">
                        <a16:creationId xmlns:a16="http://schemas.microsoft.com/office/drawing/2014/main" id="{53499C3A-5419-47C3-A042-693478F82D2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00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38" name="TextBox 7">
                    <a:extLst>
                      <a:ext uri="{FF2B5EF4-FFF2-40B4-BE49-F238E27FC236}">
                        <a16:creationId xmlns:a16="http://schemas.microsoft.com/office/drawing/2014/main" id="{5C645819-7004-4883-97D7-6DBC09D73EA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2234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39" name="TextBox 7">
                    <a:extLst>
                      <a:ext uri="{FF2B5EF4-FFF2-40B4-BE49-F238E27FC236}">
                        <a16:creationId xmlns:a16="http://schemas.microsoft.com/office/drawing/2014/main" id="{D4E0672A-4B84-4045-9750-DD094CC0491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9543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40" name="TextBox 7">
                    <a:extLst>
                      <a:ext uri="{FF2B5EF4-FFF2-40B4-BE49-F238E27FC236}">
                        <a16:creationId xmlns:a16="http://schemas.microsoft.com/office/drawing/2014/main" id="{72854DEA-E704-4AB7-A273-1488DA1242D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36736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</p:grpSp>
          </p:grpSp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150C668F-0607-4BBF-868E-826D767FD8A3}"/>
                  </a:ext>
                </a:extLst>
              </p:cNvPr>
              <p:cNvGrpSpPr/>
              <p:nvPr/>
            </p:nvGrpSpPr>
            <p:grpSpPr>
              <a:xfrm>
                <a:off x="3881024" y="4841637"/>
                <a:ext cx="416948" cy="2064251"/>
                <a:chOff x="501076" y="4850124"/>
                <a:chExt cx="416948" cy="2064251"/>
              </a:xfrm>
            </p:grpSpPr>
            <p:sp>
              <p:nvSpPr>
                <p:cNvPr id="29" name="TextBox 7">
                  <a:extLst>
                    <a:ext uri="{FF2B5EF4-FFF2-40B4-BE49-F238E27FC236}">
                      <a16:creationId xmlns:a16="http://schemas.microsoft.com/office/drawing/2014/main" id="{65063E8E-8AA0-4B7B-A963-E9E7A35928F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277155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30" name="TextBox 7">
                  <a:extLst>
                    <a:ext uri="{FF2B5EF4-FFF2-40B4-BE49-F238E27FC236}">
                      <a16:creationId xmlns:a16="http://schemas.microsoft.com/office/drawing/2014/main" id="{EAA5EA95-3146-424D-92F8-6DF3D4D8FDD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637376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31" name="TextBox 7">
                  <a:extLst>
                    <a:ext uri="{FF2B5EF4-FFF2-40B4-BE49-F238E27FC236}">
                      <a16:creationId xmlns:a16="http://schemas.microsoft.com/office/drawing/2014/main" id="{57AA4879-2E19-475F-B595-5C6277B8818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916937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32" name="TextBox 7">
                  <a:extLst>
                    <a:ext uri="{FF2B5EF4-FFF2-40B4-BE49-F238E27FC236}">
                      <a16:creationId xmlns:a16="http://schemas.microsoft.com/office/drawing/2014/main" id="{769B59D2-9397-4DDF-9729-D7D54BBEE6D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570569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33" name="TextBox 7">
                  <a:extLst>
                    <a:ext uri="{FF2B5EF4-FFF2-40B4-BE49-F238E27FC236}">
                      <a16:creationId xmlns:a16="http://schemas.microsoft.com/office/drawing/2014/main" id="{27A81367-A5F8-437C-A9B5-921BF8741C1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196492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34" name="TextBox 7">
                  <a:extLst>
                    <a:ext uri="{FF2B5EF4-FFF2-40B4-BE49-F238E27FC236}">
                      <a16:creationId xmlns:a16="http://schemas.microsoft.com/office/drawing/2014/main" id="{D49A16AC-DFED-4D92-B4F2-6858221E66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4850124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3</a:t>
                  </a:r>
                </a:p>
              </p:txBody>
            </p:sp>
          </p:grpSp>
        </p:grp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7C11C276-BD4B-4AEA-B16C-9C677DE7CC9C}"/>
              </a:ext>
            </a:extLst>
          </p:cNvPr>
          <p:cNvGrpSpPr/>
          <p:nvPr/>
        </p:nvGrpSpPr>
        <p:grpSpPr>
          <a:xfrm>
            <a:off x="3167354" y="1994529"/>
            <a:ext cx="2711394" cy="2802118"/>
            <a:chOff x="6947694" y="2451729"/>
            <a:chExt cx="2711394" cy="2802118"/>
          </a:xfrm>
        </p:grpSpPr>
        <p:sp>
          <p:nvSpPr>
            <p:cNvPr id="4" name="TextBox 7">
              <a:extLst>
                <a:ext uri="{FF2B5EF4-FFF2-40B4-BE49-F238E27FC236}">
                  <a16:creationId xmlns:a16="http://schemas.microsoft.com/office/drawing/2014/main" id="{5033237F-66D4-4BE3-8CB4-0C75312AC0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88846" y="2451729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LS</a:t>
              </a: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C3424383-82C8-4A10-9FAA-9EE6A491BD64}"/>
                </a:ext>
              </a:extLst>
            </p:cNvPr>
            <p:cNvGrpSpPr/>
            <p:nvPr/>
          </p:nvGrpSpPr>
          <p:grpSpPr>
            <a:xfrm>
              <a:off x="6947694" y="2537405"/>
              <a:ext cx="2711394" cy="2716442"/>
              <a:chOff x="7094594" y="4740275"/>
              <a:chExt cx="2711394" cy="2716442"/>
            </a:xfrm>
          </p:grpSpPr>
          <p:graphicFrame>
            <p:nvGraphicFramePr>
              <p:cNvPr id="42" name="对象 41">
                <a:extLst>
                  <a:ext uri="{FF2B5EF4-FFF2-40B4-BE49-F238E27FC236}">
                    <a16:creationId xmlns:a16="http://schemas.microsoft.com/office/drawing/2014/main" id="{7AD81AB7-E46F-45E1-A747-42CD245A0DA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38534875"/>
                  </p:ext>
                </p:extLst>
              </p:nvPr>
            </p:nvGraphicFramePr>
            <p:xfrm>
              <a:off x="7169150" y="4740275"/>
              <a:ext cx="2636838" cy="23828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7" imgW="2643756" imgH="2389993" progId="Prism7.Document">
                      <p:embed/>
                    </p:oleObj>
                  </mc:Choice>
                  <mc:Fallback>
                    <p:oleObj name="Prism 7" r:id="rId7" imgW="2643756" imgH="2389993" progId="Prism7.Document">
                      <p:embed/>
                      <p:pic>
                        <p:nvPicPr>
                          <p:cNvPr id="42" name="对象 41">
                            <a:extLst>
                              <a:ext uri="{FF2B5EF4-FFF2-40B4-BE49-F238E27FC236}">
                                <a16:creationId xmlns:a16="http://schemas.microsoft.com/office/drawing/2014/main" id="{7AD81AB7-E46F-45E1-A747-42CD245A0DA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7169150" y="4740275"/>
                            <a:ext cx="2636838" cy="23828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9340180C-574C-4092-BF30-73FF73E180A0}"/>
                  </a:ext>
                </a:extLst>
              </p:cNvPr>
              <p:cNvSpPr txBox="1"/>
              <p:nvPr/>
            </p:nvSpPr>
            <p:spPr>
              <a:xfrm>
                <a:off x="8538829" y="6326201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03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4" name="组合 43">
                <a:extLst>
                  <a:ext uri="{FF2B5EF4-FFF2-40B4-BE49-F238E27FC236}">
                    <a16:creationId xmlns:a16="http://schemas.microsoft.com/office/drawing/2014/main" id="{72652431-0B98-4554-BCE3-319B08106FDB}"/>
                  </a:ext>
                </a:extLst>
              </p:cNvPr>
              <p:cNvGrpSpPr/>
              <p:nvPr/>
            </p:nvGrpSpPr>
            <p:grpSpPr>
              <a:xfrm>
                <a:off x="7322562" y="6859918"/>
                <a:ext cx="2307619" cy="596799"/>
                <a:chOff x="700609" y="6859918"/>
                <a:chExt cx="2307619" cy="596799"/>
              </a:xfrm>
            </p:grpSpPr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933A9524-39C4-4F1A-A82B-C68655FC80C3}"/>
                    </a:ext>
                  </a:extLst>
                </p:cNvPr>
                <p:cNvSpPr txBox="1"/>
                <p:nvPr/>
              </p:nvSpPr>
              <p:spPr>
                <a:xfrm>
                  <a:off x="700609" y="7148940"/>
                  <a:ext cx="230761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g2 of </a:t>
                  </a:r>
                  <a:r>
                    <a:rPr lang="en-US" altLang="zh-CN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TA3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53" name="组合 52">
                  <a:extLst>
                    <a:ext uri="{FF2B5EF4-FFF2-40B4-BE49-F238E27FC236}">
                      <a16:creationId xmlns:a16="http://schemas.microsoft.com/office/drawing/2014/main" id="{552AA237-D8C0-42E7-BFC9-43E522F34327}"/>
                    </a:ext>
                  </a:extLst>
                </p:cNvPr>
                <p:cNvGrpSpPr/>
                <p:nvPr/>
              </p:nvGrpSpPr>
              <p:grpSpPr>
                <a:xfrm>
                  <a:off x="962078" y="6859918"/>
                  <a:ext cx="1784680" cy="276999"/>
                  <a:chOff x="969004" y="6887628"/>
                  <a:chExt cx="1784680" cy="276999"/>
                </a:xfrm>
              </p:grpSpPr>
              <p:sp>
                <p:nvSpPr>
                  <p:cNvPr id="54" name="TextBox 7">
                    <a:extLst>
                      <a:ext uri="{FF2B5EF4-FFF2-40B4-BE49-F238E27FC236}">
                        <a16:creationId xmlns:a16="http://schemas.microsoft.com/office/drawing/2014/main" id="{A74EC947-5CF5-4FC1-9276-18A318D23E6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00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55" name="TextBox 7">
                    <a:extLst>
                      <a:ext uri="{FF2B5EF4-FFF2-40B4-BE49-F238E27FC236}">
                        <a16:creationId xmlns:a16="http://schemas.microsoft.com/office/drawing/2014/main" id="{71889812-6572-4036-9D74-30E64491A4C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2234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56" name="TextBox 7">
                    <a:extLst>
                      <a:ext uri="{FF2B5EF4-FFF2-40B4-BE49-F238E27FC236}">
                        <a16:creationId xmlns:a16="http://schemas.microsoft.com/office/drawing/2014/main" id="{DA705A1A-9E17-4E80-A1EB-42853E358EB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9543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57" name="TextBox 7">
                    <a:extLst>
                      <a:ext uri="{FF2B5EF4-FFF2-40B4-BE49-F238E27FC236}">
                        <a16:creationId xmlns:a16="http://schemas.microsoft.com/office/drawing/2014/main" id="{7F458D14-6545-4386-A8DB-854DCFFB74F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36736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</p:grpSp>
          </p:grpSp>
          <p:grpSp>
            <p:nvGrpSpPr>
              <p:cNvPr id="45" name="组合 44">
                <a:extLst>
                  <a:ext uri="{FF2B5EF4-FFF2-40B4-BE49-F238E27FC236}">
                    <a16:creationId xmlns:a16="http://schemas.microsoft.com/office/drawing/2014/main" id="{AFFF3DD6-5E61-4ACD-8A31-A047A92CDB49}"/>
                  </a:ext>
                </a:extLst>
              </p:cNvPr>
              <p:cNvGrpSpPr/>
              <p:nvPr/>
            </p:nvGrpSpPr>
            <p:grpSpPr>
              <a:xfrm>
                <a:off x="7094594" y="4841637"/>
                <a:ext cx="416948" cy="2064251"/>
                <a:chOff x="501076" y="4850124"/>
                <a:chExt cx="416948" cy="2064251"/>
              </a:xfrm>
            </p:grpSpPr>
            <p:sp>
              <p:nvSpPr>
                <p:cNvPr id="46" name="TextBox 7">
                  <a:extLst>
                    <a:ext uri="{FF2B5EF4-FFF2-40B4-BE49-F238E27FC236}">
                      <a16:creationId xmlns:a16="http://schemas.microsoft.com/office/drawing/2014/main" id="{CE374E07-F9CC-4F29-BC37-D0762122A25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277155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47" name="TextBox 7">
                  <a:extLst>
                    <a:ext uri="{FF2B5EF4-FFF2-40B4-BE49-F238E27FC236}">
                      <a16:creationId xmlns:a16="http://schemas.microsoft.com/office/drawing/2014/main" id="{3A941694-941E-44C9-907A-3025A1E733D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637376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48" name="TextBox 7">
                  <a:extLst>
                    <a:ext uri="{FF2B5EF4-FFF2-40B4-BE49-F238E27FC236}">
                      <a16:creationId xmlns:a16="http://schemas.microsoft.com/office/drawing/2014/main" id="{8BFA2086-0D36-4891-BD5E-0600284057C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916937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49" name="TextBox 7">
                  <a:extLst>
                    <a:ext uri="{FF2B5EF4-FFF2-40B4-BE49-F238E27FC236}">
                      <a16:creationId xmlns:a16="http://schemas.microsoft.com/office/drawing/2014/main" id="{54401A83-29DE-4150-B1C3-AF145C81BDD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570569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50" name="TextBox 7">
                  <a:extLst>
                    <a:ext uri="{FF2B5EF4-FFF2-40B4-BE49-F238E27FC236}">
                      <a16:creationId xmlns:a16="http://schemas.microsoft.com/office/drawing/2014/main" id="{08260495-52EB-4A49-850E-04370FA72F3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196492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51" name="TextBox 7">
                  <a:extLst>
                    <a:ext uri="{FF2B5EF4-FFF2-40B4-BE49-F238E27FC236}">
                      <a16:creationId xmlns:a16="http://schemas.microsoft.com/office/drawing/2014/main" id="{C5FA6AE0-E372-4511-99AD-FC737B075A7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4850124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2</a:t>
                  </a:r>
                </a:p>
              </p:txBody>
            </p:sp>
          </p:grpSp>
        </p:grp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4FA7D103-6CA2-4574-A70E-8E878D286699}"/>
              </a:ext>
            </a:extLst>
          </p:cNvPr>
          <p:cNvGrpSpPr/>
          <p:nvPr/>
        </p:nvGrpSpPr>
        <p:grpSpPr>
          <a:xfrm>
            <a:off x="5548479" y="1994529"/>
            <a:ext cx="2694016" cy="2802118"/>
            <a:chOff x="9621675" y="2451729"/>
            <a:chExt cx="2694016" cy="2802118"/>
          </a:xfrm>
        </p:grpSpPr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EF97E374-2F96-4741-9189-CCA311DA3D8A}"/>
                </a:ext>
              </a:extLst>
            </p:cNvPr>
            <p:cNvGrpSpPr/>
            <p:nvPr/>
          </p:nvGrpSpPr>
          <p:grpSpPr>
            <a:xfrm>
              <a:off x="9621675" y="2537405"/>
              <a:ext cx="2694016" cy="2716442"/>
              <a:chOff x="10350472" y="4740275"/>
              <a:chExt cx="2694016" cy="2716442"/>
            </a:xfrm>
          </p:grpSpPr>
          <p:graphicFrame>
            <p:nvGraphicFramePr>
              <p:cNvPr id="59" name="对象 58">
                <a:extLst>
                  <a:ext uri="{FF2B5EF4-FFF2-40B4-BE49-F238E27FC236}">
                    <a16:creationId xmlns:a16="http://schemas.microsoft.com/office/drawing/2014/main" id="{AD197E73-A943-4A6F-974F-790CCC03D3D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58460831"/>
                  </p:ext>
                </p:extLst>
              </p:nvPr>
            </p:nvGraphicFramePr>
            <p:xfrm>
              <a:off x="10406063" y="4740275"/>
              <a:ext cx="2638425" cy="23828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9" imgW="2643756" imgH="2389993" progId="Prism7.Document">
                      <p:embed/>
                    </p:oleObj>
                  </mc:Choice>
                  <mc:Fallback>
                    <p:oleObj name="Prism 7" r:id="rId9" imgW="2643756" imgH="2389993" progId="Prism7.Document">
                      <p:embed/>
                      <p:pic>
                        <p:nvPicPr>
                          <p:cNvPr id="59" name="对象 58">
                            <a:extLst>
                              <a:ext uri="{FF2B5EF4-FFF2-40B4-BE49-F238E27FC236}">
                                <a16:creationId xmlns:a16="http://schemas.microsoft.com/office/drawing/2014/main" id="{AD197E73-A943-4A6F-974F-790CCC03D3D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10406063" y="4740275"/>
                            <a:ext cx="2638425" cy="238283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28670702-CB3D-471F-823A-2F1BF21BF913}"/>
                  </a:ext>
                </a:extLst>
              </p:cNvPr>
              <p:cNvSpPr txBox="1"/>
              <p:nvPr/>
            </p:nvSpPr>
            <p:spPr>
              <a:xfrm>
                <a:off x="11648492" y="6332502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0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1" name="组合 60">
                <a:extLst>
                  <a:ext uri="{FF2B5EF4-FFF2-40B4-BE49-F238E27FC236}">
                    <a16:creationId xmlns:a16="http://schemas.microsoft.com/office/drawing/2014/main" id="{E3B08709-A129-41CD-B1CE-8342554B3B5A}"/>
                  </a:ext>
                </a:extLst>
              </p:cNvPr>
              <p:cNvGrpSpPr/>
              <p:nvPr/>
            </p:nvGrpSpPr>
            <p:grpSpPr>
              <a:xfrm>
                <a:off x="10582320" y="6859918"/>
                <a:ext cx="2307619" cy="596799"/>
                <a:chOff x="700609" y="6859918"/>
                <a:chExt cx="2307619" cy="596799"/>
              </a:xfrm>
            </p:grpSpPr>
            <p:sp>
              <p:nvSpPr>
                <p:cNvPr id="69" name="文本框 68">
                  <a:extLst>
                    <a:ext uri="{FF2B5EF4-FFF2-40B4-BE49-F238E27FC236}">
                      <a16:creationId xmlns:a16="http://schemas.microsoft.com/office/drawing/2014/main" id="{68C12192-6F7B-487C-9482-EB6DDE9E1FAD}"/>
                    </a:ext>
                  </a:extLst>
                </p:cNvPr>
                <p:cNvSpPr txBox="1"/>
                <p:nvPr/>
              </p:nvSpPr>
              <p:spPr>
                <a:xfrm>
                  <a:off x="700609" y="7148940"/>
                  <a:ext cx="230761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g2 of </a:t>
                  </a:r>
                  <a:r>
                    <a:rPr lang="en-US" altLang="zh-CN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TA3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0" name="组合 69">
                  <a:extLst>
                    <a:ext uri="{FF2B5EF4-FFF2-40B4-BE49-F238E27FC236}">
                      <a16:creationId xmlns:a16="http://schemas.microsoft.com/office/drawing/2014/main" id="{C611A709-499E-444C-874E-A19EB07DB62F}"/>
                    </a:ext>
                  </a:extLst>
                </p:cNvPr>
                <p:cNvGrpSpPr/>
                <p:nvPr/>
              </p:nvGrpSpPr>
              <p:grpSpPr>
                <a:xfrm>
                  <a:off x="962078" y="6859918"/>
                  <a:ext cx="1784680" cy="276999"/>
                  <a:chOff x="969004" y="6887628"/>
                  <a:chExt cx="1784680" cy="276999"/>
                </a:xfrm>
              </p:grpSpPr>
              <p:sp>
                <p:nvSpPr>
                  <p:cNvPr id="71" name="TextBox 7">
                    <a:extLst>
                      <a:ext uri="{FF2B5EF4-FFF2-40B4-BE49-F238E27FC236}">
                        <a16:creationId xmlns:a16="http://schemas.microsoft.com/office/drawing/2014/main" id="{A2875436-EF03-462E-A605-68264CF5B3B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00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72" name="TextBox 7">
                    <a:extLst>
                      <a:ext uri="{FF2B5EF4-FFF2-40B4-BE49-F238E27FC236}">
                        <a16:creationId xmlns:a16="http://schemas.microsoft.com/office/drawing/2014/main" id="{A89057AB-B337-4C28-AAB0-9EBD0B2C38D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2234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73" name="TextBox 7">
                    <a:extLst>
                      <a:ext uri="{FF2B5EF4-FFF2-40B4-BE49-F238E27FC236}">
                        <a16:creationId xmlns:a16="http://schemas.microsoft.com/office/drawing/2014/main" id="{0F9F0153-D4F4-4E68-9D04-1AF10396F3AD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9543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74" name="TextBox 7">
                    <a:extLst>
                      <a:ext uri="{FF2B5EF4-FFF2-40B4-BE49-F238E27FC236}">
                        <a16:creationId xmlns:a16="http://schemas.microsoft.com/office/drawing/2014/main" id="{9142EA4D-13C3-4E43-A434-0974C95E115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36736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</p:grpSp>
          </p:grpSp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82EA5C22-61EB-40D2-962D-A8FAC70D7129}"/>
                  </a:ext>
                </a:extLst>
              </p:cNvPr>
              <p:cNvGrpSpPr/>
              <p:nvPr/>
            </p:nvGrpSpPr>
            <p:grpSpPr>
              <a:xfrm>
                <a:off x="10350472" y="4841637"/>
                <a:ext cx="416948" cy="2064251"/>
                <a:chOff x="501076" y="4850124"/>
                <a:chExt cx="416948" cy="2064251"/>
              </a:xfrm>
            </p:grpSpPr>
            <p:sp>
              <p:nvSpPr>
                <p:cNvPr id="63" name="TextBox 7">
                  <a:extLst>
                    <a:ext uri="{FF2B5EF4-FFF2-40B4-BE49-F238E27FC236}">
                      <a16:creationId xmlns:a16="http://schemas.microsoft.com/office/drawing/2014/main" id="{9411E155-16D8-4E1F-A6B4-C0A9D75FAD0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277155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64" name="TextBox 7">
                  <a:extLst>
                    <a:ext uri="{FF2B5EF4-FFF2-40B4-BE49-F238E27FC236}">
                      <a16:creationId xmlns:a16="http://schemas.microsoft.com/office/drawing/2014/main" id="{9BBD7C49-6270-44C3-9DE9-86FE25F3536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637376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65" name="TextBox 7">
                  <a:extLst>
                    <a:ext uri="{FF2B5EF4-FFF2-40B4-BE49-F238E27FC236}">
                      <a16:creationId xmlns:a16="http://schemas.microsoft.com/office/drawing/2014/main" id="{271397C4-E8D3-4083-9625-DB12A086CF7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916937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66" name="TextBox 7">
                  <a:extLst>
                    <a:ext uri="{FF2B5EF4-FFF2-40B4-BE49-F238E27FC236}">
                      <a16:creationId xmlns:a16="http://schemas.microsoft.com/office/drawing/2014/main" id="{99E7A944-8F1C-4FE2-BA4E-60331F1F707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570569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67" name="TextBox 7">
                  <a:extLst>
                    <a:ext uri="{FF2B5EF4-FFF2-40B4-BE49-F238E27FC236}">
                      <a16:creationId xmlns:a16="http://schemas.microsoft.com/office/drawing/2014/main" id="{C2F2D6ED-0ACF-48E2-B100-35F704B126A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196492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68" name="TextBox 7">
                  <a:extLst>
                    <a:ext uri="{FF2B5EF4-FFF2-40B4-BE49-F238E27FC236}">
                      <a16:creationId xmlns:a16="http://schemas.microsoft.com/office/drawing/2014/main" id="{53ED6015-6985-42D8-9E4C-1DC820FFD8D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4850124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</p:grpSp>
        <p:sp>
          <p:nvSpPr>
            <p:cNvPr id="75" name="TextBox 7">
              <a:extLst>
                <a:ext uri="{FF2B5EF4-FFF2-40B4-BE49-F238E27FC236}">
                  <a16:creationId xmlns:a16="http://schemas.microsoft.com/office/drawing/2014/main" id="{F720CB13-1C41-4517-8191-D1E530A113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63932" y="2451729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OPRM1</a:t>
              </a:r>
            </a:p>
          </p:txBody>
        </p: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88F5B028-7826-490C-B558-D1D29D24EE38}"/>
              </a:ext>
            </a:extLst>
          </p:cNvPr>
          <p:cNvGrpSpPr/>
          <p:nvPr/>
        </p:nvGrpSpPr>
        <p:grpSpPr>
          <a:xfrm>
            <a:off x="10481116" y="1989209"/>
            <a:ext cx="2693547" cy="2802118"/>
            <a:chOff x="9621675" y="2451729"/>
            <a:chExt cx="2693547" cy="2802118"/>
          </a:xfrm>
        </p:grpSpPr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2FEE42A8-C5C2-48D3-B209-993A41D3BCB1}"/>
                </a:ext>
              </a:extLst>
            </p:cNvPr>
            <p:cNvGrpSpPr/>
            <p:nvPr/>
          </p:nvGrpSpPr>
          <p:grpSpPr>
            <a:xfrm>
              <a:off x="9621675" y="2537383"/>
              <a:ext cx="2693547" cy="2716464"/>
              <a:chOff x="10350472" y="4740253"/>
              <a:chExt cx="2693547" cy="2716464"/>
            </a:xfrm>
          </p:grpSpPr>
          <p:graphicFrame>
            <p:nvGraphicFramePr>
              <p:cNvPr id="83" name="对象 82">
                <a:extLst>
                  <a:ext uri="{FF2B5EF4-FFF2-40B4-BE49-F238E27FC236}">
                    <a16:creationId xmlns:a16="http://schemas.microsoft.com/office/drawing/2014/main" id="{134C07F1-2D0F-4F14-90FA-AEF7CD4F9A1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739734"/>
                  </p:ext>
                </p:extLst>
              </p:nvPr>
            </p:nvGraphicFramePr>
            <p:xfrm>
              <a:off x="10405594" y="4740253"/>
              <a:ext cx="2638425" cy="23828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11" imgW="2643756" imgH="2389993" progId="Prism7.Document">
                      <p:embed/>
                    </p:oleObj>
                  </mc:Choice>
                  <mc:Fallback>
                    <p:oleObj name="Prism 7" r:id="rId11" imgW="2643756" imgH="2389993" progId="Prism7.Document">
                      <p:embed/>
                      <p:pic>
                        <p:nvPicPr>
                          <p:cNvPr id="83" name="对象 82">
                            <a:extLst>
                              <a:ext uri="{FF2B5EF4-FFF2-40B4-BE49-F238E27FC236}">
                                <a16:creationId xmlns:a16="http://schemas.microsoft.com/office/drawing/2014/main" id="{134C07F1-2D0F-4F14-90FA-AEF7CD4F9A1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0405594" y="4740253"/>
                            <a:ext cx="2638425" cy="23828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69D24587-795B-4E58-8615-C2D9F2D26684}"/>
                  </a:ext>
                </a:extLst>
              </p:cNvPr>
              <p:cNvSpPr txBox="1"/>
              <p:nvPr/>
            </p:nvSpPr>
            <p:spPr>
              <a:xfrm>
                <a:off x="11648492" y="6332502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27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5" name="组合 84">
                <a:extLst>
                  <a:ext uri="{FF2B5EF4-FFF2-40B4-BE49-F238E27FC236}">
                    <a16:creationId xmlns:a16="http://schemas.microsoft.com/office/drawing/2014/main" id="{4242CA71-FE73-4EFB-B2DC-BD299B31A625}"/>
                  </a:ext>
                </a:extLst>
              </p:cNvPr>
              <p:cNvGrpSpPr/>
              <p:nvPr/>
            </p:nvGrpSpPr>
            <p:grpSpPr>
              <a:xfrm>
                <a:off x="10582320" y="6859918"/>
                <a:ext cx="2307619" cy="596799"/>
                <a:chOff x="700609" y="6859918"/>
                <a:chExt cx="2307619" cy="596799"/>
              </a:xfrm>
            </p:grpSpPr>
            <p:sp>
              <p:nvSpPr>
                <p:cNvPr id="93" name="文本框 92">
                  <a:extLst>
                    <a:ext uri="{FF2B5EF4-FFF2-40B4-BE49-F238E27FC236}">
                      <a16:creationId xmlns:a16="http://schemas.microsoft.com/office/drawing/2014/main" id="{FDBE1E4F-1DB3-4793-AA63-82E5F99DA448}"/>
                    </a:ext>
                  </a:extLst>
                </p:cNvPr>
                <p:cNvSpPr txBox="1"/>
                <p:nvPr/>
              </p:nvSpPr>
              <p:spPr>
                <a:xfrm>
                  <a:off x="700609" y="7148940"/>
                  <a:ext cx="230761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g2 of </a:t>
                  </a:r>
                  <a:r>
                    <a:rPr lang="en-US" altLang="zh-CN" sz="14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TA3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xpression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4" name="组合 93">
                  <a:extLst>
                    <a:ext uri="{FF2B5EF4-FFF2-40B4-BE49-F238E27FC236}">
                      <a16:creationId xmlns:a16="http://schemas.microsoft.com/office/drawing/2014/main" id="{C585CB9F-4933-4746-A832-3F22432ABEF7}"/>
                    </a:ext>
                  </a:extLst>
                </p:cNvPr>
                <p:cNvGrpSpPr/>
                <p:nvPr/>
              </p:nvGrpSpPr>
              <p:grpSpPr>
                <a:xfrm>
                  <a:off x="962078" y="6859918"/>
                  <a:ext cx="1784680" cy="276999"/>
                  <a:chOff x="969004" y="6887628"/>
                  <a:chExt cx="1784680" cy="276999"/>
                </a:xfrm>
              </p:grpSpPr>
              <p:sp>
                <p:nvSpPr>
                  <p:cNvPr id="95" name="TextBox 7">
                    <a:extLst>
                      <a:ext uri="{FF2B5EF4-FFF2-40B4-BE49-F238E27FC236}">
                        <a16:creationId xmlns:a16="http://schemas.microsoft.com/office/drawing/2014/main" id="{E40312B5-AA5B-4D84-BDEB-6E47284CA1A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900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96" name="TextBox 7">
                    <a:extLst>
                      <a:ext uri="{FF2B5EF4-FFF2-40B4-BE49-F238E27FC236}">
                        <a16:creationId xmlns:a16="http://schemas.microsoft.com/office/drawing/2014/main" id="{0DF57C82-A8B2-4A60-B234-90BC3A99E56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22344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97" name="TextBox 7">
                    <a:extLst>
                      <a:ext uri="{FF2B5EF4-FFF2-40B4-BE49-F238E27FC236}">
                        <a16:creationId xmlns:a16="http://schemas.microsoft.com/office/drawing/2014/main" id="{51B58805-E947-40A8-8965-88DAC95B9AE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879543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98" name="TextBox 7">
                    <a:extLst>
                      <a:ext uri="{FF2B5EF4-FFF2-40B4-BE49-F238E27FC236}">
                        <a16:creationId xmlns:a16="http://schemas.microsoft.com/office/drawing/2014/main" id="{8FED9209-4F30-4F3B-8AB2-4C2D29CF4C8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36736" y="6887628"/>
                    <a:ext cx="416948" cy="2769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</p:grpSp>
          </p:grpSp>
          <p:grpSp>
            <p:nvGrpSpPr>
              <p:cNvPr id="86" name="组合 85">
                <a:extLst>
                  <a:ext uri="{FF2B5EF4-FFF2-40B4-BE49-F238E27FC236}">
                    <a16:creationId xmlns:a16="http://schemas.microsoft.com/office/drawing/2014/main" id="{A4DFA333-449E-4431-ABC8-081E54714028}"/>
                  </a:ext>
                </a:extLst>
              </p:cNvPr>
              <p:cNvGrpSpPr/>
              <p:nvPr/>
            </p:nvGrpSpPr>
            <p:grpSpPr>
              <a:xfrm>
                <a:off x="10350472" y="4841637"/>
                <a:ext cx="416948" cy="2064251"/>
                <a:chOff x="501076" y="4850124"/>
                <a:chExt cx="416948" cy="2064251"/>
              </a:xfrm>
            </p:grpSpPr>
            <p:sp>
              <p:nvSpPr>
                <p:cNvPr id="88" name="TextBox 7">
                  <a:extLst>
                    <a:ext uri="{FF2B5EF4-FFF2-40B4-BE49-F238E27FC236}">
                      <a16:creationId xmlns:a16="http://schemas.microsoft.com/office/drawing/2014/main" id="{CA7E674D-B2A6-4883-A7C4-2D26CE604AB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637376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89" name="TextBox 7">
                  <a:extLst>
                    <a:ext uri="{FF2B5EF4-FFF2-40B4-BE49-F238E27FC236}">
                      <a16:creationId xmlns:a16="http://schemas.microsoft.com/office/drawing/2014/main" id="{FE89A376-F955-4233-8BA3-95FE31A19BF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6059812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90" name="TextBox 7">
                  <a:extLst>
                    <a:ext uri="{FF2B5EF4-FFF2-40B4-BE49-F238E27FC236}">
                      <a16:creationId xmlns:a16="http://schemas.microsoft.com/office/drawing/2014/main" id="{2AB89D24-4D48-4ADD-8C24-266195A1844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5441977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92" name="TextBox 7">
                  <a:extLst>
                    <a:ext uri="{FF2B5EF4-FFF2-40B4-BE49-F238E27FC236}">
                      <a16:creationId xmlns:a16="http://schemas.microsoft.com/office/drawing/2014/main" id="{74DA0E41-5016-4030-A78F-71C3828D485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01076" y="4850124"/>
                  <a:ext cx="416948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Arial Unicode MS" pitchFamily="34" charset="-122"/>
                      <a:cs typeface="Arial" panose="020B0604020202020204" pitchFamily="34" charset="0"/>
                    </a:rPr>
                    <a:t>15</a:t>
                  </a:r>
                </a:p>
              </p:txBody>
            </p:sp>
          </p:grpSp>
        </p:grpSp>
        <p:sp>
          <p:nvSpPr>
            <p:cNvPr id="82" name="TextBox 7">
              <a:extLst>
                <a:ext uri="{FF2B5EF4-FFF2-40B4-BE49-F238E27FC236}">
                  <a16:creationId xmlns:a16="http://schemas.microsoft.com/office/drawing/2014/main" id="{770B8665-3517-4940-9462-ED1CEF9CE3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63932" y="2451729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HAP1</a:t>
              </a:r>
            </a:p>
          </p:txBody>
        </p:sp>
      </p:grpSp>
      <p:sp>
        <p:nvSpPr>
          <p:cNvPr id="99" name="文本框 98">
            <a:extLst>
              <a:ext uri="{FF2B5EF4-FFF2-40B4-BE49-F238E27FC236}">
                <a16:creationId xmlns:a16="http://schemas.microsoft.com/office/drawing/2014/main" id="{3250F840-EC4A-4F55-8E8F-E27A7474DE0E}"/>
              </a:ext>
            </a:extLst>
          </p:cNvPr>
          <p:cNvSpPr txBox="1"/>
          <p:nvPr/>
        </p:nvSpPr>
        <p:spPr>
          <a:xfrm>
            <a:off x="685336" y="4924986"/>
            <a:ext cx="12334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0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correlation between GATA3 expression and ANSN,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GLS, OPRM1, ZBTB1, and HAP1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indicated gene expression was plotted against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GATA3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transcription to test their association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95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32">
            <a:extLst>
              <a:ext uri="{FF2B5EF4-FFF2-40B4-BE49-F238E27FC236}">
                <a16:creationId xmlns:a16="http://schemas.microsoft.com/office/drawing/2014/main" id="{FACCBED3-BCA0-449F-82F9-ACD276F20EFB}"/>
              </a:ext>
            </a:extLst>
          </p:cNvPr>
          <p:cNvSpPr txBox="1"/>
          <p:nvPr/>
        </p:nvSpPr>
        <p:spPr>
          <a:xfrm>
            <a:off x="1177514" y="250089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61ED971-4736-4908-AD02-CA8790E94316}"/>
              </a:ext>
            </a:extLst>
          </p:cNvPr>
          <p:cNvSpPr txBox="1"/>
          <p:nvPr/>
        </p:nvSpPr>
        <p:spPr>
          <a:xfrm>
            <a:off x="1829641" y="1583920"/>
            <a:ext cx="4612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CCG-ALL-2015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E8FA5DA-E3A6-43A9-8309-1127AD812380}"/>
              </a:ext>
            </a:extLst>
          </p:cNvPr>
          <p:cNvSpPr txBox="1"/>
          <p:nvPr/>
        </p:nvSpPr>
        <p:spPr>
          <a:xfrm>
            <a:off x="7681742" y="1583920"/>
            <a:ext cx="4612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D-2008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AL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1E4E6FB8-8A92-4409-8D3E-5AC34248F938}"/>
              </a:ext>
            </a:extLst>
          </p:cNvPr>
          <p:cNvGrpSpPr/>
          <p:nvPr/>
        </p:nvGrpSpPr>
        <p:grpSpPr>
          <a:xfrm>
            <a:off x="1577839" y="1996202"/>
            <a:ext cx="2552700" cy="2342265"/>
            <a:chOff x="760413" y="2747260"/>
            <a:chExt cx="2552700" cy="2342265"/>
          </a:xfrm>
        </p:grpSpPr>
        <p:graphicFrame>
          <p:nvGraphicFramePr>
            <p:cNvPr id="41" name="对象 40">
              <a:extLst>
                <a:ext uri="{FF2B5EF4-FFF2-40B4-BE49-F238E27FC236}">
                  <a16:creationId xmlns:a16="http://schemas.microsoft.com/office/drawing/2014/main" id="{27F7A61A-8AEE-4241-95FB-3B91D2776CB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7398676"/>
                </p:ext>
              </p:extLst>
            </p:nvPr>
          </p:nvGraphicFramePr>
          <p:xfrm>
            <a:off x="760413" y="3062288"/>
            <a:ext cx="2552700" cy="2027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2" imgW="2552282" imgH="2027065" progId="Prism7.Document">
                    <p:embed/>
                  </p:oleObj>
                </mc:Choice>
                <mc:Fallback>
                  <p:oleObj name="Prism 7" r:id="rId2" imgW="2552282" imgH="2027065" progId="Prism7.Document">
                    <p:embed/>
                    <p:pic>
                      <p:nvPicPr>
                        <p:cNvPr id="41" name="对象 40">
                          <a:extLst>
                            <a:ext uri="{FF2B5EF4-FFF2-40B4-BE49-F238E27FC236}">
                              <a16:creationId xmlns:a16="http://schemas.microsoft.com/office/drawing/2014/main" id="{27F7A61A-8AEE-4241-95FB-3B91D2776CB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760413" y="3062288"/>
                          <a:ext cx="2552700" cy="2027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B26DD1B4-06CE-4613-9063-DFFCAA3679FC}"/>
                </a:ext>
              </a:extLst>
            </p:cNvPr>
            <p:cNvSpPr txBox="1"/>
            <p:nvPr/>
          </p:nvSpPr>
          <p:spPr>
            <a:xfrm>
              <a:off x="1352393" y="2747260"/>
              <a:ext cx="907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s382466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FFDB09C9-5630-41A5-954F-B565013407FA}"/>
                </a:ext>
              </a:extLst>
            </p:cNvPr>
            <p:cNvGrpSpPr/>
            <p:nvPr/>
          </p:nvGrpSpPr>
          <p:grpSpPr>
            <a:xfrm>
              <a:off x="3010616" y="3111865"/>
              <a:ext cx="286761" cy="517537"/>
              <a:chOff x="3010616" y="3111865"/>
              <a:chExt cx="286761" cy="517537"/>
            </a:xfrm>
          </p:grpSpPr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FB79634F-4E62-44CC-B7AA-3E663325D35D}"/>
                  </a:ext>
                </a:extLst>
              </p:cNvPr>
              <p:cNvSpPr txBox="1"/>
              <p:nvPr/>
            </p:nvSpPr>
            <p:spPr>
              <a:xfrm>
                <a:off x="3010616" y="3111865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B833CBE9-ADB6-436A-94E2-968883015347}"/>
                  </a:ext>
                </a:extLst>
              </p:cNvPr>
              <p:cNvSpPr txBox="1"/>
              <p:nvPr/>
            </p:nvSpPr>
            <p:spPr>
              <a:xfrm>
                <a:off x="3010616" y="3352403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B386C820-2F99-42AB-A40C-6DE8BAC8DDC7}"/>
                </a:ext>
              </a:extLst>
            </p:cNvPr>
            <p:cNvGrpSpPr/>
            <p:nvPr/>
          </p:nvGrpSpPr>
          <p:grpSpPr>
            <a:xfrm>
              <a:off x="1053782" y="3740002"/>
              <a:ext cx="1501917" cy="702374"/>
              <a:chOff x="1067637" y="3740002"/>
              <a:chExt cx="1501917" cy="702374"/>
            </a:xfrm>
          </p:grpSpPr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8E2B12A2-F8E0-4F83-9BDF-70EEBB1F083B}"/>
                  </a:ext>
                </a:extLst>
              </p:cNvPr>
              <p:cNvSpPr txBox="1"/>
              <p:nvPr/>
            </p:nvSpPr>
            <p:spPr>
              <a:xfrm>
                <a:off x="1950474" y="3740002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.7%</a:t>
                </a: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907A2862-27CB-492C-B3B6-3AABAC0FE14D}"/>
                  </a:ext>
                </a:extLst>
              </p:cNvPr>
              <p:cNvSpPr txBox="1"/>
              <p:nvPr/>
            </p:nvSpPr>
            <p:spPr>
              <a:xfrm>
                <a:off x="1067637" y="4165377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4.3%</a:t>
                </a:r>
              </a:p>
            </p:txBody>
          </p:sp>
        </p:grp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2F9B9DCA-742A-42F8-A4D0-B78FFCAF7273}"/>
              </a:ext>
            </a:extLst>
          </p:cNvPr>
          <p:cNvGrpSpPr/>
          <p:nvPr/>
        </p:nvGrpSpPr>
        <p:grpSpPr>
          <a:xfrm>
            <a:off x="10216566" y="1982347"/>
            <a:ext cx="2580410" cy="2345440"/>
            <a:chOff x="10909300" y="2747260"/>
            <a:chExt cx="2580410" cy="2345440"/>
          </a:xfrm>
        </p:grpSpPr>
        <p:graphicFrame>
          <p:nvGraphicFramePr>
            <p:cNvPr id="44" name="对象 43">
              <a:extLst>
                <a:ext uri="{FF2B5EF4-FFF2-40B4-BE49-F238E27FC236}">
                  <a16:creationId xmlns:a16="http://schemas.microsoft.com/office/drawing/2014/main" id="{900374BD-C288-459F-919A-A7C20E15C6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4479820"/>
                </p:ext>
              </p:extLst>
            </p:nvPr>
          </p:nvGraphicFramePr>
          <p:xfrm>
            <a:off x="10909300" y="3059113"/>
            <a:ext cx="2552700" cy="2033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4" imgW="2552282" imgH="2033186" progId="Prism7.Document">
                    <p:embed/>
                  </p:oleObj>
                </mc:Choice>
                <mc:Fallback>
                  <p:oleObj name="Prism 7" r:id="rId4" imgW="2552282" imgH="2033186" progId="Prism7.Document">
                    <p:embed/>
                    <p:pic>
                      <p:nvPicPr>
                        <p:cNvPr id="44" name="对象 43">
                          <a:extLst>
                            <a:ext uri="{FF2B5EF4-FFF2-40B4-BE49-F238E27FC236}">
                              <a16:creationId xmlns:a16="http://schemas.microsoft.com/office/drawing/2014/main" id="{900374BD-C288-459F-919A-A7C20E15C64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0909300" y="3059113"/>
                          <a:ext cx="2552700" cy="2033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D94DE6CB-C0EA-468A-B260-548F1D86BD69}"/>
                </a:ext>
              </a:extLst>
            </p:cNvPr>
            <p:cNvSpPr txBox="1"/>
            <p:nvPr/>
          </p:nvSpPr>
          <p:spPr>
            <a:xfrm>
              <a:off x="11443845" y="2747260"/>
              <a:ext cx="907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s378109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id="{B79010CA-EF7D-42EF-8484-7C85A20324A4}"/>
                </a:ext>
              </a:extLst>
            </p:cNvPr>
            <p:cNvGrpSpPr/>
            <p:nvPr/>
          </p:nvGrpSpPr>
          <p:grpSpPr>
            <a:xfrm>
              <a:off x="13202949" y="3098009"/>
              <a:ext cx="286761" cy="517537"/>
              <a:chOff x="3010616" y="3111865"/>
              <a:chExt cx="286761" cy="517537"/>
            </a:xfrm>
          </p:grpSpPr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553CBF72-7A8B-441F-BCF4-5955149AAB34}"/>
                  </a:ext>
                </a:extLst>
              </p:cNvPr>
              <p:cNvSpPr txBox="1"/>
              <p:nvPr/>
            </p:nvSpPr>
            <p:spPr>
              <a:xfrm>
                <a:off x="3010616" y="3111865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3411F927-C4C0-45E2-B1F6-AACB70BDE859}"/>
                  </a:ext>
                </a:extLst>
              </p:cNvPr>
              <p:cNvSpPr txBox="1"/>
              <p:nvPr/>
            </p:nvSpPr>
            <p:spPr>
              <a:xfrm>
                <a:off x="3010616" y="3352403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</p:grpSp>
        <p:grpSp>
          <p:nvGrpSpPr>
            <p:cNvPr id="99" name="组合 98">
              <a:extLst>
                <a:ext uri="{FF2B5EF4-FFF2-40B4-BE49-F238E27FC236}">
                  <a16:creationId xmlns:a16="http://schemas.microsoft.com/office/drawing/2014/main" id="{D9D1DA87-DDDB-42DE-AB24-DFFE3061D622}"/>
                </a:ext>
              </a:extLst>
            </p:cNvPr>
            <p:cNvGrpSpPr/>
            <p:nvPr/>
          </p:nvGrpSpPr>
          <p:grpSpPr>
            <a:xfrm>
              <a:off x="11204939" y="3740002"/>
              <a:ext cx="1501917" cy="702374"/>
              <a:chOff x="1067636" y="3740002"/>
              <a:chExt cx="1501917" cy="702374"/>
            </a:xfrm>
          </p:grpSpPr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06D5D35C-34EF-418E-9D15-FBEA64776AD6}"/>
                  </a:ext>
                </a:extLst>
              </p:cNvPr>
              <p:cNvSpPr txBox="1"/>
              <p:nvPr/>
            </p:nvSpPr>
            <p:spPr>
              <a:xfrm>
                <a:off x="1950473" y="3740002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8.7%</a:t>
                </a: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14ACB38A-675D-41A9-B575-39708B606EE3}"/>
                  </a:ext>
                </a:extLst>
              </p:cNvPr>
              <p:cNvSpPr txBox="1"/>
              <p:nvPr/>
            </p:nvSpPr>
            <p:spPr>
              <a:xfrm>
                <a:off x="1067636" y="4165377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1.3%</a:t>
                </a:r>
              </a:p>
            </p:txBody>
          </p:sp>
        </p:grp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6CBA4550-9C43-41E7-82B9-FD41259DF127}"/>
              </a:ext>
            </a:extLst>
          </p:cNvPr>
          <p:cNvGrpSpPr/>
          <p:nvPr/>
        </p:nvGrpSpPr>
        <p:grpSpPr>
          <a:xfrm>
            <a:off x="4151742" y="1996202"/>
            <a:ext cx="2624782" cy="2342265"/>
            <a:chOff x="3860800" y="2747260"/>
            <a:chExt cx="2624782" cy="2342265"/>
          </a:xfrm>
        </p:grpSpPr>
        <p:graphicFrame>
          <p:nvGraphicFramePr>
            <p:cNvPr id="42" name="对象 41">
              <a:extLst>
                <a:ext uri="{FF2B5EF4-FFF2-40B4-BE49-F238E27FC236}">
                  <a16:creationId xmlns:a16="http://schemas.microsoft.com/office/drawing/2014/main" id="{BB6797D9-72EE-4E4F-AE5D-A53D5ACB38D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23555229"/>
                </p:ext>
              </p:extLst>
            </p:nvPr>
          </p:nvGraphicFramePr>
          <p:xfrm>
            <a:off x="3860800" y="3062288"/>
            <a:ext cx="2601913" cy="2027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6" imgW="2602341" imgH="2027065" progId="Prism7.Document">
                    <p:embed/>
                  </p:oleObj>
                </mc:Choice>
                <mc:Fallback>
                  <p:oleObj name="Prism 7" r:id="rId6" imgW="2602341" imgH="2027065" progId="Prism7.Document">
                    <p:embed/>
                    <p:pic>
                      <p:nvPicPr>
                        <p:cNvPr id="42" name="对象 41">
                          <a:extLst>
                            <a:ext uri="{FF2B5EF4-FFF2-40B4-BE49-F238E27FC236}">
                              <a16:creationId xmlns:a16="http://schemas.microsoft.com/office/drawing/2014/main" id="{BB6797D9-72EE-4E4F-AE5D-A53D5ACB38D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860800" y="3062288"/>
                          <a:ext cx="2601913" cy="2027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B68788B3-0D51-4990-A219-FB88575C8840}"/>
                </a:ext>
              </a:extLst>
            </p:cNvPr>
            <p:cNvSpPr txBox="1"/>
            <p:nvPr/>
          </p:nvSpPr>
          <p:spPr>
            <a:xfrm>
              <a:off x="4399880" y="2747260"/>
              <a:ext cx="907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s378109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483F3062-D9BC-46D9-929D-B1F344726497}"/>
                </a:ext>
              </a:extLst>
            </p:cNvPr>
            <p:cNvGrpSpPr/>
            <p:nvPr/>
          </p:nvGrpSpPr>
          <p:grpSpPr>
            <a:xfrm>
              <a:off x="6198821" y="3107489"/>
              <a:ext cx="286761" cy="517537"/>
              <a:chOff x="3010616" y="3111865"/>
              <a:chExt cx="286761" cy="517537"/>
            </a:xfrm>
          </p:grpSpPr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06F699E7-EB4A-4AF3-B7E7-3B16749E69D2}"/>
                  </a:ext>
                </a:extLst>
              </p:cNvPr>
              <p:cNvSpPr txBox="1"/>
              <p:nvPr/>
            </p:nvSpPr>
            <p:spPr>
              <a:xfrm>
                <a:off x="3010616" y="3111865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BCF72FDE-C95C-450C-A966-84684C872C41}"/>
                  </a:ext>
                </a:extLst>
              </p:cNvPr>
              <p:cNvSpPr txBox="1"/>
              <p:nvPr/>
            </p:nvSpPr>
            <p:spPr>
              <a:xfrm>
                <a:off x="3010616" y="3352403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</p:grpSp>
        <p:grpSp>
          <p:nvGrpSpPr>
            <p:cNvPr id="102" name="组合 101">
              <a:extLst>
                <a:ext uri="{FF2B5EF4-FFF2-40B4-BE49-F238E27FC236}">
                  <a16:creationId xmlns:a16="http://schemas.microsoft.com/office/drawing/2014/main" id="{9FB6E24C-33B7-44C3-81DF-3BE2386C02F9}"/>
                </a:ext>
              </a:extLst>
            </p:cNvPr>
            <p:cNvGrpSpPr/>
            <p:nvPr/>
          </p:nvGrpSpPr>
          <p:grpSpPr>
            <a:xfrm>
              <a:off x="4138142" y="3740002"/>
              <a:ext cx="1501917" cy="702374"/>
              <a:chOff x="1067637" y="3740002"/>
              <a:chExt cx="1501917" cy="702374"/>
            </a:xfrm>
          </p:grpSpPr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7CBF8560-42B3-45D6-A702-B54B68E6BE90}"/>
                  </a:ext>
                </a:extLst>
              </p:cNvPr>
              <p:cNvSpPr txBox="1"/>
              <p:nvPr/>
            </p:nvSpPr>
            <p:spPr>
              <a:xfrm>
                <a:off x="1950474" y="3740002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.5%</a:t>
                </a: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16616B4A-08EF-47C9-BA1B-DF3AB4DC356B}"/>
                  </a:ext>
                </a:extLst>
              </p:cNvPr>
              <p:cNvSpPr txBox="1"/>
              <p:nvPr/>
            </p:nvSpPr>
            <p:spPr>
              <a:xfrm>
                <a:off x="1067637" y="4165377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4.5%</a:t>
                </a:r>
              </a:p>
            </p:txBody>
          </p:sp>
        </p:grp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4748A022-2FF1-4D65-A72D-2F17FB9944AF}"/>
              </a:ext>
            </a:extLst>
          </p:cNvPr>
          <p:cNvGrpSpPr/>
          <p:nvPr/>
        </p:nvGrpSpPr>
        <p:grpSpPr>
          <a:xfrm>
            <a:off x="7605853" y="1982347"/>
            <a:ext cx="2588341" cy="2345440"/>
            <a:chOff x="7661275" y="2747260"/>
            <a:chExt cx="2588341" cy="2345440"/>
          </a:xfrm>
        </p:grpSpPr>
        <p:graphicFrame>
          <p:nvGraphicFramePr>
            <p:cNvPr id="43" name="对象 42">
              <a:extLst>
                <a:ext uri="{FF2B5EF4-FFF2-40B4-BE49-F238E27FC236}">
                  <a16:creationId xmlns:a16="http://schemas.microsoft.com/office/drawing/2014/main" id="{A10BE0E3-C89A-41CE-808C-5892FF2C35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94033171"/>
                </p:ext>
              </p:extLst>
            </p:nvPr>
          </p:nvGraphicFramePr>
          <p:xfrm>
            <a:off x="7661275" y="3059113"/>
            <a:ext cx="2560638" cy="2033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8" imgW="2561285" imgH="2033186" progId="Prism7.Document">
                    <p:embed/>
                  </p:oleObj>
                </mc:Choice>
                <mc:Fallback>
                  <p:oleObj name="Prism 7" r:id="rId8" imgW="2561285" imgH="2033186" progId="Prism7.Document">
                    <p:embed/>
                    <p:pic>
                      <p:nvPicPr>
                        <p:cNvPr id="43" name="对象 42">
                          <a:extLst>
                            <a:ext uri="{FF2B5EF4-FFF2-40B4-BE49-F238E27FC236}">
                              <a16:creationId xmlns:a16="http://schemas.microsoft.com/office/drawing/2014/main" id="{A10BE0E3-C89A-41CE-808C-5892FF2C350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661275" y="3059113"/>
                          <a:ext cx="2560638" cy="2033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599AAF58-DED0-4BD6-90EA-BFA0033BAD61}"/>
                </a:ext>
              </a:extLst>
            </p:cNvPr>
            <p:cNvSpPr txBox="1"/>
            <p:nvPr/>
          </p:nvSpPr>
          <p:spPr>
            <a:xfrm>
              <a:off x="8148768" y="2747260"/>
              <a:ext cx="9076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s382466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81F31A8C-3FB8-46D7-BD60-259D3ED6C2F8}"/>
                </a:ext>
              </a:extLst>
            </p:cNvPr>
            <p:cNvGrpSpPr/>
            <p:nvPr/>
          </p:nvGrpSpPr>
          <p:grpSpPr>
            <a:xfrm>
              <a:off x="9962855" y="3116240"/>
              <a:ext cx="286761" cy="517537"/>
              <a:chOff x="3010616" y="3111865"/>
              <a:chExt cx="286761" cy="517537"/>
            </a:xfrm>
          </p:grpSpPr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7DCCD079-C384-43F5-9FFB-8CDDD6E2737D}"/>
                  </a:ext>
                </a:extLst>
              </p:cNvPr>
              <p:cNvSpPr txBox="1"/>
              <p:nvPr/>
            </p:nvSpPr>
            <p:spPr>
              <a:xfrm>
                <a:off x="3010616" y="3111865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7D0A73EC-FD9A-4C0A-A08A-4F36639536CC}"/>
                  </a:ext>
                </a:extLst>
              </p:cNvPr>
              <p:cNvSpPr txBox="1"/>
              <p:nvPr/>
            </p:nvSpPr>
            <p:spPr>
              <a:xfrm>
                <a:off x="3010616" y="3352403"/>
                <a:ext cx="2867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F02083FA-AD5C-4D63-A3F1-2B3B71E3176E}"/>
                </a:ext>
              </a:extLst>
            </p:cNvPr>
            <p:cNvGrpSpPr/>
            <p:nvPr/>
          </p:nvGrpSpPr>
          <p:grpSpPr>
            <a:xfrm>
              <a:off x="7944493" y="3740002"/>
              <a:ext cx="1501918" cy="702374"/>
              <a:chOff x="1067636" y="3740002"/>
              <a:chExt cx="1501918" cy="702374"/>
            </a:xfrm>
          </p:grpSpPr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FDB1AF76-BB8C-46DB-99A3-91183E9D40D4}"/>
                  </a:ext>
                </a:extLst>
              </p:cNvPr>
              <p:cNvSpPr txBox="1"/>
              <p:nvPr/>
            </p:nvSpPr>
            <p:spPr>
              <a:xfrm>
                <a:off x="1950474" y="3740002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9.9%</a:t>
                </a: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8545979C-1B8A-42B3-BCBF-25D06E7412C8}"/>
                  </a:ext>
                </a:extLst>
              </p:cNvPr>
              <p:cNvSpPr txBox="1"/>
              <p:nvPr/>
            </p:nvSpPr>
            <p:spPr>
              <a:xfrm>
                <a:off x="1067636" y="4165377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.1%</a:t>
                </a:r>
              </a:p>
            </p:txBody>
          </p:sp>
        </p:grp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2371A6A2-1A3E-4D10-A6C9-19B28EF42094}"/>
              </a:ext>
            </a:extLst>
          </p:cNvPr>
          <p:cNvSpPr txBox="1"/>
          <p:nvPr/>
        </p:nvSpPr>
        <p:spPr>
          <a:xfrm>
            <a:off x="671206" y="5634519"/>
            <a:ext cx="12334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e minor allele frequencies (MAF) of rs3824662 and rs3791093 among the CCCG-ALL-2015 (A) and GD-2008-ALL (B) study cohort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915D3C2-6437-4464-8AD8-FD3ED8225623}"/>
              </a:ext>
            </a:extLst>
          </p:cNvPr>
          <p:cNvSpPr txBox="1"/>
          <p:nvPr/>
        </p:nvSpPr>
        <p:spPr>
          <a:xfrm>
            <a:off x="469147" y="114174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AF2E80F-E574-48A0-AE0C-73C98CA5E37E}"/>
              </a:ext>
            </a:extLst>
          </p:cNvPr>
          <p:cNvSpPr txBox="1"/>
          <p:nvPr/>
        </p:nvSpPr>
        <p:spPr>
          <a:xfrm>
            <a:off x="6887354" y="114174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73589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9F659F8-7912-42D6-BCF3-6EA1EFB9B8D9}"/>
              </a:ext>
            </a:extLst>
          </p:cNvPr>
          <p:cNvSpPr txBox="1"/>
          <p:nvPr/>
        </p:nvSpPr>
        <p:spPr>
          <a:xfrm flipH="1">
            <a:off x="85781" y="124822"/>
            <a:ext cx="96909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8D3A759E-7681-474F-B440-AAC241BEA55E}"/>
              </a:ext>
            </a:extLst>
          </p:cNvPr>
          <p:cNvGrpSpPr/>
          <p:nvPr/>
        </p:nvGrpSpPr>
        <p:grpSpPr>
          <a:xfrm>
            <a:off x="1924566" y="5150450"/>
            <a:ext cx="11561269" cy="2972205"/>
            <a:chOff x="1653094" y="4793250"/>
            <a:chExt cx="11561269" cy="2972205"/>
          </a:xfrm>
        </p:grpSpPr>
        <p:sp>
          <p:nvSpPr>
            <p:cNvPr id="49" name="TextBox 5">
              <a:extLst>
                <a:ext uri="{FF2B5EF4-FFF2-40B4-BE49-F238E27FC236}">
                  <a16:creationId xmlns:a16="http://schemas.microsoft.com/office/drawing/2014/main" id="{C13A9BB4-A6AF-49A3-B83A-A796A7716F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32384" y="6013947"/>
              <a:ext cx="1749197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MRD19 Positive(%)</a:t>
              </a:r>
            </a:p>
          </p:txBody>
        </p:sp>
        <p:sp>
          <p:nvSpPr>
            <p:cNvPr id="25" name="TextBox 6">
              <a:extLst>
                <a:ext uri="{FF2B5EF4-FFF2-40B4-BE49-F238E27FC236}">
                  <a16:creationId xmlns:a16="http://schemas.microsoft.com/office/drawing/2014/main" id="{A5AAC7E9-D750-4782-A264-3D94BE0047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08678" y="4793250"/>
              <a:ext cx="961670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96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26" name="对象 25">
              <a:extLst>
                <a:ext uri="{FF2B5EF4-FFF2-40B4-BE49-F238E27FC236}">
                  <a16:creationId xmlns:a16="http://schemas.microsoft.com/office/drawing/2014/main" id="{8A781608-9265-461B-B5D1-0B9C81627C8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85928036"/>
                </p:ext>
              </p:extLst>
            </p:nvPr>
          </p:nvGraphicFramePr>
          <p:xfrm>
            <a:off x="3839986" y="4959363"/>
            <a:ext cx="1630362" cy="2720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3" imgW="1634296" imgH="2546973" progId="Prism7.Document">
                    <p:embed/>
                  </p:oleObj>
                </mc:Choice>
                <mc:Fallback>
                  <p:oleObj name="Prism 7" r:id="rId3" imgW="1634296" imgH="2546973" progId="Prism7.Document">
                    <p:embed/>
                    <p:pic>
                      <p:nvPicPr>
                        <p:cNvPr id="26" name="对象 25">
                          <a:extLst>
                            <a:ext uri="{FF2B5EF4-FFF2-40B4-BE49-F238E27FC236}">
                              <a16:creationId xmlns:a16="http://schemas.microsoft.com/office/drawing/2014/main" id="{8A781608-9265-461B-B5D1-0B9C81627C8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839986" y="4959363"/>
                          <a:ext cx="1630362" cy="2720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22BB598-29D3-4BFB-B500-9968D3D9E853}"/>
                </a:ext>
              </a:extLst>
            </p:cNvPr>
            <p:cNvSpPr txBox="1"/>
            <p:nvPr/>
          </p:nvSpPr>
          <p:spPr>
            <a:xfrm>
              <a:off x="3853822" y="70396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F5D79F2-5FAB-43B0-A8DA-A23C9AA81349}"/>
                </a:ext>
              </a:extLst>
            </p:cNvPr>
            <p:cNvSpPr txBox="1"/>
            <p:nvPr/>
          </p:nvSpPr>
          <p:spPr>
            <a:xfrm>
              <a:off x="4141515" y="5276931"/>
              <a:ext cx="515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33.3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8ECD8A69-AE2D-4D66-9047-0B82B3FF5E2C}"/>
                </a:ext>
              </a:extLst>
            </p:cNvPr>
            <p:cNvSpPr txBox="1"/>
            <p:nvPr/>
          </p:nvSpPr>
          <p:spPr>
            <a:xfrm>
              <a:off x="4532782" y="5760702"/>
              <a:ext cx="4828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22.9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46F45E7-4D53-4C88-8FFA-C70C08348F5E}"/>
                </a:ext>
              </a:extLst>
            </p:cNvPr>
            <p:cNvSpPr txBox="1"/>
            <p:nvPr/>
          </p:nvSpPr>
          <p:spPr>
            <a:xfrm>
              <a:off x="4895289" y="5976382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8.8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5" name="TextBox 7">
              <a:extLst>
                <a:ext uri="{FF2B5EF4-FFF2-40B4-BE49-F238E27FC236}">
                  <a16:creationId xmlns:a16="http://schemas.microsoft.com/office/drawing/2014/main" id="{69EA84AF-7D47-4B5B-B0B1-B9D1CFA92B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8889" y="7457678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C9B4740-26C1-47AE-975E-5CB4D721E038}"/>
                </a:ext>
              </a:extLst>
            </p:cNvPr>
            <p:cNvSpPr txBox="1"/>
            <p:nvPr/>
          </p:nvSpPr>
          <p:spPr>
            <a:xfrm>
              <a:off x="4191841" y="7226840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75BF59F8-0E90-4B18-BEA1-668070E955F7}"/>
                </a:ext>
              </a:extLst>
            </p:cNvPr>
            <p:cNvSpPr txBox="1"/>
            <p:nvPr/>
          </p:nvSpPr>
          <p:spPr>
            <a:xfrm>
              <a:off x="4488383" y="7226840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38EF02AE-0776-411F-82DA-F0F841ED64F1}"/>
                </a:ext>
              </a:extLst>
            </p:cNvPr>
            <p:cNvSpPr txBox="1"/>
            <p:nvPr/>
          </p:nvSpPr>
          <p:spPr>
            <a:xfrm>
              <a:off x="4924776" y="7226840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E17AB36A-3070-48B7-BC73-1963A6C29A7B}"/>
                </a:ext>
              </a:extLst>
            </p:cNvPr>
            <p:cNvSpPr txBox="1"/>
            <p:nvPr/>
          </p:nvSpPr>
          <p:spPr>
            <a:xfrm>
              <a:off x="3768864" y="6559350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19B4FE6A-CC83-4B0E-ACA1-C656061B062C}"/>
                </a:ext>
              </a:extLst>
            </p:cNvPr>
            <p:cNvSpPr txBox="1"/>
            <p:nvPr/>
          </p:nvSpPr>
          <p:spPr>
            <a:xfrm>
              <a:off x="3768864" y="604776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02A56EB2-0362-44E1-A94C-766C8C47A122}"/>
                </a:ext>
              </a:extLst>
            </p:cNvPr>
            <p:cNvSpPr txBox="1"/>
            <p:nvPr/>
          </p:nvSpPr>
          <p:spPr>
            <a:xfrm>
              <a:off x="3768864" y="508288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5E93BCE3-C921-4770-AED1-BF3BCCDF7080}"/>
                </a:ext>
              </a:extLst>
            </p:cNvPr>
            <p:cNvSpPr txBox="1"/>
            <p:nvPr/>
          </p:nvSpPr>
          <p:spPr>
            <a:xfrm>
              <a:off x="3768864" y="557964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8A828AEB-CCBD-48E2-B31F-F667B5DEFC63}"/>
                </a:ext>
              </a:extLst>
            </p:cNvPr>
            <p:cNvSpPr/>
            <p:nvPr/>
          </p:nvSpPr>
          <p:spPr>
            <a:xfrm>
              <a:off x="4191841" y="7457678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EE35C927-060B-4445-A4E0-21977221071A}"/>
                </a:ext>
              </a:extLst>
            </p:cNvPr>
            <p:cNvSpPr/>
            <p:nvPr/>
          </p:nvSpPr>
          <p:spPr>
            <a:xfrm>
              <a:off x="4513419" y="7457678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矩形 155">
              <a:extLst>
                <a:ext uri="{FF2B5EF4-FFF2-40B4-BE49-F238E27FC236}">
                  <a16:creationId xmlns:a16="http://schemas.microsoft.com/office/drawing/2014/main" id="{D85DFF24-FCD6-410C-994F-55520B4CC009}"/>
                </a:ext>
              </a:extLst>
            </p:cNvPr>
            <p:cNvSpPr/>
            <p:nvPr/>
          </p:nvSpPr>
          <p:spPr>
            <a:xfrm>
              <a:off x="4891915" y="7457678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6">
              <a:extLst>
                <a:ext uri="{FF2B5EF4-FFF2-40B4-BE49-F238E27FC236}">
                  <a16:creationId xmlns:a16="http://schemas.microsoft.com/office/drawing/2014/main" id="{E20CCC44-CC82-4B5B-81A8-5435CBDF9B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58328" y="4793250"/>
              <a:ext cx="1128789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35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117" name="对象 116">
              <a:extLst>
                <a:ext uri="{FF2B5EF4-FFF2-40B4-BE49-F238E27FC236}">
                  <a16:creationId xmlns:a16="http://schemas.microsoft.com/office/drawing/2014/main" id="{D8CA78C3-D147-4170-B082-45B8B57D76F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9217374"/>
                </p:ext>
              </p:extLst>
            </p:nvPr>
          </p:nvGraphicFramePr>
          <p:xfrm>
            <a:off x="5666399" y="4959363"/>
            <a:ext cx="1630362" cy="2720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5" imgW="1634296" imgH="2546973" progId="Prism7.Document">
                    <p:embed/>
                  </p:oleObj>
                </mc:Choice>
                <mc:Fallback>
                  <p:oleObj name="Prism 7" r:id="rId5" imgW="1634296" imgH="2546973" progId="Prism7.Document">
                    <p:embed/>
                    <p:pic>
                      <p:nvPicPr>
                        <p:cNvPr id="117" name="对象 116">
                          <a:extLst>
                            <a:ext uri="{FF2B5EF4-FFF2-40B4-BE49-F238E27FC236}">
                              <a16:creationId xmlns:a16="http://schemas.microsoft.com/office/drawing/2014/main" id="{D8CA78C3-D147-4170-B082-45B8B57D76F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666399" y="4959363"/>
                          <a:ext cx="1630362" cy="2720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F8527CCF-3FDC-4FDF-B4D0-41FD4AC3778E}"/>
                </a:ext>
              </a:extLst>
            </p:cNvPr>
            <p:cNvSpPr txBox="1"/>
            <p:nvPr/>
          </p:nvSpPr>
          <p:spPr>
            <a:xfrm>
              <a:off x="5884798" y="5319006"/>
              <a:ext cx="6998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63.6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B1B0A048-A56C-4979-8DBB-A00C7F60E133}"/>
                </a:ext>
              </a:extLst>
            </p:cNvPr>
            <p:cNvSpPr txBox="1"/>
            <p:nvPr/>
          </p:nvSpPr>
          <p:spPr>
            <a:xfrm>
              <a:off x="6307343" y="5872017"/>
              <a:ext cx="5311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42.5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72A792BD-D32D-44DA-B44C-6B165E42B274}"/>
                </a:ext>
              </a:extLst>
            </p:cNvPr>
            <p:cNvSpPr txBox="1"/>
            <p:nvPr/>
          </p:nvSpPr>
          <p:spPr>
            <a:xfrm>
              <a:off x="6721702" y="5791524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45.1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6" name="TextBox 7">
              <a:extLst>
                <a:ext uri="{FF2B5EF4-FFF2-40B4-BE49-F238E27FC236}">
                  <a16:creationId xmlns:a16="http://schemas.microsoft.com/office/drawing/2014/main" id="{E9FA394B-D960-4D60-8715-13F2AD4BE4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55302" y="7457409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E7618AF3-68A3-47FE-A6F6-4D44144E5643}"/>
                </a:ext>
              </a:extLst>
            </p:cNvPr>
            <p:cNvSpPr txBox="1"/>
            <p:nvPr/>
          </p:nvSpPr>
          <p:spPr>
            <a:xfrm>
              <a:off x="6018254" y="7223571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6FC1E160-9041-4660-88A0-59C772D9FB5C}"/>
                </a:ext>
              </a:extLst>
            </p:cNvPr>
            <p:cNvSpPr txBox="1"/>
            <p:nvPr/>
          </p:nvSpPr>
          <p:spPr>
            <a:xfrm>
              <a:off x="6314796" y="7223571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A498C5A6-3552-41C8-AC04-7D0417B450ED}"/>
                </a:ext>
              </a:extLst>
            </p:cNvPr>
            <p:cNvSpPr txBox="1"/>
            <p:nvPr/>
          </p:nvSpPr>
          <p:spPr>
            <a:xfrm>
              <a:off x="6751189" y="7223571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478E105F-05F0-4E24-A87D-092FA0086C94}"/>
                </a:ext>
              </a:extLst>
            </p:cNvPr>
            <p:cNvSpPr txBox="1"/>
            <p:nvPr/>
          </p:nvSpPr>
          <p:spPr>
            <a:xfrm>
              <a:off x="5680235" y="703087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FE00DB91-7B76-42FB-A892-470814BEEF3A}"/>
                </a:ext>
              </a:extLst>
            </p:cNvPr>
            <p:cNvSpPr txBox="1"/>
            <p:nvPr/>
          </p:nvSpPr>
          <p:spPr>
            <a:xfrm>
              <a:off x="5595277" y="6594928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BEDB7AF7-E658-43A2-998B-1E58FE814FA1}"/>
                </a:ext>
              </a:extLst>
            </p:cNvPr>
            <p:cNvSpPr txBox="1"/>
            <p:nvPr/>
          </p:nvSpPr>
          <p:spPr>
            <a:xfrm>
              <a:off x="5595277" y="602553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50E28BF3-7A7B-4FDC-9E9E-210B5818653E}"/>
                </a:ext>
              </a:extLst>
            </p:cNvPr>
            <p:cNvSpPr txBox="1"/>
            <p:nvPr/>
          </p:nvSpPr>
          <p:spPr>
            <a:xfrm>
              <a:off x="5595277" y="554533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5DDC654E-43D0-4AA8-9293-F45476F1D2B7}"/>
                </a:ext>
              </a:extLst>
            </p:cNvPr>
            <p:cNvSpPr txBox="1"/>
            <p:nvPr/>
          </p:nvSpPr>
          <p:spPr>
            <a:xfrm>
              <a:off x="5595277" y="50881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矩形 156">
              <a:extLst>
                <a:ext uri="{FF2B5EF4-FFF2-40B4-BE49-F238E27FC236}">
                  <a16:creationId xmlns:a16="http://schemas.microsoft.com/office/drawing/2014/main" id="{AC69828E-BDFA-43FE-A79E-7ACEA0C32176}"/>
                </a:ext>
              </a:extLst>
            </p:cNvPr>
            <p:cNvSpPr/>
            <p:nvPr/>
          </p:nvSpPr>
          <p:spPr>
            <a:xfrm>
              <a:off x="6018254" y="7457409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矩形 157">
              <a:extLst>
                <a:ext uri="{FF2B5EF4-FFF2-40B4-BE49-F238E27FC236}">
                  <a16:creationId xmlns:a16="http://schemas.microsoft.com/office/drawing/2014/main" id="{7D3A46FE-0964-4C3E-885B-0688E591C5B9}"/>
                </a:ext>
              </a:extLst>
            </p:cNvPr>
            <p:cNvSpPr/>
            <p:nvPr/>
          </p:nvSpPr>
          <p:spPr>
            <a:xfrm>
              <a:off x="6339832" y="7457409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矩形 158">
              <a:extLst>
                <a:ext uri="{FF2B5EF4-FFF2-40B4-BE49-F238E27FC236}">
                  <a16:creationId xmlns:a16="http://schemas.microsoft.com/office/drawing/2014/main" id="{DA679184-D13F-4A57-8717-CCB4C3A1E63E}"/>
                </a:ext>
              </a:extLst>
            </p:cNvPr>
            <p:cNvSpPr/>
            <p:nvPr/>
          </p:nvSpPr>
          <p:spPr>
            <a:xfrm>
              <a:off x="6718328" y="7457409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6">
              <a:extLst>
                <a:ext uri="{FF2B5EF4-FFF2-40B4-BE49-F238E27FC236}">
                  <a16:creationId xmlns:a16="http://schemas.microsoft.com/office/drawing/2014/main" id="{36C69FE5-6C4C-4676-B6E0-F1D9D2099D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27445" y="4793250"/>
              <a:ext cx="1027903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49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134" name="对象 133">
              <a:extLst>
                <a:ext uri="{FF2B5EF4-FFF2-40B4-BE49-F238E27FC236}">
                  <a16:creationId xmlns:a16="http://schemas.microsoft.com/office/drawing/2014/main" id="{2666294E-E524-404E-AC45-BAD330729B3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11680449"/>
                </p:ext>
              </p:extLst>
            </p:nvPr>
          </p:nvGraphicFramePr>
          <p:xfrm>
            <a:off x="2022291" y="4956188"/>
            <a:ext cx="1630362" cy="2724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7" imgW="1634296" imgH="2546973" progId="Prism7.Document">
                    <p:embed/>
                  </p:oleObj>
                </mc:Choice>
                <mc:Fallback>
                  <p:oleObj name="Prism 7" r:id="rId7" imgW="1634296" imgH="2546973" progId="Prism7.Document">
                    <p:embed/>
                    <p:pic>
                      <p:nvPicPr>
                        <p:cNvPr id="134" name="对象 133">
                          <a:extLst>
                            <a:ext uri="{FF2B5EF4-FFF2-40B4-BE49-F238E27FC236}">
                              <a16:creationId xmlns:a16="http://schemas.microsoft.com/office/drawing/2014/main" id="{2666294E-E524-404E-AC45-BAD330729B3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022291" y="4956188"/>
                          <a:ext cx="1630362" cy="2724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2B47C82B-6961-46ED-B8D3-476519E432D6}"/>
                </a:ext>
              </a:extLst>
            </p:cNvPr>
            <p:cNvSpPr txBox="1"/>
            <p:nvPr/>
          </p:nvSpPr>
          <p:spPr>
            <a:xfrm>
              <a:off x="2036127" y="704035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B7A09CF5-3A24-43DB-99E6-E0394A3AC952}"/>
                </a:ext>
              </a:extLst>
            </p:cNvPr>
            <p:cNvSpPr txBox="1"/>
            <p:nvPr/>
          </p:nvSpPr>
          <p:spPr>
            <a:xfrm>
              <a:off x="2323820" y="5037794"/>
              <a:ext cx="5435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75.8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593AAA15-011C-463D-9FA1-491F4E4635D4}"/>
                </a:ext>
              </a:extLst>
            </p:cNvPr>
            <p:cNvSpPr txBox="1"/>
            <p:nvPr/>
          </p:nvSpPr>
          <p:spPr>
            <a:xfrm>
              <a:off x="2716002" y="533829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64.0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542ED6E7-32B6-486C-8B6D-0896ACCA0BD8}"/>
                </a:ext>
              </a:extLst>
            </p:cNvPr>
            <p:cNvSpPr txBox="1"/>
            <p:nvPr/>
          </p:nvSpPr>
          <p:spPr>
            <a:xfrm>
              <a:off x="3119159" y="5348111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63.9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985E93BD-0B16-41FD-ACBE-7C8A06F6DC18}"/>
                </a:ext>
              </a:extLst>
            </p:cNvPr>
            <p:cNvSpPr txBox="1"/>
            <p:nvPr/>
          </p:nvSpPr>
          <p:spPr>
            <a:xfrm>
              <a:off x="1951169" y="6554451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798F65D6-F6E8-4E21-A269-9213946E1FD7}"/>
                </a:ext>
              </a:extLst>
            </p:cNvPr>
            <p:cNvSpPr txBox="1"/>
            <p:nvPr/>
          </p:nvSpPr>
          <p:spPr>
            <a:xfrm>
              <a:off x="1951169" y="605037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272E328E-556E-431A-BA71-1DA119459BEB}"/>
                </a:ext>
              </a:extLst>
            </p:cNvPr>
            <p:cNvSpPr txBox="1"/>
            <p:nvPr/>
          </p:nvSpPr>
          <p:spPr>
            <a:xfrm>
              <a:off x="1951169" y="556664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7D37804F-A3E2-4EA5-B579-43583EA9EC35}"/>
                </a:ext>
              </a:extLst>
            </p:cNvPr>
            <p:cNvSpPr txBox="1"/>
            <p:nvPr/>
          </p:nvSpPr>
          <p:spPr>
            <a:xfrm>
              <a:off x="1951169" y="507569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7">
              <a:extLst>
                <a:ext uri="{FF2B5EF4-FFF2-40B4-BE49-F238E27FC236}">
                  <a16:creationId xmlns:a16="http://schemas.microsoft.com/office/drawing/2014/main" id="{B2AE6002-D453-45E9-BF65-BDDDB63920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11194" y="7440456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51BC41D6-F9AB-4658-8E2D-FC413FC29123}"/>
                </a:ext>
              </a:extLst>
            </p:cNvPr>
            <p:cNvSpPr txBox="1"/>
            <p:nvPr/>
          </p:nvSpPr>
          <p:spPr>
            <a:xfrm>
              <a:off x="2374146" y="720828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3846F88F-8060-4506-8304-4F000FA704BA}"/>
                </a:ext>
              </a:extLst>
            </p:cNvPr>
            <p:cNvSpPr txBox="1"/>
            <p:nvPr/>
          </p:nvSpPr>
          <p:spPr>
            <a:xfrm>
              <a:off x="2670688" y="7208289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54BDCC1C-A825-46B2-9DCA-FAA37CC4A526}"/>
                </a:ext>
              </a:extLst>
            </p:cNvPr>
            <p:cNvSpPr txBox="1"/>
            <p:nvPr/>
          </p:nvSpPr>
          <p:spPr>
            <a:xfrm>
              <a:off x="3107081" y="7208289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矩形 159">
              <a:extLst>
                <a:ext uri="{FF2B5EF4-FFF2-40B4-BE49-F238E27FC236}">
                  <a16:creationId xmlns:a16="http://schemas.microsoft.com/office/drawing/2014/main" id="{89D573D1-8EC5-4ECF-90F3-D83E9F6F2875}"/>
                </a:ext>
              </a:extLst>
            </p:cNvPr>
            <p:cNvSpPr/>
            <p:nvPr/>
          </p:nvSpPr>
          <p:spPr>
            <a:xfrm>
              <a:off x="2374146" y="7440456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E1A0162B-04C7-42D7-8371-16CAC2B0EE52}"/>
                </a:ext>
              </a:extLst>
            </p:cNvPr>
            <p:cNvSpPr/>
            <p:nvPr/>
          </p:nvSpPr>
          <p:spPr>
            <a:xfrm>
              <a:off x="2695724" y="7440456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矩形 161">
              <a:extLst>
                <a:ext uri="{FF2B5EF4-FFF2-40B4-BE49-F238E27FC236}">
                  <a16:creationId xmlns:a16="http://schemas.microsoft.com/office/drawing/2014/main" id="{92F45C4A-33D0-472B-8143-C658682206AB}"/>
                </a:ext>
              </a:extLst>
            </p:cNvPr>
            <p:cNvSpPr/>
            <p:nvPr/>
          </p:nvSpPr>
          <p:spPr>
            <a:xfrm>
              <a:off x="3074220" y="7440456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5">
              <a:extLst>
                <a:ext uri="{FF2B5EF4-FFF2-40B4-BE49-F238E27FC236}">
                  <a16:creationId xmlns:a16="http://schemas.microsoft.com/office/drawing/2014/main" id="{17239443-8189-46D3-A2A7-B954D6D619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836130" y="6013947"/>
              <a:ext cx="1749197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MRD46 Positive(%)</a:t>
              </a:r>
            </a:p>
          </p:txBody>
        </p:sp>
        <p:sp>
          <p:nvSpPr>
            <p:cNvPr id="163" name="TextBox 6">
              <a:extLst>
                <a:ext uri="{FF2B5EF4-FFF2-40B4-BE49-F238E27FC236}">
                  <a16:creationId xmlns:a16="http://schemas.microsoft.com/office/drawing/2014/main" id="{3C9FDFC0-6928-434A-86D0-389148E006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217370" y="4793250"/>
              <a:ext cx="895308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36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170" name="对象 169">
              <a:extLst>
                <a:ext uri="{FF2B5EF4-FFF2-40B4-BE49-F238E27FC236}">
                  <a16:creationId xmlns:a16="http://schemas.microsoft.com/office/drawing/2014/main" id="{C17BAEE5-91FD-4674-8C1B-2118FCDD0B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8206590"/>
                </p:ext>
              </p:extLst>
            </p:nvPr>
          </p:nvGraphicFramePr>
          <p:xfrm>
            <a:off x="11579238" y="4960951"/>
            <a:ext cx="1635125" cy="2719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9" imgW="1637537" imgH="2540853" progId="Prism7.Document">
                    <p:embed/>
                  </p:oleObj>
                </mc:Choice>
                <mc:Fallback>
                  <p:oleObj name="Prism 7" r:id="rId9" imgW="1637537" imgH="2540853" progId="Prism7.Document">
                    <p:embed/>
                    <p:pic>
                      <p:nvPicPr>
                        <p:cNvPr id="170" name="对象 169">
                          <a:extLst>
                            <a:ext uri="{FF2B5EF4-FFF2-40B4-BE49-F238E27FC236}">
                              <a16:creationId xmlns:a16="http://schemas.microsoft.com/office/drawing/2014/main" id="{C17BAEE5-91FD-4674-8C1B-2118FCDD0B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1579238" y="4960951"/>
                          <a:ext cx="1635125" cy="2719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2955941A-094A-4720-AEA9-1E54D1C8A7E6}"/>
                </a:ext>
              </a:extLst>
            </p:cNvPr>
            <p:cNvSpPr txBox="1"/>
            <p:nvPr/>
          </p:nvSpPr>
          <p:spPr>
            <a:xfrm>
              <a:off x="11879454" y="5123522"/>
              <a:ext cx="5435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27.3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E6D62E16-29D7-42F7-84DB-2DBFE6D47152}"/>
                </a:ext>
              </a:extLst>
            </p:cNvPr>
            <p:cNvSpPr txBox="1"/>
            <p:nvPr/>
          </p:nvSpPr>
          <p:spPr>
            <a:xfrm>
              <a:off x="12271634" y="5695492"/>
              <a:ext cx="4828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8.3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32BA7F46-CE29-4DFF-BD9B-0EB3A6CE4B29}"/>
                </a:ext>
              </a:extLst>
            </p:cNvPr>
            <p:cNvSpPr txBox="1"/>
            <p:nvPr/>
          </p:nvSpPr>
          <p:spPr>
            <a:xfrm>
              <a:off x="12631927" y="6091066"/>
              <a:ext cx="4828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.3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9" name="TextBox 7">
              <a:extLst>
                <a:ext uri="{FF2B5EF4-FFF2-40B4-BE49-F238E27FC236}">
                  <a16:creationId xmlns:a16="http://schemas.microsoft.com/office/drawing/2014/main" id="{54B6C4AF-B68F-4E63-8A81-4679DB46C7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66828" y="7440456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58C999AF-C62F-4EF2-B8D9-9E12E7DFB6CD}"/>
                </a:ext>
              </a:extLst>
            </p:cNvPr>
            <p:cNvSpPr txBox="1"/>
            <p:nvPr/>
          </p:nvSpPr>
          <p:spPr>
            <a:xfrm>
              <a:off x="11929780" y="720828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0608FE65-EDE6-4828-9FBC-40CA21176276}"/>
                </a:ext>
              </a:extLst>
            </p:cNvPr>
            <p:cNvSpPr txBox="1"/>
            <p:nvPr/>
          </p:nvSpPr>
          <p:spPr>
            <a:xfrm>
              <a:off x="12226322" y="7208289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81">
              <a:extLst>
                <a:ext uri="{FF2B5EF4-FFF2-40B4-BE49-F238E27FC236}">
                  <a16:creationId xmlns:a16="http://schemas.microsoft.com/office/drawing/2014/main" id="{0CD1F52C-2C99-4600-AF1E-E0557CFD6ABC}"/>
                </a:ext>
              </a:extLst>
            </p:cNvPr>
            <p:cNvSpPr txBox="1"/>
            <p:nvPr/>
          </p:nvSpPr>
          <p:spPr>
            <a:xfrm>
              <a:off x="12662715" y="7208289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矩形 182">
              <a:extLst>
                <a:ext uri="{FF2B5EF4-FFF2-40B4-BE49-F238E27FC236}">
                  <a16:creationId xmlns:a16="http://schemas.microsoft.com/office/drawing/2014/main" id="{01262261-7252-4EEA-B45C-C566C401597F}"/>
                </a:ext>
              </a:extLst>
            </p:cNvPr>
            <p:cNvSpPr/>
            <p:nvPr/>
          </p:nvSpPr>
          <p:spPr>
            <a:xfrm>
              <a:off x="11929780" y="7440456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矩形 183">
              <a:extLst>
                <a:ext uri="{FF2B5EF4-FFF2-40B4-BE49-F238E27FC236}">
                  <a16:creationId xmlns:a16="http://schemas.microsoft.com/office/drawing/2014/main" id="{24C99CAE-4C36-4E1C-A1EC-B82B469EB742}"/>
                </a:ext>
              </a:extLst>
            </p:cNvPr>
            <p:cNvSpPr/>
            <p:nvPr/>
          </p:nvSpPr>
          <p:spPr>
            <a:xfrm>
              <a:off x="12251358" y="7440456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矩形 184">
              <a:extLst>
                <a:ext uri="{FF2B5EF4-FFF2-40B4-BE49-F238E27FC236}">
                  <a16:creationId xmlns:a16="http://schemas.microsoft.com/office/drawing/2014/main" id="{63A8FC40-519D-4AB4-A241-226947FC3C6A}"/>
                </a:ext>
              </a:extLst>
            </p:cNvPr>
            <p:cNvSpPr/>
            <p:nvPr/>
          </p:nvSpPr>
          <p:spPr>
            <a:xfrm>
              <a:off x="12629854" y="7440456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ADBD22EA-0159-4BC9-BDED-AB51AA15B845}"/>
                </a:ext>
              </a:extLst>
            </p:cNvPr>
            <p:cNvSpPr txBox="1"/>
            <p:nvPr/>
          </p:nvSpPr>
          <p:spPr>
            <a:xfrm>
              <a:off x="11591761" y="704035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61B3237D-FA05-4FB8-8012-89453ACF6B35}"/>
                </a:ext>
              </a:extLst>
            </p:cNvPr>
            <p:cNvSpPr txBox="1"/>
            <p:nvPr/>
          </p:nvSpPr>
          <p:spPr>
            <a:xfrm>
              <a:off x="11506803" y="6382995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07282008-52B3-4E5A-8F85-AD3A81B042FD}"/>
                </a:ext>
              </a:extLst>
            </p:cNvPr>
            <p:cNvSpPr txBox="1"/>
            <p:nvPr/>
          </p:nvSpPr>
          <p:spPr>
            <a:xfrm>
              <a:off x="11506803" y="573604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0A59919D-2E8F-4AD7-AD61-6F4EFF8E14E8}"/>
                </a:ext>
              </a:extLst>
            </p:cNvPr>
            <p:cNvSpPr txBox="1"/>
            <p:nvPr/>
          </p:nvSpPr>
          <p:spPr>
            <a:xfrm>
              <a:off x="11506803" y="510427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6">
              <a:extLst>
                <a:ext uri="{FF2B5EF4-FFF2-40B4-BE49-F238E27FC236}">
                  <a16:creationId xmlns:a16="http://schemas.microsoft.com/office/drawing/2014/main" id="{13ECCEB0-827C-43E2-A290-EC756BB087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33259" y="4793250"/>
              <a:ext cx="953895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745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186" name="对象 185">
              <a:extLst>
                <a:ext uri="{FF2B5EF4-FFF2-40B4-BE49-F238E27FC236}">
                  <a16:creationId xmlns:a16="http://schemas.microsoft.com/office/drawing/2014/main" id="{C1FC6736-E311-4859-9A38-65EAC4DF0E0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27884405"/>
                </p:ext>
              </p:extLst>
            </p:nvPr>
          </p:nvGraphicFramePr>
          <p:xfrm>
            <a:off x="9752029" y="4964126"/>
            <a:ext cx="1635125" cy="2716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11" imgW="1637537" imgH="2540853" progId="Prism7.Document">
                    <p:embed/>
                  </p:oleObj>
                </mc:Choice>
                <mc:Fallback>
                  <p:oleObj name="Prism 7" r:id="rId11" imgW="1637537" imgH="2540853" progId="Prism7.Document">
                    <p:embed/>
                    <p:pic>
                      <p:nvPicPr>
                        <p:cNvPr id="186" name="对象 185">
                          <a:extLst>
                            <a:ext uri="{FF2B5EF4-FFF2-40B4-BE49-F238E27FC236}">
                              <a16:creationId xmlns:a16="http://schemas.microsoft.com/office/drawing/2014/main" id="{C1FC6736-E311-4859-9A38-65EAC4DF0E0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9752029" y="4964126"/>
                          <a:ext cx="1635125" cy="2716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99FFCBDC-3487-4C45-A188-5C28B6C972E8}"/>
                </a:ext>
              </a:extLst>
            </p:cNvPr>
            <p:cNvSpPr txBox="1"/>
            <p:nvPr/>
          </p:nvSpPr>
          <p:spPr>
            <a:xfrm>
              <a:off x="10008461" y="5747640"/>
              <a:ext cx="6998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6.1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A4D3C8C4-C544-42D2-B397-44AA3CD3E7CE}"/>
                </a:ext>
              </a:extLst>
            </p:cNvPr>
            <p:cNvSpPr txBox="1"/>
            <p:nvPr/>
          </p:nvSpPr>
          <p:spPr>
            <a:xfrm>
              <a:off x="10497627" y="565770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6.5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7139A97C-82A9-4742-B3FE-AD27C8D7EFD3}"/>
                </a:ext>
              </a:extLst>
            </p:cNvPr>
            <p:cNvSpPr txBox="1"/>
            <p:nvPr/>
          </p:nvSpPr>
          <p:spPr>
            <a:xfrm>
              <a:off x="10887843" y="543432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7.4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90" name="TextBox 7">
              <a:extLst>
                <a:ext uri="{FF2B5EF4-FFF2-40B4-BE49-F238E27FC236}">
                  <a16:creationId xmlns:a16="http://schemas.microsoft.com/office/drawing/2014/main" id="{A60DDC82-2E00-4350-9F6A-DB60381F9F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78965" y="7457409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A479D848-3030-4A20-84D2-27619C1045D3}"/>
                </a:ext>
              </a:extLst>
            </p:cNvPr>
            <p:cNvSpPr txBox="1"/>
            <p:nvPr/>
          </p:nvSpPr>
          <p:spPr>
            <a:xfrm>
              <a:off x="10141917" y="7223571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文本框 191">
              <a:extLst>
                <a:ext uri="{FF2B5EF4-FFF2-40B4-BE49-F238E27FC236}">
                  <a16:creationId xmlns:a16="http://schemas.microsoft.com/office/drawing/2014/main" id="{D75CDE43-CEBC-46EA-842A-84C1A84CA159}"/>
                </a:ext>
              </a:extLst>
            </p:cNvPr>
            <p:cNvSpPr txBox="1"/>
            <p:nvPr/>
          </p:nvSpPr>
          <p:spPr>
            <a:xfrm>
              <a:off x="10438459" y="7223571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5A77B359-CF9E-416A-AA05-74B80A7C951C}"/>
                </a:ext>
              </a:extLst>
            </p:cNvPr>
            <p:cNvSpPr txBox="1"/>
            <p:nvPr/>
          </p:nvSpPr>
          <p:spPr>
            <a:xfrm>
              <a:off x="10874852" y="7223571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矩形 212">
              <a:extLst>
                <a:ext uri="{FF2B5EF4-FFF2-40B4-BE49-F238E27FC236}">
                  <a16:creationId xmlns:a16="http://schemas.microsoft.com/office/drawing/2014/main" id="{81132986-3C91-48FE-B9C9-9A0FDB376519}"/>
                </a:ext>
              </a:extLst>
            </p:cNvPr>
            <p:cNvSpPr/>
            <p:nvPr/>
          </p:nvSpPr>
          <p:spPr>
            <a:xfrm>
              <a:off x="10141917" y="7457409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矩形 215">
              <a:extLst>
                <a:ext uri="{FF2B5EF4-FFF2-40B4-BE49-F238E27FC236}">
                  <a16:creationId xmlns:a16="http://schemas.microsoft.com/office/drawing/2014/main" id="{4C9F8657-6FEA-418E-A7CA-8FC06A640D0E}"/>
                </a:ext>
              </a:extLst>
            </p:cNvPr>
            <p:cNvSpPr/>
            <p:nvPr/>
          </p:nvSpPr>
          <p:spPr>
            <a:xfrm>
              <a:off x="10463495" y="7457409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矩形 222">
              <a:extLst>
                <a:ext uri="{FF2B5EF4-FFF2-40B4-BE49-F238E27FC236}">
                  <a16:creationId xmlns:a16="http://schemas.microsoft.com/office/drawing/2014/main" id="{FD01ADAE-65AB-44BE-8363-91E4B6F6D876}"/>
                </a:ext>
              </a:extLst>
            </p:cNvPr>
            <p:cNvSpPr/>
            <p:nvPr/>
          </p:nvSpPr>
          <p:spPr>
            <a:xfrm>
              <a:off x="10841991" y="7457409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E4212E7C-FD75-490E-8064-5E9F409DE92D}"/>
                </a:ext>
              </a:extLst>
            </p:cNvPr>
            <p:cNvSpPr txBox="1"/>
            <p:nvPr/>
          </p:nvSpPr>
          <p:spPr>
            <a:xfrm>
              <a:off x="9803898" y="703087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2F3A0104-099F-4F9C-A5D6-864FA99A5033}"/>
                </a:ext>
              </a:extLst>
            </p:cNvPr>
            <p:cNvSpPr txBox="1"/>
            <p:nvPr/>
          </p:nvSpPr>
          <p:spPr>
            <a:xfrm>
              <a:off x="9718940" y="6637792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0E637E2B-9269-4019-8B6B-828658F0D126}"/>
                </a:ext>
              </a:extLst>
            </p:cNvPr>
            <p:cNvSpPr txBox="1"/>
            <p:nvPr/>
          </p:nvSpPr>
          <p:spPr>
            <a:xfrm>
              <a:off x="9803899" y="6254144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E99330C1-5902-4173-9AB3-ACC57B071AF0}"/>
                </a:ext>
              </a:extLst>
            </p:cNvPr>
            <p:cNvSpPr txBox="1"/>
            <p:nvPr/>
          </p:nvSpPr>
          <p:spPr>
            <a:xfrm>
              <a:off x="9803899" y="5873951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F93F1962-B927-4626-99A4-157ADE614F66}"/>
                </a:ext>
              </a:extLst>
            </p:cNvPr>
            <p:cNvSpPr txBox="1"/>
            <p:nvPr/>
          </p:nvSpPr>
          <p:spPr>
            <a:xfrm>
              <a:off x="9718940" y="50881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1B629542-BAE2-42FD-9BEB-FB3DFB09C19C}"/>
                </a:ext>
              </a:extLst>
            </p:cNvPr>
            <p:cNvSpPr txBox="1"/>
            <p:nvPr/>
          </p:nvSpPr>
          <p:spPr>
            <a:xfrm>
              <a:off x="9803899" y="5483412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6">
              <a:extLst>
                <a:ext uri="{FF2B5EF4-FFF2-40B4-BE49-F238E27FC236}">
                  <a16:creationId xmlns:a16="http://schemas.microsoft.com/office/drawing/2014/main" id="{24ABFBC6-5F9B-4968-BC06-2A2A501A13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12187" y="4793250"/>
              <a:ext cx="1063515" cy="46166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</a:t>
              </a:r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 = </a:t>
              </a:r>
              <a:r>
                <a:rPr lang="en-US" altLang="zh-CN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647</a:t>
              </a:r>
            </a:p>
            <a:p>
              <a:pPr eaLnBrk="1" hangingPunct="1"/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graphicFrame>
          <p:nvGraphicFramePr>
            <p:cNvPr id="224" name="对象 223">
              <a:extLst>
                <a:ext uri="{FF2B5EF4-FFF2-40B4-BE49-F238E27FC236}">
                  <a16:creationId xmlns:a16="http://schemas.microsoft.com/office/drawing/2014/main" id="{EBF9BF84-E6B8-464A-9885-4857BBFB26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15181211"/>
                </p:ext>
              </p:extLst>
            </p:nvPr>
          </p:nvGraphicFramePr>
          <p:xfrm>
            <a:off x="7934341" y="4964126"/>
            <a:ext cx="1671638" cy="2716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13" imgW="1675351" imgH="2540853" progId="Prism7.Document">
                    <p:embed/>
                  </p:oleObj>
                </mc:Choice>
                <mc:Fallback>
                  <p:oleObj name="Prism 7" r:id="rId13" imgW="1675351" imgH="2540853" progId="Prism7.Document">
                    <p:embed/>
                    <p:pic>
                      <p:nvPicPr>
                        <p:cNvPr id="224" name="对象 223">
                          <a:extLst>
                            <a:ext uri="{FF2B5EF4-FFF2-40B4-BE49-F238E27FC236}">
                              <a16:creationId xmlns:a16="http://schemas.microsoft.com/office/drawing/2014/main" id="{EBF9BF84-E6B8-464A-9885-4857BBFB26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7934341" y="4964126"/>
                          <a:ext cx="1671638" cy="2716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A8988B0F-A273-491A-9F82-23B992F8E137}"/>
                </a:ext>
              </a:extLst>
            </p:cNvPr>
            <p:cNvSpPr txBox="1"/>
            <p:nvPr/>
          </p:nvSpPr>
          <p:spPr>
            <a:xfrm>
              <a:off x="8262646" y="6862862"/>
              <a:ext cx="515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FFC1082C-7588-43D0-BDD9-79636D4B12F5}"/>
                </a:ext>
              </a:extLst>
            </p:cNvPr>
            <p:cNvSpPr txBox="1"/>
            <p:nvPr/>
          </p:nvSpPr>
          <p:spPr>
            <a:xfrm>
              <a:off x="8653914" y="5632114"/>
              <a:ext cx="4828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0.65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8D204BF5-0802-4AC0-870F-23756DD908F9}"/>
                </a:ext>
              </a:extLst>
            </p:cNvPr>
            <p:cNvSpPr txBox="1"/>
            <p:nvPr/>
          </p:nvSpPr>
          <p:spPr>
            <a:xfrm>
              <a:off x="9016420" y="5290584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0.82</a:t>
              </a:r>
              <a:endParaRPr lang="zh-CN" altLang="en-US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9" name="TextBox 7">
              <a:extLst>
                <a:ext uri="{FF2B5EF4-FFF2-40B4-BE49-F238E27FC236}">
                  <a16:creationId xmlns:a16="http://schemas.microsoft.com/office/drawing/2014/main" id="{B3875A2B-7CCF-4870-B9E8-3CDF4E7A87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50020" y="7457678"/>
              <a:ext cx="482825" cy="307777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pPr algn="r"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 =</a:t>
              </a: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824B831B-A802-4AB5-B055-DBC836AB64E2}"/>
                </a:ext>
              </a:extLst>
            </p:cNvPr>
            <p:cNvSpPr txBox="1"/>
            <p:nvPr/>
          </p:nvSpPr>
          <p:spPr>
            <a:xfrm>
              <a:off x="8312972" y="7226840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3E89A4BC-A4C0-4A66-9AC7-31FBD39FF135}"/>
                </a:ext>
              </a:extLst>
            </p:cNvPr>
            <p:cNvSpPr txBox="1"/>
            <p:nvPr/>
          </p:nvSpPr>
          <p:spPr>
            <a:xfrm>
              <a:off x="8609514" y="7226840"/>
              <a:ext cx="532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01431A97-480E-4A6D-98B5-12814717BB94}"/>
                </a:ext>
              </a:extLst>
            </p:cNvPr>
            <p:cNvSpPr txBox="1"/>
            <p:nvPr/>
          </p:nvSpPr>
          <p:spPr>
            <a:xfrm>
              <a:off x="9045907" y="7226840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/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矩形 236">
              <a:extLst>
                <a:ext uri="{FF2B5EF4-FFF2-40B4-BE49-F238E27FC236}">
                  <a16:creationId xmlns:a16="http://schemas.microsoft.com/office/drawing/2014/main" id="{5FF09CAD-853A-4632-9D24-68F15322A5C4}"/>
                </a:ext>
              </a:extLst>
            </p:cNvPr>
            <p:cNvSpPr/>
            <p:nvPr/>
          </p:nvSpPr>
          <p:spPr>
            <a:xfrm>
              <a:off x="8312972" y="7457678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矩形 237">
              <a:extLst>
                <a:ext uri="{FF2B5EF4-FFF2-40B4-BE49-F238E27FC236}">
                  <a16:creationId xmlns:a16="http://schemas.microsoft.com/office/drawing/2014/main" id="{01A0E49C-86A1-4EF2-B059-6653B0AEFFDE}"/>
                </a:ext>
              </a:extLst>
            </p:cNvPr>
            <p:cNvSpPr/>
            <p:nvPr/>
          </p:nvSpPr>
          <p:spPr>
            <a:xfrm>
              <a:off x="8634550" y="7457678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5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矩形 238">
              <a:extLst>
                <a:ext uri="{FF2B5EF4-FFF2-40B4-BE49-F238E27FC236}">
                  <a16:creationId xmlns:a16="http://schemas.microsoft.com/office/drawing/2014/main" id="{08BA8AFE-F653-4581-8056-0CBBCFFC826C}"/>
                </a:ext>
              </a:extLst>
            </p:cNvPr>
            <p:cNvSpPr/>
            <p:nvPr/>
          </p:nvSpPr>
          <p:spPr>
            <a:xfrm>
              <a:off x="9013046" y="7457678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12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3119AB20-FAB4-4ACB-BCA2-D37DFBD8FA93}"/>
                </a:ext>
              </a:extLst>
            </p:cNvPr>
            <p:cNvSpPr txBox="1"/>
            <p:nvPr/>
          </p:nvSpPr>
          <p:spPr>
            <a:xfrm>
              <a:off x="8012184" y="70396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4AED47F6-0518-4605-9BCB-AB8DE88F4A63}"/>
                </a:ext>
              </a:extLst>
            </p:cNvPr>
            <p:cNvSpPr txBox="1"/>
            <p:nvPr/>
          </p:nvSpPr>
          <p:spPr>
            <a:xfrm>
              <a:off x="7798985" y="6645078"/>
              <a:ext cx="482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DA22687C-0B33-4592-B63F-F5B690998008}"/>
                </a:ext>
              </a:extLst>
            </p:cNvPr>
            <p:cNvSpPr txBox="1"/>
            <p:nvPr/>
          </p:nvSpPr>
          <p:spPr>
            <a:xfrm>
              <a:off x="7883944" y="587630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文本框 234">
              <a:extLst>
                <a:ext uri="{FF2B5EF4-FFF2-40B4-BE49-F238E27FC236}">
                  <a16:creationId xmlns:a16="http://schemas.microsoft.com/office/drawing/2014/main" id="{3064C382-2DAF-4DAA-96D0-99AD03DE3DC3}"/>
                </a:ext>
              </a:extLst>
            </p:cNvPr>
            <p:cNvSpPr txBox="1"/>
            <p:nvPr/>
          </p:nvSpPr>
          <p:spPr>
            <a:xfrm>
              <a:off x="7883944" y="509717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52CF738C-B514-4225-9BCC-1638BE6F4337}"/>
                </a:ext>
              </a:extLst>
            </p:cNvPr>
            <p:cNvSpPr txBox="1"/>
            <p:nvPr/>
          </p:nvSpPr>
          <p:spPr>
            <a:xfrm>
              <a:off x="7883944" y="547962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64B349AB-449D-4AD3-9247-77A959A50426}"/>
                </a:ext>
              </a:extLst>
            </p:cNvPr>
            <p:cNvSpPr txBox="1"/>
            <p:nvPr/>
          </p:nvSpPr>
          <p:spPr>
            <a:xfrm>
              <a:off x="7798985" y="6268834"/>
              <a:ext cx="482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5">
            <a:extLst>
              <a:ext uri="{FF2B5EF4-FFF2-40B4-BE49-F238E27FC236}">
                <a16:creationId xmlns:a16="http://schemas.microsoft.com/office/drawing/2014/main" id="{4900291D-F217-43FD-B286-8126D985237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03857" y="3025727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19 Positive(%)</a:t>
            </a: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801025C7-659E-4467-84F0-AAD6E86D72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0150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67</a:t>
            </a: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AED05AAA-4043-48C9-A3CE-636CF81CCD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8471016"/>
              </p:ext>
            </p:extLst>
          </p:nvPr>
        </p:nvGraphicFramePr>
        <p:xfrm>
          <a:off x="4123177" y="1976460"/>
          <a:ext cx="1630363" cy="272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5" imgW="1634296" imgH="2546973" progId="Prism7.Document">
                  <p:embed/>
                </p:oleObj>
              </mc:Choice>
              <mc:Fallback>
                <p:oleObj name="Prism 7" r:id="rId15" imgW="1634296" imgH="2546973" progId="Prism7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AED05AAA-4043-48C9-A3CE-636CF81CCD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123177" y="1976460"/>
                        <a:ext cx="1630363" cy="272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9E6ADF14-CFC6-4302-A704-2BAE8BF6BDF1}"/>
              </a:ext>
            </a:extLst>
          </p:cNvPr>
          <p:cNvSpPr txBox="1"/>
          <p:nvPr/>
        </p:nvSpPr>
        <p:spPr>
          <a:xfrm>
            <a:off x="4125294" y="405865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C2E763E-FB19-48A5-92C0-6812AB2440A8}"/>
              </a:ext>
            </a:extLst>
          </p:cNvPr>
          <p:cNvSpPr txBox="1"/>
          <p:nvPr/>
        </p:nvSpPr>
        <p:spPr>
          <a:xfrm>
            <a:off x="4040336" y="3643301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C01237B-4794-4059-BE08-2F09D014EF61}"/>
              </a:ext>
            </a:extLst>
          </p:cNvPr>
          <p:cNvSpPr txBox="1"/>
          <p:nvPr/>
        </p:nvSpPr>
        <p:spPr>
          <a:xfrm>
            <a:off x="4040336" y="28946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09D51D1-1755-435F-BEE2-3F163D100006}"/>
              </a:ext>
            </a:extLst>
          </p:cNvPr>
          <p:cNvSpPr txBox="1"/>
          <p:nvPr/>
        </p:nvSpPr>
        <p:spPr>
          <a:xfrm>
            <a:off x="4040336" y="209910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ADF9423-D8A7-4B70-B30A-3C73DDC2D2CF}"/>
              </a:ext>
            </a:extLst>
          </p:cNvPr>
          <p:cNvSpPr txBox="1"/>
          <p:nvPr/>
        </p:nvSpPr>
        <p:spPr>
          <a:xfrm>
            <a:off x="4440340" y="232466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9.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9187D34-7CE5-4560-B620-DA0A6F2C42AC}"/>
              </a:ext>
            </a:extLst>
          </p:cNvPr>
          <p:cNvSpPr txBox="1"/>
          <p:nvPr/>
        </p:nvSpPr>
        <p:spPr>
          <a:xfrm>
            <a:off x="4829862" y="307345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.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2AE81BF-6532-44FD-BE71-CE46C2E4F8C7}"/>
              </a:ext>
            </a:extLst>
          </p:cNvPr>
          <p:cNvSpPr txBox="1"/>
          <p:nvPr/>
        </p:nvSpPr>
        <p:spPr>
          <a:xfrm>
            <a:off x="5199121" y="313001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9.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9EABCAB6-FE46-4776-B5F8-25DFBCBCD1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0569" y="4479538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60A3E181-428C-48E0-A0D5-2A1879958CBE}"/>
              </a:ext>
            </a:extLst>
          </p:cNvPr>
          <p:cNvSpPr/>
          <p:nvPr/>
        </p:nvSpPr>
        <p:spPr>
          <a:xfrm>
            <a:off x="4491282" y="4479538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DE09725E-AC92-40E7-8D15-D6B36CAF69E8}"/>
              </a:ext>
            </a:extLst>
          </p:cNvPr>
          <p:cNvSpPr/>
          <p:nvPr/>
        </p:nvSpPr>
        <p:spPr>
          <a:xfrm>
            <a:off x="4820816" y="4479538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AF75B3B-FF90-43B3-8E3E-58935F62C763}"/>
              </a:ext>
            </a:extLst>
          </p:cNvPr>
          <p:cNvSpPr/>
          <p:nvPr/>
        </p:nvSpPr>
        <p:spPr>
          <a:xfrm>
            <a:off x="5202733" y="4479538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4F17E40-D769-493C-A225-5EDEE3C41D6C}"/>
              </a:ext>
            </a:extLst>
          </p:cNvPr>
          <p:cNvSpPr txBox="1"/>
          <p:nvPr/>
        </p:nvSpPr>
        <p:spPr>
          <a:xfrm>
            <a:off x="4491282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26FA677-44A7-4D9E-B782-58151474ACBE}"/>
              </a:ext>
            </a:extLst>
          </p:cNvPr>
          <p:cNvSpPr txBox="1"/>
          <p:nvPr/>
        </p:nvSpPr>
        <p:spPr>
          <a:xfrm>
            <a:off x="4820816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E0BEE68-2448-47FF-9BA7-A2D4B0CFEE06}"/>
              </a:ext>
            </a:extLst>
          </p:cNvPr>
          <p:cNvSpPr txBox="1"/>
          <p:nvPr/>
        </p:nvSpPr>
        <p:spPr>
          <a:xfrm>
            <a:off x="5202733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D909FD86-B0B4-4D9C-900E-D4F244178DA6}"/>
              </a:ext>
            </a:extLst>
          </p:cNvPr>
          <p:cNvSpPr txBox="1"/>
          <p:nvPr/>
        </p:nvSpPr>
        <p:spPr>
          <a:xfrm>
            <a:off x="4040336" y="24711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7BDE182E-582F-4A00-AD8B-C5656BE04AC1}"/>
              </a:ext>
            </a:extLst>
          </p:cNvPr>
          <p:cNvSpPr txBox="1"/>
          <p:nvPr/>
        </p:nvSpPr>
        <p:spPr>
          <a:xfrm>
            <a:off x="4040336" y="3265558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6">
            <a:extLst>
              <a:ext uri="{FF2B5EF4-FFF2-40B4-BE49-F238E27FC236}">
                <a16:creationId xmlns:a16="http://schemas.microsoft.com/office/drawing/2014/main" id="{9A710CCC-856D-4134-B0AB-09B76A5D0F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9800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67</a:t>
            </a:r>
          </a:p>
        </p:txBody>
      </p:sp>
      <p:graphicFrame>
        <p:nvGraphicFramePr>
          <p:cNvPr id="48" name="对象 47">
            <a:extLst>
              <a:ext uri="{FF2B5EF4-FFF2-40B4-BE49-F238E27FC236}">
                <a16:creationId xmlns:a16="http://schemas.microsoft.com/office/drawing/2014/main" id="{F8A202D5-E664-40E7-958D-40383F50A9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7848612"/>
              </p:ext>
            </p:extLst>
          </p:nvPr>
        </p:nvGraphicFramePr>
        <p:xfrm>
          <a:off x="5949590" y="1976460"/>
          <a:ext cx="1630363" cy="272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7" imgW="1634296" imgH="2546973" progId="Prism7.Document">
                  <p:embed/>
                </p:oleObj>
              </mc:Choice>
              <mc:Fallback>
                <p:oleObj name="Prism 7" r:id="rId17" imgW="1634296" imgH="2546973" progId="Prism7.Document">
                  <p:embed/>
                  <p:pic>
                    <p:nvPicPr>
                      <p:cNvPr id="48" name="对象 47">
                        <a:extLst>
                          <a:ext uri="{FF2B5EF4-FFF2-40B4-BE49-F238E27FC236}">
                            <a16:creationId xmlns:a16="http://schemas.microsoft.com/office/drawing/2014/main" id="{F8A202D5-E664-40E7-958D-40383F50A9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949590" y="1976460"/>
                        <a:ext cx="1630363" cy="272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文本框 49">
            <a:extLst>
              <a:ext uri="{FF2B5EF4-FFF2-40B4-BE49-F238E27FC236}">
                <a16:creationId xmlns:a16="http://schemas.microsoft.com/office/drawing/2014/main" id="{844F9B03-397B-4F23-8895-794B2A24297E}"/>
              </a:ext>
            </a:extLst>
          </p:cNvPr>
          <p:cNvSpPr txBox="1"/>
          <p:nvPr/>
        </p:nvSpPr>
        <p:spPr>
          <a:xfrm>
            <a:off x="5951707" y="40583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A0AC62B-8A44-49FC-8969-DF3D70988F47}"/>
              </a:ext>
            </a:extLst>
          </p:cNvPr>
          <p:cNvSpPr txBox="1"/>
          <p:nvPr/>
        </p:nvSpPr>
        <p:spPr>
          <a:xfrm>
            <a:off x="5866749" y="362243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F24ECCE-44A3-4196-BE3C-F203FAC7A270}"/>
              </a:ext>
            </a:extLst>
          </p:cNvPr>
          <p:cNvSpPr txBox="1"/>
          <p:nvPr/>
        </p:nvSpPr>
        <p:spPr>
          <a:xfrm>
            <a:off x="5866749" y="30530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4DAE79E-B57A-47C3-9E80-392F6B6B38DD}"/>
              </a:ext>
            </a:extLst>
          </p:cNvPr>
          <p:cNvSpPr txBox="1"/>
          <p:nvPr/>
        </p:nvSpPr>
        <p:spPr>
          <a:xfrm>
            <a:off x="6266753" y="232445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6.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A1940AF-860D-457F-B40D-3ADEB1DFFDC7}"/>
              </a:ext>
            </a:extLst>
          </p:cNvPr>
          <p:cNvSpPr txBox="1"/>
          <p:nvPr/>
        </p:nvSpPr>
        <p:spPr>
          <a:xfrm>
            <a:off x="6656275" y="290911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.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0A072DC-60C8-4675-B993-AC865975016C}"/>
              </a:ext>
            </a:extLst>
          </p:cNvPr>
          <p:cNvSpPr txBox="1"/>
          <p:nvPr/>
        </p:nvSpPr>
        <p:spPr>
          <a:xfrm>
            <a:off x="7025534" y="279600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6.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7">
            <a:extLst>
              <a:ext uri="{FF2B5EF4-FFF2-40B4-BE49-F238E27FC236}">
                <a16:creationId xmlns:a16="http://schemas.microsoft.com/office/drawing/2014/main" id="{27378D77-1C07-476B-940D-3E2859ABDA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6982" y="4479269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0F6D5153-1D43-40BE-AFD4-5C0E946A330B}"/>
              </a:ext>
            </a:extLst>
          </p:cNvPr>
          <p:cNvSpPr/>
          <p:nvPr/>
        </p:nvSpPr>
        <p:spPr>
          <a:xfrm>
            <a:off x="6317695" y="4479269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9D62C36B-8123-427D-846B-24CFDEF554B2}"/>
              </a:ext>
            </a:extLst>
          </p:cNvPr>
          <p:cNvSpPr/>
          <p:nvPr/>
        </p:nvSpPr>
        <p:spPr>
          <a:xfrm>
            <a:off x="6647229" y="4479269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D950F2C6-5C8F-4C74-92A5-388560C71809}"/>
              </a:ext>
            </a:extLst>
          </p:cNvPr>
          <p:cNvSpPr/>
          <p:nvPr/>
        </p:nvSpPr>
        <p:spPr>
          <a:xfrm>
            <a:off x="7029146" y="4479269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D5DAC3D-185C-471A-BE18-ACD4937A39E5}"/>
              </a:ext>
            </a:extLst>
          </p:cNvPr>
          <p:cNvSpPr txBox="1"/>
          <p:nvPr/>
        </p:nvSpPr>
        <p:spPr>
          <a:xfrm>
            <a:off x="6317695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FDC29F0A-E479-4D22-A84F-38F1D2C02714}"/>
              </a:ext>
            </a:extLst>
          </p:cNvPr>
          <p:cNvSpPr txBox="1"/>
          <p:nvPr/>
        </p:nvSpPr>
        <p:spPr>
          <a:xfrm>
            <a:off x="6647229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54AB620E-454B-48B7-BD27-33A81EC60ACF}"/>
              </a:ext>
            </a:extLst>
          </p:cNvPr>
          <p:cNvSpPr txBox="1"/>
          <p:nvPr/>
        </p:nvSpPr>
        <p:spPr>
          <a:xfrm>
            <a:off x="7029146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E2AECB52-134F-420B-B932-C30E20CB716E}"/>
              </a:ext>
            </a:extLst>
          </p:cNvPr>
          <p:cNvSpPr txBox="1"/>
          <p:nvPr/>
        </p:nvSpPr>
        <p:spPr>
          <a:xfrm>
            <a:off x="5866749" y="25728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DE4DE78B-AD62-4AFF-9F50-D361E728494B}"/>
              </a:ext>
            </a:extLst>
          </p:cNvPr>
          <p:cNvSpPr txBox="1"/>
          <p:nvPr/>
        </p:nvSpPr>
        <p:spPr>
          <a:xfrm>
            <a:off x="5866749" y="21156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6">
            <a:extLst>
              <a:ext uri="{FF2B5EF4-FFF2-40B4-BE49-F238E27FC236}">
                <a16:creationId xmlns:a16="http://schemas.microsoft.com/office/drawing/2014/main" id="{AE58F1DA-4647-4EF9-B8DF-AE4755A9F1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8917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16</a:t>
            </a:r>
          </a:p>
        </p:txBody>
      </p:sp>
      <p:sp>
        <p:nvSpPr>
          <p:cNvPr id="205" name="TextBox 7">
            <a:extLst>
              <a:ext uri="{FF2B5EF4-FFF2-40B4-BE49-F238E27FC236}">
                <a16:creationId xmlns:a16="http://schemas.microsoft.com/office/drawing/2014/main" id="{21ACF541-BDBD-4A6F-A685-5314AAF1BE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2874" y="4457553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06" name="矩形 205">
            <a:extLst>
              <a:ext uri="{FF2B5EF4-FFF2-40B4-BE49-F238E27FC236}">
                <a16:creationId xmlns:a16="http://schemas.microsoft.com/office/drawing/2014/main" id="{8F46CA49-2108-467F-90B0-F5ECD3098748}"/>
              </a:ext>
            </a:extLst>
          </p:cNvPr>
          <p:cNvSpPr/>
          <p:nvPr/>
        </p:nvSpPr>
        <p:spPr>
          <a:xfrm>
            <a:off x="2673587" y="445755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矩形 206">
            <a:extLst>
              <a:ext uri="{FF2B5EF4-FFF2-40B4-BE49-F238E27FC236}">
                <a16:creationId xmlns:a16="http://schemas.microsoft.com/office/drawing/2014/main" id="{47117B2C-FEA4-4A46-BD4A-E9E479CF3235}"/>
              </a:ext>
            </a:extLst>
          </p:cNvPr>
          <p:cNvSpPr/>
          <p:nvPr/>
        </p:nvSpPr>
        <p:spPr>
          <a:xfrm>
            <a:off x="3003121" y="4457553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矩形 207">
            <a:extLst>
              <a:ext uri="{FF2B5EF4-FFF2-40B4-BE49-F238E27FC236}">
                <a16:creationId xmlns:a16="http://schemas.microsoft.com/office/drawing/2014/main" id="{8A1FCBF8-EBCA-4986-9580-585D66144205}"/>
              </a:ext>
            </a:extLst>
          </p:cNvPr>
          <p:cNvSpPr/>
          <p:nvPr/>
        </p:nvSpPr>
        <p:spPr>
          <a:xfrm>
            <a:off x="3385038" y="4457553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5" name="对象 194">
            <a:extLst>
              <a:ext uri="{FF2B5EF4-FFF2-40B4-BE49-F238E27FC236}">
                <a16:creationId xmlns:a16="http://schemas.microsoft.com/office/drawing/2014/main" id="{C8C8E197-1F26-4396-BEA9-EF77B54015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3461870"/>
              </p:ext>
            </p:extLst>
          </p:nvPr>
        </p:nvGraphicFramePr>
        <p:xfrm>
          <a:off x="2305482" y="1978048"/>
          <a:ext cx="1630363" cy="272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9" imgW="1634296" imgH="2546973" progId="Prism7.Document">
                  <p:embed/>
                </p:oleObj>
              </mc:Choice>
              <mc:Fallback>
                <p:oleObj name="Prism 7" r:id="rId19" imgW="1634296" imgH="2546973" progId="Prism7.Document">
                  <p:embed/>
                  <p:pic>
                    <p:nvPicPr>
                      <p:cNvPr id="195" name="对象 194">
                        <a:extLst>
                          <a:ext uri="{FF2B5EF4-FFF2-40B4-BE49-F238E27FC236}">
                            <a16:creationId xmlns:a16="http://schemas.microsoft.com/office/drawing/2014/main" id="{C8C8E197-1F26-4396-BEA9-EF77B54015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305482" y="1978048"/>
                        <a:ext cx="1630363" cy="272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7" name="文本框 196">
            <a:extLst>
              <a:ext uri="{FF2B5EF4-FFF2-40B4-BE49-F238E27FC236}">
                <a16:creationId xmlns:a16="http://schemas.microsoft.com/office/drawing/2014/main" id="{9DEC4FB8-7779-4E27-B27E-9C6B18AC9C55}"/>
              </a:ext>
            </a:extLst>
          </p:cNvPr>
          <p:cNvSpPr txBox="1"/>
          <p:nvPr/>
        </p:nvSpPr>
        <p:spPr>
          <a:xfrm>
            <a:off x="2307599" y="403742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93CAEB62-C434-486B-8544-17134CC38570}"/>
              </a:ext>
            </a:extLst>
          </p:cNvPr>
          <p:cNvSpPr txBox="1"/>
          <p:nvPr/>
        </p:nvSpPr>
        <p:spPr>
          <a:xfrm>
            <a:off x="2222641" y="3545036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043DA878-1B59-41EB-8A4F-7DEBFF055A50}"/>
              </a:ext>
            </a:extLst>
          </p:cNvPr>
          <p:cNvSpPr txBox="1"/>
          <p:nvPr/>
        </p:nvSpPr>
        <p:spPr>
          <a:xfrm>
            <a:off x="2222641" y="309982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id="{F15A511B-4F84-41A5-B507-C1D01E750EFC}"/>
              </a:ext>
            </a:extLst>
          </p:cNvPr>
          <p:cNvSpPr txBox="1"/>
          <p:nvPr/>
        </p:nvSpPr>
        <p:spPr>
          <a:xfrm>
            <a:off x="2622645" y="200109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8.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id="{A69E9275-7638-40E9-A354-EF08DA1F46E7}"/>
              </a:ext>
            </a:extLst>
          </p:cNvPr>
          <p:cNvSpPr txBox="1"/>
          <p:nvPr/>
        </p:nvSpPr>
        <p:spPr>
          <a:xfrm>
            <a:off x="3012167" y="237181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3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182082F9-DF62-4970-B26A-664FDA545862}"/>
              </a:ext>
            </a:extLst>
          </p:cNvPr>
          <p:cNvSpPr txBox="1"/>
          <p:nvPr/>
        </p:nvSpPr>
        <p:spPr>
          <a:xfrm>
            <a:off x="3381426" y="233546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4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F54DB6A9-9E79-4886-B0D8-D19F9700E078}"/>
              </a:ext>
            </a:extLst>
          </p:cNvPr>
          <p:cNvSpPr txBox="1"/>
          <p:nvPr/>
        </p:nvSpPr>
        <p:spPr>
          <a:xfrm>
            <a:off x="2673587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4E9000D2-616A-48A7-93B5-8894290BA457}"/>
              </a:ext>
            </a:extLst>
          </p:cNvPr>
          <p:cNvSpPr txBox="1"/>
          <p:nvPr/>
        </p:nvSpPr>
        <p:spPr>
          <a:xfrm>
            <a:off x="3003121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B5601EA7-AA94-44BE-8483-C383B8C12B8B}"/>
              </a:ext>
            </a:extLst>
          </p:cNvPr>
          <p:cNvSpPr txBox="1"/>
          <p:nvPr/>
        </p:nvSpPr>
        <p:spPr>
          <a:xfrm>
            <a:off x="3385038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6BEB23B6-1A6C-4C47-8514-4ED4B321DEFE}"/>
              </a:ext>
            </a:extLst>
          </p:cNvPr>
          <p:cNvSpPr txBox="1"/>
          <p:nvPr/>
        </p:nvSpPr>
        <p:spPr>
          <a:xfrm>
            <a:off x="2222641" y="25631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15A747CE-38C8-4635-AC78-B85C7E21A12A}"/>
              </a:ext>
            </a:extLst>
          </p:cNvPr>
          <p:cNvSpPr txBox="1"/>
          <p:nvPr/>
        </p:nvSpPr>
        <p:spPr>
          <a:xfrm>
            <a:off x="2222641" y="20724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5">
            <a:extLst>
              <a:ext uri="{FF2B5EF4-FFF2-40B4-BE49-F238E27FC236}">
                <a16:creationId xmlns:a16="http://schemas.microsoft.com/office/drawing/2014/main" id="{4952997E-FA68-4F10-B963-F8F8F7DCD6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107601" y="3025727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46 Positive(%)</a:t>
            </a:r>
          </a:p>
        </p:txBody>
      </p:sp>
      <p:sp>
        <p:nvSpPr>
          <p:cNvPr id="145" name="TextBox 6">
            <a:extLst>
              <a:ext uri="{FF2B5EF4-FFF2-40B4-BE49-F238E27FC236}">
                <a16:creationId xmlns:a16="http://schemas.microsoft.com/office/drawing/2014/main" id="{D2BB7028-23BA-4A48-BBDC-CE3748A962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88842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39</a:t>
            </a:r>
          </a:p>
        </p:txBody>
      </p:sp>
      <p:sp>
        <p:nvSpPr>
          <p:cNvPr id="273" name="TextBox 7">
            <a:extLst>
              <a:ext uri="{FF2B5EF4-FFF2-40B4-BE49-F238E27FC236}">
                <a16:creationId xmlns:a16="http://schemas.microsoft.com/office/drawing/2014/main" id="{13AAE8D8-82C4-43F4-962B-B5485A7E20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32799" y="4457553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74" name="矩形 273">
            <a:extLst>
              <a:ext uri="{FF2B5EF4-FFF2-40B4-BE49-F238E27FC236}">
                <a16:creationId xmlns:a16="http://schemas.microsoft.com/office/drawing/2014/main" id="{D522435F-9E04-489E-B6BC-4AC7FF61F202}"/>
              </a:ext>
            </a:extLst>
          </p:cNvPr>
          <p:cNvSpPr/>
          <p:nvPr/>
        </p:nvSpPr>
        <p:spPr>
          <a:xfrm>
            <a:off x="12163512" y="445755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矩形 274">
            <a:extLst>
              <a:ext uri="{FF2B5EF4-FFF2-40B4-BE49-F238E27FC236}">
                <a16:creationId xmlns:a16="http://schemas.microsoft.com/office/drawing/2014/main" id="{16942CCA-C5CB-4976-9A95-4B942BC57000}"/>
              </a:ext>
            </a:extLst>
          </p:cNvPr>
          <p:cNvSpPr/>
          <p:nvPr/>
        </p:nvSpPr>
        <p:spPr>
          <a:xfrm>
            <a:off x="12493046" y="4457553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矩形 275">
            <a:extLst>
              <a:ext uri="{FF2B5EF4-FFF2-40B4-BE49-F238E27FC236}">
                <a16:creationId xmlns:a16="http://schemas.microsoft.com/office/drawing/2014/main" id="{05369460-A3CD-4FA7-B0B9-991C1CD03980}"/>
              </a:ext>
            </a:extLst>
          </p:cNvPr>
          <p:cNvSpPr/>
          <p:nvPr/>
        </p:nvSpPr>
        <p:spPr>
          <a:xfrm>
            <a:off x="12874963" y="4457553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8" name="对象 277">
            <a:extLst>
              <a:ext uri="{FF2B5EF4-FFF2-40B4-BE49-F238E27FC236}">
                <a16:creationId xmlns:a16="http://schemas.microsoft.com/office/drawing/2014/main" id="{4DD80E40-45D4-4A98-87CB-9342C4750C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6193576"/>
              </p:ext>
            </p:extLst>
          </p:nvPr>
        </p:nvGraphicFramePr>
        <p:xfrm>
          <a:off x="11850710" y="1982810"/>
          <a:ext cx="1635125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1" imgW="1637537" imgH="2540853" progId="Prism7.Document">
                  <p:embed/>
                </p:oleObj>
              </mc:Choice>
              <mc:Fallback>
                <p:oleObj name="Prism 7" r:id="rId21" imgW="1637537" imgH="2540853" progId="Prism7.Document">
                  <p:embed/>
                  <p:pic>
                    <p:nvPicPr>
                      <p:cNvPr id="278" name="对象 277">
                        <a:extLst>
                          <a:ext uri="{FF2B5EF4-FFF2-40B4-BE49-F238E27FC236}">
                            <a16:creationId xmlns:a16="http://schemas.microsoft.com/office/drawing/2014/main" id="{4DD80E40-45D4-4A98-87CB-9342C4750C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1850710" y="1982810"/>
                        <a:ext cx="1635125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2" name="文本框 281">
            <a:extLst>
              <a:ext uri="{FF2B5EF4-FFF2-40B4-BE49-F238E27FC236}">
                <a16:creationId xmlns:a16="http://schemas.microsoft.com/office/drawing/2014/main" id="{96AD8C9D-BDAB-44FC-894A-EE6E48F8EF0F}"/>
              </a:ext>
            </a:extLst>
          </p:cNvPr>
          <p:cNvSpPr txBox="1"/>
          <p:nvPr/>
        </p:nvSpPr>
        <p:spPr>
          <a:xfrm>
            <a:off x="12112567" y="2129681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7.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>
            <a:extLst>
              <a:ext uri="{FF2B5EF4-FFF2-40B4-BE49-F238E27FC236}">
                <a16:creationId xmlns:a16="http://schemas.microsoft.com/office/drawing/2014/main" id="{A116A7B0-0584-4CE1-9E87-71BFA00A53C5}"/>
              </a:ext>
            </a:extLst>
          </p:cNvPr>
          <p:cNvSpPr txBox="1"/>
          <p:nvPr/>
        </p:nvSpPr>
        <p:spPr>
          <a:xfrm>
            <a:off x="12502090" y="2729006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.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文本框 283">
            <a:extLst>
              <a:ext uri="{FF2B5EF4-FFF2-40B4-BE49-F238E27FC236}">
                <a16:creationId xmlns:a16="http://schemas.microsoft.com/office/drawing/2014/main" id="{A18DDA42-FD9E-405D-A2FE-0041352A2752}"/>
              </a:ext>
            </a:extLst>
          </p:cNvPr>
          <p:cNvSpPr txBox="1"/>
          <p:nvPr/>
        </p:nvSpPr>
        <p:spPr>
          <a:xfrm>
            <a:off x="12871349" y="3092706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2.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文本框 284">
            <a:extLst>
              <a:ext uri="{FF2B5EF4-FFF2-40B4-BE49-F238E27FC236}">
                <a16:creationId xmlns:a16="http://schemas.microsoft.com/office/drawing/2014/main" id="{1FCB6960-0318-4863-AB10-70EC83EBB7B2}"/>
              </a:ext>
            </a:extLst>
          </p:cNvPr>
          <p:cNvSpPr txBox="1"/>
          <p:nvPr/>
        </p:nvSpPr>
        <p:spPr>
          <a:xfrm>
            <a:off x="12163512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文本框 285">
            <a:extLst>
              <a:ext uri="{FF2B5EF4-FFF2-40B4-BE49-F238E27FC236}">
                <a16:creationId xmlns:a16="http://schemas.microsoft.com/office/drawing/2014/main" id="{A097EF94-E3FE-402F-974F-75DC04A93FE4}"/>
              </a:ext>
            </a:extLst>
          </p:cNvPr>
          <p:cNvSpPr txBox="1"/>
          <p:nvPr/>
        </p:nvSpPr>
        <p:spPr>
          <a:xfrm>
            <a:off x="12493046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文本框 286">
            <a:extLst>
              <a:ext uri="{FF2B5EF4-FFF2-40B4-BE49-F238E27FC236}">
                <a16:creationId xmlns:a16="http://schemas.microsoft.com/office/drawing/2014/main" id="{E0759C9D-6934-414D-8571-7FD8EB48134C}"/>
              </a:ext>
            </a:extLst>
          </p:cNvPr>
          <p:cNvSpPr txBox="1"/>
          <p:nvPr/>
        </p:nvSpPr>
        <p:spPr>
          <a:xfrm>
            <a:off x="12874963" y="422538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文本框 327">
            <a:extLst>
              <a:ext uri="{FF2B5EF4-FFF2-40B4-BE49-F238E27FC236}">
                <a16:creationId xmlns:a16="http://schemas.microsoft.com/office/drawing/2014/main" id="{3B1DB415-4BBE-4270-BD2A-30970825F9E6}"/>
              </a:ext>
            </a:extLst>
          </p:cNvPr>
          <p:cNvSpPr txBox="1"/>
          <p:nvPr/>
        </p:nvSpPr>
        <p:spPr>
          <a:xfrm>
            <a:off x="11863233" y="40623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文本框 328">
            <a:extLst>
              <a:ext uri="{FF2B5EF4-FFF2-40B4-BE49-F238E27FC236}">
                <a16:creationId xmlns:a16="http://schemas.microsoft.com/office/drawing/2014/main" id="{60CC7D34-C471-4D10-B133-91E6D9C133C8}"/>
              </a:ext>
            </a:extLst>
          </p:cNvPr>
          <p:cNvSpPr txBox="1"/>
          <p:nvPr/>
        </p:nvSpPr>
        <p:spPr>
          <a:xfrm>
            <a:off x="11778275" y="340496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文本框 329">
            <a:extLst>
              <a:ext uri="{FF2B5EF4-FFF2-40B4-BE49-F238E27FC236}">
                <a16:creationId xmlns:a16="http://schemas.microsoft.com/office/drawing/2014/main" id="{58B54919-115B-42D6-BD5D-10A6998B118D}"/>
              </a:ext>
            </a:extLst>
          </p:cNvPr>
          <p:cNvSpPr txBox="1"/>
          <p:nvPr/>
        </p:nvSpPr>
        <p:spPr>
          <a:xfrm>
            <a:off x="11778275" y="27580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文本框 330">
            <a:extLst>
              <a:ext uri="{FF2B5EF4-FFF2-40B4-BE49-F238E27FC236}">
                <a16:creationId xmlns:a16="http://schemas.microsoft.com/office/drawing/2014/main" id="{37C4E74D-8601-457C-932C-D279EA2A68F4}"/>
              </a:ext>
            </a:extLst>
          </p:cNvPr>
          <p:cNvSpPr txBox="1"/>
          <p:nvPr/>
        </p:nvSpPr>
        <p:spPr>
          <a:xfrm>
            <a:off x="11778275" y="21262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6">
            <a:extLst>
              <a:ext uri="{FF2B5EF4-FFF2-40B4-BE49-F238E27FC236}">
                <a16:creationId xmlns:a16="http://schemas.microsoft.com/office/drawing/2014/main" id="{5A5D5747-76DE-4011-AC2C-EB0C2EAF4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4731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727</a:t>
            </a:r>
          </a:p>
        </p:txBody>
      </p:sp>
      <p:graphicFrame>
        <p:nvGraphicFramePr>
          <p:cNvPr id="257" name="对象 256">
            <a:extLst>
              <a:ext uri="{FF2B5EF4-FFF2-40B4-BE49-F238E27FC236}">
                <a16:creationId xmlns:a16="http://schemas.microsoft.com/office/drawing/2014/main" id="{0E16BF54-A5EC-4AB2-ACFD-8A0CA633AE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9652467"/>
              </p:ext>
            </p:extLst>
          </p:nvPr>
        </p:nvGraphicFramePr>
        <p:xfrm>
          <a:off x="10023501" y="1981223"/>
          <a:ext cx="1635125" cy="271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3" imgW="1637537" imgH="2540853" progId="Prism7.Document">
                  <p:embed/>
                </p:oleObj>
              </mc:Choice>
              <mc:Fallback>
                <p:oleObj name="Prism 7" r:id="rId23" imgW="1637537" imgH="2540853" progId="Prism7.Document">
                  <p:embed/>
                  <p:pic>
                    <p:nvPicPr>
                      <p:cNvPr id="257" name="对象 256">
                        <a:extLst>
                          <a:ext uri="{FF2B5EF4-FFF2-40B4-BE49-F238E27FC236}">
                            <a16:creationId xmlns:a16="http://schemas.microsoft.com/office/drawing/2014/main" id="{0E16BF54-A5EC-4AB2-ACFD-8A0CA633AE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023501" y="1981223"/>
                        <a:ext cx="1635125" cy="2717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1" name="文本框 260">
            <a:extLst>
              <a:ext uri="{FF2B5EF4-FFF2-40B4-BE49-F238E27FC236}">
                <a16:creationId xmlns:a16="http://schemas.microsoft.com/office/drawing/2014/main" id="{3EDA9213-7E6C-42F6-BE49-77ED9E5DBBB4}"/>
              </a:ext>
            </a:extLst>
          </p:cNvPr>
          <p:cNvSpPr txBox="1"/>
          <p:nvPr/>
        </p:nvSpPr>
        <p:spPr>
          <a:xfrm>
            <a:off x="10384162" y="271022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文本框 261">
            <a:extLst>
              <a:ext uri="{FF2B5EF4-FFF2-40B4-BE49-F238E27FC236}">
                <a16:creationId xmlns:a16="http://schemas.microsoft.com/office/drawing/2014/main" id="{FE600461-99F6-48C5-B175-867BFD98B551}"/>
              </a:ext>
            </a:extLst>
          </p:cNvPr>
          <p:cNvSpPr txBox="1"/>
          <p:nvPr/>
        </p:nvSpPr>
        <p:spPr>
          <a:xfrm>
            <a:off x="10773684" y="263764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文本框 262">
            <a:extLst>
              <a:ext uri="{FF2B5EF4-FFF2-40B4-BE49-F238E27FC236}">
                <a16:creationId xmlns:a16="http://schemas.microsoft.com/office/drawing/2014/main" id="{AAA774B5-A1EF-4E8A-A956-3B9A54622650}"/>
              </a:ext>
            </a:extLst>
          </p:cNvPr>
          <p:cNvSpPr txBox="1"/>
          <p:nvPr/>
        </p:nvSpPr>
        <p:spPr>
          <a:xfrm>
            <a:off x="11142943" y="246738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.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7">
            <a:extLst>
              <a:ext uri="{FF2B5EF4-FFF2-40B4-BE49-F238E27FC236}">
                <a16:creationId xmlns:a16="http://schemas.microsoft.com/office/drawing/2014/main" id="{2AE4E6D8-FFAD-44B9-8A2C-A1FBCC3533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61913" y="4479269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65" name="矩形 264">
            <a:extLst>
              <a:ext uri="{FF2B5EF4-FFF2-40B4-BE49-F238E27FC236}">
                <a16:creationId xmlns:a16="http://schemas.microsoft.com/office/drawing/2014/main" id="{5B5CBB99-7AF0-4F7B-8A71-568656F78B72}"/>
              </a:ext>
            </a:extLst>
          </p:cNvPr>
          <p:cNvSpPr/>
          <p:nvPr/>
        </p:nvSpPr>
        <p:spPr>
          <a:xfrm>
            <a:off x="10392626" y="4479269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矩形 265">
            <a:extLst>
              <a:ext uri="{FF2B5EF4-FFF2-40B4-BE49-F238E27FC236}">
                <a16:creationId xmlns:a16="http://schemas.microsoft.com/office/drawing/2014/main" id="{B53DB36B-AB37-4020-8713-CE36287A35B3}"/>
              </a:ext>
            </a:extLst>
          </p:cNvPr>
          <p:cNvSpPr/>
          <p:nvPr/>
        </p:nvSpPr>
        <p:spPr>
          <a:xfrm>
            <a:off x="10722160" y="4479269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矩形 266">
            <a:extLst>
              <a:ext uri="{FF2B5EF4-FFF2-40B4-BE49-F238E27FC236}">
                <a16:creationId xmlns:a16="http://schemas.microsoft.com/office/drawing/2014/main" id="{D10859C6-2EE4-4B5A-9483-A9D338CE97FE}"/>
              </a:ext>
            </a:extLst>
          </p:cNvPr>
          <p:cNvSpPr/>
          <p:nvPr/>
        </p:nvSpPr>
        <p:spPr>
          <a:xfrm>
            <a:off x="11104077" y="4479269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文本框 267">
            <a:extLst>
              <a:ext uri="{FF2B5EF4-FFF2-40B4-BE49-F238E27FC236}">
                <a16:creationId xmlns:a16="http://schemas.microsoft.com/office/drawing/2014/main" id="{967EDEB0-72EA-4C9B-A48A-3104F5FF6552}"/>
              </a:ext>
            </a:extLst>
          </p:cNvPr>
          <p:cNvSpPr txBox="1"/>
          <p:nvPr/>
        </p:nvSpPr>
        <p:spPr>
          <a:xfrm>
            <a:off x="10392626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>
            <a:extLst>
              <a:ext uri="{FF2B5EF4-FFF2-40B4-BE49-F238E27FC236}">
                <a16:creationId xmlns:a16="http://schemas.microsoft.com/office/drawing/2014/main" id="{00A35AE1-66A1-485F-B71A-5C8AF01E39B8}"/>
              </a:ext>
            </a:extLst>
          </p:cNvPr>
          <p:cNvSpPr txBox="1"/>
          <p:nvPr/>
        </p:nvSpPr>
        <p:spPr>
          <a:xfrm>
            <a:off x="10722160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id="{E029735C-6E23-43F2-A8E4-CFC202B568EC}"/>
              </a:ext>
            </a:extLst>
          </p:cNvPr>
          <p:cNvSpPr txBox="1"/>
          <p:nvPr/>
        </p:nvSpPr>
        <p:spPr>
          <a:xfrm>
            <a:off x="11104077" y="424543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文本框 321">
            <a:extLst>
              <a:ext uri="{FF2B5EF4-FFF2-40B4-BE49-F238E27FC236}">
                <a16:creationId xmlns:a16="http://schemas.microsoft.com/office/drawing/2014/main" id="{664CB18E-E287-471E-A277-29FC5241C4DB}"/>
              </a:ext>
            </a:extLst>
          </p:cNvPr>
          <p:cNvSpPr txBox="1"/>
          <p:nvPr/>
        </p:nvSpPr>
        <p:spPr>
          <a:xfrm>
            <a:off x="10075370" y="405284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文本框 322">
            <a:extLst>
              <a:ext uri="{FF2B5EF4-FFF2-40B4-BE49-F238E27FC236}">
                <a16:creationId xmlns:a16="http://schemas.microsoft.com/office/drawing/2014/main" id="{C51D297A-7FED-4AD6-A22F-43A2B7E46B4D}"/>
              </a:ext>
            </a:extLst>
          </p:cNvPr>
          <p:cNvSpPr txBox="1"/>
          <p:nvPr/>
        </p:nvSpPr>
        <p:spPr>
          <a:xfrm>
            <a:off x="9990412" y="3659760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文本框 323">
            <a:extLst>
              <a:ext uri="{FF2B5EF4-FFF2-40B4-BE49-F238E27FC236}">
                <a16:creationId xmlns:a16="http://schemas.microsoft.com/office/drawing/2014/main" id="{26531851-277C-4315-864B-FFD314E13168}"/>
              </a:ext>
            </a:extLst>
          </p:cNvPr>
          <p:cNvSpPr txBox="1"/>
          <p:nvPr/>
        </p:nvSpPr>
        <p:spPr>
          <a:xfrm>
            <a:off x="10075371" y="3276112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文本框 324">
            <a:extLst>
              <a:ext uri="{FF2B5EF4-FFF2-40B4-BE49-F238E27FC236}">
                <a16:creationId xmlns:a16="http://schemas.microsoft.com/office/drawing/2014/main" id="{2F387DB2-58B4-45A6-95C6-EFE2878DC1CA}"/>
              </a:ext>
            </a:extLst>
          </p:cNvPr>
          <p:cNvSpPr txBox="1"/>
          <p:nvPr/>
        </p:nvSpPr>
        <p:spPr>
          <a:xfrm>
            <a:off x="10075371" y="2895919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文本框 325">
            <a:extLst>
              <a:ext uri="{FF2B5EF4-FFF2-40B4-BE49-F238E27FC236}">
                <a16:creationId xmlns:a16="http://schemas.microsoft.com/office/drawing/2014/main" id="{9147406C-C7C9-477A-87E7-D438AEC33875}"/>
              </a:ext>
            </a:extLst>
          </p:cNvPr>
          <p:cNvSpPr txBox="1"/>
          <p:nvPr/>
        </p:nvSpPr>
        <p:spPr>
          <a:xfrm>
            <a:off x="9990412" y="21100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文本框 326">
            <a:extLst>
              <a:ext uri="{FF2B5EF4-FFF2-40B4-BE49-F238E27FC236}">
                <a16:creationId xmlns:a16="http://schemas.microsoft.com/office/drawing/2014/main" id="{FD5BDAD5-AEC0-403E-B32E-A3FD96C17BAB}"/>
              </a:ext>
            </a:extLst>
          </p:cNvPr>
          <p:cNvSpPr txBox="1"/>
          <p:nvPr/>
        </p:nvSpPr>
        <p:spPr>
          <a:xfrm>
            <a:off x="10075371" y="2505380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6">
            <a:extLst>
              <a:ext uri="{FF2B5EF4-FFF2-40B4-BE49-F238E27FC236}">
                <a16:creationId xmlns:a16="http://schemas.microsoft.com/office/drawing/2014/main" id="{4CEE4A0A-0DAA-4E73-8508-6D5C4ED0BB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83659" y="1764660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42</a:t>
            </a:r>
          </a:p>
        </p:txBody>
      </p:sp>
      <p:graphicFrame>
        <p:nvGraphicFramePr>
          <p:cNvPr id="240" name="对象 239">
            <a:extLst>
              <a:ext uri="{FF2B5EF4-FFF2-40B4-BE49-F238E27FC236}">
                <a16:creationId xmlns:a16="http://schemas.microsoft.com/office/drawing/2014/main" id="{79EB2B05-8E67-4E63-B320-0F32765430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4703126"/>
              </p:ext>
            </p:extLst>
          </p:nvPr>
        </p:nvGraphicFramePr>
        <p:xfrm>
          <a:off x="8205813" y="1976461"/>
          <a:ext cx="1670050" cy="272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5" imgW="1672470" imgH="2546973" progId="Prism7.Document">
                  <p:embed/>
                </p:oleObj>
              </mc:Choice>
              <mc:Fallback>
                <p:oleObj name="Prism 7" r:id="rId25" imgW="1672470" imgH="2546973" progId="Prism7.Document">
                  <p:embed/>
                  <p:pic>
                    <p:nvPicPr>
                      <p:cNvPr id="240" name="对象 239">
                        <a:extLst>
                          <a:ext uri="{FF2B5EF4-FFF2-40B4-BE49-F238E27FC236}">
                            <a16:creationId xmlns:a16="http://schemas.microsoft.com/office/drawing/2014/main" id="{79EB2B05-8E67-4E63-B320-0F32765430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8205813" y="1976461"/>
                        <a:ext cx="1670050" cy="272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5" name="文本框 244">
            <a:extLst>
              <a:ext uri="{FF2B5EF4-FFF2-40B4-BE49-F238E27FC236}">
                <a16:creationId xmlns:a16="http://schemas.microsoft.com/office/drawing/2014/main" id="{A3092A5A-9F73-4C30-8E92-9632AEC03328}"/>
              </a:ext>
            </a:extLst>
          </p:cNvPr>
          <p:cNvSpPr txBox="1"/>
          <p:nvPr/>
        </p:nvSpPr>
        <p:spPr>
          <a:xfrm>
            <a:off x="8650446" y="39105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F744F014-3598-4162-8E03-AC0D86104A6C}"/>
              </a:ext>
            </a:extLst>
          </p:cNvPr>
          <p:cNvSpPr txBox="1"/>
          <p:nvPr/>
        </p:nvSpPr>
        <p:spPr>
          <a:xfrm>
            <a:off x="8933370" y="2659113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6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文本框 246">
            <a:extLst>
              <a:ext uri="{FF2B5EF4-FFF2-40B4-BE49-F238E27FC236}">
                <a16:creationId xmlns:a16="http://schemas.microsoft.com/office/drawing/2014/main" id="{7F070809-89A9-4AB4-B07F-379C2E076EAF}"/>
              </a:ext>
            </a:extLst>
          </p:cNvPr>
          <p:cNvSpPr txBox="1"/>
          <p:nvPr/>
        </p:nvSpPr>
        <p:spPr>
          <a:xfrm>
            <a:off x="9302629" y="2301332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8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7">
            <a:extLst>
              <a:ext uri="{FF2B5EF4-FFF2-40B4-BE49-F238E27FC236}">
                <a16:creationId xmlns:a16="http://schemas.microsoft.com/office/drawing/2014/main" id="{4F065928-647B-4227-81EA-D2F30CD0C0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64078" y="4479538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49" name="矩形 248">
            <a:extLst>
              <a:ext uri="{FF2B5EF4-FFF2-40B4-BE49-F238E27FC236}">
                <a16:creationId xmlns:a16="http://schemas.microsoft.com/office/drawing/2014/main" id="{B0DFABCD-B014-4D4B-8628-404BC87A83C6}"/>
              </a:ext>
            </a:extLst>
          </p:cNvPr>
          <p:cNvSpPr/>
          <p:nvPr/>
        </p:nvSpPr>
        <p:spPr>
          <a:xfrm>
            <a:off x="8594791" y="4479538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矩形 249">
            <a:extLst>
              <a:ext uri="{FF2B5EF4-FFF2-40B4-BE49-F238E27FC236}">
                <a16:creationId xmlns:a16="http://schemas.microsoft.com/office/drawing/2014/main" id="{03DB5FCF-BC49-4EB9-B7FB-F72BED5EE31D}"/>
              </a:ext>
            </a:extLst>
          </p:cNvPr>
          <p:cNvSpPr/>
          <p:nvPr/>
        </p:nvSpPr>
        <p:spPr>
          <a:xfrm>
            <a:off x="8924325" y="4479538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矩形 250">
            <a:extLst>
              <a:ext uri="{FF2B5EF4-FFF2-40B4-BE49-F238E27FC236}">
                <a16:creationId xmlns:a16="http://schemas.microsoft.com/office/drawing/2014/main" id="{60F8C56A-73E9-431C-A661-4990C1AA79EF}"/>
              </a:ext>
            </a:extLst>
          </p:cNvPr>
          <p:cNvSpPr/>
          <p:nvPr/>
        </p:nvSpPr>
        <p:spPr>
          <a:xfrm>
            <a:off x="9306242" y="4479538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id="{F2DBDAF9-45A6-43EF-B6DB-24BA426C56D3}"/>
              </a:ext>
            </a:extLst>
          </p:cNvPr>
          <p:cNvSpPr txBox="1"/>
          <p:nvPr/>
        </p:nvSpPr>
        <p:spPr>
          <a:xfrm>
            <a:off x="8594791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文本框 252">
            <a:extLst>
              <a:ext uri="{FF2B5EF4-FFF2-40B4-BE49-F238E27FC236}">
                <a16:creationId xmlns:a16="http://schemas.microsoft.com/office/drawing/2014/main" id="{80501259-3E14-4467-B101-AE396A48C685}"/>
              </a:ext>
            </a:extLst>
          </p:cNvPr>
          <p:cNvSpPr txBox="1"/>
          <p:nvPr/>
        </p:nvSpPr>
        <p:spPr>
          <a:xfrm>
            <a:off x="8924325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文本框 253">
            <a:extLst>
              <a:ext uri="{FF2B5EF4-FFF2-40B4-BE49-F238E27FC236}">
                <a16:creationId xmlns:a16="http://schemas.microsoft.com/office/drawing/2014/main" id="{082F8A64-6B19-409C-911C-91784013B908}"/>
              </a:ext>
            </a:extLst>
          </p:cNvPr>
          <p:cNvSpPr txBox="1"/>
          <p:nvPr/>
        </p:nvSpPr>
        <p:spPr>
          <a:xfrm>
            <a:off x="9306242" y="424870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文本框 315">
            <a:extLst>
              <a:ext uri="{FF2B5EF4-FFF2-40B4-BE49-F238E27FC236}">
                <a16:creationId xmlns:a16="http://schemas.microsoft.com/office/drawing/2014/main" id="{24AD8B63-6CAA-4242-AF87-31C879D94661}"/>
              </a:ext>
            </a:extLst>
          </p:cNvPr>
          <p:cNvSpPr txBox="1"/>
          <p:nvPr/>
        </p:nvSpPr>
        <p:spPr>
          <a:xfrm>
            <a:off x="8283656" y="40615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文本框 316">
            <a:extLst>
              <a:ext uri="{FF2B5EF4-FFF2-40B4-BE49-F238E27FC236}">
                <a16:creationId xmlns:a16="http://schemas.microsoft.com/office/drawing/2014/main" id="{1AC04FDA-8249-495B-9BB1-19A88C5B8620}"/>
              </a:ext>
            </a:extLst>
          </p:cNvPr>
          <p:cNvSpPr txBox="1"/>
          <p:nvPr/>
        </p:nvSpPr>
        <p:spPr>
          <a:xfrm>
            <a:off x="8070457" y="3667046"/>
            <a:ext cx="482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文本框 317">
            <a:extLst>
              <a:ext uri="{FF2B5EF4-FFF2-40B4-BE49-F238E27FC236}">
                <a16:creationId xmlns:a16="http://schemas.microsoft.com/office/drawing/2014/main" id="{1DBA1D0E-A261-47C1-AC20-AC2202D56ADB}"/>
              </a:ext>
            </a:extLst>
          </p:cNvPr>
          <p:cNvSpPr txBox="1"/>
          <p:nvPr/>
        </p:nvSpPr>
        <p:spPr>
          <a:xfrm>
            <a:off x="8155416" y="289827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文本框 318">
            <a:extLst>
              <a:ext uri="{FF2B5EF4-FFF2-40B4-BE49-F238E27FC236}">
                <a16:creationId xmlns:a16="http://schemas.microsoft.com/office/drawing/2014/main" id="{61DB8E32-67C3-4A8D-84DB-148CB8B617C6}"/>
              </a:ext>
            </a:extLst>
          </p:cNvPr>
          <p:cNvSpPr txBox="1"/>
          <p:nvPr/>
        </p:nvSpPr>
        <p:spPr>
          <a:xfrm>
            <a:off x="8155416" y="211914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文本框 319">
            <a:extLst>
              <a:ext uri="{FF2B5EF4-FFF2-40B4-BE49-F238E27FC236}">
                <a16:creationId xmlns:a16="http://schemas.microsoft.com/office/drawing/2014/main" id="{CB821DC3-459F-4DDC-B9CD-4BC09089C7BB}"/>
              </a:ext>
            </a:extLst>
          </p:cNvPr>
          <p:cNvSpPr txBox="1"/>
          <p:nvPr/>
        </p:nvSpPr>
        <p:spPr>
          <a:xfrm>
            <a:off x="8155416" y="25015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文本框 320">
            <a:extLst>
              <a:ext uri="{FF2B5EF4-FFF2-40B4-BE49-F238E27FC236}">
                <a16:creationId xmlns:a16="http://schemas.microsoft.com/office/drawing/2014/main" id="{322F6684-AE02-4ECA-BD73-6438D87D31DD}"/>
              </a:ext>
            </a:extLst>
          </p:cNvPr>
          <p:cNvSpPr txBox="1"/>
          <p:nvPr/>
        </p:nvSpPr>
        <p:spPr>
          <a:xfrm>
            <a:off x="8070457" y="3290802"/>
            <a:ext cx="482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id="{9729539B-6005-46C1-8D67-9A8CD3A4867F}"/>
              </a:ext>
            </a:extLst>
          </p:cNvPr>
          <p:cNvSpPr txBox="1"/>
          <p:nvPr/>
        </p:nvSpPr>
        <p:spPr>
          <a:xfrm>
            <a:off x="333364" y="77546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35E02598-6EE5-4975-BD66-B4430C194237}"/>
              </a:ext>
            </a:extLst>
          </p:cNvPr>
          <p:cNvGrpSpPr/>
          <p:nvPr/>
        </p:nvGrpSpPr>
        <p:grpSpPr>
          <a:xfrm>
            <a:off x="328547" y="1123255"/>
            <a:ext cx="13447494" cy="584775"/>
            <a:chOff x="328547" y="1237559"/>
            <a:chExt cx="13447494" cy="584775"/>
          </a:xfrm>
        </p:grpSpPr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F0126EBF-B1D9-4077-8C52-6271E565C117}"/>
                </a:ext>
              </a:extLst>
            </p:cNvPr>
            <p:cNvSpPr txBox="1"/>
            <p:nvPr/>
          </p:nvSpPr>
          <p:spPr>
            <a:xfrm>
              <a:off x="328547" y="1237559"/>
              <a:ext cx="179119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CCG-ALL-2015</a:t>
              </a:r>
            </a:p>
            <a:p>
              <a:pPr algn="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RD</a:t>
              </a:r>
            </a:p>
          </p:txBody>
        </p:sp>
        <p:sp>
          <p:nvSpPr>
            <p:cNvPr id="333" name="文本框 332">
              <a:extLst>
                <a:ext uri="{FF2B5EF4-FFF2-40B4-BE49-F238E27FC236}">
                  <a16:creationId xmlns:a16="http://schemas.microsoft.com/office/drawing/2014/main" id="{994F2042-3C46-48E4-B28C-9A1560853F4A}"/>
                </a:ext>
              </a:extLst>
            </p:cNvPr>
            <p:cNvSpPr txBox="1"/>
            <p:nvPr/>
          </p:nvSpPr>
          <p:spPr>
            <a:xfrm>
              <a:off x="2328863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1%</a:t>
              </a:r>
            </a:p>
          </p:txBody>
        </p:sp>
        <p:sp>
          <p:nvSpPr>
            <p:cNvPr id="334" name="文本框 333">
              <a:extLst>
                <a:ext uri="{FF2B5EF4-FFF2-40B4-BE49-F238E27FC236}">
                  <a16:creationId xmlns:a16="http://schemas.microsoft.com/office/drawing/2014/main" id="{9A92DB3D-98C8-4905-9450-B93208F33BC0}"/>
                </a:ext>
              </a:extLst>
            </p:cNvPr>
            <p:cNvSpPr txBox="1"/>
            <p:nvPr/>
          </p:nvSpPr>
          <p:spPr>
            <a:xfrm>
              <a:off x="4207344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0.1%,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&lt;1%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文本框 334">
              <a:extLst>
                <a:ext uri="{FF2B5EF4-FFF2-40B4-BE49-F238E27FC236}">
                  <a16:creationId xmlns:a16="http://schemas.microsoft.com/office/drawing/2014/main" id="{8084BB98-5127-4796-BB11-23F9FF5B4D0A}"/>
                </a:ext>
              </a:extLst>
            </p:cNvPr>
            <p:cNvSpPr txBox="1"/>
            <p:nvPr/>
          </p:nvSpPr>
          <p:spPr>
            <a:xfrm>
              <a:off x="6089396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0.01%,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&lt;0.1%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文本框 335">
              <a:extLst>
                <a:ext uri="{FF2B5EF4-FFF2-40B4-BE49-F238E27FC236}">
                  <a16:creationId xmlns:a16="http://schemas.microsoft.com/office/drawing/2014/main" id="{288CDEB0-BF5B-49E5-9E2A-1D8E4E936F89}"/>
                </a:ext>
              </a:extLst>
            </p:cNvPr>
            <p:cNvSpPr txBox="1"/>
            <p:nvPr/>
          </p:nvSpPr>
          <p:spPr>
            <a:xfrm>
              <a:off x="8341778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1%</a:t>
              </a:r>
            </a:p>
          </p:txBody>
        </p:sp>
        <p:sp>
          <p:nvSpPr>
            <p:cNvPr id="337" name="文本框 336">
              <a:extLst>
                <a:ext uri="{FF2B5EF4-FFF2-40B4-BE49-F238E27FC236}">
                  <a16:creationId xmlns:a16="http://schemas.microsoft.com/office/drawing/2014/main" id="{7B50FB1C-4426-436D-8C44-FD3436677A10}"/>
                </a:ext>
              </a:extLst>
            </p:cNvPr>
            <p:cNvSpPr txBox="1"/>
            <p:nvPr/>
          </p:nvSpPr>
          <p:spPr>
            <a:xfrm>
              <a:off x="10091663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0.1%,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&lt;1%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文本框 337">
              <a:extLst>
                <a:ext uri="{FF2B5EF4-FFF2-40B4-BE49-F238E27FC236}">
                  <a16:creationId xmlns:a16="http://schemas.microsoft.com/office/drawing/2014/main" id="{451680BE-AFB5-4A8F-AF3B-809A7A0ED8EE}"/>
                </a:ext>
              </a:extLst>
            </p:cNvPr>
            <p:cNvSpPr txBox="1"/>
            <p:nvPr/>
          </p:nvSpPr>
          <p:spPr>
            <a:xfrm>
              <a:off x="11930851" y="1484352"/>
              <a:ext cx="1845190" cy="33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&gt;=0.01%,</a:t>
              </a:r>
              <a:r>
                <a: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&lt;0.1%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9" name="文本框 338">
            <a:extLst>
              <a:ext uri="{FF2B5EF4-FFF2-40B4-BE49-F238E27FC236}">
                <a16:creationId xmlns:a16="http://schemas.microsoft.com/office/drawing/2014/main" id="{9C2E7013-DDB8-480B-820E-C5EA0A2B0CBE}"/>
              </a:ext>
            </a:extLst>
          </p:cNvPr>
          <p:cNvSpPr txBox="1"/>
          <p:nvPr/>
        </p:nvSpPr>
        <p:spPr>
          <a:xfrm>
            <a:off x="808507" y="1746306"/>
            <a:ext cx="1311231" cy="339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s3824662</a:t>
            </a:r>
          </a:p>
        </p:txBody>
      </p:sp>
      <p:sp>
        <p:nvSpPr>
          <p:cNvPr id="340" name="文本框 339">
            <a:extLst>
              <a:ext uri="{FF2B5EF4-FFF2-40B4-BE49-F238E27FC236}">
                <a16:creationId xmlns:a16="http://schemas.microsoft.com/office/drawing/2014/main" id="{C32A596B-1D39-4DB8-A9C3-58EA658BEF2D}"/>
              </a:ext>
            </a:extLst>
          </p:cNvPr>
          <p:cNvSpPr txBox="1"/>
          <p:nvPr/>
        </p:nvSpPr>
        <p:spPr>
          <a:xfrm>
            <a:off x="808507" y="5142061"/>
            <a:ext cx="1311231" cy="339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s3781093</a:t>
            </a:r>
          </a:p>
        </p:txBody>
      </p:sp>
    </p:spTree>
    <p:extLst>
      <p:ext uri="{BB962C8B-B14F-4D97-AF65-F5344CB8AC3E}">
        <p14:creationId xmlns:p14="http://schemas.microsoft.com/office/powerpoint/2010/main" val="3638699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5" name="对象 194">
            <a:extLst>
              <a:ext uri="{FF2B5EF4-FFF2-40B4-BE49-F238E27FC236}">
                <a16:creationId xmlns:a16="http://schemas.microsoft.com/office/drawing/2014/main" id="{C8C8E197-1F26-4396-BEA9-EF77B54015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6869191"/>
              </p:ext>
            </p:extLst>
          </p:nvPr>
        </p:nvGraphicFramePr>
        <p:xfrm>
          <a:off x="2224087" y="1746417"/>
          <a:ext cx="1712913" cy="2714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1715326" imgH="2540853" progId="Prism7.Document">
                  <p:embed/>
                </p:oleObj>
              </mc:Choice>
              <mc:Fallback>
                <p:oleObj name="Prism 7" r:id="rId3" imgW="1715326" imgH="2540853" progId="Prism7.Document">
                  <p:embed/>
                  <p:pic>
                    <p:nvPicPr>
                      <p:cNvPr id="195" name="对象 194">
                        <a:extLst>
                          <a:ext uri="{FF2B5EF4-FFF2-40B4-BE49-F238E27FC236}">
                            <a16:creationId xmlns:a16="http://schemas.microsoft.com/office/drawing/2014/main" id="{C8C8E197-1F26-4396-BEA9-EF77B54015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24087" y="1746417"/>
                        <a:ext cx="1712913" cy="2714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F9F659F8-7912-42D6-BCF3-6EA1EFB9B8D9}"/>
              </a:ext>
            </a:extLst>
          </p:cNvPr>
          <p:cNvSpPr txBox="1"/>
          <p:nvPr/>
        </p:nvSpPr>
        <p:spPr>
          <a:xfrm flipH="1">
            <a:off x="85781" y="124822"/>
            <a:ext cx="96909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sp>
        <p:nvSpPr>
          <p:cNvPr id="49" name="TextBox 5">
            <a:extLst>
              <a:ext uri="{FF2B5EF4-FFF2-40B4-BE49-F238E27FC236}">
                <a16:creationId xmlns:a16="http://schemas.microsoft.com/office/drawing/2014/main" id="{C13A9BB4-A6AF-49A3-B83A-A796A7716F3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03856" y="6136364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15 Positive(%)</a:t>
            </a:r>
          </a:p>
        </p:txBody>
      </p:sp>
      <p:sp>
        <p:nvSpPr>
          <p:cNvPr id="25" name="TextBox 6">
            <a:extLst>
              <a:ext uri="{FF2B5EF4-FFF2-40B4-BE49-F238E27FC236}">
                <a16:creationId xmlns:a16="http://schemas.microsoft.com/office/drawing/2014/main" id="{A5AAC7E9-D750-4782-A264-3D94BE0047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0150" y="4915667"/>
            <a:ext cx="1103836" cy="461665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39</a:t>
            </a:r>
          </a:p>
          <a:p>
            <a:pPr eaLnBrk="1" hangingPunct="1"/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26" name="对象 25">
            <a:extLst>
              <a:ext uri="{FF2B5EF4-FFF2-40B4-BE49-F238E27FC236}">
                <a16:creationId xmlns:a16="http://schemas.microsoft.com/office/drawing/2014/main" id="{8A781608-9265-461B-B5D1-0B9C81627C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7046958"/>
              </p:ext>
            </p:extLst>
          </p:nvPr>
        </p:nvGraphicFramePr>
        <p:xfrm>
          <a:off x="4027486" y="5083342"/>
          <a:ext cx="1712913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5" imgW="1715326" imgH="2540853" progId="Prism7.Document">
                  <p:embed/>
                </p:oleObj>
              </mc:Choice>
              <mc:Fallback>
                <p:oleObj name="Prism 7" r:id="rId5" imgW="1715326" imgH="2540853" progId="Prism7.Document">
                  <p:embed/>
                  <p:pic>
                    <p:nvPicPr>
                      <p:cNvPr id="26" name="对象 25">
                        <a:extLst>
                          <a:ext uri="{FF2B5EF4-FFF2-40B4-BE49-F238E27FC236}">
                            <a16:creationId xmlns:a16="http://schemas.microsoft.com/office/drawing/2014/main" id="{8A781608-9265-461B-B5D1-0B9C81627C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27486" y="5083342"/>
                        <a:ext cx="1712913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文本框 27">
            <a:extLst>
              <a:ext uri="{FF2B5EF4-FFF2-40B4-BE49-F238E27FC236}">
                <a16:creationId xmlns:a16="http://schemas.microsoft.com/office/drawing/2014/main" id="{5F5D79F2-5FAB-43B0-A8DA-A23C9AA81349}"/>
              </a:ext>
            </a:extLst>
          </p:cNvPr>
          <p:cNvSpPr txBox="1"/>
          <p:nvPr/>
        </p:nvSpPr>
        <p:spPr>
          <a:xfrm>
            <a:off x="4427275" y="5056442"/>
            <a:ext cx="515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ECD8A69-AE2D-4D66-9047-0B82B3FF5E2C}"/>
              </a:ext>
            </a:extLst>
          </p:cNvPr>
          <p:cNvSpPr txBox="1"/>
          <p:nvPr/>
        </p:nvSpPr>
        <p:spPr>
          <a:xfrm>
            <a:off x="4789965" y="5683087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8.3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46F45E7-4D53-4C88-8FFA-C70C08348F5E}"/>
              </a:ext>
            </a:extLst>
          </p:cNvPr>
          <p:cNvSpPr txBox="1"/>
          <p:nvPr/>
        </p:nvSpPr>
        <p:spPr>
          <a:xfrm>
            <a:off x="5152471" y="5498718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77.6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5" name="TextBox 7">
            <a:extLst>
              <a:ext uri="{FF2B5EF4-FFF2-40B4-BE49-F238E27FC236}">
                <a16:creationId xmlns:a16="http://schemas.microsoft.com/office/drawing/2014/main" id="{69EA84AF-7D47-4B5B-B0B1-B9D1CFA92B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0361" y="7580095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C9B4740-26C1-47AE-975E-5CB4D721E038}"/>
              </a:ext>
            </a:extLst>
          </p:cNvPr>
          <p:cNvSpPr txBox="1"/>
          <p:nvPr/>
        </p:nvSpPr>
        <p:spPr>
          <a:xfrm>
            <a:off x="4463313" y="734925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75BF59F8-0E90-4B18-BEA1-668070E955F7}"/>
              </a:ext>
            </a:extLst>
          </p:cNvPr>
          <p:cNvSpPr txBox="1"/>
          <p:nvPr/>
        </p:nvSpPr>
        <p:spPr>
          <a:xfrm>
            <a:off x="4759855" y="7349257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8EF02AE-0776-411F-82DA-F0F841ED64F1}"/>
              </a:ext>
            </a:extLst>
          </p:cNvPr>
          <p:cNvSpPr txBox="1"/>
          <p:nvPr/>
        </p:nvSpPr>
        <p:spPr>
          <a:xfrm>
            <a:off x="5196248" y="7349257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矩形 147">
            <a:extLst>
              <a:ext uri="{FF2B5EF4-FFF2-40B4-BE49-F238E27FC236}">
                <a16:creationId xmlns:a16="http://schemas.microsoft.com/office/drawing/2014/main" id="{8A828AEB-CCBD-48E2-B31F-F667B5DEFC63}"/>
              </a:ext>
            </a:extLst>
          </p:cNvPr>
          <p:cNvSpPr/>
          <p:nvPr/>
        </p:nvSpPr>
        <p:spPr>
          <a:xfrm>
            <a:off x="4513006" y="7580095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矩形 148">
            <a:extLst>
              <a:ext uri="{FF2B5EF4-FFF2-40B4-BE49-F238E27FC236}">
                <a16:creationId xmlns:a16="http://schemas.microsoft.com/office/drawing/2014/main" id="{EE35C927-060B-4445-A4E0-21977221071A}"/>
              </a:ext>
            </a:extLst>
          </p:cNvPr>
          <p:cNvSpPr/>
          <p:nvPr/>
        </p:nvSpPr>
        <p:spPr>
          <a:xfrm>
            <a:off x="4834584" y="758009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矩形 155">
            <a:extLst>
              <a:ext uri="{FF2B5EF4-FFF2-40B4-BE49-F238E27FC236}">
                <a16:creationId xmlns:a16="http://schemas.microsoft.com/office/drawing/2014/main" id="{D85DFF24-FCD6-410C-994F-55520B4CC009}"/>
              </a:ext>
            </a:extLst>
          </p:cNvPr>
          <p:cNvSpPr/>
          <p:nvPr/>
        </p:nvSpPr>
        <p:spPr>
          <a:xfrm>
            <a:off x="5213080" y="758009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6">
            <a:extLst>
              <a:ext uri="{FF2B5EF4-FFF2-40B4-BE49-F238E27FC236}">
                <a16:creationId xmlns:a16="http://schemas.microsoft.com/office/drawing/2014/main" id="{E20CCC44-CC82-4B5B-81A8-5435CBDF9B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9800" y="4915667"/>
            <a:ext cx="1002481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772</a:t>
            </a:r>
          </a:p>
        </p:txBody>
      </p:sp>
      <p:graphicFrame>
        <p:nvGraphicFramePr>
          <p:cNvPr id="117" name="对象 116">
            <a:extLst>
              <a:ext uri="{FF2B5EF4-FFF2-40B4-BE49-F238E27FC236}">
                <a16:creationId xmlns:a16="http://schemas.microsoft.com/office/drawing/2014/main" id="{D8CA78C3-D147-4170-B082-45B8B57D76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543073"/>
              </p:ext>
            </p:extLst>
          </p:nvPr>
        </p:nvGraphicFramePr>
        <p:xfrm>
          <a:off x="5853111" y="5083342"/>
          <a:ext cx="1712913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7" imgW="1715326" imgH="2540853" progId="Prism7.Document">
                  <p:embed/>
                </p:oleObj>
              </mc:Choice>
              <mc:Fallback>
                <p:oleObj name="Prism 7" r:id="rId7" imgW="1715326" imgH="2540853" progId="Prism7.Document">
                  <p:embed/>
                  <p:pic>
                    <p:nvPicPr>
                      <p:cNvPr id="117" name="对象 116">
                        <a:extLst>
                          <a:ext uri="{FF2B5EF4-FFF2-40B4-BE49-F238E27FC236}">
                            <a16:creationId xmlns:a16="http://schemas.microsoft.com/office/drawing/2014/main" id="{D8CA78C3-D147-4170-B082-45B8B57D76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853111" y="5083342"/>
                        <a:ext cx="1712913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9" name="文本框 118">
            <a:extLst>
              <a:ext uri="{FF2B5EF4-FFF2-40B4-BE49-F238E27FC236}">
                <a16:creationId xmlns:a16="http://schemas.microsoft.com/office/drawing/2014/main" id="{F8527CCF-3FDC-4FDF-B4D0-41FD4AC3778E}"/>
              </a:ext>
            </a:extLst>
          </p:cNvPr>
          <p:cNvSpPr txBox="1"/>
          <p:nvPr/>
        </p:nvSpPr>
        <p:spPr>
          <a:xfrm>
            <a:off x="6156270" y="5084229"/>
            <a:ext cx="699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B1B0A048-A56C-4979-8DBB-A00C7F60E133}"/>
              </a:ext>
            </a:extLst>
          </p:cNvPr>
          <p:cNvSpPr txBox="1"/>
          <p:nvPr/>
        </p:nvSpPr>
        <p:spPr>
          <a:xfrm>
            <a:off x="6617243" y="5594376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73.2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72A792BD-D32D-44DA-B44C-6B165E42B274}"/>
              </a:ext>
            </a:extLst>
          </p:cNvPr>
          <p:cNvSpPr txBox="1"/>
          <p:nvPr/>
        </p:nvSpPr>
        <p:spPr>
          <a:xfrm>
            <a:off x="6978884" y="5313856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87.8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6" name="TextBox 7">
            <a:extLst>
              <a:ext uri="{FF2B5EF4-FFF2-40B4-BE49-F238E27FC236}">
                <a16:creationId xmlns:a16="http://schemas.microsoft.com/office/drawing/2014/main" id="{E9FA394B-D960-4D60-8715-13F2AD4BE4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6774" y="7579826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17" name="文本框 216">
            <a:extLst>
              <a:ext uri="{FF2B5EF4-FFF2-40B4-BE49-F238E27FC236}">
                <a16:creationId xmlns:a16="http://schemas.microsoft.com/office/drawing/2014/main" id="{E7618AF3-68A3-47FE-A6F6-4D44144E5643}"/>
              </a:ext>
            </a:extLst>
          </p:cNvPr>
          <p:cNvSpPr txBox="1"/>
          <p:nvPr/>
        </p:nvSpPr>
        <p:spPr>
          <a:xfrm>
            <a:off x="6289726" y="734598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6FC1E160-9041-4660-88A0-59C772D9FB5C}"/>
              </a:ext>
            </a:extLst>
          </p:cNvPr>
          <p:cNvSpPr txBox="1"/>
          <p:nvPr/>
        </p:nvSpPr>
        <p:spPr>
          <a:xfrm>
            <a:off x="6586268" y="7345988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文本框 218">
            <a:extLst>
              <a:ext uri="{FF2B5EF4-FFF2-40B4-BE49-F238E27FC236}">
                <a16:creationId xmlns:a16="http://schemas.microsoft.com/office/drawing/2014/main" id="{A498C5A6-3552-41C8-AC04-7D0417B450ED}"/>
              </a:ext>
            </a:extLst>
          </p:cNvPr>
          <p:cNvSpPr txBox="1"/>
          <p:nvPr/>
        </p:nvSpPr>
        <p:spPr>
          <a:xfrm>
            <a:off x="7022661" y="7345988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>
            <a:extLst>
              <a:ext uri="{FF2B5EF4-FFF2-40B4-BE49-F238E27FC236}">
                <a16:creationId xmlns:a16="http://schemas.microsoft.com/office/drawing/2014/main" id="{AC69828E-BDFA-43FE-A79E-7ACEA0C32176}"/>
              </a:ext>
            </a:extLst>
          </p:cNvPr>
          <p:cNvSpPr/>
          <p:nvPr/>
        </p:nvSpPr>
        <p:spPr>
          <a:xfrm>
            <a:off x="6289726" y="757982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矩形 157">
            <a:extLst>
              <a:ext uri="{FF2B5EF4-FFF2-40B4-BE49-F238E27FC236}">
                <a16:creationId xmlns:a16="http://schemas.microsoft.com/office/drawing/2014/main" id="{7D3A46FE-0964-4C3E-885B-0688E591C5B9}"/>
              </a:ext>
            </a:extLst>
          </p:cNvPr>
          <p:cNvSpPr/>
          <p:nvPr/>
        </p:nvSpPr>
        <p:spPr>
          <a:xfrm>
            <a:off x="6611304" y="7579826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矩形 158">
            <a:extLst>
              <a:ext uri="{FF2B5EF4-FFF2-40B4-BE49-F238E27FC236}">
                <a16:creationId xmlns:a16="http://schemas.microsoft.com/office/drawing/2014/main" id="{DA679184-D13F-4A57-8717-CCB4C3A1E63E}"/>
              </a:ext>
            </a:extLst>
          </p:cNvPr>
          <p:cNvSpPr/>
          <p:nvPr/>
        </p:nvSpPr>
        <p:spPr>
          <a:xfrm>
            <a:off x="6989800" y="7579826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6">
            <a:extLst>
              <a:ext uri="{FF2B5EF4-FFF2-40B4-BE49-F238E27FC236}">
                <a16:creationId xmlns:a16="http://schemas.microsoft.com/office/drawing/2014/main" id="{36C69FE5-6C4C-4676-B6E0-F1D9D2099D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8917" y="4915667"/>
            <a:ext cx="1071290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57</a:t>
            </a:r>
          </a:p>
        </p:txBody>
      </p:sp>
      <p:graphicFrame>
        <p:nvGraphicFramePr>
          <p:cNvPr id="134" name="对象 133">
            <a:extLst>
              <a:ext uri="{FF2B5EF4-FFF2-40B4-BE49-F238E27FC236}">
                <a16:creationId xmlns:a16="http://schemas.microsoft.com/office/drawing/2014/main" id="{2666294E-E524-404E-AC45-BAD330729B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7280149"/>
              </p:ext>
            </p:extLst>
          </p:nvPr>
        </p:nvGraphicFramePr>
        <p:xfrm>
          <a:off x="2224088" y="5080167"/>
          <a:ext cx="1712912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9" imgW="1715326" imgH="2540853" progId="Prism7.Document">
                  <p:embed/>
                </p:oleObj>
              </mc:Choice>
              <mc:Fallback>
                <p:oleObj name="Prism 7" r:id="rId9" imgW="1715326" imgH="2540853" progId="Prism7.Document">
                  <p:embed/>
                  <p:pic>
                    <p:nvPicPr>
                      <p:cNvPr id="134" name="对象 133">
                        <a:extLst>
                          <a:ext uri="{FF2B5EF4-FFF2-40B4-BE49-F238E27FC236}">
                            <a16:creationId xmlns:a16="http://schemas.microsoft.com/office/drawing/2014/main" id="{2666294E-E524-404E-AC45-BAD330729B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24088" y="5080167"/>
                        <a:ext cx="1712912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6" name="文本框 135">
            <a:extLst>
              <a:ext uri="{FF2B5EF4-FFF2-40B4-BE49-F238E27FC236}">
                <a16:creationId xmlns:a16="http://schemas.microsoft.com/office/drawing/2014/main" id="{B7A09CF5-3A24-43DB-99E6-E0394A3AC952}"/>
              </a:ext>
            </a:extLst>
          </p:cNvPr>
          <p:cNvSpPr txBox="1"/>
          <p:nvPr/>
        </p:nvSpPr>
        <p:spPr>
          <a:xfrm>
            <a:off x="2595292" y="5288803"/>
            <a:ext cx="543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88.9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593AAA15-011C-463D-9FA1-491F4E4635D4}"/>
              </a:ext>
            </a:extLst>
          </p:cNvPr>
          <p:cNvSpPr txBox="1"/>
          <p:nvPr/>
        </p:nvSpPr>
        <p:spPr>
          <a:xfrm>
            <a:off x="3001760" y="5917914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6.1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542ED6E7-32B6-486C-8B6D-0896ACCA0BD8}"/>
              </a:ext>
            </a:extLst>
          </p:cNvPr>
          <p:cNvSpPr txBox="1"/>
          <p:nvPr/>
        </p:nvSpPr>
        <p:spPr>
          <a:xfrm>
            <a:off x="3426173" y="60420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TextBox 7">
            <a:extLst>
              <a:ext uri="{FF2B5EF4-FFF2-40B4-BE49-F238E27FC236}">
                <a16:creationId xmlns:a16="http://schemas.microsoft.com/office/drawing/2014/main" id="{B2AE6002-D453-45E9-BF65-BDDDB63920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2666" y="7562873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20" name="文本框 219">
            <a:extLst>
              <a:ext uri="{FF2B5EF4-FFF2-40B4-BE49-F238E27FC236}">
                <a16:creationId xmlns:a16="http://schemas.microsoft.com/office/drawing/2014/main" id="{51BC41D6-F9AB-4658-8E2D-FC413FC29123}"/>
              </a:ext>
            </a:extLst>
          </p:cNvPr>
          <p:cNvSpPr txBox="1"/>
          <p:nvPr/>
        </p:nvSpPr>
        <p:spPr>
          <a:xfrm>
            <a:off x="2645618" y="733070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文本框 220">
            <a:extLst>
              <a:ext uri="{FF2B5EF4-FFF2-40B4-BE49-F238E27FC236}">
                <a16:creationId xmlns:a16="http://schemas.microsoft.com/office/drawing/2014/main" id="{3846F88F-8060-4506-8304-4F000FA704BA}"/>
              </a:ext>
            </a:extLst>
          </p:cNvPr>
          <p:cNvSpPr txBox="1"/>
          <p:nvPr/>
        </p:nvSpPr>
        <p:spPr>
          <a:xfrm>
            <a:off x="2942160" y="7330706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54BDCC1C-A825-46B2-9DCA-FAA37CC4A526}"/>
              </a:ext>
            </a:extLst>
          </p:cNvPr>
          <p:cNvSpPr txBox="1"/>
          <p:nvPr/>
        </p:nvSpPr>
        <p:spPr>
          <a:xfrm>
            <a:off x="3378553" y="7330706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矩形 159">
            <a:extLst>
              <a:ext uri="{FF2B5EF4-FFF2-40B4-BE49-F238E27FC236}">
                <a16:creationId xmlns:a16="http://schemas.microsoft.com/office/drawing/2014/main" id="{89D573D1-8EC5-4ECF-90F3-D83E9F6F2875}"/>
              </a:ext>
            </a:extLst>
          </p:cNvPr>
          <p:cNvSpPr/>
          <p:nvPr/>
        </p:nvSpPr>
        <p:spPr>
          <a:xfrm>
            <a:off x="2695311" y="7562873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矩形 160">
            <a:extLst>
              <a:ext uri="{FF2B5EF4-FFF2-40B4-BE49-F238E27FC236}">
                <a16:creationId xmlns:a16="http://schemas.microsoft.com/office/drawing/2014/main" id="{E1A0162B-04C7-42D7-8371-16CAC2B0EE52}"/>
              </a:ext>
            </a:extLst>
          </p:cNvPr>
          <p:cNvSpPr/>
          <p:nvPr/>
        </p:nvSpPr>
        <p:spPr>
          <a:xfrm>
            <a:off x="3016889" y="756287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矩形 161">
            <a:extLst>
              <a:ext uri="{FF2B5EF4-FFF2-40B4-BE49-F238E27FC236}">
                <a16:creationId xmlns:a16="http://schemas.microsoft.com/office/drawing/2014/main" id="{92F45C4A-33D0-472B-8143-C658682206AB}"/>
              </a:ext>
            </a:extLst>
          </p:cNvPr>
          <p:cNvSpPr/>
          <p:nvPr/>
        </p:nvSpPr>
        <p:spPr>
          <a:xfrm>
            <a:off x="3395385" y="756287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5">
            <a:extLst>
              <a:ext uri="{FF2B5EF4-FFF2-40B4-BE49-F238E27FC236}">
                <a16:creationId xmlns:a16="http://schemas.microsoft.com/office/drawing/2014/main" id="{17239443-8189-46D3-A2A7-B954D6D6198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247302" y="6136364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33 Positive(%)</a:t>
            </a:r>
          </a:p>
        </p:txBody>
      </p:sp>
      <p:sp>
        <p:nvSpPr>
          <p:cNvPr id="163" name="TextBox 6">
            <a:extLst>
              <a:ext uri="{FF2B5EF4-FFF2-40B4-BE49-F238E27FC236}">
                <a16:creationId xmlns:a16="http://schemas.microsoft.com/office/drawing/2014/main" id="{3C9FDFC0-6928-434A-86D0-389148E006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88842" y="4915667"/>
            <a:ext cx="1169634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22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170" name="对象 169">
            <a:extLst>
              <a:ext uri="{FF2B5EF4-FFF2-40B4-BE49-F238E27FC236}">
                <a16:creationId xmlns:a16="http://schemas.microsoft.com/office/drawing/2014/main" id="{C17BAEE5-91FD-4674-8C1B-2118FCDD0B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8925273"/>
              </p:ext>
            </p:extLst>
          </p:nvPr>
        </p:nvGraphicFramePr>
        <p:xfrm>
          <a:off x="11726860" y="5083342"/>
          <a:ext cx="1712912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1" imgW="1715326" imgH="2540853" progId="Prism7.Document">
                  <p:embed/>
                </p:oleObj>
              </mc:Choice>
              <mc:Fallback>
                <p:oleObj name="Prism 7" r:id="rId11" imgW="1715326" imgH="2540853" progId="Prism7.Document">
                  <p:embed/>
                  <p:pic>
                    <p:nvPicPr>
                      <p:cNvPr id="170" name="对象 169">
                        <a:extLst>
                          <a:ext uri="{FF2B5EF4-FFF2-40B4-BE49-F238E27FC236}">
                            <a16:creationId xmlns:a16="http://schemas.microsoft.com/office/drawing/2014/main" id="{C17BAEE5-91FD-4674-8C1B-2118FCDD0B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1726860" y="5083342"/>
                        <a:ext cx="1712912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" name="文本框 171">
            <a:extLst>
              <a:ext uri="{FF2B5EF4-FFF2-40B4-BE49-F238E27FC236}">
                <a16:creationId xmlns:a16="http://schemas.microsoft.com/office/drawing/2014/main" id="{2955941A-094A-4720-AEA9-1E54D1C8A7E6}"/>
              </a:ext>
            </a:extLst>
          </p:cNvPr>
          <p:cNvSpPr txBox="1"/>
          <p:nvPr/>
        </p:nvSpPr>
        <p:spPr>
          <a:xfrm>
            <a:off x="12093774" y="5445968"/>
            <a:ext cx="543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E6D62E16-29D7-42F7-84DB-2DBFE6D47152}"/>
              </a:ext>
            </a:extLst>
          </p:cNvPr>
          <p:cNvSpPr txBox="1"/>
          <p:nvPr/>
        </p:nvSpPr>
        <p:spPr>
          <a:xfrm>
            <a:off x="12564361" y="62608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8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32BA7F46-CE29-4DFF-BD9B-0EB3A6CE4B29}"/>
              </a:ext>
            </a:extLst>
          </p:cNvPr>
          <p:cNvSpPr txBox="1"/>
          <p:nvPr/>
        </p:nvSpPr>
        <p:spPr>
          <a:xfrm>
            <a:off x="12860534" y="6370649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2.3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79" name="TextBox 7">
            <a:extLst>
              <a:ext uri="{FF2B5EF4-FFF2-40B4-BE49-F238E27FC236}">
                <a16:creationId xmlns:a16="http://schemas.microsoft.com/office/drawing/2014/main" id="{54B6C4AF-B68F-4E63-8A81-4679DB46C7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4500" y="7562873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58C999AF-C62F-4EF2-B8D9-9E12E7DFB6CD}"/>
              </a:ext>
            </a:extLst>
          </p:cNvPr>
          <p:cNvSpPr txBox="1"/>
          <p:nvPr/>
        </p:nvSpPr>
        <p:spPr>
          <a:xfrm>
            <a:off x="12277452" y="733070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0608FE65-EDE6-4828-9FBC-40CA21176276}"/>
              </a:ext>
            </a:extLst>
          </p:cNvPr>
          <p:cNvSpPr txBox="1"/>
          <p:nvPr/>
        </p:nvSpPr>
        <p:spPr>
          <a:xfrm>
            <a:off x="12573994" y="7330706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0CD1F52C-2C99-4600-AF1E-E0557CFD6ABC}"/>
              </a:ext>
            </a:extLst>
          </p:cNvPr>
          <p:cNvSpPr txBox="1"/>
          <p:nvPr/>
        </p:nvSpPr>
        <p:spPr>
          <a:xfrm>
            <a:off x="13010387" y="7330706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矩形 182">
            <a:extLst>
              <a:ext uri="{FF2B5EF4-FFF2-40B4-BE49-F238E27FC236}">
                <a16:creationId xmlns:a16="http://schemas.microsoft.com/office/drawing/2014/main" id="{01262261-7252-4EEA-B45C-C566C401597F}"/>
              </a:ext>
            </a:extLst>
          </p:cNvPr>
          <p:cNvSpPr/>
          <p:nvPr/>
        </p:nvSpPr>
        <p:spPr>
          <a:xfrm>
            <a:off x="12277452" y="756287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矩形 183">
            <a:extLst>
              <a:ext uri="{FF2B5EF4-FFF2-40B4-BE49-F238E27FC236}">
                <a16:creationId xmlns:a16="http://schemas.microsoft.com/office/drawing/2014/main" id="{24C99CAE-4C36-4E1C-A1EC-B82B469EB742}"/>
              </a:ext>
            </a:extLst>
          </p:cNvPr>
          <p:cNvSpPr/>
          <p:nvPr/>
        </p:nvSpPr>
        <p:spPr>
          <a:xfrm>
            <a:off x="12648723" y="756287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id="{63A8FC40-519D-4AB4-A241-226947FC3C6A}"/>
              </a:ext>
            </a:extLst>
          </p:cNvPr>
          <p:cNvSpPr/>
          <p:nvPr/>
        </p:nvSpPr>
        <p:spPr>
          <a:xfrm>
            <a:off x="13027219" y="7562873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6">
            <a:extLst>
              <a:ext uri="{FF2B5EF4-FFF2-40B4-BE49-F238E27FC236}">
                <a16:creationId xmlns:a16="http://schemas.microsoft.com/office/drawing/2014/main" id="{13ECCEB0-827C-43E2-A290-EC756BB087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4731" y="4915667"/>
            <a:ext cx="1169634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27</a:t>
            </a:r>
          </a:p>
        </p:txBody>
      </p:sp>
      <p:graphicFrame>
        <p:nvGraphicFramePr>
          <p:cNvPr id="186" name="对象 185">
            <a:extLst>
              <a:ext uri="{FF2B5EF4-FFF2-40B4-BE49-F238E27FC236}">
                <a16:creationId xmlns:a16="http://schemas.microsoft.com/office/drawing/2014/main" id="{C1FC6736-E311-4859-9A38-65EAC4DF0E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4692005"/>
              </p:ext>
            </p:extLst>
          </p:nvPr>
        </p:nvGraphicFramePr>
        <p:xfrm>
          <a:off x="10066365" y="5086543"/>
          <a:ext cx="1635125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3" imgW="1637537" imgH="2540853" progId="Prism7.Document">
                  <p:embed/>
                </p:oleObj>
              </mc:Choice>
              <mc:Fallback>
                <p:oleObj name="Prism 7" r:id="rId13" imgW="1637537" imgH="2540853" progId="Prism7.Document">
                  <p:embed/>
                  <p:pic>
                    <p:nvPicPr>
                      <p:cNvPr id="186" name="对象 185">
                        <a:extLst>
                          <a:ext uri="{FF2B5EF4-FFF2-40B4-BE49-F238E27FC236}">
                            <a16:creationId xmlns:a16="http://schemas.microsoft.com/office/drawing/2014/main" id="{C1FC6736-E311-4859-9A38-65EAC4DF0E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066365" y="5086543"/>
                        <a:ext cx="1635125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7" name="文本框 186">
            <a:extLst>
              <a:ext uri="{FF2B5EF4-FFF2-40B4-BE49-F238E27FC236}">
                <a16:creationId xmlns:a16="http://schemas.microsoft.com/office/drawing/2014/main" id="{99FFCBDC-3487-4C45-A188-5C28B6C972E8}"/>
              </a:ext>
            </a:extLst>
          </p:cNvPr>
          <p:cNvSpPr txBox="1"/>
          <p:nvPr/>
        </p:nvSpPr>
        <p:spPr>
          <a:xfrm>
            <a:off x="10308509" y="5398563"/>
            <a:ext cx="699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0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A4D3C8C4-C544-42D2-B397-44AA3CD3E7CE}"/>
              </a:ext>
            </a:extLst>
          </p:cNvPr>
          <p:cNvSpPr txBox="1"/>
          <p:nvPr/>
        </p:nvSpPr>
        <p:spPr>
          <a:xfrm>
            <a:off x="10833604" y="57801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8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7139A97C-82A9-4742-B3FE-AD27C8D7EFD3}"/>
              </a:ext>
            </a:extLst>
          </p:cNvPr>
          <p:cNvSpPr txBox="1"/>
          <p:nvPr/>
        </p:nvSpPr>
        <p:spPr>
          <a:xfrm>
            <a:off x="11131124" y="6385428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9.4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90" name="TextBox 7">
            <a:extLst>
              <a:ext uri="{FF2B5EF4-FFF2-40B4-BE49-F238E27FC236}">
                <a16:creationId xmlns:a16="http://schemas.microsoft.com/office/drawing/2014/main" id="{A60DDC82-2E00-4350-9F6A-DB60381F9F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6637" y="7579826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A479D848-3030-4A20-84D2-27619C1045D3}"/>
              </a:ext>
            </a:extLst>
          </p:cNvPr>
          <p:cNvSpPr txBox="1"/>
          <p:nvPr/>
        </p:nvSpPr>
        <p:spPr>
          <a:xfrm>
            <a:off x="10489589" y="734598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D75CDE43-CEBC-46EA-842A-84C1A84CA159}"/>
              </a:ext>
            </a:extLst>
          </p:cNvPr>
          <p:cNvSpPr txBox="1"/>
          <p:nvPr/>
        </p:nvSpPr>
        <p:spPr>
          <a:xfrm>
            <a:off x="10786131" y="7345988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5A77B359-CF9E-416A-AA05-74B80A7C951C}"/>
              </a:ext>
            </a:extLst>
          </p:cNvPr>
          <p:cNvSpPr txBox="1"/>
          <p:nvPr/>
        </p:nvSpPr>
        <p:spPr>
          <a:xfrm>
            <a:off x="11222524" y="7345988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矩形 212">
            <a:extLst>
              <a:ext uri="{FF2B5EF4-FFF2-40B4-BE49-F238E27FC236}">
                <a16:creationId xmlns:a16="http://schemas.microsoft.com/office/drawing/2014/main" id="{81132986-3C91-48FE-B9C9-9A0FDB376519}"/>
              </a:ext>
            </a:extLst>
          </p:cNvPr>
          <p:cNvSpPr/>
          <p:nvPr/>
        </p:nvSpPr>
        <p:spPr>
          <a:xfrm>
            <a:off x="10489589" y="757982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矩形 215">
            <a:extLst>
              <a:ext uri="{FF2B5EF4-FFF2-40B4-BE49-F238E27FC236}">
                <a16:creationId xmlns:a16="http://schemas.microsoft.com/office/drawing/2014/main" id="{4C9F8657-6FEA-418E-A7CA-8FC06A640D0E}"/>
              </a:ext>
            </a:extLst>
          </p:cNvPr>
          <p:cNvSpPr/>
          <p:nvPr/>
        </p:nvSpPr>
        <p:spPr>
          <a:xfrm>
            <a:off x="10860860" y="757982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矩形 222">
            <a:extLst>
              <a:ext uri="{FF2B5EF4-FFF2-40B4-BE49-F238E27FC236}">
                <a16:creationId xmlns:a16="http://schemas.microsoft.com/office/drawing/2014/main" id="{FD01ADAE-65AB-44BE-8363-91E4B6F6D876}"/>
              </a:ext>
            </a:extLst>
          </p:cNvPr>
          <p:cNvSpPr/>
          <p:nvPr/>
        </p:nvSpPr>
        <p:spPr>
          <a:xfrm>
            <a:off x="11239356" y="757982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6">
            <a:extLst>
              <a:ext uri="{FF2B5EF4-FFF2-40B4-BE49-F238E27FC236}">
                <a16:creationId xmlns:a16="http://schemas.microsoft.com/office/drawing/2014/main" id="{24ABFBC6-5F9B-4968-BC06-2A2A501A13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83659" y="4915667"/>
            <a:ext cx="1157336" cy="461665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11</a:t>
            </a:r>
          </a:p>
          <a:p>
            <a:pPr eaLnBrk="1" hangingPunct="1"/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224" name="对象 223">
            <a:extLst>
              <a:ext uri="{FF2B5EF4-FFF2-40B4-BE49-F238E27FC236}">
                <a16:creationId xmlns:a16="http://schemas.microsoft.com/office/drawing/2014/main" id="{EBF9BF84-E6B8-464A-9885-4857BBFB26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9154312"/>
              </p:ext>
            </p:extLst>
          </p:nvPr>
        </p:nvGraphicFramePr>
        <p:xfrm>
          <a:off x="8312150" y="5084930"/>
          <a:ext cx="1630363" cy="272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5" imgW="1634296" imgH="2546973" progId="Prism7.Document">
                  <p:embed/>
                </p:oleObj>
              </mc:Choice>
              <mc:Fallback>
                <p:oleObj name="Prism 7" r:id="rId15" imgW="1634296" imgH="2546973" progId="Prism7.Document">
                  <p:embed/>
                  <p:pic>
                    <p:nvPicPr>
                      <p:cNvPr id="224" name="对象 223">
                        <a:extLst>
                          <a:ext uri="{FF2B5EF4-FFF2-40B4-BE49-F238E27FC236}">
                            <a16:creationId xmlns:a16="http://schemas.microsoft.com/office/drawing/2014/main" id="{EBF9BF84-E6B8-464A-9885-4857BBFB26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312150" y="5084930"/>
                        <a:ext cx="1630363" cy="272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6" name="文本框 225">
            <a:extLst>
              <a:ext uri="{FF2B5EF4-FFF2-40B4-BE49-F238E27FC236}">
                <a16:creationId xmlns:a16="http://schemas.microsoft.com/office/drawing/2014/main" id="{A8988B0F-A273-491A-9F82-23B992F8E137}"/>
              </a:ext>
            </a:extLst>
          </p:cNvPr>
          <p:cNvSpPr txBox="1"/>
          <p:nvPr/>
        </p:nvSpPr>
        <p:spPr>
          <a:xfrm>
            <a:off x="8564283" y="6028003"/>
            <a:ext cx="515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id="{FFC1082C-7588-43D0-BDD9-79636D4B12F5}"/>
              </a:ext>
            </a:extLst>
          </p:cNvPr>
          <p:cNvSpPr txBox="1"/>
          <p:nvPr/>
        </p:nvSpPr>
        <p:spPr>
          <a:xfrm>
            <a:off x="9019672" y="52687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8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id="{8D204BF5-0802-4AC0-870F-23756DD908F9}"/>
              </a:ext>
            </a:extLst>
          </p:cNvPr>
          <p:cNvSpPr txBox="1"/>
          <p:nvPr/>
        </p:nvSpPr>
        <p:spPr>
          <a:xfrm>
            <a:off x="9323763" y="5898781"/>
            <a:ext cx="471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1.3</a:t>
            </a:r>
            <a:endParaRPr lang="zh-CN" altLang="en-US" sz="120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29" name="TextBox 7">
            <a:extLst>
              <a:ext uri="{FF2B5EF4-FFF2-40B4-BE49-F238E27FC236}">
                <a16:creationId xmlns:a16="http://schemas.microsoft.com/office/drawing/2014/main" id="{B3875A2B-7CCF-4870-B9E8-3CDF4E7A87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7692" y="7580095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id="{824B831B-A802-4AB5-B055-DBC836AB64E2}"/>
              </a:ext>
            </a:extLst>
          </p:cNvPr>
          <p:cNvSpPr txBox="1"/>
          <p:nvPr/>
        </p:nvSpPr>
        <p:spPr>
          <a:xfrm>
            <a:off x="8660644" y="734925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id="{3E89A4BC-A4C0-4A66-9AC7-31FBD39FF135}"/>
              </a:ext>
            </a:extLst>
          </p:cNvPr>
          <p:cNvSpPr txBox="1"/>
          <p:nvPr/>
        </p:nvSpPr>
        <p:spPr>
          <a:xfrm>
            <a:off x="8957186" y="7349257"/>
            <a:ext cx="532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id="{01431A97-480E-4A6D-98B5-12814717BB94}"/>
              </a:ext>
            </a:extLst>
          </p:cNvPr>
          <p:cNvSpPr txBox="1"/>
          <p:nvPr/>
        </p:nvSpPr>
        <p:spPr>
          <a:xfrm>
            <a:off x="9393579" y="7349257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/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矩形 236">
            <a:extLst>
              <a:ext uri="{FF2B5EF4-FFF2-40B4-BE49-F238E27FC236}">
                <a16:creationId xmlns:a16="http://schemas.microsoft.com/office/drawing/2014/main" id="{5FF09CAD-853A-4632-9D24-68F15322A5C4}"/>
              </a:ext>
            </a:extLst>
          </p:cNvPr>
          <p:cNvSpPr/>
          <p:nvPr/>
        </p:nvSpPr>
        <p:spPr>
          <a:xfrm>
            <a:off x="8660644" y="758009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矩形 237">
            <a:extLst>
              <a:ext uri="{FF2B5EF4-FFF2-40B4-BE49-F238E27FC236}">
                <a16:creationId xmlns:a16="http://schemas.microsoft.com/office/drawing/2014/main" id="{01A0E49C-86A1-4EF2-B059-6653B0AEFFDE}"/>
              </a:ext>
            </a:extLst>
          </p:cNvPr>
          <p:cNvSpPr/>
          <p:nvPr/>
        </p:nvSpPr>
        <p:spPr>
          <a:xfrm>
            <a:off x="9031915" y="758009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矩形 238">
            <a:extLst>
              <a:ext uri="{FF2B5EF4-FFF2-40B4-BE49-F238E27FC236}">
                <a16:creationId xmlns:a16="http://schemas.microsoft.com/office/drawing/2014/main" id="{08BA8AFE-F653-4581-8056-0CBBCFFC826C}"/>
              </a:ext>
            </a:extLst>
          </p:cNvPr>
          <p:cNvSpPr/>
          <p:nvPr/>
        </p:nvSpPr>
        <p:spPr>
          <a:xfrm>
            <a:off x="9410411" y="758009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5">
            <a:extLst>
              <a:ext uri="{FF2B5EF4-FFF2-40B4-BE49-F238E27FC236}">
                <a16:creationId xmlns:a16="http://schemas.microsoft.com/office/drawing/2014/main" id="{4900291D-F217-43FD-B286-8126D985237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03857" y="2790944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15 Positive(%)</a:t>
            </a: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801025C7-659E-4467-84F0-AAD6E86D72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0150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82</a:t>
            </a: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AED05AAA-4043-48C9-A3CE-636CF81CCD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4792686"/>
              </p:ext>
            </p:extLst>
          </p:nvPr>
        </p:nvGraphicFramePr>
        <p:xfrm>
          <a:off x="4027487" y="1744830"/>
          <a:ext cx="1712912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7" imgW="1715326" imgH="2540853" progId="Prism7.Document">
                  <p:embed/>
                </p:oleObj>
              </mc:Choice>
              <mc:Fallback>
                <p:oleObj name="Prism 7" r:id="rId17" imgW="1715326" imgH="2540853" progId="Prism7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AED05AAA-4043-48C9-A3CE-636CF81CCD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027487" y="1744830"/>
                        <a:ext cx="1712912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2ADF9423-D8A7-4B70-B30A-3C73DDC2D2CF}"/>
              </a:ext>
            </a:extLst>
          </p:cNvPr>
          <p:cNvSpPr txBox="1"/>
          <p:nvPr/>
        </p:nvSpPr>
        <p:spPr>
          <a:xfrm>
            <a:off x="4450865" y="174697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9187D34-7CE5-4560-B620-DA0A6F2C42AC}"/>
              </a:ext>
            </a:extLst>
          </p:cNvPr>
          <p:cNvSpPr txBox="1"/>
          <p:nvPr/>
        </p:nvSpPr>
        <p:spPr>
          <a:xfrm>
            <a:off x="4790171" y="2495767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1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2AE81BF-6532-44FD-BE71-CE46C2E4F8C7}"/>
              </a:ext>
            </a:extLst>
          </p:cNvPr>
          <p:cNvSpPr txBox="1"/>
          <p:nvPr/>
        </p:nvSpPr>
        <p:spPr>
          <a:xfrm>
            <a:off x="5145142" y="2309435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7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9EABCAB6-FE46-4776-B5F8-25DFBCBCD1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0569" y="4244755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60A3E181-428C-48E0-A0D5-2A1879958CBE}"/>
              </a:ext>
            </a:extLst>
          </p:cNvPr>
          <p:cNvSpPr/>
          <p:nvPr/>
        </p:nvSpPr>
        <p:spPr>
          <a:xfrm>
            <a:off x="4497951" y="4244755"/>
            <a:ext cx="3701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DE09725E-AC92-40E7-8D15-D6B36CAF69E8}"/>
              </a:ext>
            </a:extLst>
          </p:cNvPr>
          <p:cNvSpPr/>
          <p:nvPr/>
        </p:nvSpPr>
        <p:spPr>
          <a:xfrm>
            <a:off x="4870509" y="4244755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0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AF75B3B-FF90-43B3-8E3E-58935F62C763}"/>
              </a:ext>
            </a:extLst>
          </p:cNvPr>
          <p:cNvSpPr/>
          <p:nvPr/>
        </p:nvSpPr>
        <p:spPr>
          <a:xfrm>
            <a:off x="5252425" y="424475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4F17E40-D769-493C-A225-5EDEE3C41D6C}"/>
              </a:ext>
            </a:extLst>
          </p:cNvPr>
          <p:cNvSpPr txBox="1"/>
          <p:nvPr/>
        </p:nvSpPr>
        <p:spPr>
          <a:xfrm>
            <a:off x="4491282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26FA677-44A7-4D9E-B782-58151474ACBE}"/>
              </a:ext>
            </a:extLst>
          </p:cNvPr>
          <p:cNvSpPr txBox="1"/>
          <p:nvPr/>
        </p:nvSpPr>
        <p:spPr>
          <a:xfrm>
            <a:off x="4820816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E0BEE68-2448-47FF-9BA7-A2D4B0CFEE06}"/>
              </a:ext>
            </a:extLst>
          </p:cNvPr>
          <p:cNvSpPr txBox="1"/>
          <p:nvPr/>
        </p:nvSpPr>
        <p:spPr>
          <a:xfrm>
            <a:off x="5202733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6">
            <a:extLst>
              <a:ext uri="{FF2B5EF4-FFF2-40B4-BE49-F238E27FC236}">
                <a16:creationId xmlns:a16="http://schemas.microsoft.com/office/drawing/2014/main" id="{9A710CCC-856D-4134-B0AB-09B76A5D0F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9800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89</a:t>
            </a:r>
          </a:p>
        </p:txBody>
      </p:sp>
      <p:graphicFrame>
        <p:nvGraphicFramePr>
          <p:cNvPr id="48" name="对象 47">
            <a:extLst>
              <a:ext uri="{FF2B5EF4-FFF2-40B4-BE49-F238E27FC236}">
                <a16:creationId xmlns:a16="http://schemas.microsoft.com/office/drawing/2014/main" id="{F8A202D5-E664-40E7-958D-40383F50A9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8880050"/>
              </p:ext>
            </p:extLst>
          </p:nvPr>
        </p:nvGraphicFramePr>
        <p:xfrm>
          <a:off x="5853111" y="1744830"/>
          <a:ext cx="1712913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9" imgW="1715326" imgH="2540853" progId="Prism7.Document">
                  <p:embed/>
                </p:oleObj>
              </mc:Choice>
              <mc:Fallback>
                <p:oleObj name="Prism 7" r:id="rId19" imgW="1715326" imgH="2540853" progId="Prism7.Document">
                  <p:embed/>
                  <p:pic>
                    <p:nvPicPr>
                      <p:cNvPr id="48" name="对象 47">
                        <a:extLst>
                          <a:ext uri="{FF2B5EF4-FFF2-40B4-BE49-F238E27FC236}">
                            <a16:creationId xmlns:a16="http://schemas.microsoft.com/office/drawing/2014/main" id="{F8A202D5-E664-40E7-958D-40383F50A9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853111" y="1744830"/>
                        <a:ext cx="1712913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文本框 53">
            <a:extLst>
              <a:ext uri="{FF2B5EF4-FFF2-40B4-BE49-F238E27FC236}">
                <a16:creationId xmlns:a16="http://schemas.microsoft.com/office/drawing/2014/main" id="{14DAE79E-B57A-47C3-9E80-392F6B6B38DD}"/>
              </a:ext>
            </a:extLst>
          </p:cNvPr>
          <p:cNvSpPr txBox="1"/>
          <p:nvPr/>
        </p:nvSpPr>
        <p:spPr>
          <a:xfrm>
            <a:off x="6275691" y="173247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A1940AF-860D-457F-B40D-3ADEB1DFFDC7}"/>
              </a:ext>
            </a:extLst>
          </p:cNvPr>
          <p:cNvSpPr txBox="1"/>
          <p:nvPr/>
        </p:nvSpPr>
        <p:spPr>
          <a:xfrm>
            <a:off x="6600709" y="2274269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2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0A072DC-60C8-4675-B993-AC865975016C}"/>
              </a:ext>
            </a:extLst>
          </p:cNvPr>
          <p:cNvSpPr txBox="1"/>
          <p:nvPr/>
        </p:nvSpPr>
        <p:spPr>
          <a:xfrm>
            <a:off x="6969968" y="1989718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7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7">
            <a:extLst>
              <a:ext uri="{FF2B5EF4-FFF2-40B4-BE49-F238E27FC236}">
                <a16:creationId xmlns:a16="http://schemas.microsoft.com/office/drawing/2014/main" id="{27378D77-1C07-476B-940D-3E2859ABDA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6982" y="4244486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0F6D5153-1D43-40BE-AFD4-5C0E946A330B}"/>
              </a:ext>
            </a:extLst>
          </p:cNvPr>
          <p:cNvSpPr/>
          <p:nvPr/>
        </p:nvSpPr>
        <p:spPr>
          <a:xfrm>
            <a:off x="6324364" y="4244486"/>
            <a:ext cx="3701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9D62C36B-8123-427D-846B-24CFDEF554B2}"/>
              </a:ext>
            </a:extLst>
          </p:cNvPr>
          <p:cNvSpPr/>
          <p:nvPr/>
        </p:nvSpPr>
        <p:spPr>
          <a:xfrm>
            <a:off x="6696922" y="4244486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0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D950F2C6-5C8F-4C74-92A5-388560C71809}"/>
              </a:ext>
            </a:extLst>
          </p:cNvPr>
          <p:cNvSpPr/>
          <p:nvPr/>
        </p:nvSpPr>
        <p:spPr>
          <a:xfrm>
            <a:off x="7078838" y="424448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D5DAC3D-185C-471A-BE18-ACD4937A39E5}"/>
              </a:ext>
            </a:extLst>
          </p:cNvPr>
          <p:cNvSpPr txBox="1"/>
          <p:nvPr/>
        </p:nvSpPr>
        <p:spPr>
          <a:xfrm>
            <a:off x="6317695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FDC29F0A-E479-4D22-A84F-38F1D2C02714}"/>
              </a:ext>
            </a:extLst>
          </p:cNvPr>
          <p:cNvSpPr txBox="1"/>
          <p:nvPr/>
        </p:nvSpPr>
        <p:spPr>
          <a:xfrm>
            <a:off x="6647229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54AB620E-454B-48B7-BD27-33A81EC60ACF}"/>
              </a:ext>
            </a:extLst>
          </p:cNvPr>
          <p:cNvSpPr txBox="1"/>
          <p:nvPr/>
        </p:nvSpPr>
        <p:spPr>
          <a:xfrm>
            <a:off x="7029146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6">
            <a:extLst>
              <a:ext uri="{FF2B5EF4-FFF2-40B4-BE49-F238E27FC236}">
                <a16:creationId xmlns:a16="http://schemas.microsoft.com/office/drawing/2014/main" id="{AE58F1DA-4647-4EF9-B8DF-AE4755A9F1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8917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53</a:t>
            </a:r>
          </a:p>
        </p:txBody>
      </p:sp>
      <p:sp>
        <p:nvSpPr>
          <p:cNvPr id="205" name="TextBox 7">
            <a:extLst>
              <a:ext uri="{FF2B5EF4-FFF2-40B4-BE49-F238E27FC236}">
                <a16:creationId xmlns:a16="http://schemas.microsoft.com/office/drawing/2014/main" id="{21ACF541-BDBD-4A6F-A685-5314AAF1BE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2874" y="4222770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06" name="矩形 205">
            <a:extLst>
              <a:ext uri="{FF2B5EF4-FFF2-40B4-BE49-F238E27FC236}">
                <a16:creationId xmlns:a16="http://schemas.microsoft.com/office/drawing/2014/main" id="{8F46CA49-2108-467F-90B0-F5ECD3098748}"/>
              </a:ext>
            </a:extLst>
          </p:cNvPr>
          <p:cNvSpPr/>
          <p:nvPr/>
        </p:nvSpPr>
        <p:spPr>
          <a:xfrm>
            <a:off x="2680256" y="4222770"/>
            <a:ext cx="3701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矩形 206">
            <a:extLst>
              <a:ext uri="{FF2B5EF4-FFF2-40B4-BE49-F238E27FC236}">
                <a16:creationId xmlns:a16="http://schemas.microsoft.com/office/drawing/2014/main" id="{47117B2C-FEA4-4A46-BD4A-E9E479CF3235}"/>
              </a:ext>
            </a:extLst>
          </p:cNvPr>
          <p:cNvSpPr/>
          <p:nvPr/>
        </p:nvSpPr>
        <p:spPr>
          <a:xfrm>
            <a:off x="3077661" y="422277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矩形 207">
            <a:extLst>
              <a:ext uri="{FF2B5EF4-FFF2-40B4-BE49-F238E27FC236}">
                <a16:creationId xmlns:a16="http://schemas.microsoft.com/office/drawing/2014/main" id="{8A1FCBF8-EBCA-4986-9580-585D66144205}"/>
              </a:ext>
            </a:extLst>
          </p:cNvPr>
          <p:cNvSpPr/>
          <p:nvPr/>
        </p:nvSpPr>
        <p:spPr>
          <a:xfrm>
            <a:off x="3434731" y="422277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id="{F15A511B-4F84-41A5-B507-C1D01E750EFC}"/>
              </a:ext>
            </a:extLst>
          </p:cNvPr>
          <p:cNvSpPr txBox="1"/>
          <p:nvPr/>
        </p:nvSpPr>
        <p:spPr>
          <a:xfrm>
            <a:off x="2647075" y="19091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id="{A69E9275-7638-40E9-A354-EF08DA1F46E7}"/>
              </a:ext>
            </a:extLst>
          </p:cNvPr>
          <p:cNvSpPr txBox="1"/>
          <p:nvPr/>
        </p:nvSpPr>
        <p:spPr>
          <a:xfrm>
            <a:off x="2972477" y="2679965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2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182082F9-DF62-4970-B26A-664FDA545862}"/>
              </a:ext>
            </a:extLst>
          </p:cNvPr>
          <p:cNvSpPr txBox="1"/>
          <p:nvPr/>
        </p:nvSpPr>
        <p:spPr>
          <a:xfrm>
            <a:off x="3405856" y="27007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F54DB6A9-9E79-4886-B0D8-D19F9700E078}"/>
              </a:ext>
            </a:extLst>
          </p:cNvPr>
          <p:cNvSpPr txBox="1"/>
          <p:nvPr/>
        </p:nvSpPr>
        <p:spPr>
          <a:xfrm>
            <a:off x="2673587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4E9000D2-616A-48A7-93B5-8894290BA457}"/>
              </a:ext>
            </a:extLst>
          </p:cNvPr>
          <p:cNvSpPr txBox="1"/>
          <p:nvPr/>
        </p:nvSpPr>
        <p:spPr>
          <a:xfrm>
            <a:off x="3003121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B5601EA7-AA94-44BE-8483-C383B8C12B8B}"/>
              </a:ext>
            </a:extLst>
          </p:cNvPr>
          <p:cNvSpPr txBox="1"/>
          <p:nvPr/>
        </p:nvSpPr>
        <p:spPr>
          <a:xfrm>
            <a:off x="3385038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5">
            <a:extLst>
              <a:ext uri="{FF2B5EF4-FFF2-40B4-BE49-F238E27FC236}">
                <a16:creationId xmlns:a16="http://schemas.microsoft.com/office/drawing/2014/main" id="{4952997E-FA68-4F10-B963-F8F8F7DCD6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247301" y="2790944"/>
            <a:ext cx="1749197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RD33 Positive(%)</a:t>
            </a:r>
          </a:p>
        </p:txBody>
      </p:sp>
      <p:sp>
        <p:nvSpPr>
          <p:cNvPr id="145" name="TextBox 6">
            <a:extLst>
              <a:ext uri="{FF2B5EF4-FFF2-40B4-BE49-F238E27FC236}">
                <a16:creationId xmlns:a16="http://schemas.microsoft.com/office/drawing/2014/main" id="{D2BB7028-23BA-4A48-BBDC-CE3748A962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88842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15</a:t>
            </a:r>
          </a:p>
        </p:txBody>
      </p:sp>
      <p:sp>
        <p:nvSpPr>
          <p:cNvPr id="273" name="TextBox 7">
            <a:extLst>
              <a:ext uri="{FF2B5EF4-FFF2-40B4-BE49-F238E27FC236}">
                <a16:creationId xmlns:a16="http://schemas.microsoft.com/office/drawing/2014/main" id="{13AAE8D8-82C4-43F4-962B-B5485A7E20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83599" y="4222770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74" name="矩形 273">
            <a:extLst>
              <a:ext uri="{FF2B5EF4-FFF2-40B4-BE49-F238E27FC236}">
                <a16:creationId xmlns:a16="http://schemas.microsoft.com/office/drawing/2014/main" id="{D522435F-9E04-489E-B6BC-4AC7FF61F202}"/>
              </a:ext>
            </a:extLst>
          </p:cNvPr>
          <p:cNvSpPr/>
          <p:nvPr/>
        </p:nvSpPr>
        <p:spPr>
          <a:xfrm>
            <a:off x="12214312" y="422277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矩形 274">
            <a:extLst>
              <a:ext uri="{FF2B5EF4-FFF2-40B4-BE49-F238E27FC236}">
                <a16:creationId xmlns:a16="http://schemas.microsoft.com/office/drawing/2014/main" id="{16942CCA-C5CB-4976-9A95-4B942BC57000}"/>
              </a:ext>
            </a:extLst>
          </p:cNvPr>
          <p:cNvSpPr/>
          <p:nvPr/>
        </p:nvSpPr>
        <p:spPr>
          <a:xfrm>
            <a:off x="12618386" y="422277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矩形 275">
            <a:extLst>
              <a:ext uri="{FF2B5EF4-FFF2-40B4-BE49-F238E27FC236}">
                <a16:creationId xmlns:a16="http://schemas.microsoft.com/office/drawing/2014/main" id="{05369460-A3CD-4FA7-B0B9-991C1CD03980}"/>
              </a:ext>
            </a:extLst>
          </p:cNvPr>
          <p:cNvSpPr/>
          <p:nvPr/>
        </p:nvSpPr>
        <p:spPr>
          <a:xfrm>
            <a:off x="12975455" y="4222770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8" name="对象 277">
            <a:extLst>
              <a:ext uri="{FF2B5EF4-FFF2-40B4-BE49-F238E27FC236}">
                <a16:creationId xmlns:a16="http://schemas.microsoft.com/office/drawing/2014/main" id="{4DD80E40-45D4-4A98-87CB-9342C4750C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2936159"/>
              </p:ext>
            </p:extLst>
          </p:nvPr>
        </p:nvGraphicFramePr>
        <p:xfrm>
          <a:off x="11726860" y="1748005"/>
          <a:ext cx="1712912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1" imgW="1715326" imgH="2540853" progId="Prism7.Document">
                  <p:embed/>
                </p:oleObj>
              </mc:Choice>
              <mc:Fallback>
                <p:oleObj name="Prism 7" r:id="rId21" imgW="1715326" imgH="2540853" progId="Prism7.Document">
                  <p:embed/>
                  <p:pic>
                    <p:nvPicPr>
                      <p:cNvPr id="278" name="对象 277">
                        <a:extLst>
                          <a:ext uri="{FF2B5EF4-FFF2-40B4-BE49-F238E27FC236}">
                            <a16:creationId xmlns:a16="http://schemas.microsoft.com/office/drawing/2014/main" id="{4DD80E40-45D4-4A98-87CB-9342C4750C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1726860" y="1748005"/>
                        <a:ext cx="1712912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2" name="文本框 281">
            <a:extLst>
              <a:ext uri="{FF2B5EF4-FFF2-40B4-BE49-F238E27FC236}">
                <a16:creationId xmlns:a16="http://schemas.microsoft.com/office/drawing/2014/main" id="{96AD8C9D-BDAB-44FC-894A-EE6E48F8EF0F}"/>
              </a:ext>
            </a:extLst>
          </p:cNvPr>
          <p:cNvSpPr txBox="1"/>
          <p:nvPr/>
        </p:nvSpPr>
        <p:spPr>
          <a:xfrm>
            <a:off x="12205263" y="223780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>
            <a:extLst>
              <a:ext uri="{FF2B5EF4-FFF2-40B4-BE49-F238E27FC236}">
                <a16:creationId xmlns:a16="http://schemas.microsoft.com/office/drawing/2014/main" id="{A116A7B0-0584-4CE1-9E87-71BFA00A53C5}"/>
              </a:ext>
            </a:extLst>
          </p:cNvPr>
          <p:cNvSpPr txBox="1"/>
          <p:nvPr/>
        </p:nvSpPr>
        <p:spPr>
          <a:xfrm>
            <a:off x="12502088" y="2922857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8.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文本框 283">
            <a:extLst>
              <a:ext uri="{FF2B5EF4-FFF2-40B4-BE49-F238E27FC236}">
                <a16:creationId xmlns:a16="http://schemas.microsoft.com/office/drawing/2014/main" id="{A18DDA42-FD9E-405D-A2FE-0041352A2752}"/>
              </a:ext>
            </a:extLst>
          </p:cNvPr>
          <p:cNvSpPr txBox="1"/>
          <p:nvPr/>
        </p:nvSpPr>
        <p:spPr>
          <a:xfrm>
            <a:off x="12857060" y="3057952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1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文本框 284">
            <a:extLst>
              <a:ext uri="{FF2B5EF4-FFF2-40B4-BE49-F238E27FC236}">
                <a16:creationId xmlns:a16="http://schemas.microsoft.com/office/drawing/2014/main" id="{1FCB6960-0318-4863-AB10-70EC83EBB7B2}"/>
              </a:ext>
            </a:extLst>
          </p:cNvPr>
          <p:cNvSpPr txBox="1"/>
          <p:nvPr/>
        </p:nvSpPr>
        <p:spPr>
          <a:xfrm>
            <a:off x="12214312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文本框 285">
            <a:extLst>
              <a:ext uri="{FF2B5EF4-FFF2-40B4-BE49-F238E27FC236}">
                <a16:creationId xmlns:a16="http://schemas.microsoft.com/office/drawing/2014/main" id="{A097EF94-E3FE-402F-974F-75DC04A93FE4}"/>
              </a:ext>
            </a:extLst>
          </p:cNvPr>
          <p:cNvSpPr txBox="1"/>
          <p:nvPr/>
        </p:nvSpPr>
        <p:spPr>
          <a:xfrm>
            <a:off x="12543846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文本框 286">
            <a:extLst>
              <a:ext uri="{FF2B5EF4-FFF2-40B4-BE49-F238E27FC236}">
                <a16:creationId xmlns:a16="http://schemas.microsoft.com/office/drawing/2014/main" id="{E0759C9D-6934-414D-8571-7FD8EB48134C}"/>
              </a:ext>
            </a:extLst>
          </p:cNvPr>
          <p:cNvSpPr txBox="1"/>
          <p:nvPr/>
        </p:nvSpPr>
        <p:spPr>
          <a:xfrm>
            <a:off x="12925763" y="399060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6">
            <a:extLst>
              <a:ext uri="{FF2B5EF4-FFF2-40B4-BE49-F238E27FC236}">
                <a16:creationId xmlns:a16="http://schemas.microsoft.com/office/drawing/2014/main" id="{5A5D5747-76DE-4011-AC2C-EB0C2EAF4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4731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13</a:t>
            </a:r>
          </a:p>
        </p:txBody>
      </p:sp>
      <p:sp>
        <p:nvSpPr>
          <p:cNvPr id="264" name="TextBox 7">
            <a:extLst>
              <a:ext uri="{FF2B5EF4-FFF2-40B4-BE49-F238E27FC236}">
                <a16:creationId xmlns:a16="http://schemas.microsoft.com/office/drawing/2014/main" id="{2AE4E6D8-FFAD-44B9-8A2C-A1FBCC3533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12713" y="4244486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65" name="矩形 264">
            <a:extLst>
              <a:ext uri="{FF2B5EF4-FFF2-40B4-BE49-F238E27FC236}">
                <a16:creationId xmlns:a16="http://schemas.microsoft.com/office/drawing/2014/main" id="{5B5CBB99-7AF0-4F7B-8A71-568656F78B72}"/>
              </a:ext>
            </a:extLst>
          </p:cNvPr>
          <p:cNvSpPr/>
          <p:nvPr/>
        </p:nvSpPr>
        <p:spPr>
          <a:xfrm>
            <a:off x="10443426" y="424448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矩形 265">
            <a:extLst>
              <a:ext uri="{FF2B5EF4-FFF2-40B4-BE49-F238E27FC236}">
                <a16:creationId xmlns:a16="http://schemas.microsoft.com/office/drawing/2014/main" id="{B53DB36B-AB37-4020-8713-CE36287A35B3}"/>
              </a:ext>
            </a:extLst>
          </p:cNvPr>
          <p:cNvSpPr/>
          <p:nvPr/>
        </p:nvSpPr>
        <p:spPr>
          <a:xfrm>
            <a:off x="10822653" y="4244486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矩形 266">
            <a:extLst>
              <a:ext uri="{FF2B5EF4-FFF2-40B4-BE49-F238E27FC236}">
                <a16:creationId xmlns:a16="http://schemas.microsoft.com/office/drawing/2014/main" id="{D10859C6-2EE4-4B5A-9483-A9D338CE97FE}"/>
              </a:ext>
            </a:extLst>
          </p:cNvPr>
          <p:cNvSpPr/>
          <p:nvPr/>
        </p:nvSpPr>
        <p:spPr>
          <a:xfrm>
            <a:off x="11204570" y="4244486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文本框 267">
            <a:extLst>
              <a:ext uri="{FF2B5EF4-FFF2-40B4-BE49-F238E27FC236}">
                <a16:creationId xmlns:a16="http://schemas.microsoft.com/office/drawing/2014/main" id="{967EDEB0-72EA-4C9B-A48A-3104F5FF6552}"/>
              </a:ext>
            </a:extLst>
          </p:cNvPr>
          <p:cNvSpPr txBox="1"/>
          <p:nvPr/>
        </p:nvSpPr>
        <p:spPr>
          <a:xfrm>
            <a:off x="10443426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>
            <a:extLst>
              <a:ext uri="{FF2B5EF4-FFF2-40B4-BE49-F238E27FC236}">
                <a16:creationId xmlns:a16="http://schemas.microsoft.com/office/drawing/2014/main" id="{00A35AE1-66A1-485F-B71A-5C8AF01E39B8}"/>
              </a:ext>
            </a:extLst>
          </p:cNvPr>
          <p:cNvSpPr txBox="1"/>
          <p:nvPr/>
        </p:nvSpPr>
        <p:spPr>
          <a:xfrm>
            <a:off x="10772960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id="{E029735C-6E23-43F2-A8E4-CFC202B568EC}"/>
              </a:ext>
            </a:extLst>
          </p:cNvPr>
          <p:cNvSpPr txBox="1"/>
          <p:nvPr/>
        </p:nvSpPr>
        <p:spPr>
          <a:xfrm>
            <a:off x="11154877" y="40106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6">
            <a:extLst>
              <a:ext uri="{FF2B5EF4-FFF2-40B4-BE49-F238E27FC236}">
                <a16:creationId xmlns:a16="http://schemas.microsoft.com/office/drawing/2014/main" id="{4CEE4A0A-0DAA-4E73-8508-6D5C4ED0BB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83659" y="1529877"/>
            <a:ext cx="846707" cy="27699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=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71</a:t>
            </a:r>
          </a:p>
        </p:txBody>
      </p:sp>
      <p:graphicFrame>
        <p:nvGraphicFramePr>
          <p:cNvPr id="240" name="对象 239">
            <a:extLst>
              <a:ext uri="{FF2B5EF4-FFF2-40B4-BE49-F238E27FC236}">
                <a16:creationId xmlns:a16="http://schemas.microsoft.com/office/drawing/2014/main" id="{79EB2B05-8E67-4E63-B320-0F32765430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182661"/>
              </p:ext>
            </p:extLst>
          </p:nvPr>
        </p:nvGraphicFramePr>
        <p:xfrm>
          <a:off x="8294688" y="1744830"/>
          <a:ext cx="1635125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3" imgW="1637537" imgH="2540853" progId="Prism7.Document">
                  <p:embed/>
                </p:oleObj>
              </mc:Choice>
              <mc:Fallback>
                <p:oleObj name="Prism 7" r:id="rId23" imgW="1637537" imgH="2540853" progId="Prism7.Document">
                  <p:embed/>
                  <p:pic>
                    <p:nvPicPr>
                      <p:cNvPr id="240" name="对象 239">
                        <a:extLst>
                          <a:ext uri="{FF2B5EF4-FFF2-40B4-BE49-F238E27FC236}">
                            <a16:creationId xmlns:a16="http://schemas.microsoft.com/office/drawing/2014/main" id="{79EB2B05-8E67-4E63-B320-0F32765430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294688" y="1744830"/>
                        <a:ext cx="1635125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5" name="文本框 244">
            <a:extLst>
              <a:ext uri="{FF2B5EF4-FFF2-40B4-BE49-F238E27FC236}">
                <a16:creationId xmlns:a16="http://schemas.microsoft.com/office/drawing/2014/main" id="{A3092A5A-9F73-4C30-8E92-9632AEC03328}"/>
              </a:ext>
            </a:extLst>
          </p:cNvPr>
          <p:cNvSpPr txBox="1"/>
          <p:nvPr/>
        </p:nvSpPr>
        <p:spPr>
          <a:xfrm>
            <a:off x="8624612" y="2072419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.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F744F014-3598-4162-8E03-AC0D86104A6C}"/>
              </a:ext>
            </a:extLst>
          </p:cNvPr>
          <p:cNvSpPr txBox="1"/>
          <p:nvPr/>
        </p:nvSpPr>
        <p:spPr>
          <a:xfrm>
            <a:off x="8980597" y="2118578"/>
            <a:ext cx="482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6.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文本框 246">
            <a:extLst>
              <a:ext uri="{FF2B5EF4-FFF2-40B4-BE49-F238E27FC236}">
                <a16:creationId xmlns:a16="http://schemas.microsoft.com/office/drawing/2014/main" id="{7F070809-89A9-4AB4-B07F-379C2E076EAF}"/>
              </a:ext>
            </a:extLst>
          </p:cNvPr>
          <p:cNvSpPr txBox="1"/>
          <p:nvPr/>
        </p:nvSpPr>
        <p:spPr>
          <a:xfrm>
            <a:off x="9365188" y="2560457"/>
            <a:ext cx="471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1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7">
            <a:extLst>
              <a:ext uri="{FF2B5EF4-FFF2-40B4-BE49-F238E27FC236}">
                <a16:creationId xmlns:a16="http://schemas.microsoft.com/office/drawing/2014/main" id="{4F065928-647B-4227-81EA-D2F30CD0C0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4878" y="4244755"/>
            <a:ext cx="482825" cy="30777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249" name="矩形 248">
            <a:extLst>
              <a:ext uri="{FF2B5EF4-FFF2-40B4-BE49-F238E27FC236}">
                <a16:creationId xmlns:a16="http://schemas.microsoft.com/office/drawing/2014/main" id="{B0DFABCD-B014-4D4B-8628-404BC87A83C6}"/>
              </a:ext>
            </a:extLst>
          </p:cNvPr>
          <p:cNvSpPr/>
          <p:nvPr/>
        </p:nvSpPr>
        <p:spPr>
          <a:xfrm>
            <a:off x="8645591" y="424475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矩形 249">
            <a:extLst>
              <a:ext uri="{FF2B5EF4-FFF2-40B4-BE49-F238E27FC236}">
                <a16:creationId xmlns:a16="http://schemas.microsoft.com/office/drawing/2014/main" id="{03DB5FCF-BC49-4EB9-B7FB-F72BED5EE31D}"/>
              </a:ext>
            </a:extLst>
          </p:cNvPr>
          <p:cNvSpPr/>
          <p:nvPr/>
        </p:nvSpPr>
        <p:spPr>
          <a:xfrm>
            <a:off x="9024818" y="4244755"/>
            <a:ext cx="4331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9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矩形 250">
            <a:extLst>
              <a:ext uri="{FF2B5EF4-FFF2-40B4-BE49-F238E27FC236}">
                <a16:creationId xmlns:a16="http://schemas.microsoft.com/office/drawing/2014/main" id="{60F8C56A-73E9-431C-A661-4990C1AA79EF}"/>
              </a:ext>
            </a:extLst>
          </p:cNvPr>
          <p:cNvSpPr/>
          <p:nvPr/>
        </p:nvSpPr>
        <p:spPr>
          <a:xfrm>
            <a:off x="9406734" y="4244755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6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id="{F2DBDAF9-45A6-43EF-B6DB-24BA426C56D3}"/>
              </a:ext>
            </a:extLst>
          </p:cNvPr>
          <p:cNvSpPr txBox="1"/>
          <p:nvPr/>
        </p:nvSpPr>
        <p:spPr>
          <a:xfrm>
            <a:off x="8645591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文本框 252">
            <a:extLst>
              <a:ext uri="{FF2B5EF4-FFF2-40B4-BE49-F238E27FC236}">
                <a16:creationId xmlns:a16="http://schemas.microsoft.com/office/drawing/2014/main" id="{80501259-3E14-4467-B101-AE396A48C685}"/>
              </a:ext>
            </a:extLst>
          </p:cNvPr>
          <p:cNvSpPr txBox="1"/>
          <p:nvPr/>
        </p:nvSpPr>
        <p:spPr>
          <a:xfrm>
            <a:off x="8975125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文本框 253">
            <a:extLst>
              <a:ext uri="{FF2B5EF4-FFF2-40B4-BE49-F238E27FC236}">
                <a16:creationId xmlns:a16="http://schemas.microsoft.com/office/drawing/2014/main" id="{082F8A64-6B19-409C-911C-91784013B908}"/>
              </a:ext>
            </a:extLst>
          </p:cNvPr>
          <p:cNvSpPr txBox="1"/>
          <p:nvPr/>
        </p:nvSpPr>
        <p:spPr>
          <a:xfrm>
            <a:off x="9357042" y="401391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/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id="{9729539B-6005-46C1-8D67-9A8CD3A4867F}"/>
              </a:ext>
            </a:extLst>
          </p:cNvPr>
          <p:cNvSpPr txBox="1"/>
          <p:nvPr/>
        </p:nvSpPr>
        <p:spPr>
          <a:xfrm>
            <a:off x="333364" y="54068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F0126EBF-B1D9-4077-8C52-6271E565C117}"/>
              </a:ext>
            </a:extLst>
          </p:cNvPr>
          <p:cNvSpPr txBox="1"/>
          <p:nvPr/>
        </p:nvSpPr>
        <p:spPr>
          <a:xfrm>
            <a:off x="328547" y="888472"/>
            <a:ext cx="17911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D-2008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-ALL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RD</a:t>
            </a:r>
          </a:p>
        </p:txBody>
      </p:sp>
      <p:sp>
        <p:nvSpPr>
          <p:cNvPr id="333" name="文本框 332">
            <a:extLst>
              <a:ext uri="{FF2B5EF4-FFF2-40B4-BE49-F238E27FC236}">
                <a16:creationId xmlns:a16="http://schemas.microsoft.com/office/drawing/2014/main" id="{994F2042-3C46-48E4-B28C-9A1560853F4A}"/>
              </a:ext>
            </a:extLst>
          </p:cNvPr>
          <p:cNvSpPr txBox="1"/>
          <p:nvPr/>
        </p:nvSpPr>
        <p:spPr>
          <a:xfrm>
            <a:off x="2328863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1%</a:t>
            </a: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id="{9A92DB3D-98C8-4905-9450-B93208F33BC0}"/>
              </a:ext>
            </a:extLst>
          </p:cNvPr>
          <p:cNvSpPr txBox="1"/>
          <p:nvPr/>
        </p:nvSpPr>
        <p:spPr>
          <a:xfrm>
            <a:off x="4207344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0.1%,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&lt;1%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文本框 334">
            <a:extLst>
              <a:ext uri="{FF2B5EF4-FFF2-40B4-BE49-F238E27FC236}">
                <a16:creationId xmlns:a16="http://schemas.microsoft.com/office/drawing/2014/main" id="{8084BB98-5127-4796-BB11-23F9FF5B4D0A}"/>
              </a:ext>
            </a:extLst>
          </p:cNvPr>
          <p:cNvSpPr txBox="1"/>
          <p:nvPr/>
        </p:nvSpPr>
        <p:spPr>
          <a:xfrm>
            <a:off x="6089396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0.01%,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&lt;0.1%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文本框 335">
            <a:extLst>
              <a:ext uri="{FF2B5EF4-FFF2-40B4-BE49-F238E27FC236}">
                <a16:creationId xmlns:a16="http://schemas.microsoft.com/office/drawing/2014/main" id="{288CDEB0-BF5B-49E5-9E2A-1D8E4E936F89}"/>
              </a:ext>
            </a:extLst>
          </p:cNvPr>
          <p:cNvSpPr txBox="1"/>
          <p:nvPr/>
        </p:nvSpPr>
        <p:spPr>
          <a:xfrm>
            <a:off x="8341778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1%</a:t>
            </a:r>
          </a:p>
        </p:txBody>
      </p:sp>
      <p:sp>
        <p:nvSpPr>
          <p:cNvPr id="337" name="文本框 336">
            <a:extLst>
              <a:ext uri="{FF2B5EF4-FFF2-40B4-BE49-F238E27FC236}">
                <a16:creationId xmlns:a16="http://schemas.microsoft.com/office/drawing/2014/main" id="{7B50FB1C-4426-436D-8C44-FD3436677A10}"/>
              </a:ext>
            </a:extLst>
          </p:cNvPr>
          <p:cNvSpPr txBox="1"/>
          <p:nvPr/>
        </p:nvSpPr>
        <p:spPr>
          <a:xfrm>
            <a:off x="10091663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0.1%,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&lt;1%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文本框 337">
            <a:extLst>
              <a:ext uri="{FF2B5EF4-FFF2-40B4-BE49-F238E27FC236}">
                <a16:creationId xmlns:a16="http://schemas.microsoft.com/office/drawing/2014/main" id="{451680BE-AFB5-4A8F-AF3B-809A7A0ED8EE}"/>
              </a:ext>
            </a:extLst>
          </p:cNvPr>
          <p:cNvSpPr txBox="1"/>
          <p:nvPr/>
        </p:nvSpPr>
        <p:spPr>
          <a:xfrm>
            <a:off x="11930851" y="1135265"/>
            <a:ext cx="1845190" cy="337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gt;=0.01%,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&lt;0.1%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文本框 338">
            <a:extLst>
              <a:ext uri="{FF2B5EF4-FFF2-40B4-BE49-F238E27FC236}">
                <a16:creationId xmlns:a16="http://schemas.microsoft.com/office/drawing/2014/main" id="{9C2E7013-DDB8-480B-820E-C5EA0A2B0CBE}"/>
              </a:ext>
            </a:extLst>
          </p:cNvPr>
          <p:cNvSpPr txBox="1"/>
          <p:nvPr/>
        </p:nvSpPr>
        <p:spPr>
          <a:xfrm>
            <a:off x="808507" y="1511523"/>
            <a:ext cx="1311231" cy="339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s3824662</a:t>
            </a:r>
          </a:p>
        </p:txBody>
      </p:sp>
      <p:sp>
        <p:nvSpPr>
          <p:cNvPr id="340" name="文本框 339">
            <a:extLst>
              <a:ext uri="{FF2B5EF4-FFF2-40B4-BE49-F238E27FC236}">
                <a16:creationId xmlns:a16="http://schemas.microsoft.com/office/drawing/2014/main" id="{C32A596B-1D39-4DB8-A9C3-58EA658BEF2D}"/>
              </a:ext>
            </a:extLst>
          </p:cNvPr>
          <p:cNvSpPr txBox="1"/>
          <p:nvPr/>
        </p:nvSpPr>
        <p:spPr>
          <a:xfrm>
            <a:off x="808507" y="4907278"/>
            <a:ext cx="1311231" cy="339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s3781093</a:t>
            </a:r>
          </a:p>
        </p:txBody>
      </p:sp>
      <p:graphicFrame>
        <p:nvGraphicFramePr>
          <p:cNvPr id="257" name="对象 256">
            <a:extLst>
              <a:ext uri="{FF2B5EF4-FFF2-40B4-BE49-F238E27FC236}">
                <a16:creationId xmlns:a16="http://schemas.microsoft.com/office/drawing/2014/main" id="{0E16BF54-A5EC-4AB2-ACFD-8A0CA633AE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2484343"/>
              </p:ext>
            </p:extLst>
          </p:nvPr>
        </p:nvGraphicFramePr>
        <p:xfrm>
          <a:off x="10071128" y="1743242"/>
          <a:ext cx="1630362" cy="272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5" imgW="1634296" imgH="2546973" progId="Prism7.Document">
                  <p:embed/>
                </p:oleObj>
              </mc:Choice>
              <mc:Fallback>
                <p:oleObj name="Prism 7" r:id="rId25" imgW="1634296" imgH="2546973" progId="Prism7.Document">
                  <p:embed/>
                  <p:pic>
                    <p:nvPicPr>
                      <p:cNvPr id="257" name="对象 256">
                        <a:extLst>
                          <a:ext uri="{FF2B5EF4-FFF2-40B4-BE49-F238E27FC236}">
                            <a16:creationId xmlns:a16="http://schemas.microsoft.com/office/drawing/2014/main" id="{0E16BF54-A5EC-4AB2-ACFD-8A0CA633AE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0071128" y="1743242"/>
                        <a:ext cx="1630362" cy="2724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2" name="文本框 261">
            <a:extLst>
              <a:ext uri="{FF2B5EF4-FFF2-40B4-BE49-F238E27FC236}">
                <a16:creationId xmlns:a16="http://schemas.microsoft.com/office/drawing/2014/main" id="{FE600461-99F6-48C5-B175-867BFD98B551}"/>
              </a:ext>
            </a:extLst>
          </p:cNvPr>
          <p:cNvSpPr txBox="1"/>
          <p:nvPr/>
        </p:nvSpPr>
        <p:spPr>
          <a:xfrm>
            <a:off x="10772508" y="261717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2.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文本框 262">
            <a:extLst>
              <a:ext uri="{FF2B5EF4-FFF2-40B4-BE49-F238E27FC236}">
                <a16:creationId xmlns:a16="http://schemas.microsoft.com/office/drawing/2014/main" id="{AAA774B5-A1EF-4E8A-A956-3B9A54622650}"/>
              </a:ext>
            </a:extLst>
          </p:cNvPr>
          <p:cNvSpPr txBox="1"/>
          <p:nvPr/>
        </p:nvSpPr>
        <p:spPr>
          <a:xfrm>
            <a:off x="11177310" y="30898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文本框 240">
            <a:extLst>
              <a:ext uri="{FF2B5EF4-FFF2-40B4-BE49-F238E27FC236}">
                <a16:creationId xmlns:a16="http://schemas.microsoft.com/office/drawing/2014/main" id="{F78A0DC5-3328-47F6-B6A7-B8D52090FEF9}"/>
              </a:ext>
            </a:extLst>
          </p:cNvPr>
          <p:cNvSpPr txBox="1"/>
          <p:nvPr/>
        </p:nvSpPr>
        <p:spPr>
          <a:xfrm>
            <a:off x="10445545" y="20409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9DEC4FB8-7779-4E27-B27E-9C6B18AC9C55}"/>
              </a:ext>
            </a:extLst>
          </p:cNvPr>
          <p:cNvSpPr txBox="1"/>
          <p:nvPr/>
        </p:nvSpPr>
        <p:spPr>
          <a:xfrm>
            <a:off x="2341467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93CAEB62-C434-486B-8544-17134CC38570}"/>
              </a:ext>
            </a:extLst>
          </p:cNvPr>
          <p:cNvSpPr txBox="1"/>
          <p:nvPr/>
        </p:nvSpPr>
        <p:spPr>
          <a:xfrm>
            <a:off x="2256509" y="34245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043DA878-1B59-41EB-8A4F-7DEBFF055A50}"/>
              </a:ext>
            </a:extLst>
          </p:cNvPr>
          <p:cNvSpPr txBox="1"/>
          <p:nvPr/>
        </p:nvSpPr>
        <p:spPr>
          <a:xfrm>
            <a:off x="2256509" y="3036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6BEB23B6-1A6C-4C47-8514-4ED4B321DEFE}"/>
              </a:ext>
            </a:extLst>
          </p:cNvPr>
          <p:cNvSpPr txBox="1"/>
          <p:nvPr/>
        </p:nvSpPr>
        <p:spPr>
          <a:xfrm>
            <a:off x="2256509" y="26395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15A747CE-38C8-4635-AC78-B85C7E21A12A}"/>
              </a:ext>
            </a:extLst>
          </p:cNvPr>
          <p:cNvSpPr txBox="1"/>
          <p:nvPr/>
        </p:nvSpPr>
        <p:spPr>
          <a:xfrm>
            <a:off x="2256509" y="22503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文本框 241">
            <a:extLst>
              <a:ext uri="{FF2B5EF4-FFF2-40B4-BE49-F238E27FC236}">
                <a16:creationId xmlns:a16="http://schemas.microsoft.com/office/drawing/2014/main" id="{64DB7FDD-C143-40DB-9BF2-3E760FB1754A}"/>
              </a:ext>
            </a:extLst>
          </p:cNvPr>
          <p:cNvSpPr txBox="1"/>
          <p:nvPr/>
        </p:nvSpPr>
        <p:spPr>
          <a:xfrm>
            <a:off x="2171549" y="18820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文本框 243">
            <a:extLst>
              <a:ext uri="{FF2B5EF4-FFF2-40B4-BE49-F238E27FC236}">
                <a16:creationId xmlns:a16="http://schemas.microsoft.com/office/drawing/2014/main" id="{80C65325-5F6E-45CB-BDE6-F84D9428C490}"/>
              </a:ext>
            </a:extLst>
          </p:cNvPr>
          <p:cNvSpPr txBox="1"/>
          <p:nvPr/>
        </p:nvSpPr>
        <p:spPr>
          <a:xfrm>
            <a:off x="4144423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文本框 254">
            <a:extLst>
              <a:ext uri="{FF2B5EF4-FFF2-40B4-BE49-F238E27FC236}">
                <a16:creationId xmlns:a16="http://schemas.microsoft.com/office/drawing/2014/main" id="{ADC09699-004A-471F-9631-66DB35454656}"/>
              </a:ext>
            </a:extLst>
          </p:cNvPr>
          <p:cNvSpPr txBox="1"/>
          <p:nvPr/>
        </p:nvSpPr>
        <p:spPr>
          <a:xfrm>
            <a:off x="4059465" y="34245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文本框 255">
            <a:extLst>
              <a:ext uri="{FF2B5EF4-FFF2-40B4-BE49-F238E27FC236}">
                <a16:creationId xmlns:a16="http://schemas.microsoft.com/office/drawing/2014/main" id="{35759104-BA02-4111-9619-65747A086ECC}"/>
              </a:ext>
            </a:extLst>
          </p:cNvPr>
          <p:cNvSpPr txBox="1"/>
          <p:nvPr/>
        </p:nvSpPr>
        <p:spPr>
          <a:xfrm>
            <a:off x="4059465" y="3036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文本框 257">
            <a:extLst>
              <a:ext uri="{FF2B5EF4-FFF2-40B4-BE49-F238E27FC236}">
                <a16:creationId xmlns:a16="http://schemas.microsoft.com/office/drawing/2014/main" id="{700F2AF4-426A-436C-961B-59B708A40D79}"/>
              </a:ext>
            </a:extLst>
          </p:cNvPr>
          <p:cNvSpPr txBox="1"/>
          <p:nvPr/>
        </p:nvSpPr>
        <p:spPr>
          <a:xfrm>
            <a:off x="4059465" y="26395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文本框 258">
            <a:extLst>
              <a:ext uri="{FF2B5EF4-FFF2-40B4-BE49-F238E27FC236}">
                <a16:creationId xmlns:a16="http://schemas.microsoft.com/office/drawing/2014/main" id="{3FF91B6B-AA3D-4409-B7F9-4A4653E6F531}"/>
              </a:ext>
            </a:extLst>
          </p:cNvPr>
          <p:cNvSpPr txBox="1"/>
          <p:nvPr/>
        </p:nvSpPr>
        <p:spPr>
          <a:xfrm>
            <a:off x="4059465" y="22503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文本框 259">
            <a:extLst>
              <a:ext uri="{FF2B5EF4-FFF2-40B4-BE49-F238E27FC236}">
                <a16:creationId xmlns:a16="http://schemas.microsoft.com/office/drawing/2014/main" id="{F2A8327A-18E8-437F-8BCC-D5D535369D4F}"/>
              </a:ext>
            </a:extLst>
          </p:cNvPr>
          <p:cNvSpPr txBox="1"/>
          <p:nvPr/>
        </p:nvSpPr>
        <p:spPr>
          <a:xfrm>
            <a:off x="3974505" y="18820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文本框 271">
            <a:extLst>
              <a:ext uri="{FF2B5EF4-FFF2-40B4-BE49-F238E27FC236}">
                <a16:creationId xmlns:a16="http://schemas.microsoft.com/office/drawing/2014/main" id="{F58D5154-4A5A-4E0D-9E73-88155D489B80}"/>
              </a:ext>
            </a:extLst>
          </p:cNvPr>
          <p:cNvSpPr txBox="1"/>
          <p:nvPr/>
        </p:nvSpPr>
        <p:spPr>
          <a:xfrm>
            <a:off x="5939579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文本框 276">
            <a:extLst>
              <a:ext uri="{FF2B5EF4-FFF2-40B4-BE49-F238E27FC236}">
                <a16:creationId xmlns:a16="http://schemas.microsoft.com/office/drawing/2014/main" id="{25172385-6DB2-4218-87D9-AE4D9B88BE1A}"/>
              </a:ext>
            </a:extLst>
          </p:cNvPr>
          <p:cNvSpPr txBox="1"/>
          <p:nvPr/>
        </p:nvSpPr>
        <p:spPr>
          <a:xfrm>
            <a:off x="5854621" y="34245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文本框 278">
            <a:extLst>
              <a:ext uri="{FF2B5EF4-FFF2-40B4-BE49-F238E27FC236}">
                <a16:creationId xmlns:a16="http://schemas.microsoft.com/office/drawing/2014/main" id="{3FDF77D7-2785-498E-8956-945766C76B9C}"/>
              </a:ext>
            </a:extLst>
          </p:cNvPr>
          <p:cNvSpPr txBox="1"/>
          <p:nvPr/>
        </p:nvSpPr>
        <p:spPr>
          <a:xfrm>
            <a:off x="5854621" y="3036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文本框 279">
            <a:extLst>
              <a:ext uri="{FF2B5EF4-FFF2-40B4-BE49-F238E27FC236}">
                <a16:creationId xmlns:a16="http://schemas.microsoft.com/office/drawing/2014/main" id="{01E5D70C-2E60-4A3B-AD6E-A3533AB2F058}"/>
              </a:ext>
            </a:extLst>
          </p:cNvPr>
          <p:cNvSpPr txBox="1"/>
          <p:nvPr/>
        </p:nvSpPr>
        <p:spPr>
          <a:xfrm>
            <a:off x="5854621" y="26395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文本框 280">
            <a:extLst>
              <a:ext uri="{FF2B5EF4-FFF2-40B4-BE49-F238E27FC236}">
                <a16:creationId xmlns:a16="http://schemas.microsoft.com/office/drawing/2014/main" id="{3DDC0E8B-0B48-4C3A-BDC6-67329C02910C}"/>
              </a:ext>
            </a:extLst>
          </p:cNvPr>
          <p:cNvSpPr txBox="1"/>
          <p:nvPr/>
        </p:nvSpPr>
        <p:spPr>
          <a:xfrm>
            <a:off x="5854621" y="22503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文本框 287">
            <a:extLst>
              <a:ext uri="{FF2B5EF4-FFF2-40B4-BE49-F238E27FC236}">
                <a16:creationId xmlns:a16="http://schemas.microsoft.com/office/drawing/2014/main" id="{262057A8-A7EC-4F9F-A5F5-5AD6C66A92FD}"/>
              </a:ext>
            </a:extLst>
          </p:cNvPr>
          <p:cNvSpPr txBox="1"/>
          <p:nvPr/>
        </p:nvSpPr>
        <p:spPr>
          <a:xfrm>
            <a:off x="5769661" y="18820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文本框 291">
            <a:extLst>
              <a:ext uri="{FF2B5EF4-FFF2-40B4-BE49-F238E27FC236}">
                <a16:creationId xmlns:a16="http://schemas.microsoft.com/office/drawing/2014/main" id="{512A1166-4B4B-4071-8D62-409DF0D12AAF}"/>
              </a:ext>
            </a:extLst>
          </p:cNvPr>
          <p:cNvSpPr txBox="1"/>
          <p:nvPr/>
        </p:nvSpPr>
        <p:spPr>
          <a:xfrm>
            <a:off x="8341749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文本框 292">
            <a:extLst>
              <a:ext uri="{FF2B5EF4-FFF2-40B4-BE49-F238E27FC236}">
                <a16:creationId xmlns:a16="http://schemas.microsoft.com/office/drawing/2014/main" id="{9B9F93AA-4626-45AC-8128-1A4117EFCCB0}"/>
              </a:ext>
            </a:extLst>
          </p:cNvPr>
          <p:cNvSpPr txBox="1"/>
          <p:nvPr/>
        </p:nvSpPr>
        <p:spPr>
          <a:xfrm>
            <a:off x="8256791" y="33475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文本框 294">
            <a:extLst>
              <a:ext uri="{FF2B5EF4-FFF2-40B4-BE49-F238E27FC236}">
                <a16:creationId xmlns:a16="http://schemas.microsoft.com/office/drawing/2014/main" id="{79D9D30D-13F1-470E-820A-648239D74C14}"/>
              </a:ext>
            </a:extLst>
          </p:cNvPr>
          <p:cNvSpPr txBox="1"/>
          <p:nvPr/>
        </p:nvSpPr>
        <p:spPr>
          <a:xfrm>
            <a:off x="8247166" y="28512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文本框 295">
            <a:extLst>
              <a:ext uri="{FF2B5EF4-FFF2-40B4-BE49-F238E27FC236}">
                <a16:creationId xmlns:a16="http://schemas.microsoft.com/office/drawing/2014/main" id="{EAFE3AE4-9E6C-4C17-AE05-57425F15FA5B}"/>
              </a:ext>
            </a:extLst>
          </p:cNvPr>
          <p:cNvSpPr txBox="1"/>
          <p:nvPr/>
        </p:nvSpPr>
        <p:spPr>
          <a:xfrm>
            <a:off x="8256791" y="23755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DB4D62AD-B4BB-4C5E-8511-E67411F2B3AE}"/>
              </a:ext>
            </a:extLst>
          </p:cNvPr>
          <p:cNvSpPr txBox="1"/>
          <p:nvPr/>
        </p:nvSpPr>
        <p:spPr>
          <a:xfrm>
            <a:off x="8256791" y="18820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文本框 298">
            <a:extLst>
              <a:ext uri="{FF2B5EF4-FFF2-40B4-BE49-F238E27FC236}">
                <a16:creationId xmlns:a16="http://schemas.microsoft.com/office/drawing/2014/main" id="{82DA8D4F-0207-4348-A57E-235495B58FE9}"/>
              </a:ext>
            </a:extLst>
          </p:cNvPr>
          <p:cNvSpPr txBox="1"/>
          <p:nvPr/>
        </p:nvSpPr>
        <p:spPr>
          <a:xfrm>
            <a:off x="11857662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文本框 299">
            <a:extLst>
              <a:ext uri="{FF2B5EF4-FFF2-40B4-BE49-F238E27FC236}">
                <a16:creationId xmlns:a16="http://schemas.microsoft.com/office/drawing/2014/main" id="{DBD2CE52-8FD1-4FE3-B200-A73CD2455687}"/>
              </a:ext>
            </a:extLst>
          </p:cNvPr>
          <p:cNvSpPr txBox="1"/>
          <p:nvPr/>
        </p:nvSpPr>
        <p:spPr>
          <a:xfrm>
            <a:off x="11772704" y="34245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EDC25D2E-4BC4-4CA0-A9E4-1CF73A065037}"/>
              </a:ext>
            </a:extLst>
          </p:cNvPr>
          <p:cNvSpPr txBox="1"/>
          <p:nvPr/>
        </p:nvSpPr>
        <p:spPr>
          <a:xfrm>
            <a:off x="11772704" y="3036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文本框 301">
            <a:extLst>
              <a:ext uri="{FF2B5EF4-FFF2-40B4-BE49-F238E27FC236}">
                <a16:creationId xmlns:a16="http://schemas.microsoft.com/office/drawing/2014/main" id="{4AA64F95-30FE-4CB6-8D4B-49721D821D35}"/>
              </a:ext>
            </a:extLst>
          </p:cNvPr>
          <p:cNvSpPr txBox="1"/>
          <p:nvPr/>
        </p:nvSpPr>
        <p:spPr>
          <a:xfrm>
            <a:off x="11772704" y="26395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文本框 302">
            <a:extLst>
              <a:ext uri="{FF2B5EF4-FFF2-40B4-BE49-F238E27FC236}">
                <a16:creationId xmlns:a16="http://schemas.microsoft.com/office/drawing/2014/main" id="{E1A08582-B6AC-4FC0-B5E6-791E516F19AD}"/>
              </a:ext>
            </a:extLst>
          </p:cNvPr>
          <p:cNvSpPr txBox="1"/>
          <p:nvPr/>
        </p:nvSpPr>
        <p:spPr>
          <a:xfrm>
            <a:off x="11772704" y="22503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文本框 303">
            <a:extLst>
              <a:ext uri="{FF2B5EF4-FFF2-40B4-BE49-F238E27FC236}">
                <a16:creationId xmlns:a16="http://schemas.microsoft.com/office/drawing/2014/main" id="{ED0907FC-D356-46E9-9DCF-3A86792D5822}"/>
              </a:ext>
            </a:extLst>
          </p:cNvPr>
          <p:cNvSpPr txBox="1"/>
          <p:nvPr/>
        </p:nvSpPr>
        <p:spPr>
          <a:xfrm>
            <a:off x="11687744" y="18820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文本框 305">
            <a:extLst>
              <a:ext uri="{FF2B5EF4-FFF2-40B4-BE49-F238E27FC236}">
                <a16:creationId xmlns:a16="http://schemas.microsoft.com/office/drawing/2014/main" id="{4FBBE193-6A7B-4C2F-BFCD-CA295263A1EB}"/>
              </a:ext>
            </a:extLst>
          </p:cNvPr>
          <p:cNvSpPr txBox="1"/>
          <p:nvPr/>
        </p:nvSpPr>
        <p:spPr>
          <a:xfrm>
            <a:off x="10114184" y="38026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文本框 306">
            <a:extLst>
              <a:ext uri="{FF2B5EF4-FFF2-40B4-BE49-F238E27FC236}">
                <a16:creationId xmlns:a16="http://schemas.microsoft.com/office/drawing/2014/main" id="{8CB16B78-3957-4496-9E0A-2CA7032828D0}"/>
              </a:ext>
            </a:extLst>
          </p:cNvPr>
          <p:cNvSpPr txBox="1"/>
          <p:nvPr/>
        </p:nvSpPr>
        <p:spPr>
          <a:xfrm>
            <a:off x="10029226" y="3179018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文本框 307">
            <a:extLst>
              <a:ext uri="{FF2B5EF4-FFF2-40B4-BE49-F238E27FC236}">
                <a16:creationId xmlns:a16="http://schemas.microsoft.com/office/drawing/2014/main" id="{66E4B95D-B324-4A66-A4D3-1D2BB84E2399}"/>
              </a:ext>
            </a:extLst>
          </p:cNvPr>
          <p:cNvSpPr txBox="1"/>
          <p:nvPr/>
        </p:nvSpPr>
        <p:spPr>
          <a:xfrm>
            <a:off x="10029226" y="25284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文本框 310">
            <a:extLst>
              <a:ext uri="{FF2B5EF4-FFF2-40B4-BE49-F238E27FC236}">
                <a16:creationId xmlns:a16="http://schemas.microsoft.com/office/drawing/2014/main" id="{2556E26A-5463-4623-8ECE-81DBCB142CAE}"/>
              </a:ext>
            </a:extLst>
          </p:cNvPr>
          <p:cNvSpPr txBox="1"/>
          <p:nvPr/>
        </p:nvSpPr>
        <p:spPr>
          <a:xfrm>
            <a:off x="10029226" y="18820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文本框 370">
            <a:extLst>
              <a:ext uri="{FF2B5EF4-FFF2-40B4-BE49-F238E27FC236}">
                <a16:creationId xmlns:a16="http://schemas.microsoft.com/office/drawing/2014/main" id="{55CBF4FF-B0DE-418E-8738-3F9F99AE06EC}"/>
              </a:ext>
            </a:extLst>
          </p:cNvPr>
          <p:cNvSpPr txBox="1"/>
          <p:nvPr/>
        </p:nvSpPr>
        <p:spPr>
          <a:xfrm>
            <a:off x="2341467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文本框 371">
            <a:extLst>
              <a:ext uri="{FF2B5EF4-FFF2-40B4-BE49-F238E27FC236}">
                <a16:creationId xmlns:a16="http://schemas.microsoft.com/office/drawing/2014/main" id="{6473FF9A-E487-4E51-A9AE-C0E3BE0A5169}"/>
              </a:ext>
            </a:extLst>
          </p:cNvPr>
          <p:cNvSpPr txBox="1"/>
          <p:nvPr/>
        </p:nvSpPr>
        <p:spPr>
          <a:xfrm>
            <a:off x="2256509" y="67773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文本框 372">
            <a:extLst>
              <a:ext uri="{FF2B5EF4-FFF2-40B4-BE49-F238E27FC236}">
                <a16:creationId xmlns:a16="http://schemas.microsoft.com/office/drawing/2014/main" id="{62647401-59F7-4591-BBBD-82A10105EFB2}"/>
              </a:ext>
            </a:extLst>
          </p:cNvPr>
          <p:cNvSpPr txBox="1"/>
          <p:nvPr/>
        </p:nvSpPr>
        <p:spPr>
          <a:xfrm>
            <a:off x="2256509" y="63892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文本框 373">
            <a:extLst>
              <a:ext uri="{FF2B5EF4-FFF2-40B4-BE49-F238E27FC236}">
                <a16:creationId xmlns:a16="http://schemas.microsoft.com/office/drawing/2014/main" id="{550ADE30-0D82-4D46-AAC4-F023FB6CB639}"/>
              </a:ext>
            </a:extLst>
          </p:cNvPr>
          <p:cNvSpPr txBox="1"/>
          <p:nvPr/>
        </p:nvSpPr>
        <p:spPr>
          <a:xfrm>
            <a:off x="2256509" y="59923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文本框 374">
            <a:extLst>
              <a:ext uri="{FF2B5EF4-FFF2-40B4-BE49-F238E27FC236}">
                <a16:creationId xmlns:a16="http://schemas.microsoft.com/office/drawing/2014/main" id="{A4DE32AC-F0D4-461A-82D9-46DCAC031694}"/>
              </a:ext>
            </a:extLst>
          </p:cNvPr>
          <p:cNvSpPr txBox="1"/>
          <p:nvPr/>
        </p:nvSpPr>
        <p:spPr>
          <a:xfrm>
            <a:off x="2256509" y="56031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文本框 375">
            <a:extLst>
              <a:ext uri="{FF2B5EF4-FFF2-40B4-BE49-F238E27FC236}">
                <a16:creationId xmlns:a16="http://schemas.microsoft.com/office/drawing/2014/main" id="{98451141-8E86-4AB6-B953-1D00C20AE49B}"/>
              </a:ext>
            </a:extLst>
          </p:cNvPr>
          <p:cNvSpPr txBox="1"/>
          <p:nvPr/>
        </p:nvSpPr>
        <p:spPr>
          <a:xfrm>
            <a:off x="2171549" y="52348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文本框 364">
            <a:extLst>
              <a:ext uri="{FF2B5EF4-FFF2-40B4-BE49-F238E27FC236}">
                <a16:creationId xmlns:a16="http://schemas.microsoft.com/office/drawing/2014/main" id="{349A5406-0DCD-4A9E-B03F-ECCDEF22811D}"/>
              </a:ext>
            </a:extLst>
          </p:cNvPr>
          <p:cNvSpPr txBox="1"/>
          <p:nvPr/>
        </p:nvSpPr>
        <p:spPr>
          <a:xfrm>
            <a:off x="4144423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文本框 365">
            <a:extLst>
              <a:ext uri="{FF2B5EF4-FFF2-40B4-BE49-F238E27FC236}">
                <a16:creationId xmlns:a16="http://schemas.microsoft.com/office/drawing/2014/main" id="{13770A24-E64E-4633-B63A-C7DE6FA36A62}"/>
              </a:ext>
            </a:extLst>
          </p:cNvPr>
          <p:cNvSpPr txBox="1"/>
          <p:nvPr/>
        </p:nvSpPr>
        <p:spPr>
          <a:xfrm>
            <a:off x="4059465" y="67773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文本框 366">
            <a:extLst>
              <a:ext uri="{FF2B5EF4-FFF2-40B4-BE49-F238E27FC236}">
                <a16:creationId xmlns:a16="http://schemas.microsoft.com/office/drawing/2014/main" id="{589A99DE-8FA3-48B2-B895-A8B1AB45C5B6}"/>
              </a:ext>
            </a:extLst>
          </p:cNvPr>
          <p:cNvSpPr txBox="1"/>
          <p:nvPr/>
        </p:nvSpPr>
        <p:spPr>
          <a:xfrm>
            <a:off x="4059465" y="63892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文本框 367">
            <a:extLst>
              <a:ext uri="{FF2B5EF4-FFF2-40B4-BE49-F238E27FC236}">
                <a16:creationId xmlns:a16="http://schemas.microsoft.com/office/drawing/2014/main" id="{9D7C1E53-69BE-4607-9EAD-AB6D2F819FE5}"/>
              </a:ext>
            </a:extLst>
          </p:cNvPr>
          <p:cNvSpPr txBox="1"/>
          <p:nvPr/>
        </p:nvSpPr>
        <p:spPr>
          <a:xfrm>
            <a:off x="4059465" y="59923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文本框 368">
            <a:extLst>
              <a:ext uri="{FF2B5EF4-FFF2-40B4-BE49-F238E27FC236}">
                <a16:creationId xmlns:a16="http://schemas.microsoft.com/office/drawing/2014/main" id="{F895B95E-7AD5-46B4-9D59-D0345CB5AAB6}"/>
              </a:ext>
            </a:extLst>
          </p:cNvPr>
          <p:cNvSpPr txBox="1"/>
          <p:nvPr/>
        </p:nvSpPr>
        <p:spPr>
          <a:xfrm>
            <a:off x="4059465" y="56031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文本框 369">
            <a:extLst>
              <a:ext uri="{FF2B5EF4-FFF2-40B4-BE49-F238E27FC236}">
                <a16:creationId xmlns:a16="http://schemas.microsoft.com/office/drawing/2014/main" id="{D06F8DC9-1158-4F19-B3B1-05FD8F651C88}"/>
              </a:ext>
            </a:extLst>
          </p:cNvPr>
          <p:cNvSpPr txBox="1"/>
          <p:nvPr/>
        </p:nvSpPr>
        <p:spPr>
          <a:xfrm>
            <a:off x="3974505" y="52348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文本框 358">
            <a:extLst>
              <a:ext uri="{FF2B5EF4-FFF2-40B4-BE49-F238E27FC236}">
                <a16:creationId xmlns:a16="http://schemas.microsoft.com/office/drawing/2014/main" id="{C037F999-2C49-4ACC-BE89-0CEEDF54AFE1}"/>
              </a:ext>
            </a:extLst>
          </p:cNvPr>
          <p:cNvSpPr txBox="1"/>
          <p:nvPr/>
        </p:nvSpPr>
        <p:spPr>
          <a:xfrm>
            <a:off x="5939579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文本框 359">
            <a:extLst>
              <a:ext uri="{FF2B5EF4-FFF2-40B4-BE49-F238E27FC236}">
                <a16:creationId xmlns:a16="http://schemas.microsoft.com/office/drawing/2014/main" id="{0E4C0BB7-1029-4A4C-A84E-340CBABF9114}"/>
              </a:ext>
            </a:extLst>
          </p:cNvPr>
          <p:cNvSpPr txBox="1"/>
          <p:nvPr/>
        </p:nvSpPr>
        <p:spPr>
          <a:xfrm>
            <a:off x="5854621" y="67773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文本框 360">
            <a:extLst>
              <a:ext uri="{FF2B5EF4-FFF2-40B4-BE49-F238E27FC236}">
                <a16:creationId xmlns:a16="http://schemas.microsoft.com/office/drawing/2014/main" id="{395404D8-EFD2-42E1-B038-F55D498538EB}"/>
              </a:ext>
            </a:extLst>
          </p:cNvPr>
          <p:cNvSpPr txBox="1"/>
          <p:nvPr/>
        </p:nvSpPr>
        <p:spPr>
          <a:xfrm>
            <a:off x="5854621" y="63892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文本框 361">
            <a:extLst>
              <a:ext uri="{FF2B5EF4-FFF2-40B4-BE49-F238E27FC236}">
                <a16:creationId xmlns:a16="http://schemas.microsoft.com/office/drawing/2014/main" id="{70B0979C-ECF7-46E5-B2EE-2E27F0EDBEAF}"/>
              </a:ext>
            </a:extLst>
          </p:cNvPr>
          <p:cNvSpPr txBox="1"/>
          <p:nvPr/>
        </p:nvSpPr>
        <p:spPr>
          <a:xfrm>
            <a:off x="5854621" y="59923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文本框 362">
            <a:extLst>
              <a:ext uri="{FF2B5EF4-FFF2-40B4-BE49-F238E27FC236}">
                <a16:creationId xmlns:a16="http://schemas.microsoft.com/office/drawing/2014/main" id="{11D83C34-BE2A-4D4B-B18B-90374C33ED7C}"/>
              </a:ext>
            </a:extLst>
          </p:cNvPr>
          <p:cNvSpPr txBox="1"/>
          <p:nvPr/>
        </p:nvSpPr>
        <p:spPr>
          <a:xfrm>
            <a:off x="5854621" y="56031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文本框 363">
            <a:extLst>
              <a:ext uri="{FF2B5EF4-FFF2-40B4-BE49-F238E27FC236}">
                <a16:creationId xmlns:a16="http://schemas.microsoft.com/office/drawing/2014/main" id="{A14304EE-EBE4-4210-BF0E-5EB84107AFF6}"/>
              </a:ext>
            </a:extLst>
          </p:cNvPr>
          <p:cNvSpPr txBox="1"/>
          <p:nvPr/>
        </p:nvSpPr>
        <p:spPr>
          <a:xfrm>
            <a:off x="5769661" y="52348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文本框 353">
            <a:extLst>
              <a:ext uri="{FF2B5EF4-FFF2-40B4-BE49-F238E27FC236}">
                <a16:creationId xmlns:a16="http://schemas.microsoft.com/office/drawing/2014/main" id="{6E4342D9-1A63-485E-8B2D-1C61BBBA806C}"/>
              </a:ext>
            </a:extLst>
          </p:cNvPr>
          <p:cNvSpPr txBox="1"/>
          <p:nvPr/>
        </p:nvSpPr>
        <p:spPr>
          <a:xfrm>
            <a:off x="8341749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文本框 354">
            <a:extLst>
              <a:ext uri="{FF2B5EF4-FFF2-40B4-BE49-F238E27FC236}">
                <a16:creationId xmlns:a16="http://schemas.microsoft.com/office/drawing/2014/main" id="{EDA5767B-D3B3-4A57-B03C-589B584D9D4F}"/>
              </a:ext>
            </a:extLst>
          </p:cNvPr>
          <p:cNvSpPr txBox="1"/>
          <p:nvPr/>
        </p:nvSpPr>
        <p:spPr>
          <a:xfrm>
            <a:off x="8256791" y="67003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文本框 355">
            <a:extLst>
              <a:ext uri="{FF2B5EF4-FFF2-40B4-BE49-F238E27FC236}">
                <a16:creationId xmlns:a16="http://schemas.microsoft.com/office/drawing/2014/main" id="{A7B5EF70-9180-422D-8A41-E0A764E234A0}"/>
              </a:ext>
            </a:extLst>
          </p:cNvPr>
          <p:cNvSpPr txBox="1"/>
          <p:nvPr/>
        </p:nvSpPr>
        <p:spPr>
          <a:xfrm>
            <a:off x="8247166" y="62040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文本框 356">
            <a:extLst>
              <a:ext uri="{FF2B5EF4-FFF2-40B4-BE49-F238E27FC236}">
                <a16:creationId xmlns:a16="http://schemas.microsoft.com/office/drawing/2014/main" id="{9EE803F1-4780-4720-9BE2-9CE9E7E95A68}"/>
              </a:ext>
            </a:extLst>
          </p:cNvPr>
          <p:cNvSpPr txBox="1"/>
          <p:nvPr/>
        </p:nvSpPr>
        <p:spPr>
          <a:xfrm>
            <a:off x="8256791" y="57283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文本框 357">
            <a:extLst>
              <a:ext uri="{FF2B5EF4-FFF2-40B4-BE49-F238E27FC236}">
                <a16:creationId xmlns:a16="http://schemas.microsoft.com/office/drawing/2014/main" id="{C55ED207-AA80-4882-A813-DC48CF439E55}"/>
              </a:ext>
            </a:extLst>
          </p:cNvPr>
          <p:cNvSpPr txBox="1"/>
          <p:nvPr/>
        </p:nvSpPr>
        <p:spPr>
          <a:xfrm>
            <a:off x="8256791" y="5234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文本框 347">
            <a:extLst>
              <a:ext uri="{FF2B5EF4-FFF2-40B4-BE49-F238E27FC236}">
                <a16:creationId xmlns:a16="http://schemas.microsoft.com/office/drawing/2014/main" id="{54E0DE7A-71FC-427C-B1D4-DE10D10AEDCF}"/>
              </a:ext>
            </a:extLst>
          </p:cNvPr>
          <p:cNvSpPr txBox="1"/>
          <p:nvPr/>
        </p:nvSpPr>
        <p:spPr>
          <a:xfrm>
            <a:off x="11857662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文本框 348">
            <a:extLst>
              <a:ext uri="{FF2B5EF4-FFF2-40B4-BE49-F238E27FC236}">
                <a16:creationId xmlns:a16="http://schemas.microsoft.com/office/drawing/2014/main" id="{F55B8301-F9EA-4AC2-8AB4-8662EE11B47E}"/>
              </a:ext>
            </a:extLst>
          </p:cNvPr>
          <p:cNvSpPr txBox="1"/>
          <p:nvPr/>
        </p:nvSpPr>
        <p:spPr>
          <a:xfrm>
            <a:off x="11772704" y="67773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文本框 349">
            <a:extLst>
              <a:ext uri="{FF2B5EF4-FFF2-40B4-BE49-F238E27FC236}">
                <a16:creationId xmlns:a16="http://schemas.microsoft.com/office/drawing/2014/main" id="{E1EC8620-2C6A-4891-A552-65E3AF51B942}"/>
              </a:ext>
            </a:extLst>
          </p:cNvPr>
          <p:cNvSpPr txBox="1"/>
          <p:nvPr/>
        </p:nvSpPr>
        <p:spPr>
          <a:xfrm>
            <a:off x="11772704" y="63892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文本框 350">
            <a:extLst>
              <a:ext uri="{FF2B5EF4-FFF2-40B4-BE49-F238E27FC236}">
                <a16:creationId xmlns:a16="http://schemas.microsoft.com/office/drawing/2014/main" id="{425ED516-251B-4A43-8C09-2F1F919D115D}"/>
              </a:ext>
            </a:extLst>
          </p:cNvPr>
          <p:cNvSpPr txBox="1"/>
          <p:nvPr/>
        </p:nvSpPr>
        <p:spPr>
          <a:xfrm>
            <a:off x="11772704" y="59923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文本框 351">
            <a:extLst>
              <a:ext uri="{FF2B5EF4-FFF2-40B4-BE49-F238E27FC236}">
                <a16:creationId xmlns:a16="http://schemas.microsoft.com/office/drawing/2014/main" id="{BA3EF11B-0786-45BF-8D84-28B674511EFE}"/>
              </a:ext>
            </a:extLst>
          </p:cNvPr>
          <p:cNvSpPr txBox="1"/>
          <p:nvPr/>
        </p:nvSpPr>
        <p:spPr>
          <a:xfrm>
            <a:off x="11772704" y="56031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文本框 352">
            <a:extLst>
              <a:ext uri="{FF2B5EF4-FFF2-40B4-BE49-F238E27FC236}">
                <a16:creationId xmlns:a16="http://schemas.microsoft.com/office/drawing/2014/main" id="{3A10831E-AB6B-4D3F-B7FD-F4F5263D49D9}"/>
              </a:ext>
            </a:extLst>
          </p:cNvPr>
          <p:cNvSpPr txBox="1"/>
          <p:nvPr/>
        </p:nvSpPr>
        <p:spPr>
          <a:xfrm>
            <a:off x="11687744" y="52348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文本框 343">
            <a:extLst>
              <a:ext uri="{FF2B5EF4-FFF2-40B4-BE49-F238E27FC236}">
                <a16:creationId xmlns:a16="http://schemas.microsoft.com/office/drawing/2014/main" id="{7FDA8545-2A1D-4937-8AC2-837F99335A23}"/>
              </a:ext>
            </a:extLst>
          </p:cNvPr>
          <p:cNvSpPr txBox="1"/>
          <p:nvPr/>
        </p:nvSpPr>
        <p:spPr>
          <a:xfrm>
            <a:off x="10114184" y="7155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文本框 344">
            <a:extLst>
              <a:ext uri="{FF2B5EF4-FFF2-40B4-BE49-F238E27FC236}">
                <a16:creationId xmlns:a16="http://schemas.microsoft.com/office/drawing/2014/main" id="{9B3629BA-B58A-4E50-B4F7-3CCC4F9C5354}"/>
              </a:ext>
            </a:extLst>
          </p:cNvPr>
          <p:cNvSpPr txBox="1"/>
          <p:nvPr/>
        </p:nvSpPr>
        <p:spPr>
          <a:xfrm>
            <a:off x="10029226" y="6531818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文本框 345">
            <a:extLst>
              <a:ext uri="{FF2B5EF4-FFF2-40B4-BE49-F238E27FC236}">
                <a16:creationId xmlns:a16="http://schemas.microsoft.com/office/drawing/2014/main" id="{7A61AB28-A484-4966-A82D-388D4A06F85B}"/>
              </a:ext>
            </a:extLst>
          </p:cNvPr>
          <p:cNvSpPr txBox="1"/>
          <p:nvPr/>
        </p:nvSpPr>
        <p:spPr>
          <a:xfrm>
            <a:off x="10029226" y="58812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文本框 346">
            <a:extLst>
              <a:ext uri="{FF2B5EF4-FFF2-40B4-BE49-F238E27FC236}">
                <a16:creationId xmlns:a16="http://schemas.microsoft.com/office/drawing/2014/main" id="{F5E09569-B5EC-4364-9E6B-1BB47456F21B}"/>
              </a:ext>
            </a:extLst>
          </p:cNvPr>
          <p:cNvSpPr txBox="1"/>
          <p:nvPr/>
        </p:nvSpPr>
        <p:spPr>
          <a:xfrm>
            <a:off x="10029226" y="5234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553D45BB-AFA4-4249-856A-F96E9FF0F75C}"/>
              </a:ext>
            </a:extLst>
          </p:cNvPr>
          <p:cNvSpPr txBox="1"/>
          <p:nvPr/>
        </p:nvSpPr>
        <p:spPr>
          <a:xfrm>
            <a:off x="1087394" y="7971861"/>
            <a:ext cx="1284252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108849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correlation of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GATA3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enotype with MRD level among CCCG-ALL-2015 and GD-ALL-2008 study cohorts.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3488352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A53B1E5-6C3F-407E-ADDB-82CA4B201BCD}"/>
              </a:ext>
            </a:extLst>
          </p:cNvPr>
          <p:cNvSpPr txBox="1"/>
          <p:nvPr/>
        </p:nvSpPr>
        <p:spPr>
          <a:xfrm>
            <a:off x="4365513" y="2164217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M189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415F7CD9-9750-4C5F-B4DE-6F55032EEB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7496714"/>
              </p:ext>
            </p:extLst>
          </p:nvPr>
        </p:nvGraphicFramePr>
        <p:xfrm>
          <a:off x="4302478" y="2410705"/>
          <a:ext cx="1444625" cy="21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1445225" imgH="2476764" progId="Prism7.Document">
                  <p:embed/>
                </p:oleObj>
              </mc:Choice>
              <mc:Fallback>
                <p:oleObj name="Prism 7" r:id="rId2" imgW="1445225" imgH="2476764" progId="Prism7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415F7CD9-9750-4C5F-B4DE-6F55032EEB0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02478" y="2410705"/>
                        <a:ext cx="1444625" cy="21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" name="组合 16">
            <a:extLst>
              <a:ext uri="{FF2B5EF4-FFF2-40B4-BE49-F238E27FC236}">
                <a16:creationId xmlns:a16="http://schemas.microsoft.com/office/drawing/2014/main" id="{EFB0F145-674D-4232-9411-83B5182805BB}"/>
              </a:ext>
            </a:extLst>
          </p:cNvPr>
          <p:cNvGrpSpPr/>
          <p:nvPr/>
        </p:nvGrpSpPr>
        <p:grpSpPr>
          <a:xfrm>
            <a:off x="4477599" y="4524401"/>
            <a:ext cx="1125950" cy="617777"/>
            <a:chOff x="2987047" y="3877713"/>
            <a:chExt cx="1125950" cy="617777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CB57EA0D-B7AD-40E8-BB88-FC97FC920B6A}"/>
                </a:ext>
              </a:extLst>
            </p:cNvPr>
            <p:cNvSpPr txBox="1"/>
            <p:nvPr/>
          </p:nvSpPr>
          <p:spPr>
            <a:xfrm>
              <a:off x="3817723" y="387771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422EDA3-BB86-4162-8533-EA85763017C8}"/>
                </a:ext>
              </a:extLst>
            </p:cNvPr>
            <p:cNvSpPr txBox="1"/>
            <p:nvPr/>
          </p:nvSpPr>
          <p:spPr>
            <a:xfrm>
              <a:off x="3437649" y="3877713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38D9886-8C4D-4445-81D6-5A5661BA11B7}"/>
                </a:ext>
              </a:extLst>
            </p:cNvPr>
            <p:cNvSpPr txBox="1"/>
            <p:nvPr/>
          </p:nvSpPr>
          <p:spPr>
            <a:xfrm>
              <a:off x="2987047" y="3877713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876EDC17-0E4D-491C-A768-3ADBACF50CB4}"/>
                </a:ext>
              </a:extLst>
            </p:cNvPr>
            <p:cNvGrpSpPr/>
            <p:nvPr/>
          </p:nvGrpSpPr>
          <p:grpSpPr>
            <a:xfrm>
              <a:off x="3006038" y="4154712"/>
              <a:ext cx="1092824" cy="340778"/>
              <a:chOff x="3006038" y="4154712"/>
              <a:chExt cx="1092824" cy="340778"/>
            </a:xfrm>
          </p:grpSpPr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5723785D-1685-48F2-8179-5A74DD3B62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06038" y="4154712"/>
                <a:ext cx="10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EFE6269F-73CB-42B9-B5DB-270C8ADF53BD}"/>
                  </a:ext>
                </a:extLst>
              </p:cNvPr>
              <p:cNvSpPr txBox="1"/>
              <p:nvPr/>
            </p:nvSpPr>
            <p:spPr>
              <a:xfrm>
                <a:off x="3069413" y="4187713"/>
                <a:ext cx="10294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s3781093</a:t>
                </a:r>
              </a:p>
            </p:txBody>
          </p:sp>
        </p:grpSp>
      </p:grpSp>
      <p:sp>
        <p:nvSpPr>
          <p:cNvPr id="18" name="TextBox 5">
            <a:extLst>
              <a:ext uri="{FF2B5EF4-FFF2-40B4-BE49-F238E27FC236}">
                <a16:creationId xmlns:a16="http://schemas.microsoft.com/office/drawing/2014/main" id="{821AEB1F-913F-4D75-AE82-60967330B12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63989" y="3393238"/>
            <a:ext cx="160813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Luciferase activity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609574A-39E1-4F63-ACB4-2733466DABCF}"/>
              </a:ext>
            </a:extLst>
          </p:cNvPr>
          <p:cNvSpPr txBox="1"/>
          <p:nvPr/>
        </p:nvSpPr>
        <p:spPr>
          <a:xfrm>
            <a:off x="4174683" y="42938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B45E979-E20E-4DA6-B437-43359A2FA7EA}"/>
              </a:ext>
            </a:extLst>
          </p:cNvPr>
          <p:cNvSpPr txBox="1"/>
          <p:nvPr/>
        </p:nvSpPr>
        <p:spPr>
          <a:xfrm>
            <a:off x="4046443" y="384624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82C47D8-EBE1-4C4D-BD9E-226A3A2E02D9}"/>
              </a:ext>
            </a:extLst>
          </p:cNvPr>
          <p:cNvSpPr txBox="1"/>
          <p:nvPr/>
        </p:nvSpPr>
        <p:spPr>
          <a:xfrm>
            <a:off x="4046443" y="2934082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B9667E1-406E-4321-B9FB-5F00DC099C3D}"/>
              </a:ext>
            </a:extLst>
          </p:cNvPr>
          <p:cNvSpPr txBox="1"/>
          <p:nvPr/>
        </p:nvSpPr>
        <p:spPr>
          <a:xfrm>
            <a:off x="3979663" y="2484099"/>
            <a:ext cx="464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F4949B7-58B7-4828-91AD-9CCDEA0D4B3D}"/>
              </a:ext>
            </a:extLst>
          </p:cNvPr>
          <p:cNvSpPr txBox="1"/>
          <p:nvPr/>
        </p:nvSpPr>
        <p:spPr>
          <a:xfrm>
            <a:off x="5036590" y="2387330"/>
            <a:ext cx="425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DFA696E-7DAC-42E3-9B08-057C5BE04A31}"/>
              </a:ext>
            </a:extLst>
          </p:cNvPr>
          <p:cNvSpPr txBox="1"/>
          <p:nvPr/>
        </p:nvSpPr>
        <p:spPr>
          <a:xfrm>
            <a:off x="4046443" y="3389455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ACCBED3-BCA0-449F-82F9-ACD276F20EFB}"/>
              </a:ext>
            </a:extLst>
          </p:cNvPr>
          <p:cNvSpPr txBox="1"/>
          <p:nvPr/>
        </p:nvSpPr>
        <p:spPr>
          <a:xfrm>
            <a:off x="1177514" y="250089"/>
            <a:ext cx="36086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1DFD81D9-0A68-41A1-B55D-DB9D48F65573}"/>
              </a:ext>
            </a:extLst>
          </p:cNvPr>
          <p:cNvSpPr txBox="1"/>
          <p:nvPr/>
        </p:nvSpPr>
        <p:spPr>
          <a:xfrm>
            <a:off x="671206" y="5634519"/>
            <a:ext cx="12334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Luciferase reporter assay comparing the enhancer activities of the fragments containing either the rs3781093 risk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C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llele or wild type T allele in GM18900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,</a:t>
            </a:r>
            <a:r>
              <a:rPr lang="zh-CN" alt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Nalm6, and Reh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cells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51E697D2-E217-4547-9938-366F635C4657}"/>
              </a:ext>
            </a:extLst>
          </p:cNvPr>
          <p:cNvSpPr txBox="1"/>
          <p:nvPr/>
        </p:nvSpPr>
        <p:spPr>
          <a:xfrm>
            <a:off x="6648710" y="2164217"/>
            <a:ext cx="857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M189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3" name="对象 92">
            <a:extLst>
              <a:ext uri="{FF2B5EF4-FFF2-40B4-BE49-F238E27FC236}">
                <a16:creationId xmlns:a16="http://schemas.microsoft.com/office/drawing/2014/main" id="{D5E9DB4F-150E-4658-A1D7-C95F1AEFC9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7609445"/>
              </p:ext>
            </p:extLst>
          </p:nvPr>
        </p:nvGraphicFramePr>
        <p:xfrm>
          <a:off x="6500144" y="2403093"/>
          <a:ext cx="1444625" cy="21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1445225" imgH="2476764" progId="Prism7.Document">
                  <p:embed/>
                </p:oleObj>
              </mc:Choice>
              <mc:Fallback>
                <p:oleObj name="Prism 7" r:id="rId2" imgW="1445225" imgH="2476764" progId="Prism7.Document">
                  <p:embed/>
                  <p:pic>
                    <p:nvPicPr>
                      <p:cNvPr id="93" name="对象 92">
                        <a:extLst>
                          <a:ext uri="{FF2B5EF4-FFF2-40B4-BE49-F238E27FC236}">
                            <a16:creationId xmlns:a16="http://schemas.microsoft.com/office/drawing/2014/main" id="{D5E9DB4F-150E-4658-A1D7-C95F1AEFC9F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00144" y="2403093"/>
                        <a:ext cx="1444625" cy="21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4" name="组合 93">
            <a:extLst>
              <a:ext uri="{FF2B5EF4-FFF2-40B4-BE49-F238E27FC236}">
                <a16:creationId xmlns:a16="http://schemas.microsoft.com/office/drawing/2014/main" id="{F5555769-8BE3-4498-BFF2-06C639498C51}"/>
              </a:ext>
            </a:extLst>
          </p:cNvPr>
          <p:cNvGrpSpPr/>
          <p:nvPr/>
        </p:nvGrpSpPr>
        <p:grpSpPr>
          <a:xfrm>
            <a:off x="6675265" y="4516789"/>
            <a:ext cx="1125950" cy="617777"/>
            <a:chOff x="2987047" y="3877713"/>
            <a:chExt cx="1125950" cy="617777"/>
          </a:xfrm>
        </p:grpSpPr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402CE2B4-8B9A-4E18-B961-027236808F87}"/>
                </a:ext>
              </a:extLst>
            </p:cNvPr>
            <p:cNvSpPr txBox="1"/>
            <p:nvPr/>
          </p:nvSpPr>
          <p:spPr>
            <a:xfrm>
              <a:off x="3817723" y="387771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8AD6E0B9-512B-4110-BE7C-A2166B781AD7}"/>
                </a:ext>
              </a:extLst>
            </p:cNvPr>
            <p:cNvSpPr txBox="1"/>
            <p:nvPr/>
          </p:nvSpPr>
          <p:spPr>
            <a:xfrm>
              <a:off x="3437649" y="3877713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2857AC52-7BB8-432A-9C2B-BC406DE4BDAC}"/>
                </a:ext>
              </a:extLst>
            </p:cNvPr>
            <p:cNvSpPr txBox="1"/>
            <p:nvPr/>
          </p:nvSpPr>
          <p:spPr>
            <a:xfrm>
              <a:off x="2987047" y="3877713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C114F81A-DBB2-4D93-B582-CF550851D24D}"/>
                </a:ext>
              </a:extLst>
            </p:cNvPr>
            <p:cNvGrpSpPr/>
            <p:nvPr/>
          </p:nvGrpSpPr>
          <p:grpSpPr>
            <a:xfrm>
              <a:off x="3006038" y="4154712"/>
              <a:ext cx="1092824" cy="340778"/>
              <a:chOff x="3006038" y="4154712"/>
              <a:chExt cx="1092824" cy="340778"/>
            </a:xfrm>
          </p:grpSpPr>
          <p:cxnSp>
            <p:nvCxnSpPr>
              <p:cNvPr id="106" name="直接连接符 105">
                <a:extLst>
                  <a:ext uri="{FF2B5EF4-FFF2-40B4-BE49-F238E27FC236}">
                    <a16:creationId xmlns:a16="http://schemas.microsoft.com/office/drawing/2014/main" id="{BAD2E6CC-D3B1-4A3D-8DA3-C97A9671B1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06038" y="4154712"/>
                <a:ext cx="10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B0031FA6-971E-4731-B873-C523A07CFB2F}"/>
                  </a:ext>
                </a:extLst>
              </p:cNvPr>
              <p:cNvSpPr txBox="1"/>
              <p:nvPr/>
            </p:nvSpPr>
            <p:spPr>
              <a:xfrm>
                <a:off x="3069413" y="4187713"/>
                <a:ext cx="10294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s3781093</a:t>
                </a:r>
              </a:p>
            </p:txBody>
          </p:sp>
        </p:grpSp>
      </p:grpSp>
      <p:sp>
        <p:nvSpPr>
          <p:cNvPr id="95" name="TextBox 5">
            <a:extLst>
              <a:ext uri="{FF2B5EF4-FFF2-40B4-BE49-F238E27FC236}">
                <a16:creationId xmlns:a16="http://schemas.microsoft.com/office/drawing/2014/main" id="{3AB244C9-E808-406D-BAE7-A94D4E8B867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361655" y="3385626"/>
            <a:ext cx="160813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Luciferase activity</a:t>
            </a: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4DAB25F3-72B3-40AC-8190-9991B687270E}"/>
              </a:ext>
            </a:extLst>
          </p:cNvPr>
          <p:cNvSpPr txBox="1"/>
          <p:nvPr/>
        </p:nvSpPr>
        <p:spPr>
          <a:xfrm>
            <a:off x="6372349" y="42861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2D214DB9-18EA-4DE0-8845-529854ED9B0F}"/>
              </a:ext>
            </a:extLst>
          </p:cNvPr>
          <p:cNvSpPr txBox="1"/>
          <p:nvPr/>
        </p:nvSpPr>
        <p:spPr>
          <a:xfrm>
            <a:off x="6244109" y="383862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E2E5E1F9-0C16-4D91-87D1-022DE4850DAD}"/>
              </a:ext>
            </a:extLst>
          </p:cNvPr>
          <p:cNvSpPr txBox="1"/>
          <p:nvPr/>
        </p:nvSpPr>
        <p:spPr>
          <a:xfrm>
            <a:off x="6244109" y="2926470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AF6D4869-3647-4339-A17D-116369FDAC73}"/>
              </a:ext>
            </a:extLst>
          </p:cNvPr>
          <p:cNvSpPr txBox="1"/>
          <p:nvPr/>
        </p:nvSpPr>
        <p:spPr>
          <a:xfrm>
            <a:off x="6177329" y="2476487"/>
            <a:ext cx="464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837A38FC-29DB-41E2-B4B0-055EC722ACBD}"/>
              </a:ext>
            </a:extLst>
          </p:cNvPr>
          <p:cNvSpPr txBox="1"/>
          <p:nvPr/>
        </p:nvSpPr>
        <p:spPr>
          <a:xfrm>
            <a:off x="7234256" y="2379718"/>
            <a:ext cx="425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524F9A88-7916-4592-817B-82D212A57B46}"/>
              </a:ext>
            </a:extLst>
          </p:cNvPr>
          <p:cNvSpPr txBox="1"/>
          <p:nvPr/>
        </p:nvSpPr>
        <p:spPr>
          <a:xfrm>
            <a:off x="6244109" y="3381843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9" name="对象 108">
            <a:extLst>
              <a:ext uri="{FF2B5EF4-FFF2-40B4-BE49-F238E27FC236}">
                <a16:creationId xmlns:a16="http://schemas.microsoft.com/office/drawing/2014/main" id="{0B299B12-0DE2-4B22-BEDE-C8FD97742C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1511167"/>
              </p:ext>
            </p:extLst>
          </p:nvPr>
        </p:nvGraphicFramePr>
        <p:xfrm>
          <a:off x="8841106" y="2405593"/>
          <a:ext cx="1444625" cy="21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1445225" imgH="2476764" progId="Prism7.Document">
                  <p:embed/>
                </p:oleObj>
              </mc:Choice>
              <mc:Fallback>
                <p:oleObj name="Prism 7" r:id="rId2" imgW="1445225" imgH="2476764" progId="Prism7.Document">
                  <p:embed/>
                  <p:pic>
                    <p:nvPicPr>
                      <p:cNvPr id="109" name="对象 108">
                        <a:extLst>
                          <a:ext uri="{FF2B5EF4-FFF2-40B4-BE49-F238E27FC236}">
                            <a16:creationId xmlns:a16="http://schemas.microsoft.com/office/drawing/2014/main" id="{0B299B12-0DE2-4B22-BEDE-C8FD97742C5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841106" y="2405593"/>
                        <a:ext cx="1444625" cy="21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0" name="组合 109">
            <a:extLst>
              <a:ext uri="{FF2B5EF4-FFF2-40B4-BE49-F238E27FC236}">
                <a16:creationId xmlns:a16="http://schemas.microsoft.com/office/drawing/2014/main" id="{FD2B0CBB-DA58-4FB8-80DA-481C9A51A648}"/>
              </a:ext>
            </a:extLst>
          </p:cNvPr>
          <p:cNvGrpSpPr/>
          <p:nvPr/>
        </p:nvGrpSpPr>
        <p:grpSpPr>
          <a:xfrm>
            <a:off x="9016227" y="4519289"/>
            <a:ext cx="1125950" cy="617777"/>
            <a:chOff x="2987047" y="3877713"/>
            <a:chExt cx="1125950" cy="617777"/>
          </a:xfrm>
        </p:grpSpPr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35397D77-63AD-4926-8202-BEA1E240A05C}"/>
                </a:ext>
              </a:extLst>
            </p:cNvPr>
            <p:cNvSpPr txBox="1"/>
            <p:nvPr/>
          </p:nvSpPr>
          <p:spPr>
            <a:xfrm>
              <a:off x="3817723" y="387771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7B3C0B63-7CBC-4040-BBA0-806FA252EFA3}"/>
                </a:ext>
              </a:extLst>
            </p:cNvPr>
            <p:cNvSpPr txBox="1"/>
            <p:nvPr/>
          </p:nvSpPr>
          <p:spPr>
            <a:xfrm>
              <a:off x="3437649" y="3877713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CF9605DF-1752-4687-8713-FE79B38EA4DC}"/>
                </a:ext>
              </a:extLst>
            </p:cNvPr>
            <p:cNvSpPr txBox="1"/>
            <p:nvPr/>
          </p:nvSpPr>
          <p:spPr>
            <a:xfrm>
              <a:off x="2987047" y="3877713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2440A6FF-D484-4F9B-B4A5-475BB1EE1EED}"/>
                </a:ext>
              </a:extLst>
            </p:cNvPr>
            <p:cNvGrpSpPr/>
            <p:nvPr/>
          </p:nvGrpSpPr>
          <p:grpSpPr>
            <a:xfrm>
              <a:off x="3006038" y="4154712"/>
              <a:ext cx="1092824" cy="340778"/>
              <a:chOff x="3006038" y="4154712"/>
              <a:chExt cx="1092824" cy="340778"/>
            </a:xfrm>
          </p:grpSpPr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E9C0CD36-810D-4AF4-9D0E-1C8DAE8E80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06038" y="4154712"/>
                <a:ext cx="10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D4D3530D-211E-43BC-979C-FED5EDCA835F}"/>
                  </a:ext>
                </a:extLst>
              </p:cNvPr>
              <p:cNvSpPr txBox="1"/>
              <p:nvPr/>
            </p:nvSpPr>
            <p:spPr>
              <a:xfrm>
                <a:off x="3069413" y="4187713"/>
                <a:ext cx="10294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s3781093</a:t>
                </a:r>
              </a:p>
            </p:txBody>
          </p:sp>
        </p:grpSp>
      </p:grpSp>
      <p:sp>
        <p:nvSpPr>
          <p:cNvPr id="111" name="TextBox 5">
            <a:extLst>
              <a:ext uri="{FF2B5EF4-FFF2-40B4-BE49-F238E27FC236}">
                <a16:creationId xmlns:a16="http://schemas.microsoft.com/office/drawing/2014/main" id="{11CF06A7-6F87-431C-81FE-A8B5E2EDA63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702617" y="3388126"/>
            <a:ext cx="160813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Luciferase activity</a:t>
            </a: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1C386595-C74F-45CA-9967-A36FA4E35B69}"/>
              </a:ext>
            </a:extLst>
          </p:cNvPr>
          <p:cNvSpPr txBox="1"/>
          <p:nvPr/>
        </p:nvSpPr>
        <p:spPr>
          <a:xfrm>
            <a:off x="8713311" y="42886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07F7DAC8-C0F0-446D-B6FF-06801D2C8B51}"/>
              </a:ext>
            </a:extLst>
          </p:cNvPr>
          <p:cNvSpPr txBox="1"/>
          <p:nvPr/>
        </p:nvSpPr>
        <p:spPr>
          <a:xfrm>
            <a:off x="8585071" y="384112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EF3F9733-F4CD-4428-B79C-073DA82F1F77}"/>
              </a:ext>
            </a:extLst>
          </p:cNvPr>
          <p:cNvSpPr txBox="1"/>
          <p:nvPr/>
        </p:nvSpPr>
        <p:spPr>
          <a:xfrm>
            <a:off x="8585071" y="2928970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DBAA551A-9599-435D-8AD3-F985EB252126}"/>
              </a:ext>
            </a:extLst>
          </p:cNvPr>
          <p:cNvSpPr txBox="1"/>
          <p:nvPr/>
        </p:nvSpPr>
        <p:spPr>
          <a:xfrm>
            <a:off x="8518291" y="2478987"/>
            <a:ext cx="464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0A5FC626-547D-4E92-AF90-C21F5330DE18}"/>
              </a:ext>
            </a:extLst>
          </p:cNvPr>
          <p:cNvSpPr txBox="1"/>
          <p:nvPr/>
        </p:nvSpPr>
        <p:spPr>
          <a:xfrm>
            <a:off x="9575218" y="2382218"/>
            <a:ext cx="425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0B21C1B4-4B33-4453-BA68-C79832C706A0}"/>
              </a:ext>
            </a:extLst>
          </p:cNvPr>
          <p:cNvSpPr txBox="1"/>
          <p:nvPr/>
        </p:nvSpPr>
        <p:spPr>
          <a:xfrm>
            <a:off x="8585071" y="3384343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7F31D952-B3B2-49F4-A011-8AB58422F71B}"/>
              </a:ext>
            </a:extLst>
          </p:cNvPr>
          <p:cNvSpPr txBox="1"/>
          <p:nvPr/>
        </p:nvSpPr>
        <p:spPr>
          <a:xfrm>
            <a:off x="8909104" y="2164217"/>
            <a:ext cx="857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M189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26135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32">
            <a:extLst>
              <a:ext uri="{FF2B5EF4-FFF2-40B4-BE49-F238E27FC236}">
                <a16:creationId xmlns:a16="http://schemas.microsoft.com/office/drawing/2014/main" id="{FACCBED3-BCA0-449F-82F9-ACD276F20EFB}"/>
              </a:ext>
            </a:extLst>
          </p:cNvPr>
          <p:cNvSpPr txBox="1"/>
          <p:nvPr/>
        </p:nvSpPr>
        <p:spPr>
          <a:xfrm>
            <a:off x="1177514" y="250089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2AE9B9E-6C90-4ECA-9BDC-5EC4705DA4A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08" t="70308" r="38611" b="17778"/>
          <a:stretch/>
        </p:blipFill>
        <p:spPr>
          <a:xfrm>
            <a:off x="1372209" y="4001028"/>
            <a:ext cx="7154333" cy="817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D72EA08-F53C-4F16-A44F-125B1F64AD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55" t="42037" r="38264" b="45370"/>
          <a:stretch/>
        </p:blipFill>
        <p:spPr>
          <a:xfrm>
            <a:off x="1372209" y="3059113"/>
            <a:ext cx="7154334" cy="86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C54623F-9F51-4754-9280-34E10CC71E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50" t="18272" r="37710" b="69629"/>
          <a:stretch/>
        </p:blipFill>
        <p:spPr>
          <a:xfrm>
            <a:off x="1372209" y="2157261"/>
            <a:ext cx="7137408" cy="8297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8975464-8002-40CF-8E58-F51691158C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237" t="69976" r="37083" b="17778"/>
          <a:stretch/>
        </p:blipFill>
        <p:spPr>
          <a:xfrm>
            <a:off x="1372209" y="5823667"/>
            <a:ext cx="7154333" cy="8398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5C9FC50-799F-4106-8148-3A78E0BFC6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237" t="40928" r="37083" b="46479"/>
          <a:stretch/>
        </p:blipFill>
        <p:spPr>
          <a:xfrm>
            <a:off x="1372209" y="4885491"/>
            <a:ext cx="7154334" cy="86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430B85C-70BA-4807-98C6-75626C7A5D7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237" t="13968" r="37221" b="74118"/>
          <a:stretch/>
        </p:blipFill>
        <p:spPr>
          <a:xfrm>
            <a:off x="1372209" y="1268107"/>
            <a:ext cx="7137408" cy="81703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116F8F1A-AC11-4DCF-86A1-28997DD391AD}"/>
              </a:ext>
            </a:extLst>
          </p:cNvPr>
          <p:cNvCxnSpPr>
            <a:cxnSpLocks/>
          </p:cNvCxnSpPr>
          <p:nvPr/>
        </p:nvCxnSpPr>
        <p:spPr>
          <a:xfrm flipH="1">
            <a:off x="3821495" y="972685"/>
            <a:ext cx="206829" cy="227993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832C4925-B90D-4601-B42A-7341932A6423}"/>
              </a:ext>
            </a:extLst>
          </p:cNvPr>
          <p:cNvSpPr txBox="1"/>
          <p:nvPr/>
        </p:nvSpPr>
        <p:spPr>
          <a:xfrm>
            <a:off x="4028324" y="877004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s3824662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0987F41-FFE4-48A2-9AFD-F1010D28268E}"/>
              </a:ext>
            </a:extLst>
          </p:cNvPr>
          <p:cNvSpPr txBox="1"/>
          <p:nvPr/>
        </p:nvSpPr>
        <p:spPr>
          <a:xfrm>
            <a:off x="8526542" y="1740101"/>
            <a:ext cx="1369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C/C #1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3FD3B3A-BD82-41C8-8077-E6FAA5AE7D41}"/>
              </a:ext>
            </a:extLst>
          </p:cNvPr>
          <p:cNvSpPr txBox="1"/>
          <p:nvPr/>
        </p:nvSpPr>
        <p:spPr>
          <a:xfrm>
            <a:off x="8526542" y="2681402"/>
            <a:ext cx="1369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C/C #2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F1A4BDE-82E7-46F3-8C8C-46A7FD976D44}"/>
              </a:ext>
            </a:extLst>
          </p:cNvPr>
          <p:cNvSpPr txBox="1"/>
          <p:nvPr/>
        </p:nvSpPr>
        <p:spPr>
          <a:xfrm>
            <a:off x="8526542" y="3605636"/>
            <a:ext cx="13467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C/A #1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65645F9-A8D5-4C59-8876-CBF48680B550}"/>
              </a:ext>
            </a:extLst>
          </p:cNvPr>
          <p:cNvSpPr txBox="1"/>
          <p:nvPr/>
        </p:nvSpPr>
        <p:spPr>
          <a:xfrm>
            <a:off x="8526542" y="4546937"/>
            <a:ext cx="1369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C/A #2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A1CF85F-A108-4028-A803-3B3FFA6078EA}"/>
              </a:ext>
            </a:extLst>
          </p:cNvPr>
          <p:cNvSpPr txBox="1"/>
          <p:nvPr/>
        </p:nvSpPr>
        <p:spPr>
          <a:xfrm>
            <a:off x="8526542" y="5403742"/>
            <a:ext cx="1369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A/A #1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89534D1-62E1-48AF-82B8-DA6259F1E5FF}"/>
              </a:ext>
            </a:extLst>
          </p:cNvPr>
          <p:cNvSpPr txBox="1"/>
          <p:nvPr/>
        </p:nvSpPr>
        <p:spPr>
          <a:xfrm>
            <a:off x="8526542" y="6345043"/>
            <a:ext cx="13692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one A/A #2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42A755A-E663-47F1-BE71-882416967A9E}"/>
              </a:ext>
            </a:extLst>
          </p:cNvPr>
          <p:cNvSpPr txBox="1"/>
          <p:nvPr/>
        </p:nvSpPr>
        <p:spPr>
          <a:xfrm>
            <a:off x="671206" y="7062263"/>
            <a:ext cx="12334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epresentative sanger sequencing plots for GATA3 SNP rs3824662 C/C, C/A, and A/A genotype clone in Crispr-Cas9 editing GM12878 cells.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17708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ECAF0B23-33C6-4B07-8559-93C9BDF5A2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8540710"/>
              </p:ext>
            </p:extLst>
          </p:nvPr>
        </p:nvGraphicFramePr>
        <p:xfrm>
          <a:off x="4560116" y="2280577"/>
          <a:ext cx="3509962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509523" imgH="2464523" progId="Prism7.Document">
                  <p:embed/>
                </p:oleObj>
              </mc:Choice>
              <mc:Fallback>
                <p:oleObj name="Prism 7" r:id="rId2" imgW="3509523" imgH="2464523" progId="Prism7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ECAF0B23-33C6-4B07-8559-93C9BDF5A2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60116" y="2280577"/>
                        <a:ext cx="3509962" cy="246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5">
            <a:extLst>
              <a:ext uri="{FF2B5EF4-FFF2-40B4-BE49-F238E27FC236}">
                <a16:creationId xmlns:a16="http://schemas.microsoft.com/office/drawing/2014/main" id="{BF9A1029-FC3C-4428-8E1F-2A5CE445BA4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02214" y="3228821"/>
            <a:ext cx="166160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4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ATA3</a:t>
            </a:r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4" name="TextBox 7">
            <a:extLst>
              <a:ext uri="{FF2B5EF4-FFF2-40B4-BE49-F238E27FC236}">
                <a16:creationId xmlns:a16="http://schemas.microsoft.com/office/drawing/2014/main" id="{48879F17-2B2A-4F4F-8DD1-29C62D04EA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3505" y="2735012"/>
            <a:ext cx="93682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esistant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7BFEB8F-AC3B-45BE-AFB0-1698C6032522}"/>
              </a:ext>
            </a:extLst>
          </p:cNvPr>
          <p:cNvSpPr txBox="1"/>
          <p:nvPr/>
        </p:nvSpPr>
        <p:spPr>
          <a:xfrm>
            <a:off x="4608096" y="422253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A8C8824-7755-4D7B-BD7C-4410EA826F1D}"/>
              </a:ext>
            </a:extLst>
          </p:cNvPr>
          <p:cNvSpPr txBox="1"/>
          <p:nvPr/>
        </p:nvSpPr>
        <p:spPr>
          <a:xfrm>
            <a:off x="4608097" y="3592483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F99CBF0-DA68-4D64-AA85-CF3F66538F10}"/>
              </a:ext>
            </a:extLst>
          </p:cNvPr>
          <p:cNvSpPr txBox="1"/>
          <p:nvPr/>
        </p:nvSpPr>
        <p:spPr>
          <a:xfrm>
            <a:off x="4523138" y="2990247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F6C47AD-66FD-44D3-9463-A8D6BECACE7B}"/>
              </a:ext>
            </a:extLst>
          </p:cNvPr>
          <p:cNvSpPr txBox="1"/>
          <p:nvPr/>
        </p:nvSpPr>
        <p:spPr>
          <a:xfrm>
            <a:off x="4523138" y="237048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7">
            <a:extLst>
              <a:ext uri="{FF2B5EF4-FFF2-40B4-BE49-F238E27FC236}">
                <a16:creationId xmlns:a16="http://schemas.microsoft.com/office/drawing/2014/main" id="{EFE2481E-B421-4590-B8F0-FFE661B74E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3505" y="2486126"/>
            <a:ext cx="8190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Sensitive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F01CA44-13F3-48F6-9675-9483435E61AF}"/>
              </a:ext>
            </a:extLst>
          </p:cNvPr>
          <p:cNvSpPr txBox="1"/>
          <p:nvPr/>
        </p:nvSpPr>
        <p:spPr>
          <a:xfrm>
            <a:off x="5019772" y="2368950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25AE745-7EC0-4825-BC10-8705045614CC}"/>
              </a:ext>
            </a:extLst>
          </p:cNvPr>
          <p:cNvSpPr txBox="1"/>
          <p:nvPr/>
        </p:nvSpPr>
        <p:spPr>
          <a:xfrm>
            <a:off x="5688639" y="2368950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B2705E9-BCF2-40E8-A460-FBEFE6FE2979}"/>
              </a:ext>
            </a:extLst>
          </p:cNvPr>
          <p:cNvSpPr txBox="1"/>
          <p:nvPr/>
        </p:nvSpPr>
        <p:spPr>
          <a:xfrm>
            <a:off x="6340573" y="2368950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467061D-17B2-4AC0-8909-CD4C69C6EAE6}"/>
              </a:ext>
            </a:extLst>
          </p:cNvPr>
          <p:cNvSpPr txBox="1"/>
          <p:nvPr/>
        </p:nvSpPr>
        <p:spPr>
          <a:xfrm>
            <a:off x="7009439" y="2368950"/>
            <a:ext cx="425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4CA22E6-D34D-4721-A930-5EC3EFC4008F}"/>
              </a:ext>
            </a:extLst>
          </p:cNvPr>
          <p:cNvSpPr txBox="1"/>
          <p:nvPr/>
        </p:nvSpPr>
        <p:spPr>
          <a:xfrm>
            <a:off x="4974934" y="4391819"/>
            <a:ext cx="6110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FF1D76A-1FC1-4AB9-800E-CF171C722F34}"/>
              </a:ext>
            </a:extLst>
          </p:cNvPr>
          <p:cNvSpPr txBox="1"/>
          <p:nvPr/>
        </p:nvSpPr>
        <p:spPr>
          <a:xfrm>
            <a:off x="5635193" y="4391819"/>
            <a:ext cx="585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As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1193397-91AA-4A32-A637-AAEDC37913C0}"/>
              </a:ext>
            </a:extLst>
          </p:cNvPr>
          <p:cNvSpPr txBox="1"/>
          <p:nvPr/>
        </p:nvSpPr>
        <p:spPr>
          <a:xfrm>
            <a:off x="6355278" y="4391819"/>
            <a:ext cx="508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CR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F601FDE-FB1C-498C-BF22-A770934A20A4}"/>
              </a:ext>
            </a:extLst>
          </p:cNvPr>
          <p:cNvSpPr txBox="1"/>
          <p:nvPr/>
        </p:nvSpPr>
        <p:spPr>
          <a:xfrm>
            <a:off x="7014094" y="4391819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R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F00AF65-1D19-44BA-BEC3-5FA8F244D5F6}"/>
              </a:ext>
            </a:extLst>
          </p:cNvPr>
          <p:cNvSpPr txBox="1"/>
          <p:nvPr/>
        </p:nvSpPr>
        <p:spPr>
          <a:xfrm>
            <a:off x="1177514" y="250089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35B5D32-55CC-42F9-8FF8-3BD9CEF16908}"/>
              </a:ext>
            </a:extLst>
          </p:cNvPr>
          <p:cNvSpPr txBox="1"/>
          <p:nvPr/>
        </p:nvSpPr>
        <p:spPr>
          <a:xfrm>
            <a:off x="671206" y="7062263"/>
            <a:ext cx="12334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GATA3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expression analysis between drug sensitive and drug resistant primary B-ALL cells.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Gene expression data was retrieved from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SE653-660 datasets. Each box plot shows the distribution of log2 of GATA3 transcription value from the 10th to the 90th percentile. The line inside each box plot represents the median; ****,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&lt; 0.0001, (Unpaired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test)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40706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4">
            <a:extLst>
              <a:ext uri="{FF2B5EF4-FFF2-40B4-BE49-F238E27FC236}">
                <a16:creationId xmlns:a16="http://schemas.microsoft.com/office/drawing/2014/main" id="{A49A4CFB-948C-4B3C-9180-BE018043A6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2569489"/>
              </p:ext>
            </p:extLst>
          </p:nvPr>
        </p:nvGraphicFramePr>
        <p:xfrm>
          <a:off x="1424854" y="1850449"/>
          <a:ext cx="5338762" cy="3586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558501" imgH="2389993" progId="Prism7.Document">
                  <p:embed/>
                </p:oleObj>
              </mc:Choice>
              <mc:Fallback>
                <p:oleObj name="Prism 7" r:id="rId2" imgW="3558501" imgH="2389993" progId="Prism7.Document">
                  <p:embed/>
                  <p:pic>
                    <p:nvPicPr>
                      <p:cNvPr id="3" name="Object 4">
                        <a:extLst>
                          <a:ext uri="{FF2B5EF4-FFF2-40B4-BE49-F238E27FC236}">
                            <a16:creationId xmlns:a16="http://schemas.microsoft.com/office/drawing/2014/main" id="{A49A4CFB-948C-4B3C-9180-BE018043A6D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4854" y="1850449"/>
                        <a:ext cx="5338762" cy="35861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3">
            <a:extLst>
              <a:ext uri="{FF2B5EF4-FFF2-40B4-BE49-F238E27FC236}">
                <a16:creationId xmlns:a16="http://schemas.microsoft.com/office/drawing/2014/main" id="{B1FE244D-3D29-4C25-839D-9AAD38E573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786005"/>
              </p:ext>
            </p:extLst>
          </p:nvPr>
        </p:nvGraphicFramePr>
        <p:xfrm>
          <a:off x="6963928" y="1834573"/>
          <a:ext cx="5338763" cy="3602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3558501" imgH="2402235" progId="Prism7.Document">
                  <p:embed/>
                </p:oleObj>
              </mc:Choice>
              <mc:Fallback>
                <p:oleObj name="Prism 7" r:id="rId4" imgW="3558501" imgH="2402235" progId="Prism7.Document">
                  <p:embed/>
                  <p:pic>
                    <p:nvPicPr>
                      <p:cNvPr id="5" name="Object 3">
                        <a:extLst>
                          <a:ext uri="{FF2B5EF4-FFF2-40B4-BE49-F238E27FC236}">
                            <a16:creationId xmlns:a16="http://schemas.microsoft.com/office/drawing/2014/main" id="{B1FE244D-3D29-4C25-839D-9AAD38E5735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63928" y="1834573"/>
                        <a:ext cx="5338763" cy="36020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文本框 47">
            <a:extLst>
              <a:ext uri="{FF2B5EF4-FFF2-40B4-BE49-F238E27FC236}">
                <a16:creationId xmlns:a16="http://schemas.microsoft.com/office/drawing/2014/main" id="{D938C79D-18E2-4574-8A0E-1268BCE8D0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1541" y="2103150"/>
            <a:ext cx="152827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Empty vector</a:t>
            </a:r>
          </a:p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(IC50=0.147 IU/ml)</a:t>
            </a:r>
          </a:p>
        </p:txBody>
      </p:sp>
      <p:sp>
        <p:nvSpPr>
          <p:cNvPr id="29" name="文本框 47">
            <a:extLst>
              <a:ext uri="{FF2B5EF4-FFF2-40B4-BE49-F238E27FC236}">
                <a16:creationId xmlns:a16="http://schemas.microsoft.com/office/drawing/2014/main" id="{5D67FC5A-6331-4D0A-BFE1-8EC91680AF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1541" y="2637197"/>
            <a:ext cx="152827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ATA3-OE</a:t>
            </a:r>
          </a:p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(IC50=0.39 IU/ml)</a:t>
            </a:r>
          </a:p>
        </p:txBody>
      </p:sp>
      <p:sp>
        <p:nvSpPr>
          <p:cNvPr id="27" name="文本框 47">
            <a:extLst>
              <a:ext uri="{FF2B5EF4-FFF2-40B4-BE49-F238E27FC236}">
                <a16:creationId xmlns:a16="http://schemas.microsoft.com/office/drawing/2014/main" id="{C9B0F416-63A1-4ACB-ABDF-5B2BB9F557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7162" y="4545668"/>
            <a:ext cx="22873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a/F3 cells (</a:t>
            </a:r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JAK2</a:t>
            </a:r>
            <a:r>
              <a:rPr lang="en-US" altLang="zh-CN" sz="1200" i="1" baseline="300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R683G</a:t>
            </a:r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+CRLF2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1" name="文本框 47">
            <a:extLst>
              <a:ext uri="{FF2B5EF4-FFF2-40B4-BE49-F238E27FC236}">
                <a16:creationId xmlns:a16="http://schemas.microsoft.com/office/drawing/2014/main" id="{0A925045-E0CE-4B6E-BEE1-CFD2FE0D67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89209" y="2116954"/>
            <a:ext cx="136122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Empty vector</a:t>
            </a:r>
          </a:p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(IC50=0.11 IU/ml)</a:t>
            </a:r>
          </a:p>
        </p:txBody>
      </p:sp>
      <p:sp>
        <p:nvSpPr>
          <p:cNvPr id="32" name="文本框 47">
            <a:extLst>
              <a:ext uri="{FF2B5EF4-FFF2-40B4-BE49-F238E27FC236}">
                <a16:creationId xmlns:a16="http://schemas.microsoft.com/office/drawing/2014/main" id="{CF12CD3E-5993-4CB5-8E74-9ED0186A05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89209" y="2637150"/>
            <a:ext cx="136122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GATA3-OE</a:t>
            </a:r>
          </a:p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(IC50=0.38 IU/ml)</a:t>
            </a:r>
          </a:p>
        </p:txBody>
      </p:sp>
      <p:sp>
        <p:nvSpPr>
          <p:cNvPr id="33" name="文本框 47">
            <a:extLst>
              <a:ext uri="{FF2B5EF4-FFF2-40B4-BE49-F238E27FC236}">
                <a16:creationId xmlns:a16="http://schemas.microsoft.com/office/drawing/2014/main" id="{CA0FFB72-4445-444C-9494-8B490CD909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58734" y="4545668"/>
            <a:ext cx="22873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a/F3 cells (</a:t>
            </a:r>
            <a:r>
              <a:rPr lang="en-US" altLang="zh-CN" sz="1200" i="1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BCR-ABL</a:t>
            </a:r>
            <a:r>
              <a:rPr lang="en-US" altLang="zh-CN" sz="12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CD16287B-C3C6-4C3A-93DB-DAB2A914BB59}"/>
              </a:ext>
            </a:extLst>
          </p:cNvPr>
          <p:cNvGrpSpPr/>
          <p:nvPr/>
        </p:nvGrpSpPr>
        <p:grpSpPr>
          <a:xfrm>
            <a:off x="1294183" y="2079779"/>
            <a:ext cx="4975254" cy="3253893"/>
            <a:chOff x="559892" y="1096106"/>
            <a:chExt cx="4975254" cy="3253893"/>
          </a:xfrm>
        </p:grpSpPr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496D34A5-AAF2-4CBE-B396-33A87E817C00}"/>
                </a:ext>
              </a:extLst>
            </p:cNvPr>
            <p:cNvGrpSpPr/>
            <p:nvPr/>
          </p:nvGrpSpPr>
          <p:grpSpPr>
            <a:xfrm>
              <a:off x="559892" y="1096106"/>
              <a:ext cx="688640" cy="2957011"/>
              <a:chOff x="559892" y="1096106"/>
              <a:chExt cx="688640" cy="2957011"/>
            </a:xfrm>
          </p:grpSpPr>
          <p:grpSp>
            <p:nvGrpSpPr>
              <p:cNvPr id="34" name="组合 33">
                <a:extLst>
                  <a:ext uri="{FF2B5EF4-FFF2-40B4-BE49-F238E27FC236}">
                    <a16:creationId xmlns:a16="http://schemas.microsoft.com/office/drawing/2014/main" id="{EB0A1C3F-ABD8-4EC3-B1B0-B373979FB261}"/>
                  </a:ext>
                </a:extLst>
              </p:cNvPr>
              <p:cNvGrpSpPr/>
              <p:nvPr/>
            </p:nvGrpSpPr>
            <p:grpSpPr>
              <a:xfrm>
                <a:off x="739197" y="1096106"/>
                <a:ext cx="509335" cy="2957011"/>
                <a:chOff x="766907" y="1096106"/>
                <a:chExt cx="509335" cy="2957011"/>
              </a:xfrm>
            </p:grpSpPr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B5D35531-595C-4A2E-81EF-B216C8044625}"/>
                    </a:ext>
                  </a:extLst>
                </p:cNvPr>
                <p:cNvSpPr txBox="1"/>
                <p:nvPr/>
              </p:nvSpPr>
              <p:spPr>
                <a:xfrm>
                  <a:off x="1006616" y="3776118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7062A49E-A3C6-4B71-91EC-D11E8A1B8850}"/>
                    </a:ext>
                  </a:extLst>
                </p:cNvPr>
                <p:cNvSpPr txBox="1"/>
                <p:nvPr/>
              </p:nvSpPr>
              <p:spPr>
                <a:xfrm>
                  <a:off x="921658" y="245352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2F9B2D03-6519-448A-8C19-17627958454A}"/>
                    </a:ext>
                  </a:extLst>
                </p:cNvPr>
                <p:cNvSpPr txBox="1"/>
                <p:nvPr/>
              </p:nvSpPr>
              <p:spPr>
                <a:xfrm>
                  <a:off x="766907" y="1096106"/>
                  <a:ext cx="50933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" name="TextBox 5">
                <a:extLst>
                  <a:ext uri="{FF2B5EF4-FFF2-40B4-BE49-F238E27FC236}">
                    <a16:creationId xmlns:a16="http://schemas.microsoft.com/office/drawing/2014/main" id="{E4215854-038F-47EB-BA8B-4BF57055EC4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209508" y="2420723"/>
                <a:ext cx="1008546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zh-CN" sz="1400" dirty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Viable (%)</a:t>
                </a:r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7F449407-0995-47AA-BF2D-994A03622F0B}"/>
                </a:ext>
              </a:extLst>
            </p:cNvPr>
            <p:cNvGrpSpPr/>
            <p:nvPr/>
          </p:nvGrpSpPr>
          <p:grpSpPr>
            <a:xfrm>
              <a:off x="1052517" y="4073000"/>
              <a:ext cx="4482629" cy="276999"/>
              <a:chOff x="1052517" y="4073000"/>
              <a:chExt cx="4482629" cy="276999"/>
            </a:xfrm>
          </p:grpSpPr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A767D2CD-23C1-4C99-A581-0F1E1B4534B1}"/>
                  </a:ext>
                </a:extLst>
              </p:cNvPr>
              <p:cNvSpPr txBox="1"/>
              <p:nvPr/>
            </p:nvSpPr>
            <p:spPr>
              <a:xfrm>
                <a:off x="1052517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3807801E-E59A-4EE5-8A15-FCEF6DD762A6}"/>
                  </a:ext>
                </a:extLst>
              </p:cNvPr>
              <p:cNvSpPr txBox="1"/>
              <p:nvPr/>
            </p:nvSpPr>
            <p:spPr>
              <a:xfrm>
                <a:off x="1652906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.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2A883966-689E-4B99-AEEB-5755B1913C44}"/>
                  </a:ext>
                </a:extLst>
              </p:cNvPr>
              <p:cNvSpPr txBox="1"/>
              <p:nvPr/>
            </p:nvSpPr>
            <p:spPr>
              <a:xfrm>
                <a:off x="225329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F283FFD9-6435-42D6-B03B-59C7084A755C}"/>
                  </a:ext>
                </a:extLst>
              </p:cNvPr>
              <p:cNvSpPr txBox="1"/>
              <p:nvPr/>
            </p:nvSpPr>
            <p:spPr>
              <a:xfrm>
                <a:off x="284817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.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1063BA7-3980-4187-85E1-9559963A2824}"/>
                  </a:ext>
                </a:extLst>
              </p:cNvPr>
              <p:cNvSpPr txBox="1"/>
              <p:nvPr/>
            </p:nvSpPr>
            <p:spPr>
              <a:xfrm>
                <a:off x="341621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5D103738-1BF0-46F8-9810-DA5725263A58}"/>
                  </a:ext>
                </a:extLst>
              </p:cNvPr>
              <p:cNvSpPr txBox="1"/>
              <p:nvPr/>
            </p:nvSpPr>
            <p:spPr>
              <a:xfrm>
                <a:off x="4101728" y="40730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B2F0C64F-19F3-4C11-8B7E-A65D2B499462}"/>
                  </a:ext>
                </a:extLst>
              </p:cNvPr>
              <p:cNvSpPr txBox="1"/>
              <p:nvPr/>
            </p:nvSpPr>
            <p:spPr>
              <a:xfrm>
                <a:off x="4619504" y="407300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EB35BBDE-6C1E-4AE2-ACF2-E9FB0E666F7F}"/>
                  </a:ext>
                </a:extLst>
              </p:cNvPr>
              <p:cNvSpPr txBox="1"/>
              <p:nvPr/>
            </p:nvSpPr>
            <p:spPr>
              <a:xfrm>
                <a:off x="5265520" y="40730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582DF1AE-9918-41DF-9413-2226117EDEF3}"/>
              </a:ext>
            </a:extLst>
          </p:cNvPr>
          <p:cNvGrpSpPr/>
          <p:nvPr/>
        </p:nvGrpSpPr>
        <p:grpSpPr>
          <a:xfrm>
            <a:off x="6814367" y="2079779"/>
            <a:ext cx="4975254" cy="3253893"/>
            <a:chOff x="559892" y="1096106"/>
            <a:chExt cx="4975254" cy="3253893"/>
          </a:xfrm>
        </p:grpSpPr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41257035-8F84-4D8C-AD7E-0557B41CF6E5}"/>
                </a:ext>
              </a:extLst>
            </p:cNvPr>
            <p:cNvGrpSpPr/>
            <p:nvPr/>
          </p:nvGrpSpPr>
          <p:grpSpPr>
            <a:xfrm>
              <a:off x="559892" y="1096106"/>
              <a:ext cx="688640" cy="2957011"/>
              <a:chOff x="559892" y="1096106"/>
              <a:chExt cx="688640" cy="2957011"/>
            </a:xfrm>
          </p:grpSpPr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BC0FFD4B-2D13-4FAB-983A-B7E0396D7013}"/>
                  </a:ext>
                </a:extLst>
              </p:cNvPr>
              <p:cNvGrpSpPr/>
              <p:nvPr/>
            </p:nvGrpSpPr>
            <p:grpSpPr>
              <a:xfrm>
                <a:off x="739197" y="1096106"/>
                <a:ext cx="509335" cy="2957011"/>
                <a:chOff x="766907" y="1096106"/>
                <a:chExt cx="509335" cy="2957011"/>
              </a:xfrm>
            </p:grpSpPr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8628BFF9-BED9-4037-8BC4-9EEEB55510C1}"/>
                    </a:ext>
                  </a:extLst>
                </p:cNvPr>
                <p:cNvSpPr txBox="1"/>
                <p:nvPr/>
              </p:nvSpPr>
              <p:spPr>
                <a:xfrm>
                  <a:off x="1006616" y="3776118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1BE433E5-E68E-4AB5-87B5-C5191832628B}"/>
                    </a:ext>
                  </a:extLst>
                </p:cNvPr>
                <p:cNvSpPr txBox="1"/>
                <p:nvPr/>
              </p:nvSpPr>
              <p:spPr>
                <a:xfrm>
                  <a:off x="921658" y="245352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8C1E3C17-1881-4507-AB73-D1D50BF843B0}"/>
                    </a:ext>
                  </a:extLst>
                </p:cNvPr>
                <p:cNvSpPr txBox="1"/>
                <p:nvPr/>
              </p:nvSpPr>
              <p:spPr>
                <a:xfrm>
                  <a:off x="766907" y="1096106"/>
                  <a:ext cx="50933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9" name="TextBox 5">
                <a:extLst>
                  <a:ext uri="{FF2B5EF4-FFF2-40B4-BE49-F238E27FC236}">
                    <a16:creationId xmlns:a16="http://schemas.microsoft.com/office/drawing/2014/main" id="{9E4C6E03-F376-4A14-A281-E4A501E410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209508" y="2420723"/>
                <a:ext cx="1008546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zh-CN" sz="1400" dirty="0">
                    <a:latin typeface="Arial" panose="020B0604020202020204" pitchFamily="34" charset="0"/>
                    <a:ea typeface="Arial Unicode MS" pitchFamily="34" charset="-122"/>
                    <a:cs typeface="Arial" panose="020B0604020202020204" pitchFamily="34" charset="0"/>
                  </a:rPr>
                  <a:t>Viable (%)</a:t>
                </a:r>
              </a:p>
            </p:txBody>
          </p:sp>
        </p:grpSp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78B81FF4-23FD-4056-934E-870A6E548A69}"/>
                </a:ext>
              </a:extLst>
            </p:cNvPr>
            <p:cNvGrpSpPr/>
            <p:nvPr/>
          </p:nvGrpSpPr>
          <p:grpSpPr>
            <a:xfrm>
              <a:off x="1052517" y="4073000"/>
              <a:ext cx="4482629" cy="276999"/>
              <a:chOff x="1052517" y="4073000"/>
              <a:chExt cx="4482629" cy="276999"/>
            </a:xfrm>
          </p:grpSpPr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0B1B455A-0E05-487A-98DC-7BDC4CEE5522}"/>
                  </a:ext>
                </a:extLst>
              </p:cNvPr>
              <p:cNvSpPr txBox="1"/>
              <p:nvPr/>
            </p:nvSpPr>
            <p:spPr>
              <a:xfrm>
                <a:off x="1052517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476C0513-2D53-4F1C-BD4A-2FCAD8B3F7AC}"/>
                  </a:ext>
                </a:extLst>
              </p:cNvPr>
              <p:cNvSpPr txBox="1"/>
              <p:nvPr/>
            </p:nvSpPr>
            <p:spPr>
              <a:xfrm>
                <a:off x="1652906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.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F714C6BA-0A0B-4CC8-BB36-EAA9CFFCD131}"/>
                  </a:ext>
                </a:extLst>
              </p:cNvPr>
              <p:cNvSpPr txBox="1"/>
              <p:nvPr/>
            </p:nvSpPr>
            <p:spPr>
              <a:xfrm>
                <a:off x="225329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73F3CB5B-3DB2-4C74-9553-ED805791C21A}"/>
                  </a:ext>
                </a:extLst>
              </p:cNvPr>
              <p:cNvSpPr txBox="1"/>
              <p:nvPr/>
            </p:nvSpPr>
            <p:spPr>
              <a:xfrm>
                <a:off x="284817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.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1528DD67-28EE-4328-906B-B5C00EDA220F}"/>
                  </a:ext>
                </a:extLst>
              </p:cNvPr>
              <p:cNvSpPr txBox="1"/>
              <p:nvPr/>
            </p:nvSpPr>
            <p:spPr>
              <a:xfrm>
                <a:off x="3416215" y="40730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854CD0FD-B877-4C22-A039-2B6B3ADC9DB6}"/>
                  </a:ext>
                </a:extLst>
              </p:cNvPr>
              <p:cNvSpPr txBox="1"/>
              <p:nvPr/>
            </p:nvSpPr>
            <p:spPr>
              <a:xfrm>
                <a:off x="4101728" y="40730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FFFB4348-8B9D-4C19-BB8B-935D1042B5D1}"/>
                  </a:ext>
                </a:extLst>
              </p:cNvPr>
              <p:cNvSpPr txBox="1"/>
              <p:nvPr/>
            </p:nvSpPr>
            <p:spPr>
              <a:xfrm>
                <a:off x="4619504" y="407300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917616DC-2574-4A69-84EE-A190EBCA434C}"/>
                  </a:ext>
                </a:extLst>
              </p:cNvPr>
              <p:cNvSpPr txBox="1"/>
              <p:nvPr/>
            </p:nvSpPr>
            <p:spPr>
              <a:xfrm>
                <a:off x="5265520" y="40730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CA14B992-CFC1-49BC-9B94-A940FC06C629}"/>
              </a:ext>
            </a:extLst>
          </p:cNvPr>
          <p:cNvSpPr txBox="1"/>
          <p:nvPr/>
        </p:nvSpPr>
        <p:spPr>
          <a:xfrm>
            <a:off x="1177514" y="250089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9AFBF97A-E4CE-442C-998B-438F753A456D}"/>
              </a:ext>
            </a:extLst>
          </p:cNvPr>
          <p:cNvSpPr txBox="1"/>
          <p:nvPr/>
        </p:nvSpPr>
        <p:spPr>
          <a:xfrm>
            <a:off x="780330" y="6388787"/>
            <a:ext cx="12334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L-Asp response of leukemic transformed Ba/F3 cell (left panel, transformed by co-transduction with JAK2</a:t>
            </a:r>
            <a:r>
              <a:rPr lang="en-US" sz="18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R683G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and CRLF2;  cells; right panel, transformed by BCR-ABL1 fusion protein) with or without GATA3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ectopic expression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. Drug sensitivity was detected by MTT assay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56179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1307CA45-D8F0-4C3D-ACF2-B9EB2789E368}"/>
              </a:ext>
            </a:extLst>
          </p:cNvPr>
          <p:cNvGrpSpPr/>
          <p:nvPr/>
        </p:nvGrpSpPr>
        <p:grpSpPr>
          <a:xfrm>
            <a:off x="627163" y="2592525"/>
            <a:ext cx="4110037" cy="2816784"/>
            <a:chOff x="354447" y="968619"/>
            <a:chExt cx="4110037" cy="2816784"/>
          </a:xfrm>
        </p:grpSpPr>
        <p:graphicFrame>
          <p:nvGraphicFramePr>
            <p:cNvPr id="2" name="对象 1">
              <a:extLst>
                <a:ext uri="{FF2B5EF4-FFF2-40B4-BE49-F238E27FC236}">
                  <a16:creationId xmlns:a16="http://schemas.microsoft.com/office/drawing/2014/main" id="{70C7D262-2D71-4A5F-ACBD-94F5DEFB11B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43805890"/>
                </p:ext>
              </p:extLst>
            </p:nvPr>
          </p:nvGraphicFramePr>
          <p:xfrm>
            <a:off x="1299009" y="1035194"/>
            <a:ext cx="3165475" cy="2460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3" imgW="3164873" imgH="2460202" progId="Prism7.Document">
                    <p:embed/>
                  </p:oleObj>
                </mc:Choice>
                <mc:Fallback>
                  <p:oleObj name="Prism 7" r:id="rId3" imgW="3164873" imgH="2460202" progId="Prism7.Document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70C7D262-2D71-4A5F-ACBD-94F5DEFB11B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299009" y="1035194"/>
                          <a:ext cx="3165475" cy="24606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5">
              <a:extLst>
                <a:ext uri="{FF2B5EF4-FFF2-40B4-BE49-F238E27FC236}">
                  <a16:creationId xmlns:a16="http://schemas.microsoft.com/office/drawing/2014/main" id="{2FDB31E6-4059-433F-97EA-3C19F80BC1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59530" y="2024900"/>
              <a:ext cx="88992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Viable %</a:t>
              </a:r>
            </a:p>
          </p:txBody>
        </p:sp>
        <p:sp>
          <p:nvSpPr>
            <p:cNvPr id="4" name="TextBox 7">
              <a:extLst>
                <a:ext uri="{FF2B5EF4-FFF2-40B4-BE49-F238E27FC236}">
                  <a16:creationId xmlns:a16="http://schemas.microsoft.com/office/drawing/2014/main" id="{F3A7D2A3-BE1D-4A77-8967-68616B5B0A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7539" y="3477626"/>
              <a:ext cx="127390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MSC GATA3</a:t>
              </a: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49153525-3A62-4CF8-8E41-D93639D73D3A}"/>
                </a:ext>
              </a:extLst>
            </p:cNvPr>
            <p:cNvSpPr/>
            <p:nvPr/>
          </p:nvSpPr>
          <p:spPr>
            <a:xfrm>
              <a:off x="1921477" y="3477626"/>
              <a:ext cx="24397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-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909C0F14-4589-4CF4-9AE8-64031C60A702}"/>
                </a:ext>
              </a:extLst>
            </p:cNvPr>
            <p:cNvSpPr/>
            <p:nvPr/>
          </p:nvSpPr>
          <p:spPr>
            <a:xfrm>
              <a:off x="2544358" y="3477626"/>
              <a:ext cx="29367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-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2F9785A-4366-4E01-BA70-8161D48A1AF0}"/>
                </a:ext>
              </a:extLst>
            </p:cNvPr>
            <p:cNvSpPr/>
            <p:nvPr/>
          </p:nvSpPr>
          <p:spPr>
            <a:xfrm>
              <a:off x="3798058" y="3477626"/>
              <a:ext cx="28886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+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3D4B726-07CC-49E3-996A-291647A89375}"/>
                </a:ext>
              </a:extLst>
            </p:cNvPr>
            <p:cNvSpPr txBox="1"/>
            <p:nvPr/>
          </p:nvSpPr>
          <p:spPr>
            <a:xfrm>
              <a:off x="1369476" y="296703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83CA0030-4EF1-45E0-AC31-A92FE573DCD1}"/>
                </a:ext>
              </a:extLst>
            </p:cNvPr>
            <p:cNvSpPr txBox="1"/>
            <p:nvPr/>
          </p:nvSpPr>
          <p:spPr>
            <a:xfrm>
              <a:off x="1284518" y="251617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53A703E-BF68-44E2-961B-501593599231}"/>
                </a:ext>
              </a:extLst>
            </p:cNvPr>
            <p:cNvSpPr txBox="1"/>
            <p:nvPr/>
          </p:nvSpPr>
          <p:spPr>
            <a:xfrm>
              <a:off x="1284518" y="2050021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974A9DE-0036-49E3-B75D-6800D363C6FD}"/>
                </a:ext>
              </a:extLst>
            </p:cNvPr>
            <p:cNvSpPr txBox="1"/>
            <p:nvPr/>
          </p:nvSpPr>
          <p:spPr>
            <a:xfrm>
              <a:off x="1284518" y="160313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BB6407A-DBB9-43B5-9300-77B472D41156}"/>
                </a:ext>
              </a:extLst>
            </p:cNvPr>
            <p:cNvSpPr txBox="1"/>
            <p:nvPr/>
          </p:nvSpPr>
          <p:spPr>
            <a:xfrm>
              <a:off x="1284518" y="114948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FF722DD-B686-44FD-AF13-0D01FDA492CC}"/>
                </a:ext>
              </a:extLst>
            </p:cNvPr>
            <p:cNvSpPr txBox="1"/>
            <p:nvPr/>
          </p:nvSpPr>
          <p:spPr>
            <a:xfrm>
              <a:off x="1925485" y="3220406"/>
              <a:ext cx="2359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E3F1D76-ED08-45A7-851D-0680E1478929}"/>
                </a:ext>
              </a:extLst>
            </p:cNvPr>
            <p:cNvSpPr txBox="1"/>
            <p:nvPr/>
          </p:nvSpPr>
          <p:spPr>
            <a:xfrm>
              <a:off x="2553976" y="3220406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FA1DD35-34A9-48BC-97CD-AC6F5719596A}"/>
                </a:ext>
              </a:extLst>
            </p:cNvPr>
            <p:cNvSpPr txBox="1"/>
            <p:nvPr/>
          </p:nvSpPr>
          <p:spPr>
            <a:xfrm>
              <a:off x="3805271" y="3220406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7">
              <a:extLst>
                <a:ext uri="{FF2B5EF4-FFF2-40B4-BE49-F238E27FC236}">
                  <a16:creationId xmlns:a16="http://schemas.microsoft.com/office/drawing/2014/main" id="{DF61F5B3-661E-430D-81DA-6FAEA9FE43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4447" y="3205017"/>
              <a:ext cx="138699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Nalm6 GATA3</a:t>
              </a: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AA160CDD-EF78-4D6B-A702-472153302901}"/>
                </a:ext>
              </a:extLst>
            </p:cNvPr>
            <p:cNvSpPr/>
            <p:nvPr/>
          </p:nvSpPr>
          <p:spPr>
            <a:xfrm>
              <a:off x="3144216" y="3477626"/>
              <a:ext cx="33855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+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2E697BE-820F-4CFF-A27C-82C498FD82FE}"/>
                </a:ext>
              </a:extLst>
            </p:cNvPr>
            <p:cNvSpPr txBox="1"/>
            <p:nvPr/>
          </p:nvSpPr>
          <p:spPr>
            <a:xfrm>
              <a:off x="3195512" y="322040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140BD308-C2BD-4F1E-8256-E6D83CC70458}"/>
                </a:ext>
              </a:extLst>
            </p:cNvPr>
            <p:cNvSpPr txBox="1"/>
            <p:nvPr/>
          </p:nvSpPr>
          <p:spPr>
            <a:xfrm>
              <a:off x="3167629" y="968619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E53E03EB-FE0E-46FD-A56C-23D18DB90B2A}"/>
                </a:ext>
              </a:extLst>
            </p:cNvPr>
            <p:cNvSpPr txBox="1"/>
            <p:nvPr/>
          </p:nvSpPr>
          <p:spPr>
            <a:xfrm>
              <a:off x="2353433" y="124561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795EED5C-19A9-4180-9CFE-4D66CE5EBF3F}"/>
              </a:ext>
            </a:extLst>
          </p:cNvPr>
          <p:cNvGrpSpPr/>
          <p:nvPr/>
        </p:nvGrpSpPr>
        <p:grpSpPr>
          <a:xfrm>
            <a:off x="5186151" y="2679033"/>
            <a:ext cx="3802035" cy="2466418"/>
            <a:chOff x="6548273" y="1055127"/>
            <a:chExt cx="3802035" cy="2466418"/>
          </a:xfrm>
        </p:grpSpPr>
        <p:graphicFrame>
          <p:nvGraphicFramePr>
            <p:cNvPr id="21" name="对象 20">
              <a:extLst>
                <a:ext uri="{FF2B5EF4-FFF2-40B4-BE49-F238E27FC236}">
                  <a16:creationId xmlns:a16="http://schemas.microsoft.com/office/drawing/2014/main" id="{8454891F-A700-4A19-A24F-6C0922AFF30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6389630"/>
                </p:ext>
              </p:extLst>
            </p:nvPr>
          </p:nvGraphicFramePr>
          <p:xfrm>
            <a:off x="6791807" y="1055127"/>
            <a:ext cx="3558501" cy="2422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5" imgW="3558501" imgH="2422037" progId="Prism7.Document">
                    <p:embed/>
                  </p:oleObj>
                </mc:Choice>
                <mc:Fallback>
                  <p:oleObj name="Prism 7" r:id="rId5" imgW="3558501" imgH="2422037" progId="Prism7.Document">
                    <p:embed/>
                    <p:pic>
                      <p:nvPicPr>
                        <p:cNvPr id="21" name="对象 20">
                          <a:extLst>
                            <a:ext uri="{FF2B5EF4-FFF2-40B4-BE49-F238E27FC236}">
                              <a16:creationId xmlns:a16="http://schemas.microsoft.com/office/drawing/2014/main" id="{8454891F-A700-4A19-A24F-6C0922AFF300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791807" y="1055127"/>
                          <a:ext cx="3558501" cy="2422037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7">
              <a:extLst>
                <a:ext uri="{FF2B5EF4-FFF2-40B4-BE49-F238E27FC236}">
                  <a16:creationId xmlns:a16="http://schemas.microsoft.com/office/drawing/2014/main" id="{53FD67B4-B0E4-4ED5-AD15-577E67FF6C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66739" y="1164729"/>
              <a:ext cx="127390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Empty vector</a:t>
              </a:r>
            </a:p>
          </p:txBody>
        </p:sp>
        <p:sp>
          <p:nvSpPr>
            <p:cNvPr id="26" name="TextBox 7">
              <a:extLst>
                <a:ext uri="{FF2B5EF4-FFF2-40B4-BE49-F238E27FC236}">
                  <a16:creationId xmlns:a16="http://schemas.microsoft.com/office/drawing/2014/main" id="{FA6CEABF-13B6-4DC9-A753-7165EEAFFA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66739" y="1378089"/>
              <a:ext cx="127390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ATA3</a:t>
              </a:r>
            </a:p>
          </p:txBody>
        </p:sp>
        <p:sp>
          <p:nvSpPr>
            <p:cNvPr id="29" name="TextBox 5">
              <a:extLst>
                <a:ext uri="{FF2B5EF4-FFF2-40B4-BE49-F238E27FC236}">
                  <a16:creationId xmlns:a16="http://schemas.microsoft.com/office/drawing/2014/main" id="{43DDE0DF-617B-40D2-AFD7-FF7A7FCE16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301250" y="2025198"/>
              <a:ext cx="801823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4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Percent</a:t>
              </a:r>
            </a:p>
          </p:txBody>
        </p:sp>
        <p:sp>
          <p:nvSpPr>
            <p:cNvPr id="30" name="TextBox 7">
              <a:extLst>
                <a:ext uri="{FF2B5EF4-FFF2-40B4-BE49-F238E27FC236}">
                  <a16:creationId xmlns:a16="http://schemas.microsoft.com/office/drawing/2014/main" id="{F8E5FE40-030E-4E32-9BCE-9DD9281B5D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00954" y="3244546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0/G1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EEC2CEC-88B1-4484-976A-3B4A0E3BDABB}"/>
                </a:ext>
              </a:extLst>
            </p:cNvPr>
            <p:cNvSpPr txBox="1"/>
            <p:nvPr/>
          </p:nvSpPr>
          <p:spPr>
            <a:xfrm>
              <a:off x="6936665" y="296733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F52D0BA-0E30-4AD3-BE49-E0E997549594}"/>
                </a:ext>
              </a:extLst>
            </p:cNvPr>
            <p:cNvSpPr txBox="1"/>
            <p:nvPr/>
          </p:nvSpPr>
          <p:spPr>
            <a:xfrm>
              <a:off x="6866947" y="257743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4FFB3D3E-649C-4E83-88E6-E8DE88747165}"/>
                </a:ext>
              </a:extLst>
            </p:cNvPr>
            <p:cNvSpPr txBox="1"/>
            <p:nvPr/>
          </p:nvSpPr>
          <p:spPr>
            <a:xfrm>
              <a:off x="6866947" y="2248439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57BCF4B0-55D8-4112-B020-DF1AD4FD813C}"/>
                </a:ext>
              </a:extLst>
            </p:cNvPr>
            <p:cNvSpPr txBox="1"/>
            <p:nvPr/>
          </p:nvSpPr>
          <p:spPr>
            <a:xfrm>
              <a:off x="6866947" y="14967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F61DB005-C10D-402B-9F76-E320B1E672C1}"/>
                </a:ext>
              </a:extLst>
            </p:cNvPr>
            <p:cNvSpPr txBox="1"/>
            <p:nvPr/>
          </p:nvSpPr>
          <p:spPr>
            <a:xfrm>
              <a:off x="6866947" y="113454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D75C7210-7D21-46A9-81DF-22B6BE9B8AC6}"/>
                </a:ext>
              </a:extLst>
            </p:cNvPr>
            <p:cNvSpPr txBox="1"/>
            <p:nvPr/>
          </p:nvSpPr>
          <p:spPr>
            <a:xfrm>
              <a:off x="6866947" y="1882679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7">
              <a:extLst>
                <a:ext uri="{FF2B5EF4-FFF2-40B4-BE49-F238E27FC236}">
                  <a16:creationId xmlns:a16="http://schemas.microsoft.com/office/drawing/2014/main" id="{53D084BC-0252-49B1-8562-2106FFA722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00114" y="3244546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39" name="TextBox 7">
              <a:extLst>
                <a:ext uri="{FF2B5EF4-FFF2-40B4-BE49-F238E27FC236}">
                  <a16:creationId xmlns:a16="http://schemas.microsoft.com/office/drawing/2014/main" id="{9C9C0ED8-E985-483C-9CDE-6DE27ACACF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14514" y="3244546"/>
              <a:ext cx="72988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G2/M</a:t>
              </a:r>
            </a:p>
          </p:txBody>
        </p:sp>
      </p:grpSp>
      <p:graphicFrame>
        <p:nvGraphicFramePr>
          <p:cNvPr id="82" name="图表 81">
            <a:extLst>
              <a:ext uri="{FF2B5EF4-FFF2-40B4-BE49-F238E27FC236}">
                <a16:creationId xmlns:a16="http://schemas.microsoft.com/office/drawing/2014/main" id="{73B27F39-9118-4910-AAA1-CE8BBFD239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7566122"/>
              </p:ext>
            </p:extLst>
          </p:nvPr>
        </p:nvGraphicFramePr>
        <p:xfrm>
          <a:off x="9036748" y="2410547"/>
          <a:ext cx="2740092" cy="26813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3" name="文本框 5">
            <a:extLst>
              <a:ext uri="{FF2B5EF4-FFF2-40B4-BE49-F238E27FC236}">
                <a16:creationId xmlns:a16="http://schemas.microsoft.com/office/drawing/2014/main" id="{8FEECFDF-994C-425D-B13D-FD417FF84BF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153585" y="3508266"/>
            <a:ext cx="1544077" cy="28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68580" tIns="34290" rIns="68580" bIns="34290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% L-Asp Allergies</a:t>
            </a:r>
          </a:p>
        </p:txBody>
      </p:sp>
      <p:sp>
        <p:nvSpPr>
          <p:cNvPr id="94" name="TextBox 7">
            <a:extLst>
              <a:ext uri="{FF2B5EF4-FFF2-40B4-BE49-F238E27FC236}">
                <a16:creationId xmlns:a16="http://schemas.microsoft.com/office/drawing/2014/main" id="{C50F9D06-8833-4B6A-BBE4-5209E31993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30622" y="5034234"/>
            <a:ext cx="48282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N =</a:t>
            </a: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955C1EF1-A938-4DFC-91CD-D0F544D4938B}"/>
              </a:ext>
            </a:extLst>
          </p:cNvPr>
          <p:cNvSpPr/>
          <p:nvPr/>
        </p:nvSpPr>
        <p:spPr>
          <a:xfrm>
            <a:off x="9610566" y="5034234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53A62949-FA2F-4BD1-9FC4-B163B8351440}"/>
              </a:ext>
            </a:extLst>
          </p:cNvPr>
          <p:cNvSpPr/>
          <p:nvPr/>
        </p:nvSpPr>
        <p:spPr>
          <a:xfrm>
            <a:off x="10254570" y="5034234"/>
            <a:ext cx="5325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54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E78349D6-975A-4E12-A46A-017F5A6295E3}"/>
              </a:ext>
            </a:extLst>
          </p:cNvPr>
          <p:cNvSpPr/>
          <p:nvPr/>
        </p:nvSpPr>
        <p:spPr>
          <a:xfrm>
            <a:off x="11031721" y="5034234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12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3689B563-0ADF-4FDA-AB18-48142143BEA8}"/>
              </a:ext>
            </a:extLst>
          </p:cNvPr>
          <p:cNvSpPr txBox="1"/>
          <p:nvPr/>
        </p:nvSpPr>
        <p:spPr>
          <a:xfrm>
            <a:off x="461273" y="1005997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ure 8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7B570C3-5B81-4CC4-BFBF-0B91D59088D9}"/>
              </a:ext>
            </a:extLst>
          </p:cNvPr>
          <p:cNvSpPr txBox="1"/>
          <p:nvPr/>
        </p:nvSpPr>
        <p:spPr>
          <a:xfrm>
            <a:off x="780330" y="6388787"/>
            <a:ext cx="12334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upplementar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8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) The stomal cell with GATA3 ectopic expression did not confer L-Asp resistance. B) Ectopic GATA3 did not altered B-ALL cells cycle distribution. C) The allele frequencies of rs3824662 in B-ALL patients with L-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ap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allergy in CCCG-ALL-2015 cohort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8AE18A2A-ADCB-4C59-8A5D-E9A895D85B7A}"/>
              </a:ext>
            </a:extLst>
          </p:cNvPr>
          <p:cNvSpPr txBox="1"/>
          <p:nvPr/>
        </p:nvSpPr>
        <p:spPr>
          <a:xfrm>
            <a:off x="676037" y="227147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0C884C4-186B-4DCE-80C1-895666C6CE51}"/>
              </a:ext>
            </a:extLst>
          </p:cNvPr>
          <p:cNvSpPr txBox="1"/>
          <p:nvPr/>
        </p:nvSpPr>
        <p:spPr>
          <a:xfrm>
            <a:off x="4929322" y="227147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A6D4199-8EE1-4146-90B5-754ECA0CF8A8}"/>
              </a:ext>
            </a:extLst>
          </p:cNvPr>
          <p:cNvSpPr txBox="1"/>
          <p:nvPr/>
        </p:nvSpPr>
        <p:spPr>
          <a:xfrm>
            <a:off x="8569435" y="227147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802138345"/>
      </p:ext>
    </p:extLst>
  </p:cSld>
  <p:clrMapOvr>
    <a:masterClrMapping/>
  </p:clrMapOvr>
</p:sld>
</file>

<file path=ppt/theme/_rels/themeOverrid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41.jpeg"/></Relationships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质朴">
    <a:dk1>
      <a:sysClr val="windowText" lastClr="000000"/>
    </a:dk1>
    <a:lt1>
      <a:sysClr val="window" lastClr="FFFFFF"/>
    </a:lt1>
    <a:dk2>
      <a:srgbClr val="464653"/>
    </a:dk2>
    <a:lt2>
      <a:srgbClr val="DDE9EC"/>
    </a:lt2>
    <a:accent1>
      <a:srgbClr val="727CA3"/>
    </a:accent1>
    <a:accent2>
      <a:srgbClr val="9FB8CD"/>
    </a:accent2>
    <a:accent3>
      <a:srgbClr val="D2DA7A"/>
    </a:accent3>
    <a:accent4>
      <a:srgbClr val="FADA7A"/>
    </a:accent4>
    <a:accent5>
      <a:srgbClr val="B88472"/>
    </a:accent5>
    <a:accent6>
      <a:srgbClr val="8E736A"/>
    </a:accent6>
    <a:hlink>
      <a:srgbClr val="B292CA"/>
    </a:hlink>
    <a:folHlink>
      <a:srgbClr val="6B5680"/>
    </a:folHlink>
  </a:clrScheme>
  <a:fontScheme name="暗香扑面">
    <a:majorFont>
      <a:latin typeface="Franklin Gothic Medium"/>
      <a:ea typeface=""/>
      <a:cs typeface=""/>
      <a:font script="Jpan" typeface="HG創英角ｺﾞｼｯｸUB"/>
      <a:font script="Hang" typeface="HY견고딕"/>
      <a:font script="Hans" typeface="微软雅黑"/>
      <a:font script="Hant" typeface="微軟正黑體"/>
      <a:font script="Arab" typeface="Arial Bold"/>
      <a:font script="Hebr" typeface="Arial Bold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 Bold"/>
      <a:font script="Uigh" typeface="Microsoft Uighur"/>
      <a:font script="Geor" typeface="Sylfaen"/>
    </a:majorFont>
    <a:minorFont>
      <a:latin typeface="Franklin Gothic Book"/>
      <a:ea typeface=""/>
      <a:cs typeface=""/>
      <a:font script="Jpan" typeface="HG創英角ｺﾞｼｯｸUB"/>
      <a:font script="Hang" typeface="맑은 고딕"/>
      <a:font script="Hans" typeface="黑体"/>
      <a:font script="Hant" typeface="新細明體"/>
      <a:font script="Arab" typeface="Arial"/>
      <a:font script="Hebr" typeface="Arial"/>
      <a:font script="Thai" typeface="Cordian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都市">
    <a:fillStyleLst>
      <a:solidFill>
        <a:schemeClr val="phClr"/>
      </a:solidFill>
      <a:gradFill rotWithShape="1">
        <a:gsLst>
          <a:gs pos="0">
            <a:schemeClr val="phClr">
              <a:tint val="1000"/>
              <a:satMod val="255000"/>
            </a:schemeClr>
          </a:gs>
          <a:gs pos="55000">
            <a:schemeClr val="phClr">
              <a:tint val="12000"/>
              <a:satMod val="255000"/>
            </a:schemeClr>
          </a:gs>
          <a:gs pos="100000">
            <a:schemeClr val="phClr">
              <a:tint val="45000"/>
              <a:satMod val="250000"/>
            </a:schemeClr>
          </a:gs>
        </a:gsLst>
        <a:path path="circle">
          <a:fillToRect l="-40000" t="-90000" r="140000" b="190000"/>
        </a:path>
      </a:gradFill>
      <a:gradFill rotWithShape="1">
        <a:gsLst>
          <a:gs pos="0">
            <a:schemeClr val="phClr">
              <a:tint val="43000"/>
              <a:satMod val="165000"/>
            </a:schemeClr>
          </a:gs>
          <a:gs pos="55000">
            <a:schemeClr val="phClr">
              <a:tint val="83000"/>
              <a:satMod val="155000"/>
            </a:schemeClr>
          </a:gs>
          <a:gs pos="100000">
            <a:schemeClr val="phClr">
              <a:shade val="85000"/>
            </a:schemeClr>
          </a:gs>
        </a:gsLst>
        <a:path path="circle">
          <a:fillToRect l="-40000" t="-90000" r="140000" b="190000"/>
        </a:path>
      </a:gradFill>
    </a:fillStyleLst>
    <a:lnStyleLst>
      <a:ln w="9525" cap="flat" cmpd="sng" algn="ctr">
        <a:solidFill>
          <a:schemeClr val="phClr"/>
        </a:solidFill>
        <a:prstDash val="solid"/>
      </a:ln>
      <a:ln w="19050" cap="flat" cmpd="sng" algn="ctr">
        <a:solidFill>
          <a:schemeClr val="phClr"/>
        </a:solidFill>
        <a:prstDash val="solid"/>
      </a:ln>
      <a:ln w="3175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51500" dist="25400" dir="5400000" rotWithShape="0">
            <a:srgbClr val="000000">
              <a:alpha val="40000"/>
            </a:srgbClr>
          </a:outerShdw>
        </a:effectLst>
      </a:effectStyle>
      <a:effectStyle>
        <a:effectLst>
          <a:outerShdw blurRad="50800" dist="25400" dir="5400000" rotWithShape="0">
            <a:srgbClr val="000000">
              <a:alpha val="45000"/>
            </a:srgbClr>
          </a:outerShdw>
        </a:effectLst>
      </a:effectStyle>
      <a:effectStyle>
        <a:effectLst>
          <a:outerShdw blurRad="50800" dist="25400" dir="5400000" rotWithShape="0">
            <a:srgbClr val="000000">
              <a:alpha val="45000"/>
            </a:srgbClr>
          </a:outerShdw>
        </a:effectLst>
        <a:scene3d>
          <a:camera prst="orthographicFront" fov="0">
            <a:rot lat="0" lon="0" rev="0"/>
          </a:camera>
          <a:lightRig rig="flat" dir="t">
            <a:rot lat="0" lon="0" rev="20040000"/>
          </a:lightRig>
        </a:scene3d>
        <a:sp3d contourW="12700" prstMaterial="dkEdge">
          <a:bevelT w="25400" h="38100" prst="convex"/>
          <a:contourClr>
            <a:schemeClr val="phClr">
              <a:satMod val="115000"/>
            </a:schemeClr>
          </a:contourClr>
        </a:sp3d>
      </a:effectStyle>
    </a:effectStyleLst>
    <a:bgFillStyleLst>
      <a:solidFill>
        <a:schemeClr val="phClr"/>
      </a:solidFill>
      <a:gradFill rotWithShape="1">
        <a:gsLst>
          <a:gs pos="100000">
            <a:schemeClr val="phClr">
              <a:tint val="80000"/>
              <a:satMod val="250000"/>
            </a:schemeClr>
          </a:gs>
          <a:gs pos="60000">
            <a:schemeClr val="phClr">
              <a:shade val="38000"/>
              <a:satMod val="175000"/>
            </a:schemeClr>
          </a:gs>
          <a:gs pos="0">
            <a:schemeClr val="phClr">
              <a:shade val="30000"/>
              <a:satMod val="175000"/>
            </a:schemeClr>
          </a:gs>
        </a:gsLst>
        <a:lin ang="5400000" scaled="0"/>
      </a:gradFill>
      <a:blipFill>
        <a:blip xmlns:r="http://schemas.openxmlformats.org/officeDocument/2006/relationships" r:embed="rId1">
          <a:duotone>
            <a:schemeClr val="phClr">
              <a:shade val="48000"/>
            </a:schemeClr>
            <a:schemeClr val="phClr">
              <a:tint val="96000"/>
              <a:satMod val="150000"/>
            </a:schemeClr>
          </a:duotone>
        </a:blip>
        <a:tile tx="0" ty="0" sx="80000" sy="80000" flip="none" algn="tl"/>
      </a:blip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86</TotalTime>
  <Words>1746</Words>
  <Application>Microsoft Office PowerPoint</Application>
  <PresentationFormat>自定义</PresentationFormat>
  <Paragraphs>760</Paragraphs>
  <Slides>11</Slides>
  <Notes>5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Office 主题​​</vt:lpstr>
      <vt:lpstr>Prism 7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hui</dc:creator>
  <cp:lastModifiedBy>Li Chunjie</cp:lastModifiedBy>
  <cp:revision>180</cp:revision>
  <dcterms:created xsi:type="dcterms:W3CDTF">2020-03-17T02:06:07Z</dcterms:created>
  <dcterms:modified xsi:type="dcterms:W3CDTF">2021-04-24T08:24:06Z</dcterms:modified>
</cp:coreProperties>
</file>